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9"/>
  </p:notesMasterIdLst>
  <p:sldIdLst>
    <p:sldId id="297" r:id="rId2"/>
    <p:sldId id="280" r:id="rId3"/>
    <p:sldId id="288" r:id="rId4"/>
    <p:sldId id="302" r:id="rId5"/>
    <p:sldId id="298" r:id="rId6"/>
    <p:sldId id="301" r:id="rId7"/>
    <p:sldId id="282" r:id="rId8"/>
    <p:sldId id="256" r:id="rId9"/>
    <p:sldId id="258" r:id="rId10"/>
    <p:sldId id="257" r:id="rId11"/>
    <p:sldId id="279" r:id="rId12"/>
    <p:sldId id="294" r:id="rId13"/>
    <p:sldId id="295" r:id="rId14"/>
    <p:sldId id="296" r:id="rId15"/>
    <p:sldId id="286" r:id="rId16"/>
    <p:sldId id="284" r:id="rId17"/>
    <p:sldId id="287" r:id="rId18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1" id="{642194CC-1A8D-4724-A56E-5F9D5F03A412}">
          <p14:sldIdLst>
            <p14:sldId id="297"/>
          </p14:sldIdLst>
        </p14:section>
        <p14:section name="S2" id="{CF552E9E-F742-45B0-B59C-F89754C8AE76}">
          <p14:sldIdLst>
            <p14:sldId id="280"/>
          </p14:sldIdLst>
        </p14:section>
        <p14:section name="S3" id="{4B0E024D-A271-4E51-99F0-41DBFA6CC49C}">
          <p14:sldIdLst>
            <p14:sldId id="288"/>
          </p14:sldIdLst>
        </p14:section>
        <p14:section name="S4" id="{AE9E4781-C2C3-41A6-88EB-3F1491B1D321}">
          <p14:sldIdLst>
            <p14:sldId id="302"/>
            <p14:sldId id="298"/>
          </p14:sldIdLst>
        </p14:section>
        <p14:section name="S5" id="{9FEE9E1F-053B-4457-B8B5-287DC5A3F01B}">
          <p14:sldIdLst>
            <p14:sldId id="301"/>
          </p14:sldIdLst>
        </p14:section>
        <p14:section name="S6" id="{2F1BADBF-0196-4CDE-B46F-02EAE93712E7}">
          <p14:sldIdLst>
            <p14:sldId id="282"/>
          </p14:sldIdLst>
        </p14:section>
        <p14:section name="S7" id="{2C3520BA-DB6B-4712-9519-FB21C6CC38C5}">
          <p14:sldIdLst>
            <p14:sldId id="256"/>
          </p14:sldIdLst>
        </p14:section>
        <p14:section name="S8" id="{BBE74CF1-D7F0-4288-9C73-2531879D2448}">
          <p14:sldIdLst>
            <p14:sldId id="258"/>
          </p14:sldIdLst>
        </p14:section>
        <p14:section name="S9" id="{112E0BA4-30FF-42C6-881E-6E4FB80BD310}">
          <p14:sldIdLst>
            <p14:sldId id="257"/>
          </p14:sldIdLst>
        </p14:section>
        <p14:section name="S10" id="{424EA216-B571-4C18-BBC5-4AE3AE685E57}">
          <p14:sldIdLst>
            <p14:sldId id="279"/>
          </p14:sldIdLst>
        </p14:section>
        <p14:section name="S11" id="{DFA2180B-00C3-D54F-9061-5C37DC5EDD5D}">
          <p14:sldIdLst>
            <p14:sldId id="294"/>
            <p14:sldId id="295"/>
            <p14:sldId id="296"/>
          </p14:sldIdLst>
        </p14:section>
        <p14:section name="Tables" id="{F8F3809B-E9E1-4632-9F9F-0AEF9FC788E2}">
          <p14:sldIdLst>
            <p14:sldId id="286"/>
            <p14:sldId id="284"/>
            <p14:sldId id="28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10E0"/>
    <a:srgbClr val="4A90E2"/>
    <a:srgbClr val="D0021B"/>
    <a:srgbClr val="F5A623"/>
    <a:srgbClr val="F8E71C"/>
    <a:srgbClr val="4175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13" autoAdjust="0"/>
    <p:restoredTop sz="95976" autoAdjust="0"/>
  </p:normalViewPr>
  <p:slideViewPr>
    <p:cSldViewPr snapToGrid="0">
      <p:cViewPr varScale="1">
        <p:scale>
          <a:sx n="92" d="100"/>
          <a:sy n="92" d="100"/>
        </p:scale>
        <p:origin x="11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03EF97-9CFC-4DB4-B62A-D60054C6BE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3695A4-D20B-4E5A-9858-014F9A88ED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950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3695A4-D20B-4E5A-9858-014F9A88ED0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2265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3695A4-D20B-4E5A-9858-014F9A88ED0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2558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3695A4-D20B-4E5A-9858-014F9A88ED08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05384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3695A4-D20B-4E5A-9858-014F9A88ED08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223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99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634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199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354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166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794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96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56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016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895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355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6843F-5A05-41DB-A197-F0523AC36257}" type="datetimeFigureOut">
              <a:rPr lang="en-US" smtClean="0"/>
              <a:t>6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1A0B6-396C-4205-A903-F71E28D06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884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80.png"/><Relationship Id="rId26" Type="http://schemas.openxmlformats.org/officeDocument/2006/relationships/image" Target="../media/image84.tiff"/><Relationship Id="rId3" Type="http://schemas.microsoft.com/office/2007/relationships/hdphoto" Target="../media/hdphoto1.wdp"/><Relationship Id="rId21" Type="http://schemas.microsoft.com/office/2007/relationships/hdphoto" Target="../media/hdphoto10.wdp"/><Relationship Id="rId34" Type="http://schemas.openxmlformats.org/officeDocument/2006/relationships/image" Target="../media/image69.png"/><Relationship Id="rId7" Type="http://schemas.microsoft.com/office/2007/relationships/hdphoto" Target="../media/hdphoto3.wdp"/><Relationship Id="rId12" Type="http://schemas.openxmlformats.org/officeDocument/2006/relationships/image" Target="../media/image77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3.wdp"/><Relationship Id="rId2" Type="http://schemas.openxmlformats.org/officeDocument/2006/relationships/image" Target="../media/image72.png"/><Relationship Id="rId16" Type="http://schemas.openxmlformats.org/officeDocument/2006/relationships/image" Target="../media/image79.png"/><Relationship Id="rId20" Type="http://schemas.openxmlformats.org/officeDocument/2006/relationships/image" Target="../media/image81.png"/><Relationship Id="rId29" Type="http://schemas.openxmlformats.org/officeDocument/2006/relationships/image" Target="../media/image8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4.png"/><Relationship Id="rId11" Type="http://schemas.microsoft.com/office/2007/relationships/hdphoto" Target="../media/hdphoto5.wdp"/><Relationship Id="rId24" Type="http://schemas.openxmlformats.org/officeDocument/2006/relationships/image" Target="../media/image83.png"/><Relationship Id="rId32" Type="http://schemas.openxmlformats.org/officeDocument/2006/relationships/image" Target="../media/image90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86.tiff"/><Relationship Id="rId10" Type="http://schemas.openxmlformats.org/officeDocument/2006/relationships/image" Target="../media/image76.png"/><Relationship Id="rId19" Type="http://schemas.microsoft.com/office/2007/relationships/hdphoto" Target="../media/hdphoto9.wdp"/><Relationship Id="rId31" Type="http://schemas.openxmlformats.org/officeDocument/2006/relationships/image" Target="../media/image89.png"/><Relationship Id="rId4" Type="http://schemas.openxmlformats.org/officeDocument/2006/relationships/image" Target="../media/image73.png"/><Relationship Id="rId9" Type="http://schemas.microsoft.com/office/2007/relationships/hdphoto" Target="../media/hdphoto4.wdp"/><Relationship Id="rId14" Type="http://schemas.openxmlformats.org/officeDocument/2006/relationships/image" Target="../media/image78.png"/><Relationship Id="rId22" Type="http://schemas.openxmlformats.org/officeDocument/2006/relationships/image" Target="../media/image82.png"/><Relationship Id="rId27" Type="http://schemas.openxmlformats.org/officeDocument/2006/relationships/image" Target="../media/image85.png"/><Relationship Id="rId30" Type="http://schemas.openxmlformats.org/officeDocument/2006/relationships/image" Target="../media/image88.tiff"/><Relationship Id="rId8" Type="http://schemas.openxmlformats.org/officeDocument/2006/relationships/image" Target="../media/image7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7.tiff"/><Relationship Id="rId13" Type="http://schemas.openxmlformats.org/officeDocument/2006/relationships/image" Target="../media/image102.tiff"/><Relationship Id="rId18" Type="http://schemas.openxmlformats.org/officeDocument/2006/relationships/image" Target="../media/image107.tiff"/><Relationship Id="rId3" Type="http://schemas.openxmlformats.org/officeDocument/2006/relationships/image" Target="../media/image92.tiff"/><Relationship Id="rId21" Type="http://schemas.openxmlformats.org/officeDocument/2006/relationships/image" Target="../media/image110.tiff"/><Relationship Id="rId7" Type="http://schemas.openxmlformats.org/officeDocument/2006/relationships/image" Target="../media/image96.tiff"/><Relationship Id="rId12" Type="http://schemas.openxmlformats.org/officeDocument/2006/relationships/image" Target="../media/image101.tiff"/><Relationship Id="rId17" Type="http://schemas.openxmlformats.org/officeDocument/2006/relationships/image" Target="../media/image106.tiff"/><Relationship Id="rId25" Type="http://schemas.openxmlformats.org/officeDocument/2006/relationships/image" Target="../media/image68.tiff"/><Relationship Id="rId2" Type="http://schemas.openxmlformats.org/officeDocument/2006/relationships/image" Target="../media/image91.tiff"/><Relationship Id="rId16" Type="http://schemas.openxmlformats.org/officeDocument/2006/relationships/image" Target="../media/image105.tiff"/><Relationship Id="rId20" Type="http://schemas.openxmlformats.org/officeDocument/2006/relationships/image" Target="../media/image10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5.tiff"/><Relationship Id="rId11" Type="http://schemas.openxmlformats.org/officeDocument/2006/relationships/image" Target="../media/image100.tiff"/><Relationship Id="rId24" Type="http://schemas.openxmlformats.org/officeDocument/2006/relationships/image" Target="../media/image86.tiff"/><Relationship Id="rId5" Type="http://schemas.openxmlformats.org/officeDocument/2006/relationships/image" Target="../media/image94.tiff"/><Relationship Id="rId15" Type="http://schemas.openxmlformats.org/officeDocument/2006/relationships/image" Target="../media/image104.tiff"/><Relationship Id="rId23" Type="http://schemas.openxmlformats.org/officeDocument/2006/relationships/image" Target="../media/image84.tiff"/><Relationship Id="rId10" Type="http://schemas.openxmlformats.org/officeDocument/2006/relationships/image" Target="../media/image99.tiff"/><Relationship Id="rId19" Type="http://schemas.openxmlformats.org/officeDocument/2006/relationships/image" Target="../media/image108.tiff"/><Relationship Id="rId4" Type="http://schemas.openxmlformats.org/officeDocument/2006/relationships/image" Target="../media/image93.tiff"/><Relationship Id="rId9" Type="http://schemas.openxmlformats.org/officeDocument/2006/relationships/image" Target="../media/image98.tiff"/><Relationship Id="rId14" Type="http://schemas.openxmlformats.org/officeDocument/2006/relationships/image" Target="../media/image103.tiff"/><Relationship Id="rId22" Type="http://schemas.openxmlformats.org/officeDocument/2006/relationships/image" Target="../media/image111.tif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8.png"/><Relationship Id="rId13" Type="http://schemas.openxmlformats.org/officeDocument/2006/relationships/image" Target="../media/image123.png"/><Relationship Id="rId18" Type="http://schemas.openxmlformats.org/officeDocument/2006/relationships/image" Target="../media/image128.png"/><Relationship Id="rId26" Type="http://schemas.openxmlformats.org/officeDocument/2006/relationships/image" Target="../media/image136.png"/><Relationship Id="rId3" Type="http://schemas.openxmlformats.org/officeDocument/2006/relationships/image" Target="../media/image113.png"/><Relationship Id="rId21" Type="http://schemas.openxmlformats.org/officeDocument/2006/relationships/image" Target="../media/image131.png"/><Relationship Id="rId7" Type="http://schemas.openxmlformats.org/officeDocument/2006/relationships/image" Target="../media/image117.png"/><Relationship Id="rId12" Type="http://schemas.openxmlformats.org/officeDocument/2006/relationships/image" Target="../media/image122.png"/><Relationship Id="rId17" Type="http://schemas.openxmlformats.org/officeDocument/2006/relationships/image" Target="../media/image127.png"/><Relationship Id="rId25" Type="http://schemas.openxmlformats.org/officeDocument/2006/relationships/image" Target="../media/image135.png"/><Relationship Id="rId2" Type="http://schemas.openxmlformats.org/officeDocument/2006/relationships/image" Target="../media/image112.png"/><Relationship Id="rId16" Type="http://schemas.openxmlformats.org/officeDocument/2006/relationships/image" Target="../media/image126.png"/><Relationship Id="rId20" Type="http://schemas.openxmlformats.org/officeDocument/2006/relationships/image" Target="../media/image130.png"/><Relationship Id="rId29" Type="http://schemas.openxmlformats.org/officeDocument/2006/relationships/image" Target="../media/image1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6.png"/><Relationship Id="rId11" Type="http://schemas.openxmlformats.org/officeDocument/2006/relationships/image" Target="../media/image121.png"/><Relationship Id="rId24" Type="http://schemas.openxmlformats.org/officeDocument/2006/relationships/image" Target="../media/image134.png"/><Relationship Id="rId5" Type="http://schemas.openxmlformats.org/officeDocument/2006/relationships/image" Target="../media/image115.png"/><Relationship Id="rId15" Type="http://schemas.openxmlformats.org/officeDocument/2006/relationships/image" Target="../media/image125.png"/><Relationship Id="rId23" Type="http://schemas.openxmlformats.org/officeDocument/2006/relationships/image" Target="../media/image133.png"/><Relationship Id="rId28" Type="http://schemas.openxmlformats.org/officeDocument/2006/relationships/image" Target="../media/image138.png"/><Relationship Id="rId10" Type="http://schemas.openxmlformats.org/officeDocument/2006/relationships/image" Target="../media/image120.png"/><Relationship Id="rId19" Type="http://schemas.openxmlformats.org/officeDocument/2006/relationships/image" Target="../media/image129.png"/><Relationship Id="rId31" Type="http://schemas.openxmlformats.org/officeDocument/2006/relationships/image" Target="../media/image141.png"/><Relationship Id="rId4" Type="http://schemas.openxmlformats.org/officeDocument/2006/relationships/image" Target="../media/image114.png"/><Relationship Id="rId9" Type="http://schemas.openxmlformats.org/officeDocument/2006/relationships/image" Target="../media/image119.png"/><Relationship Id="rId14" Type="http://schemas.openxmlformats.org/officeDocument/2006/relationships/image" Target="../media/image124.png"/><Relationship Id="rId22" Type="http://schemas.openxmlformats.org/officeDocument/2006/relationships/image" Target="../media/image132.png"/><Relationship Id="rId27" Type="http://schemas.openxmlformats.org/officeDocument/2006/relationships/image" Target="../media/image137.png"/><Relationship Id="rId30" Type="http://schemas.openxmlformats.org/officeDocument/2006/relationships/image" Target="../media/image140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7.png"/><Relationship Id="rId13" Type="http://schemas.openxmlformats.org/officeDocument/2006/relationships/image" Target="../media/image152.png"/><Relationship Id="rId18" Type="http://schemas.openxmlformats.org/officeDocument/2006/relationships/image" Target="../media/image157.png"/><Relationship Id="rId26" Type="http://schemas.openxmlformats.org/officeDocument/2006/relationships/image" Target="../media/image165.png"/><Relationship Id="rId3" Type="http://schemas.openxmlformats.org/officeDocument/2006/relationships/image" Target="../media/image142.png"/><Relationship Id="rId21" Type="http://schemas.openxmlformats.org/officeDocument/2006/relationships/image" Target="../media/image160.png"/><Relationship Id="rId7" Type="http://schemas.openxmlformats.org/officeDocument/2006/relationships/image" Target="../media/image146.png"/><Relationship Id="rId12" Type="http://schemas.openxmlformats.org/officeDocument/2006/relationships/image" Target="../media/image151.png"/><Relationship Id="rId17" Type="http://schemas.openxmlformats.org/officeDocument/2006/relationships/image" Target="../media/image156.png"/><Relationship Id="rId25" Type="http://schemas.openxmlformats.org/officeDocument/2006/relationships/image" Target="../media/image164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155.png"/><Relationship Id="rId20" Type="http://schemas.openxmlformats.org/officeDocument/2006/relationships/image" Target="../media/image159.png"/><Relationship Id="rId29" Type="http://schemas.openxmlformats.org/officeDocument/2006/relationships/image" Target="../media/image16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5.png"/><Relationship Id="rId11" Type="http://schemas.openxmlformats.org/officeDocument/2006/relationships/image" Target="../media/image150.png"/><Relationship Id="rId24" Type="http://schemas.openxmlformats.org/officeDocument/2006/relationships/image" Target="../media/image163.png"/><Relationship Id="rId32" Type="http://schemas.openxmlformats.org/officeDocument/2006/relationships/image" Target="../media/image171.png"/><Relationship Id="rId5" Type="http://schemas.openxmlformats.org/officeDocument/2006/relationships/image" Target="../media/image144.png"/><Relationship Id="rId15" Type="http://schemas.openxmlformats.org/officeDocument/2006/relationships/image" Target="../media/image154.png"/><Relationship Id="rId23" Type="http://schemas.openxmlformats.org/officeDocument/2006/relationships/image" Target="../media/image162.png"/><Relationship Id="rId28" Type="http://schemas.openxmlformats.org/officeDocument/2006/relationships/image" Target="../media/image167.png"/><Relationship Id="rId10" Type="http://schemas.openxmlformats.org/officeDocument/2006/relationships/image" Target="../media/image149.png"/><Relationship Id="rId19" Type="http://schemas.openxmlformats.org/officeDocument/2006/relationships/image" Target="../media/image158.png"/><Relationship Id="rId31" Type="http://schemas.openxmlformats.org/officeDocument/2006/relationships/image" Target="../media/image170.png"/><Relationship Id="rId4" Type="http://schemas.openxmlformats.org/officeDocument/2006/relationships/image" Target="../media/image143.png"/><Relationship Id="rId9" Type="http://schemas.openxmlformats.org/officeDocument/2006/relationships/image" Target="../media/image148.png"/><Relationship Id="rId14" Type="http://schemas.openxmlformats.org/officeDocument/2006/relationships/image" Target="../media/image153.png"/><Relationship Id="rId22" Type="http://schemas.openxmlformats.org/officeDocument/2006/relationships/image" Target="../media/image161.png"/><Relationship Id="rId27" Type="http://schemas.openxmlformats.org/officeDocument/2006/relationships/image" Target="../media/image166.png"/><Relationship Id="rId30" Type="http://schemas.openxmlformats.org/officeDocument/2006/relationships/image" Target="../media/image169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7.png"/><Relationship Id="rId13" Type="http://schemas.openxmlformats.org/officeDocument/2006/relationships/image" Target="../media/image182.png"/><Relationship Id="rId3" Type="http://schemas.openxmlformats.org/officeDocument/2006/relationships/image" Target="../media/image172.png"/><Relationship Id="rId7" Type="http://schemas.openxmlformats.org/officeDocument/2006/relationships/image" Target="../media/image176.png"/><Relationship Id="rId12" Type="http://schemas.openxmlformats.org/officeDocument/2006/relationships/image" Target="../media/image181.png"/><Relationship Id="rId17" Type="http://schemas.openxmlformats.org/officeDocument/2006/relationships/image" Target="../media/image186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8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5.png"/><Relationship Id="rId11" Type="http://schemas.openxmlformats.org/officeDocument/2006/relationships/image" Target="../media/image180.png"/><Relationship Id="rId5" Type="http://schemas.openxmlformats.org/officeDocument/2006/relationships/image" Target="../media/image174.png"/><Relationship Id="rId15" Type="http://schemas.openxmlformats.org/officeDocument/2006/relationships/image" Target="../media/image184.png"/><Relationship Id="rId10" Type="http://schemas.openxmlformats.org/officeDocument/2006/relationships/image" Target="../media/image179.png"/><Relationship Id="rId4" Type="http://schemas.openxmlformats.org/officeDocument/2006/relationships/image" Target="../media/image173.png"/><Relationship Id="rId9" Type="http://schemas.openxmlformats.org/officeDocument/2006/relationships/image" Target="../media/image178.png"/><Relationship Id="rId14" Type="http://schemas.openxmlformats.org/officeDocument/2006/relationships/image" Target="../media/image18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25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Relationship Id="rId9" Type="http://schemas.openxmlformats.org/officeDocument/2006/relationships/image" Target="../media/image2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tiff"/><Relationship Id="rId3" Type="http://schemas.openxmlformats.org/officeDocument/2006/relationships/image" Target="../media/image36.tiff"/><Relationship Id="rId7" Type="http://schemas.openxmlformats.org/officeDocument/2006/relationships/image" Target="../media/image40.tiff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tiff"/><Relationship Id="rId5" Type="http://schemas.openxmlformats.org/officeDocument/2006/relationships/image" Target="../media/image38.tiff"/><Relationship Id="rId10" Type="http://schemas.openxmlformats.org/officeDocument/2006/relationships/image" Target="../media/image43.tiff"/><Relationship Id="rId4" Type="http://schemas.openxmlformats.org/officeDocument/2006/relationships/image" Target="../media/image37.tiff"/><Relationship Id="rId9" Type="http://schemas.openxmlformats.org/officeDocument/2006/relationships/image" Target="../media/image42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8.png"/><Relationship Id="rId11" Type="http://schemas.openxmlformats.org/officeDocument/2006/relationships/image" Target="../media/image53.png"/><Relationship Id="rId5" Type="http://schemas.openxmlformats.org/officeDocument/2006/relationships/image" Target="../media/image47.png"/><Relationship Id="rId10" Type="http://schemas.openxmlformats.org/officeDocument/2006/relationships/image" Target="../media/image52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png"/><Relationship Id="rId13" Type="http://schemas.openxmlformats.org/officeDocument/2006/relationships/image" Target="../media/image65.png"/><Relationship Id="rId18" Type="http://schemas.openxmlformats.org/officeDocument/2006/relationships/image" Target="../media/image70.png"/><Relationship Id="rId3" Type="http://schemas.openxmlformats.org/officeDocument/2006/relationships/image" Target="../media/image55.png"/><Relationship Id="rId7" Type="http://schemas.openxmlformats.org/officeDocument/2006/relationships/image" Target="../media/image59.png"/><Relationship Id="rId12" Type="http://schemas.openxmlformats.org/officeDocument/2006/relationships/image" Target="../media/image64.png"/><Relationship Id="rId17" Type="http://schemas.openxmlformats.org/officeDocument/2006/relationships/image" Target="../media/image69.png"/><Relationship Id="rId2" Type="http://schemas.openxmlformats.org/officeDocument/2006/relationships/image" Target="../media/image54.png"/><Relationship Id="rId16" Type="http://schemas.openxmlformats.org/officeDocument/2006/relationships/image" Target="../media/image6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png"/><Relationship Id="rId11" Type="http://schemas.openxmlformats.org/officeDocument/2006/relationships/image" Target="../media/image63.png"/><Relationship Id="rId5" Type="http://schemas.openxmlformats.org/officeDocument/2006/relationships/image" Target="../media/image57.png"/><Relationship Id="rId15" Type="http://schemas.openxmlformats.org/officeDocument/2006/relationships/image" Target="../media/image67.png"/><Relationship Id="rId10" Type="http://schemas.openxmlformats.org/officeDocument/2006/relationships/image" Target="../media/image62.png"/><Relationship Id="rId19" Type="http://schemas.openxmlformats.org/officeDocument/2006/relationships/image" Target="../media/image71.png"/><Relationship Id="rId4" Type="http://schemas.openxmlformats.org/officeDocument/2006/relationships/image" Target="../media/image56.png"/><Relationship Id="rId9" Type="http://schemas.openxmlformats.org/officeDocument/2006/relationships/image" Target="../media/image61.png"/><Relationship Id="rId14" Type="http://schemas.openxmlformats.org/officeDocument/2006/relationships/image" Target="../media/image6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75424" y="711987"/>
            <a:ext cx="6457520" cy="5951880"/>
            <a:chOff x="1675424" y="711987"/>
            <a:chExt cx="6457520" cy="5951880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2108123-1994-8C79-09F7-1DC87C323E73}"/>
                </a:ext>
              </a:extLst>
            </p:cNvPr>
            <p:cNvSpPr txBox="1"/>
            <p:nvPr/>
          </p:nvSpPr>
          <p:spPr>
            <a:xfrm>
              <a:off x="1744980" y="5340428"/>
              <a:ext cx="6387964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igure S1. Editing of human iPSCs through CRISPR/Cas9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. A) NHEJ-mediated knockout (</a:t>
              </a:r>
              <a:r>
                <a:rPr lang="en-US" sz="800" b="1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b="1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 was performed using dual sgRNAs (sgKO5’ and sgKO3’) targeting regions flanking the CDS of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.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)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ildtype (</a:t>
              </a:r>
              <a:r>
                <a:rPr lang="en-US" sz="800" b="1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b="1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 reporter iPSCs were established through HR by simultaneous co-transfection of a donor plasmid containing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equences encoding the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CDS followed by an c-MYC tag, a self-cleaving peptide P2A and eGFP expression cassette flanked by 600 bp homology arms including PAM-site mutations as well as sgRNA cleavage sites for plasmid linearization.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)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(</a:t>
              </a:r>
              <a:r>
                <a:rPr lang="en-US" sz="800" b="1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b="1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 reporter iPSCs were established similarly to WT reporter iPSCs, however the donor plasmid contained the sequence encoding eGFP flanked by homology arms.</a:t>
              </a:r>
              <a:r>
                <a:rPr lang="en-US" sz="800" b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D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oding sequenc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enhanced green fluorescent protein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homology arm,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R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homologous recombination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PS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induced pluripotent stem cell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knockout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HEJ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nonhomologous end join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2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porcine teschovirus-1 2A self-cleaving peptide; </a:t>
              </a:r>
              <a:r>
                <a:rPr lang="en-US" sz="800" b="1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gKO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single-guide RNA for ATOH7 knockout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-</a:t>
              </a:r>
              <a:r>
                <a:rPr lang="en-US" sz="800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yc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ta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UTR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untranslated region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AM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protospacer-adjacent motif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.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41CFC325-855A-70DC-79DC-C8A2D94833E2}"/>
                </a:ext>
              </a:extLst>
            </p:cNvPr>
            <p:cNvCxnSpPr>
              <a:cxnSpLocks/>
              <a:stCxn id="62" idx="0"/>
              <a:endCxn id="49" idx="2"/>
            </p:cNvCxnSpPr>
            <p:nvPr/>
          </p:nvCxnSpPr>
          <p:spPr>
            <a:xfrm flipV="1">
              <a:off x="2696291" y="2187995"/>
              <a:ext cx="972387" cy="449958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FC16F357-613D-F060-0622-D2CC90CD26E6}"/>
                </a:ext>
              </a:extLst>
            </p:cNvPr>
            <p:cNvCxnSpPr>
              <a:cxnSpLocks/>
              <a:stCxn id="63" idx="0"/>
              <a:endCxn id="50" idx="2"/>
            </p:cNvCxnSpPr>
            <p:nvPr/>
          </p:nvCxnSpPr>
          <p:spPr>
            <a:xfrm flipH="1" flipV="1">
              <a:off x="6260453" y="2187995"/>
              <a:ext cx="866273" cy="449958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52CC5D03-3CB6-C7AC-9067-E4EE65513FA9}"/>
                </a:ext>
              </a:extLst>
            </p:cNvPr>
            <p:cNvSpPr/>
            <p:nvPr/>
          </p:nvSpPr>
          <p:spPr>
            <a:xfrm>
              <a:off x="1803400" y="2699249"/>
              <a:ext cx="6208647" cy="397323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H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C8B7317E-952E-522E-AEFD-403EE6879222}"/>
                </a:ext>
              </a:extLst>
            </p:cNvPr>
            <p:cNvSpPr/>
            <p:nvPr/>
          </p:nvSpPr>
          <p:spPr>
            <a:xfrm>
              <a:off x="1955611" y="2637953"/>
              <a:ext cx="1481359" cy="141301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SE" sz="900" b="1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  <a:r>
                <a:rPr lang="sv-S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HA</a:t>
              </a:r>
              <a:endParaRPr lang="en-CH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4438B140-C045-BB65-00DF-B2E137B1EB7C}"/>
                </a:ext>
              </a:extLst>
            </p:cNvPr>
            <p:cNvSpPr/>
            <p:nvPr/>
          </p:nvSpPr>
          <p:spPr>
            <a:xfrm>
              <a:off x="6386046" y="2637953"/>
              <a:ext cx="1481359" cy="141301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SE" sz="900" b="1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HA</a:t>
              </a:r>
              <a:endParaRPr lang="en-CH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6E18E2B1-2929-4D47-D312-6A8CB65D6773}"/>
                </a:ext>
              </a:extLst>
            </p:cNvPr>
            <p:cNvSpPr/>
            <p:nvPr/>
          </p:nvSpPr>
          <p:spPr>
            <a:xfrm>
              <a:off x="4645843" y="2637953"/>
              <a:ext cx="307708" cy="14130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H" sz="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D5B0BE44-D353-05D7-B947-FB06F5A4D2FE}"/>
                </a:ext>
              </a:extLst>
            </p:cNvPr>
            <p:cNvSpPr/>
            <p:nvPr/>
          </p:nvSpPr>
          <p:spPr>
            <a:xfrm>
              <a:off x="4953551" y="2637953"/>
              <a:ext cx="1432495" cy="14130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SE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SE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orter</a:t>
              </a:r>
              <a:endParaRPr lang="en-CH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9FE16D7-594F-22A1-E9B7-05D1AAE299B1}"/>
                </a:ext>
              </a:extLst>
            </p:cNvPr>
            <p:cNvSpPr txBox="1"/>
            <p:nvPr/>
          </p:nvSpPr>
          <p:spPr>
            <a:xfrm>
              <a:off x="4302347" y="2787128"/>
              <a:ext cx="18473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endParaRPr lang="en-CH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8439729-E84B-8665-3BA0-73AD87E65291}"/>
                </a:ext>
              </a:extLst>
            </p:cNvPr>
            <p:cNvSpPr txBox="1"/>
            <p:nvPr/>
          </p:nvSpPr>
          <p:spPr>
            <a:xfrm>
              <a:off x="1917898" y="3116896"/>
              <a:ext cx="6094149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57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mini plasmid donor</a:t>
              </a:r>
              <a:endParaRPr lang="en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E4F20196-C371-B2F3-148F-C856750762E9}"/>
                </a:ext>
              </a:extLst>
            </p:cNvPr>
            <p:cNvSpPr txBox="1"/>
            <p:nvPr/>
          </p:nvSpPr>
          <p:spPr>
            <a:xfrm>
              <a:off x="3091210" y="2787569"/>
              <a:ext cx="580608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23076B5-668B-C450-07FE-07C7C3FD97D9}"/>
                </a:ext>
              </a:extLst>
            </p:cNvPr>
            <p:cNvSpPr txBox="1"/>
            <p:nvPr/>
          </p:nvSpPr>
          <p:spPr>
            <a:xfrm>
              <a:off x="6140889" y="2787569"/>
              <a:ext cx="580608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SE" sz="7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14AAD4CD-E0C5-A953-F226-394F10EA0819}"/>
                </a:ext>
              </a:extLst>
            </p:cNvPr>
            <p:cNvSpPr/>
            <p:nvPr/>
          </p:nvSpPr>
          <p:spPr>
            <a:xfrm>
              <a:off x="3373999" y="2637953"/>
              <a:ext cx="18000" cy="14130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H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58A8053E-9117-9F42-3E1C-E5951CE5BB78}"/>
                </a:ext>
              </a:extLst>
            </p:cNvPr>
            <p:cNvSpPr/>
            <p:nvPr/>
          </p:nvSpPr>
          <p:spPr>
            <a:xfrm>
              <a:off x="6421391" y="2638484"/>
              <a:ext cx="18000" cy="14130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H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4297906E-833B-7C8E-C780-29DC20D7E5D0}"/>
                </a:ext>
              </a:extLst>
            </p:cNvPr>
            <p:cNvGrpSpPr/>
            <p:nvPr/>
          </p:nvGrpSpPr>
          <p:grpSpPr>
            <a:xfrm>
              <a:off x="1675424" y="2430495"/>
              <a:ext cx="478016" cy="398186"/>
              <a:chOff x="2714380" y="1538776"/>
              <a:chExt cx="478016" cy="398186"/>
            </a:xfrm>
          </p:grpSpPr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55E82350-61EE-27A7-A68F-301087815116}"/>
                  </a:ext>
                </a:extLst>
              </p:cNvPr>
              <p:cNvSpPr txBox="1"/>
              <p:nvPr/>
            </p:nvSpPr>
            <p:spPr>
              <a:xfrm>
                <a:off x="2714380" y="1538776"/>
                <a:ext cx="478016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SE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SE" sz="70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r>
                  <a:rPr lang="sv-SE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SE" sz="700">
                    <a:latin typeface="Arial" panose="020B0604020202020204" pitchFamily="34" charset="0"/>
                    <a:cs typeface="Arial" panose="020B0604020202020204" pitchFamily="34" charset="0"/>
                  </a:rPr>
                  <a:t>’</a:t>
                </a:r>
                <a:endParaRPr lang="en-CH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3CFD459A-3A61-882F-CC7E-273C4A452B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3388" y="1684962"/>
                <a:ext cx="0" cy="25200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0E658779-38D1-0934-248F-1054CAE27E61}"/>
                </a:ext>
              </a:extLst>
            </p:cNvPr>
            <p:cNvGrpSpPr/>
            <p:nvPr/>
          </p:nvGrpSpPr>
          <p:grpSpPr>
            <a:xfrm>
              <a:off x="7654928" y="2430495"/>
              <a:ext cx="478016" cy="398186"/>
              <a:chOff x="2729620" y="1538776"/>
              <a:chExt cx="478016" cy="398186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D0948653-72E5-2758-3CEA-B77E62DF9BBF}"/>
                  </a:ext>
                </a:extLst>
              </p:cNvPr>
              <p:cNvSpPr txBox="1"/>
              <p:nvPr/>
            </p:nvSpPr>
            <p:spPr>
              <a:xfrm>
                <a:off x="2729620" y="1538776"/>
                <a:ext cx="478016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SE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SE" sz="70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SE" sz="700">
                    <a:latin typeface="Arial" panose="020B0604020202020204" pitchFamily="34" charset="0"/>
                    <a:cs typeface="Arial" panose="020B0604020202020204" pitchFamily="34" charset="0"/>
                  </a:rPr>
                  <a:t>’</a:t>
                </a:r>
                <a:endParaRPr lang="en-CH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92A94BC0-65F6-F1D7-32E4-055E064574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68628" y="1684962"/>
                <a:ext cx="0" cy="25200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6D59C22C-BCA0-7796-E5CB-19A49D787342}"/>
                </a:ext>
              </a:extLst>
            </p:cNvPr>
            <p:cNvSpPr/>
            <p:nvPr/>
          </p:nvSpPr>
          <p:spPr>
            <a:xfrm>
              <a:off x="4594408" y="2635309"/>
              <a:ext cx="420460" cy="14130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A</a:t>
              </a:r>
              <a:endParaRPr lang="en-CH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0DBD5D8-1F3B-CF17-ADCB-93B6BCC9E09C}"/>
                </a:ext>
              </a:extLst>
            </p:cNvPr>
            <p:cNvGrpSpPr/>
            <p:nvPr/>
          </p:nvGrpSpPr>
          <p:grpSpPr>
            <a:xfrm>
              <a:off x="2927998" y="1842027"/>
              <a:ext cx="4073134" cy="592717"/>
              <a:chOff x="1521071" y="1519724"/>
              <a:chExt cx="4073134" cy="592717"/>
            </a:xfrm>
          </p:grpSpPr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82552D37-7A16-599E-C6D7-5CBF50F58002}"/>
                  </a:ext>
                </a:extLst>
              </p:cNvPr>
              <p:cNvSpPr/>
              <p:nvPr/>
            </p:nvSpPr>
            <p:spPr>
              <a:xfrm>
                <a:off x="3002430" y="1724391"/>
                <a:ext cx="1111231" cy="141301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CH" sz="900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de-CH" sz="9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DS</a:t>
                </a:r>
                <a:endParaRPr lang="en-CH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0F6595B4-D17B-289C-F303-E40220267C84}"/>
                  </a:ext>
                </a:extLst>
              </p:cNvPr>
              <p:cNvSpPr/>
              <p:nvPr/>
            </p:nvSpPr>
            <p:spPr>
              <a:xfrm>
                <a:off x="1521071" y="1724391"/>
                <a:ext cx="1481359" cy="14130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’ 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lang="en-CH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4F1C51E4-2890-34C2-121A-80D4DFDF17E5}"/>
                  </a:ext>
                </a:extLst>
              </p:cNvPr>
              <p:cNvSpPr/>
              <p:nvPr/>
            </p:nvSpPr>
            <p:spPr>
              <a:xfrm>
                <a:off x="4112846" y="1724391"/>
                <a:ext cx="1481359" cy="14130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 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lang="en-CH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066CC56A-C389-F707-A908-A84BAC78D7D5}"/>
                  </a:ext>
                </a:extLst>
              </p:cNvPr>
              <p:cNvGrpSpPr/>
              <p:nvPr/>
            </p:nvGrpSpPr>
            <p:grpSpPr>
              <a:xfrm>
                <a:off x="2729620" y="1519724"/>
                <a:ext cx="478016" cy="398186"/>
                <a:chOff x="2729620" y="1538776"/>
                <a:chExt cx="478016" cy="398186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F0FD5A35-3872-9D2B-72B4-9EA3539CB940}"/>
                    </a:ext>
                  </a:extLst>
                </p:cNvPr>
                <p:cNvSpPr txBox="1"/>
                <p:nvPr/>
              </p:nvSpPr>
              <p:spPr>
                <a:xfrm>
                  <a:off x="2729620" y="1538776"/>
                  <a:ext cx="478016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5’</a:t>
                  </a:r>
                  <a:endParaRPr lang="en-CH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7" name="Straight Connector 56">
                  <a:extLst>
                    <a:ext uri="{FF2B5EF4-FFF2-40B4-BE49-F238E27FC236}">
                      <a16:creationId xmlns:a16="http://schemas.microsoft.com/office/drawing/2014/main" id="{0A878178-A2CA-B42B-7A4A-231A07B983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68628" y="1684962"/>
                  <a:ext cx="0" cy="252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A1388C04-E536-30EA-7B04-5ADAA926C12F}"/>
                  </a:ext>
                </a:extLst>
              </p:cNvPr>
              <p:cNvGrpSpPr/>
              <p:nvPr/>
            </p:nvGrpSpPr>
            <p:grpSpPr>
              <a:xfrm>
                <a:off x="3909491" y="1519724"/>
                <a:ext cx="478016" cy="398186"/>
                <a:chOff x="2729620" y="1538776"/>
                <a:chExt cx="478016" cy="398186"/>
              </a:xfrm>
            </p:grpSpPr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1BD91F70-23F5-8146-F8A2-F89F0E733BF9}"/>
                    </a:ext>
                  </a:extLst>
                </p:cNvPr>
                <p:cNvSpPr txBox="1"/>
                <p:nvPr/>
              </p:nvSpPr>
              <p:spPr>
                <a:xfrm>
                  <a:off x="2729620" y="1538776"/>
                  <a:ext cx="478016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’</a:t>
                  </a:r>
                  <a:endParaRPr lang="en-CH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55BCA5D8-52CE-3DB1-0B44-FEAC237579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68628" y="1684962"/>
                  <a:ext cx="0" cy="252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6234D77E-58A4-3A8E-195F-932DB43E018F}"/>
                  </a:ext>
                </a:extLst>
              </p:cNvPr>
              <p:cNvSpPr txBox="1"/>
              <p:nvPr/>
            </p:nvSpPr>
            <p:spPr>
              <a:xfrm>
                <a:off x="1521071" y="1881609"/>
                <a:ext cx="407313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enomic locus </a:t>
                </a:r>
                <a:r>
                  <a:rPr lang="en-US" sz="900" b="0" i="0" dirty="0">
                    <a:solidFill>
                      <a:srgbClr val="21212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0q21.3–22.1</a:t>
                </a:r>
                <a:endParaRPr lang="en-CH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C23A6540-0691-0C2C-BA4C-9F74EFA3848F}"/>
                </a:ext>
              </a:extLst>
            </p:cNvPr>
            <p:cNvSpPr txBox="1"/>
            <p:nvPr/>
          </p:nvSpPr>
          <p:spPr>
            <a:xfrm>
              <a:off x="2565125" y="166773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E042A3AA-122B-AE6A-EC1D-C7F01AD34F1B}"/>
                </a:ext>
              </a:extLst>
            </p:cNvPr>
            <p:cNvGrpSpPr/>
            <p:nvPr/>
          </p:nvGrpSpPr>
          <p:grpSpPr>
            <a:xfrm>
              <a:off x="2482678" y="3504693"/>
              <a:ext cx="4940645" cy="1648380"/>
              <a:chOff x="2482678" y="3504693"/>
              <a:chExt cx="4940645" cy="1648380"/>
            </a:xfrm>
          </p:grpSpPr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D2D15546-C824-4A66-9909-F30FB6427172}"/>
                  </a:ext>
                </a:extLst>
              </p:cNvPr>
              <p:cNvSpPr txBox="1"/>
              <p:nvPr/>
            </p:nvSpPr>
            <p:spPr>
              <a:xfrm>
                <a:off x="2590792" y="4953018"/>
                <a:ext cx="4694022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SE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SE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7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mini plasmid donor</a:t>
                </a:r>
                <a:endParaRPr lang="en-CH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4" name="Group 113">
                <a:extLst>
                  <a:ext uri="{FF2B5EF4-FFF2-40B4-BE49-F238E27FC236}">
                    <a16:creationId xmlns:a16="http://schemas.microsoft.com/office/drawing/2014/main" id="{068A6760-0611-D61D-CE85-39E13CEE1BEE}"/>
                  </a:ext>
                </a:extLst>
              </p:cNvPr>
              <p:cNvGrpSpPr/>
              <p:nvPr/>
            </p:nvGrpSpPr>
            <p:grpSpPr>
              <a:xfrm>
                <a:off x="2482678" y="3678143"/>
                <a:ext cx="4940645" cy="1254545"/>
                <a:chOff x="2465066" y="3322888"/>
                <a:chExt cx="4940645" cy="1254545"/>
              </a:xfrm>
            </p:grpSpPr>
            <p:cxnSp>
              <p:nvCxnSpPr>
                <p:cNvPr id="79" name="Straight Connector 78">
                  <a:extLst>
                    <a:ext uri="{FF2B5EF4-FFF2-40B4-BE49-F238E27FC236}">
                      <a16:creationId xmlns:a16="http://schemas.microsoft.com/office/drawing/2014/main" id="{3ED50248-0C35-0E48-9F83-F9690D6437D7}"/>
                    </a:ext>
                  </a:extLst>
                </p:cNvPr>
                <p:cNvCxnSpPr>
                  <a:cxnSpLocks/>
                  <a:stCxn id="97" idx="0"/>
                  <a:endCxn id="84" idx="2"/>
                </p:cNvCxnSpPr>
                <p:nvPr/>
              </p:nvCxnSpPr>
              <p:spPr>
                <a:xfrm flipV="1">
                  <a:off x="3485933" y="3668856"/>
                  <a:ext cx="155608" cy="44995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888D2405-8C7D-875B-A27B-4634F3F175E6}"/>
                    </a:ext>
                  </a:extLst>
                </p:cNvPr>
                <p:cNvCxnSpPr>
                  <a:cxnSpLocks/>
                  <a:stCxn id="98" idx="0"/>
                  <a:endCxn id="85" idx="2"/>
                </p:cNvCxnSpPr>
                <p:nvPr/>
              </p:nvCxnSpPr>
              <p:spPr>
                <a:xfrm flipH="1" flipV="1">
                  <a:off x="6233316" y="3668856"/>
                  <a:ext cx="166177" cy="44995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5" name="Rectangle 94">
                  <a:extLst>
                    <a:ext uri="{FF2B5EF4-FFF2-40B4-BE49-F238E27FC236}">
                      <a16:creationId xmlns:a16="http://schemas.microsoft.com/office/drawing/2014/main" id="{C35B06C4-497B-DCCF-B1A6-119E2D8801B2}"/>
                    </a:ext>
                  </a:extLst>
                </p:cNvPr>
                <p:cNvSpPr/>
                <p:nvPr/>
              </p:nvSpPr>
              <p:spPr>
                <a:xfrm>
                  <a:off x="2590792" y="4180110"/>
                  <a:ext cx="4694022" cy="397323"/>
                </a:xfrm>
                <a:prstGeom prst="rect">
                  <a:avLst/>
                </a:pr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H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Rectangle 96">
                  <a:extLst>
                    <a:ext uri="{FF2B5EF4-FFF2-40B4-BE49-F238E27FC236}">
                      <a16:creationId xmlns:a16="http://schemas.microsoft.com/office/drawing/2014/main" id="{A57E45CA-260B-4FB4-5357-81BCC4D79C37}"/>
                    </a:ext>
                  </a:extLst>
                </p:cNvPr>
                <p:cNvSpPr/>
                <p:nvPr/>
              </p:nvSpPr>
              <p:spPr>
                <a:xfrm>
                  <a:off x="2745253" y="4118814"/>
                  <a:ext cx="1481359" cy="141301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SE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5’</a:t>
                  </a:r>
                  <a:r>
                    <a:rPr lang="sv-S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HA</a:t>
                  </a:r>
                  <a:endParaRPr lang="en-CH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Rectangle 97">
                  <a:extLst>
                    <a:ext uri="{FF2B5EF4-FFF2-40B4-BE49-F238E27FC236}">
                      <a16:creationId xmlns:a16="http://schemas.microsoft.com/office/drawing/2014/main" id="{7E065AD6-6135-5166-DC05-2A6DB83F0923}"/>
                    </a:ext>
                  </a:extLst>
                </p:cNvPr>
                <p:cNvSpPr/>
                <p:nvPr/>
              </p:nvSpPr>
              <p:spPr>
                <a:xfrm>
                  <a:off x="5658813" y="4118814"/>
                  <a:ext cx="1481359" cy="141301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SE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3’</a:t>
                  </a:r>
                  <a:r>
                    <a:rPr lang="sv-S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HA</a:t>
                  </a:r>
                  <a:endParaRPr lang="en-CH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Rectangle 99">
                  <a:extLst>
                    <a:ext uri="{FF2B5EF4-FFF2-40B4-BE49-F238E27FC236}">
                      <a16:creationId xmlns:a16="http://schemas.microsoft.com/office/drawing/2014/main" id="{1DEF95D9-5226-024A-7792-B6233BE9FE85}"/>
                    </a:ext>
                  </a:extLst>
                </p:cNvPr>
                <p:cNvSpPr/>
                <p:nvPr/>
              </p:nvSpPr>
              <p:spPr>
                <a:xfrm>
                  <a:off x="4226318" y="4118814"/>
                  <a:ext cx="1432495" cy="141301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SE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  <a:r>
                    <a:rPr lang="en-SE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reporter</a:t>
                  </a:r>
                  <a:endParaRPr lang="en-CH" sz="9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EE37BC28-9F74-7379-DF34-A254684B4252}"/>
                    </a:ext>
                  </a:extLst>
                </p:cNvPr>
                <p:cNvSpPr txBox="1"/>
                <p:nvPr/>
              </p:nvSpPr>
              <p:spPr>
                <a:xfrm>
                  <a:off x="3022654" y="4267989"/>
                  <a:ext cx="184731" cy="2308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endParaRPr lang="en-CH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3C2C8FC2-E7BA-2370-B2B1-60EBE160364D}"/>
                    </a:ext>
                  </a:extLst>
                </p:cNvPr>
                <p:cNvSpPr txBox="1"/>
                <p:nvPr/>
              </p:nvSpPr>
              <p:spPr>
                <a:xfrm>
                  <a:off x="3895132" y="4268430"/>
                  <a:ext cx="580608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.</a:t>
                  </a:r>
                  <a:endParaRPr lang="en-CH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62F4F341-003D-889F-88E9-4DC9F5B88802}"/>
                    </a:ext>
                  </a:extLst>
                </p:cNvPr>
                <p:cNvSpPr txBox="1"/>
                <p:nvPr/>
              </p:nvSpPr>
              <p:spPr>
                <a:xfrm>
                  <a:off x="5413656" y="4268430"/>
                  <a:ext cx="580608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.</a:t>
                  </a:r>
                  <a:endParaRPr lang="en-CH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Rectangle 104">
                  <a:extLst>
                    <a:ext uri="{FF2B5EF4-FFF2-40B4-BE49-F238E27FC236}">
                      <a16:creationId xmlns:a16="http://schemas.microsoft.com/office/drawing/2014/main" id="{BD8E0896-0775-A2DB-F8FD-1EFBF7462E3A}"/>
                    </a:ext>
                  </a:extLst>
                </p:cNvPr>
                <p:cNvSpPr/>
                <p:nvPr/>
              </p:nvSpPr>
              <p:spPr>
                <a:xfrm>
                  <a:off x="4173167" y="4118814"/>
                  <a:ext cx="18000" cy="141301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H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Rectangle 105">
                  <a:extLst>
                    <a:ext uri="{FF2B5EF4-FFF2-40B4-BE49-F238E27FC236}">
                      <a16:creationId xmlns:a16="http://schemas.microsoft.com/office/drawing/2014/main" id="{14002F9F-330E-DAA1-434E-35D98261B414}"/>
                    </a:ext>
                  </a:extLst>
                </p:cNvPr>
                <p:cNvSpPr/>
                <p:nvPr/>
              </p:nvSpPr>
              <p:spPr>
                <a:xfrm>
                  <a:off x="5694158" y="4119345"/>
                  <a:ext cx="18000" cy="141301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H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07" name="Group 106">
                  <a:extLst>
                    <a:ext uri="{FF2B5EF4-FFF2-40B4-BE49-F238E27FC236}">
                      <a16:creationId xmlns:a16="http://schemas.microsoft.com/office/drawing/2014/main" id="{8C8584B4-74E0-E14B-FBC5-6AABC0BC5053}"/>
                    </a:ext>
                  </a:extLst>
                </p:cNvPr>
                <p:cNvGrpSpPr/>
                <p:nvPr/>
              </p:nvGrpSpPr>
              <p:grpSpPr>
                <a:xfrm>
                  <a:off x="2465066" y="3911356"/>
                  <a:ext cx="478016" cy="398186"/>
                  <a:chOff x="4133623" y="1538776"/>
                  <a:chExt cx="478016" cy="398186"/>
                </a:xfrm>
              </p:grpSpPr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3A2BAE54-6FA8-B35A-A65A-51B7814FC16E}"/>
                      </a:ext>
                    </a:extLst>
                  </p:cNvPr>
                  <p:cNvSpPr txBox="1"/>
                  <p:nvPr/>
                </p:nvSpPr>
                <p:spPr>
                  <a:xfrm>
                    <a:off x="4133623" y="1538776"/>
                    <a:ext cx="478016" cy="20005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</a:t>
                    </a:r>
                    <a:r>
                      <a:rPr lang="en-SE" sz="7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sv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  <a:r>
                      <a:rPr lang="en-SE" sz="7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’</a:t>
                    </a:r>
                    <a:endParaRPr lang="en-CH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12" name="Straight Connector 111">
                    <a:extLst>
                      <a:ext uri="{FF2B5EF4-FFF2-40B4-BE49-F238E27FC236}">
                        <a16:creationId xmlns:a16="http://schemas.microsoft.com/office/drawing/2014/main" id="{29622593-0FBC-631F-6B55-49EC168BD1A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372631" y="1684962"/>
                    <a:ext cx="0" cy="252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08" name="Group 107">
                  <a:extLst>
                    <a:ext uri="{FF2B5EF4-FFF2-40B4-BE49-F238E27FC236}">
                      <a16:creationId xmlns:a16="http://schemas.microsoft.com/office/drawing/2014/main" id="{2463F0CD-1A1C-5DAB-BC06-65696270356E}"/>
                    </a:ext>
                  </a:extLst>
                </p:cNvPr>
                <p:cNvGrpSpPr/>
                <p:nvPr/>
              </p:nvGrpSpPr>
              <p:grpSpPr>
                <a:xfrm>
                  <a:off x="6927695" y="3911356"/>
                  <a:ext cx="478016" cy="398186"/>
                  <a:chOff x="2729620" y="1538776"/>
                  <a:chExt cx="478016" cy="398186"/>
                </a:xfrm>
              </p:grpSpPr>
              <p:sp>
                <p:nvSpPr>
                  <p:cNvPr id="109" name="TextBox 108">
                    <a:extLst>
                      <a:ext uri="{FF2B5EF4-FFF2-40B4-BE49-F238E27FC236}">
                        <a16:creationId xmlns:a16="http://schemas.microsoft.com/office/drawing/2014/main" id="{1F6F098B-A307-AB5C-423B-69D6AC3D08F1}"/>
                      </a:ext>
                    </a:extLst>
                  </p:cNvPr>
                  <p:cNvSpPr txBox="1"/>
                  <p:nvPr/>
                </p:nvSpPr>
                <p:spPr>
                  <a:xfrm>
                    <a:off x="2729620" y="1538776"/>
                    <a:ext cx="478016" cy="20005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</a:t>
                    </a:r>
                    <a:r>
                      <a:rPr lang="en-SE" sz="7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  <a:r>
                      <a:rPr lang="en-SE" sz="7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’</a:t>
                    </a:r>
                    <a:endParaRPr lang="en-CH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10" name="Straight Connector 109">
                    <a:extLst>
                      <a:ext uri="{FF2B5EF4-FFF2-40B4-BE49-F238E27FC236}">
                        <a16:creationId xmlns:a16="http://schemas.microsoft.com/office/drawing/2014/main" id="{52EF399B-BF04-A689-76F9-2510273E3A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968628" y="1684962"/>
                    <a:ext cx="0" cy="252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3" name="Rectangle 82">
                  <a:extLst>
                    <a:ext uri="{FF2B5EF4-FFF2-40B4-BE49-F238E27FC236}">
                      <a16:creationId xmlns:a16="http://schemas.microsoft.com/office/drawing/2014/main" id="{FA1A0010-44FF-22F5-2069-B68DF0CAB27C}"/>
                    </a:ext>
                  </a:extLst>
                </p:cNvPr>
                <p:cNvSpPr/>
                <p:nvPr/>
              </p:nvSpPr>
              <p:spPr>
                <a:xfrm>
                  <a:off x="4382220" y="3527555"/>
                  <a:ext cx="1111231" cy="141301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de-CH" sz="900" b="1" i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TOH7</a:t>
                  </a:r>
                  <a:r>
                    <a:rPr lang="de-CH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CDS</a:t>
                  </a:r>
                  <a:endParaRPr lang="en-CH" sz="9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Rectangle 83">
                  <a:extLst>
                    <a:ext uri="{FF2B5EF4-FFF2-40B4-BE49-F238E27FC236}">
                      <a16:creationId xmlns:a16="http://schemas.microsoft.com/office/drawing/2014/main" id="{7AC1B04D-A612-5C7B-22CA-F6DDA12947B1}"/>
                    </a:ext>
                  </a:extLst>
                </p:cNvPr>
                <p:cNvSpPr/>
                <p:nvPr/>
              </p:nvSpPr>
              <p:spPr>
                <a:xfrm>
                  <a:off x="2900861" y="3527555"/>
                  <a:ext cx="1481359" cy="141301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S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’ 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</a:t>
                  </a:r>
                  <a:r>
                    <a:rPr lang="en-S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endParaRPr lang="en-CH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Rectangle 84">
                  <a:extLst>
                    <a:ext uri="{FF2B5EF4-FFF2-40B4-BE49-F238E27FC236}">
                      <a16:creationId xmlns:a16="http://schemas.microsoft.com/office/drawing/2014/main" id="{8EA29097-2FED-7000-8028-88030DDCA5F8}"/>
                    </a:ext>
                  </a:extLst>
                </p:cNvPr>
                <p:cNvSpPr/>
                <p:nvPr/>
              </p:nvSpPr>
              <p:spPr>
                <a:xfrm>
                  <a:off x="5492636" y="3527555"/>
                  <a:ext cx="1481359" cy="141301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S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’ 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</a:t>
                  </a:r>
                  <a:r>
                    <a:rPr lang="en-S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endParaRPr lang="en-CH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86" name="Group 85">
                  <a:extLst>
                    <a:ext uri="{FF2B5EF4-FFF2-40B4-BE49-F238E27FC236}">
                      <a16:creationId xmlns:a16="http://schemas.microsoft.com/office/drawing/2014/main" id="{3AC98AAD-7D2F-6B63-303A-AF7E8ADBE54C}"/>
                    </a:ext>
                  </a:extLst>
                </p:cNvPr>
                <p:cNvGrpSpPr/>
                <p:nvPr/>
              </p:nvGrpSpPr>
              <p:grpSpPr>
                <a:xfrm>
                  <a:off x="4109410" y="3322888"/>
                  <a:ext cx="478016" cy="398186"/>
                  <a:chOff x="2729620" y="1538776"/>
                  <a:chExt cx="478016" cy="398186"/>
                </a:xfrm>
              </p:grpSpPr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6D918334-69BA-9CC2-710B-FB400EE26DCC}"/>
                      </a:ext>
                    </a:extLst>
                  </p:cNvPr>
                  <p:cNvSpPr txBox="1"/>
                  <p:nvPr/>
                </p:nvSpPr>
                <p:spPr>
                  <a:xfrm>
                    <a:off x="2729620" y="1538776"/>
                    <a:ext cx="478016" cy="20005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5’</a:t>
                    </a:r>
                    <a:endParaRPr lang="en-CH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92" name="Straight Connector 91">
                    <a:extLst>
                      <a:ext uri="{FF2B5EF4-FFF2-40B4-BE49-F238E27FC236}">
                        <a16:creationId xmlns:a16="http://schemas.microsoft.com/office/drawing/2014/main" id="{7EF85ED9-900C-459F-1A99-5C1EEBED7A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968628" y="1684962"/>
                    <a:ext cx="0" cy="252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7" name="Group 86">
                  <a:extLst>
                    <a:ext uri="{FF2B5EF4-FFF2-40B4-BE49-F238E27FC236}">
                      <a16:creationId xmlns:a16="http://schemas.microsoft.com/office/drawing/2014/main" id="{54EEB3F4-47D9-6EBC-315D-9D7C8CA21C7C}"/>
                    </a:ext>
                  </a:extLst>
                </p:cNvPr>
                <p:cNvGrpSpPr/>
                <p:nvPr/>
              </p:nvGrpSpPr>
              <p:grpSpPr>
                <a:xfrm>
                  <a:off x="5289281" y="3322888"/>
                  <a:ext cx="478016" cy="398186"/>
                  <a:chOff x="2729620" y="1538776"/>
                  <a:chExt cx="478016" cy="398186"/>
                </a:xfrm>
              </p:grpSpPr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69001BF9-9F1C-EC8F-1338-2328E02ADFE7}"/>
                      </a:ext>
                    </a:extLst>
                  </p:cNvPr>
                  <p:cNvSpPr txBox="1"/>
                  <p:nvPr/>
                </p:nvSpPr>
                <p:spPr>
                  <a:xfrm>
                    <a:off x="2729620" y="1538776"/>
                    <a:ext cx="478016" cy="20005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’</a:t>
                    </a:r>
                    <a:endParaRPr lang="en-CH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90" name="Straight Connector 89">
                    <a:extLst>
                      <a:ext uri="{FF2B5EF4-FFF2-40B4-BE49-F238E27FC236}">
                        <a16:creationId xmlns:a16="http://schemas.microsoft.com/office/drawing/2014/main" id="{E30E4E37-81B6-5507-17CE-26449A85718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968628" y="1684962"/>
                    <a:ext cx="0" cy="252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FEB7B303-450D-7368-4C86-62B56F763A7D}"/>
                    </a:ext>
                  </a:extLst>
                </p:cNvPr>
                <p:cNvSpPr txBox="1"/>
                <p:nvPr/>
              </p:nvSpPr>
              <p:spPr>
                <a:xfrm>
                  <a:off x="2900861" y="3684773"/>
                  <a:ext cx="4073134" cy="2308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enomic locus </a:t>
                  </a:r>
                  <a:r>
                    <a:rPr lang="en-US" sz="900" b="0" i="0" dirty="0">
                      <a:solidFill>
                        <a:srgbClr val="212121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10q21.3–22.1</a:t>
                  </a:r>
                  <a:endParaRPr lang="en-CH" sz="9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F222D276-028F-0414-093C-8A3A55CCF15F}"/>
                  </a:ext>
                </a:extLst>
              </p:cNvPr>
              <p:cNvSpPr txBox="1"/>
              <p:nvPr/>
            </p:nvSpPr>
            <p:spPr>
              <a:xfrm>
                <a:off x="2565125" y="3504693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6A00E193-C6D2-A126-4883-43FDEB75903E}"/>
                </a:ext>
              </a:extLst>
            </p:cNvPr>
            <p:cNvGrpSpPr/>
            <p:nvPr/>
          </p:nvGrpSpPr>
          <p:grpSpPr>
            <a:xfrm>
              <a:off x="2916433" y="888117"/>
              <a:ext cx="4073134" cy="592717"/>
              <a:chOff x="1521071" y="1519724"/>
              <a:chExt cx="4073134" cy="592717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4670C493-5925-B52D-4934-906E7AE58F99}"/>
                  </a:ext>
                </a:extLst>
              </p:cNvPr>
              <p:cNvSpPr/>
              <p:nvPr/>
            </p:nvSpPr>
            <p:spPr>
              <a:xfrm>
                <a:off x="3002430" y="1724391"/>
                <a:ext cx="1111231" cy="141301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CH" sz="900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de-CH" sz="9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DS</a:t>
                </a:r>
                <a:endParaRPr lang="en-CH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8B325456-5DBC-B5C8-501E-1CD5859C848F}"/>
                  </a:ext>
                </a:extLst>
              </p:cNvPr>
              <p:cNvSpPr/>
              <p:nvPr/>
            </p:nvSpPr>
            <p:spPr>
              <a:xfrm>
                <a:off x="1521071" y="1724391"/>
                <a:ext cx="1481359" cy="14130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’ 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lang="en-CH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DE2B7DA3-5D48-D06B-C721-F235EB08E2E0}"/>
                  </a:ext>
                </a:extLst>
              </p:cNvPr>
              <p:cNvSpPr/>
              <p:nvPr/>
            </p:nvSpPr>
            <p:spPr>
              <a:xfrm>
                <a:off x="4112846" y="1724391"/>
                <a:ext cx="1481359" cy="14130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 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S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lang="en-CH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414762B8-B039-1544-EEAF-7BF2CB818DBF}"/>
                  </a:ext>
                </a:extLst>
              </p:cNvPr>
              <p:cNvGrpSpPr/>
              <p:nvPr/>
            </p:nvGrpSpPr>
            <p:grpSpPr>
              <a:xfrm>
                <a:off x="2729620" y="1519724"/>
                <a:ext cx="478016" cy="398186"/>
                <a:chOff x="2729620" y="1538776"/>
                <a:chExt cx="478016" cy="398186"/>
              </a:xfrm>
            </p:grpSpPr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8915AA22-1BEB-76AE-4C1A-22298769ECAD}"/>
                    </a:ext>
                  </a:extLst>
                </p:cNvPr>
                <p:cNvSpPr txBox="1"/>
                <p:nvPr/>
              </p:nvSpPr>
              <p:spPr>
                <a:xfrm>
                  <a:off x="2729620" y="1538776"/>
                  <a:ext cx="478016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5’</a:t>
                  </a:r>
                  <a:endParaRPr lang="en-CH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A9A10374-ABA0-E04B-7555-82ED7AC5DC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68628" y="1684962"/>
                  <a:ext cx="0" cy="252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FC2DCBC0-C88E-80A7-E400-CC80F06BF199}"/>
                  </a:ext>
                </a:extLst>
              </p:cNvPr>
              <p:cNvGrpSpPr/>
              <p:nvPr/>
            </p:nvGrpSpPr>
            <p:grpSpPr>
              <a:xfrm>
                <a:off x="3909491" y="1519724"/>
                <a:ext cx="478016" cy="398186"/>
                <a:chOff x="2729620" y="1538776"/>
                <a:chExt cx="478016" cy="398186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EFCDF764-EE50-0A30-A4F6-A3979811BF00}"/>
                    </a:ext>
                  </a:extLst>
                </p:cNvPr>
                <p:cNvSpPr txBox="1"/>
                <p:nvPr/>
              </p:nvSpPr>
              <p:spPr>
                <a:xfrm>
                  <a:off x="2729620" y="1538776"/>
                  <a:ext cx="478016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r>
                    <a:rPr lang="en-SE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’</a:t>
                  </a:r>
                  <a:endParaRPr lang="en-CH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CAB50307-A2C4-DC34-F5B7-12899B21BC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68628" y="1684962"/>
                  <a:ext cx="0" cy="252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219FE87-6D58-FA91-C210-D28E9D109550}"/>
                  </a:ext>
                </a:extLst>
              </p:cNvPr>
              <p:cNvSpPr txBox="1"/>
              <p:nvPr/>
            </p:nvSpPr>
            <p:spPr>
              <a:xfrm>
                <a:off x="1521071" y="1881609"/>
                <a:ext cx="407313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enomic locus </a:t>
                </a:r>
                <a:r>
                  <a:rPr lang="en-US" sz="900" b="0" i="0" dirty="0">
                    <a:solidFill>
                      <a:srgbClr val="21212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0q21.3–22.1</a:t>
                </a:r>
                <a:endParaRPr lang="en-CH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12EDB48E-9446-92E7-F927-A687EE7B6943}"/>
                </a:ext>
              </a:extLst>
            </p:cNvPr>
            <p:cNvSpPr txBox="1"/>
            <p:nvPr/>
          </p:nvSpPr>
          <p:spPr>
            <a:xfrm>
              <a:off x="2565125" y="71198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9A1F111A-1876-A920-3807-BC3BDE92E321}"/>
                </a:ext>
              </a:extLst>
            </p:cNvPr>
            <p:cNvSpPr/>
            <p:nvPr/>
          </p:nvSpPr>
          <p:spPr>
            <a:xfrm>
              <a:off x="3427444" y="2637953"/>
              <a:ext cx="1111231" cy="14130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CH" sz="9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de-CH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DS</a:t>
              </a:r>
              <a:endParaRPr lang="en-CH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0C61328F-7260-D39D-D9CF-408177C40B9D}"/>
                </a:ext>
              </a:extLst>
            </p:cNvPr>
            <p:cNvSpPr/>
            <p:nvPr/>
          </p:nvSpPr>
          <p:spPr>
            <a:xfrm>
              <a:off x="4538675" y="2637953"/>
              <a:ext cx="109525" cy="14130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H" sz="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F19D5F4E-9A15-0948-AEFC-32D14BFE82FB}"/>
                </a:ext>
              </a:extLst>
            </p:cNvPr>
            <p:cNvSpPr/>
            <p:nvPr/>
          </p:nvSpPr>
          <p:spPr>
            <a:xfrm>
              <a:off x="4545651" y="2635309"/>
              <a:ext cx="94070" cy="14130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en-CH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386167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DDEAF005-204E-1C49-6E71-67C321636F42}"/>
              </a:ext>
            </a:extLst>
          </p:cNvPr>
          <p:cNvSpPr txBox="1"/>
          <p:nvPr/>
        </p:nvSpPr>
        <p:spPr>
          <a:xfrm rot="18773272">
            <a:off x="4197571" y="149044"/>
            <a:ext cx="862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352085E-40FE-BD5C-D846-49210977E351}"/>
              </a:ext>
            </a:extLst>
          </p:cNvPr>
          <p:cNvSpPr txBox="1"/>
          <p:nvPr/>
        </p:nvSpPr>
        <p:spPr>
          <a:xfrm rot="18773272">
            <a:off x="4374739" y="173771"/>
            <a:ext cx="775375" cy="233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F83D346-309B-E576-E1A6-537ABBF5C3D4}"/>
              </a:ext>
            </a:extLst>
          </p:cNvPr>
          <p:cNvSpPr txBox="1"/>
          <p:nvPr/>
        </p:nvSpPr>
        <p:spPr>
          <a:xfrm rot="18773272">
            <a:off x="4526500" y="172838"/>
            <a:ext cx="775375" cy="233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791706" y="6807"/>
            <a:ext cx="8188430" cy="6890822"/>
            <a:chOff x="791706" y="6807"/>
            <a:chExt cx="8188430" cy="6890822"/>
          </a:xfrm>
        </p:grpSpPr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ED32830F-0A3F-0CA2-D159-0597542890D3}"/>
                </a:ext>
              </a:extLst>
            </p:cNvPr>
            <p:cNvSpPr txBox="1"/>
            <p:nvPr/>
          </p:nvSpPr>
          <p:spPr>
            <a:xfrm>
              <a:off x="791706" y="5820411"/>
              <a:ext cx="8188430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9. Top cell type-specific marker genes in retinal organoids.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Entire WT week-7 retinal organoids were analyzed by hybridization-based PFA-fixed scRNA-seq and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positive (</a:t>
              </a:r>
              <a:r>
                <a:rPr lang="en-US" sz="800" b="1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b="1" i="1" baseline="300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+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 cells were selected for downstream analysis. The representative cell type-specific clusters are defined as naïve retinal progenitor cells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nRP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transient retinal progenitor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tRP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early retinal ganglion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early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RG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late retinal ganglion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late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RG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horizontal and amacrine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H&amp;A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and photoreceptor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PR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. A) Heatmaps representing raw expression of identified marker genes amongst cell clusters, as well as differential expression between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and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-GFP</a:t>
              </a:r>
              <a:r>
                <a:rPr lang="en-US" sz="800" i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cells, based</a:t>
              </a:r>
              <a:r>
                <a:rPr lang="en-US" sz="800" i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reporter-enriched mRNA-seq, and number of annotated ATOH7 binding loci identified by CUT&amp;RUN-seq, where the annotation is defined as either enhancer (&gt;5kb from TSS) or promoter (±5kb from TSS).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B)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UMAPs representing selected genes in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positive cells.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UT&amp;RUN-seq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leavage under targets and release using nuclease sequenc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EG</a:t>
              </a:r>
              <a:r>
                <a:rPr lang="en-CH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differentially expressed gene</a:t>
              </a:r>
              <a:r>
                <a:rPr lang="en-CH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 between MUT-GFP and 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NT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integrated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PFA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paraformaldehyde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scRNA-seq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single-cell RNA sequenc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S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transcription start site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UMAP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uniform manifold approximation and projection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wildtype.</a:t>
              </a: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791706" y="6807"/>
              <a:ext cx="8120741" cy="5741455"/>
              <a:chOff x="791706" y="6807"/>
              <a:chExt cx="8120741" cy="5741455"/>
            </a:xfrm>
          </p:grpSpPr>
          <p:pic>
            <p:nvPicPr>
              <p:cNvPr id="142" name="Picture 141" descr="A colorful dots on a black background&#10;&#10;Description automatically generated">
                <a:extLst>
                  <a:ext uri="{FF2B5EF4-FFF2-40B4-BE49-F238E27FC236}">
                    <a16:creationId xmlns:a16="http://schemas.microsoft.com/office/drawing/2014/main" id="{32259CBD-73E1-3AE9-D622-A53F0828A9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27651" y="3322870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44" name="Picture 143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816F8D53-3C01-275E-54A1-2995000EC2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27651" y="2342280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46" name="Picture 145" descr="A colorful dots on a black background&#10;&#10;Description automatically generated">
                <a:extLst>
                  <a:ext uri="{FF2B5EF4-FFF2-40B4-BE49-F238E27FC236}">
                    <a16:creationId xmlns:a16="http://schemas.microsoft.com/office/drawing/2014/main" id="{110EE970-2675-8923-FFA8-3849F9B646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27651" y="1356451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48" name="Picture 147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F86D8CDC-A360-618B-7FB3-DCDAD8B870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27651" y="375317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52" name="Picture 151" descr="A colorful dots on a black background&#10;&#10;Description automatically generated">
                <a:extLst>
                  <a:ext uri="{FF2B5EF4-FFF2-40B4-BE49-F238E27FC236}">
                    <a16:creationId xmlns:a16="http://schemas.microsoft.com/office/drawing/2014/main" id="{D3E89EA7-12DC-CD58-A0C2-E63469B3F7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hq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14667" y="3322870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54" name="Picture 153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0EE2506C-24C2-5319-5B7E-6D01193595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14667" y="2342280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56" name="Picture 155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9EAA117D-E848-E431-E258-4C88E0611B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hq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14667" y="375317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58" name="Picture 157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0DBBFC54-A953-BD58-8D94-62D21EC9EB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hq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918320" y="3322870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60" name="Picture 159" descr="A colorful dots on a black background&#10;&#10;Description automatically generated">
                <a:extLst>
                  <a:ext uri="{FF2B5EF4-FFF2-40B4-BE49-F238E27FC236}">
                    <a16:creationId xmlns:a16="http://schemas.microsoft.com/office/drawing/2014/main" id="{19F47DBF-2167-D55E-2F2D-9BEEE0EAC7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hq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918320" y="2342280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62" name="Picture 161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9408BFEE-08EB-DCA4-D25A-C868EA6954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hq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918320" y="1356451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64" name="Picture 163" descr="A colorful dots on a black background&#10;&#10;Description automatically generated">
                <a:extLst>
                  <a:ext uri="{FF2B5EF4-FFF2-40B4-BE49-F238E27FC236}">
                    <a16:creationId xmlns:a16="http://schemas.microsoft.com/office/drawing/2014/main" id="{F6394DE1-F634-5E3C-78CB-9E576475C6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hq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918320" y="375317"/>
                <a:ext cx="997780" cy="990000"/>
              </a:xfrm>
              <a:prstGeom prst="rect">
                <a:avLst/>
              </a:prstGeom>
            </p:spPr>
          </p:pic>
          <p:pic>
            <p:nvPicPr>
              <p:cNvPr id="166" name="Picture 165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0F3F39AC-52C7-F72B-C610-2C280D4809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hq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35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14667" y="1356451"/>
                <a:ext cx="997780" cy="990000"/>
              </a:xfrm>
              <a:prstGeom prst="rect">
                <a:avLst/>
              </a:prstGeom>
            </p:spPr>
          </p:pic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23D7B022-05CD-5D06-B85B-D7936E62C736}"/>
                  </a:ext>
                </a:extLst>
              </p:cNvPr>
              <p:cNvGrpSpPr/>
              <p:nvPr/>
            </p:nvGrpSpPr>
            <p:grpSpPr>
              <a:xfrm rot="16200000">
                <a:off x="4500081" y="2727798"/>
                <a:ext cx="1123951" cy="527691"/>
                <a:chOff x="1626216" y="5768551"/>
                <a:chExt cx="1123951" cy="527691"/>
              </a:xfrm>
            </p:grpSpPr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E8AC3C50-23E9-A002-09AC-838F614F01C0}"/>
                    </a:ext>
                  </a:extLst>
                </p:cNvPr>
                <p:cNvSpPr txBox="1"/>
                <p:nvPr/>
              </p:nvSpPr>
              <p:spPr>
                <a:xfrm>
                  <a:off x="1626216" y="5768551"/>
                  <a:ext cx="112395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fferential Expression (z-score)</a:t>
                  </a: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586E5B12-DA8B-9BBC-6CEE-C4DBCD9789B8}"/>
                    </a:ext>
                  </a:extLst>
                </p:cNvPr>
                <p:cNvSpPr txBox="1"/>
                <p:nvPr/>
              </p:nvSpPr>
              <p:spPr>
                <a:xfrm rot="5400000">
                  <a:off x="2074875" y="6077111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pic>
              <p:nvPicPr>
                <p:cNvPr id="6" name="Picture 5" descr="A picture containing screenshot, text, colorfulness, diagram&#10;&#10;Description automatically generated">
                  <a:extLst>
                    <a:ext uri="{FF2B5EF4-FFF2-40B4-BE49-F238E27FC236}">
                      <a16:creationId xmlns:a16="http://schemas.microsoft.com/office/drawing/2014/main" id="{F81E5E12-B429-59FE-F67D-9B24D11C6AD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6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5400000">
                  <a:off x="2192369" y="5625457"/>
                  <a:ext cx="77339" cy="954966"/>
                </a:xfrm>
                <a:prstGeom prst="rect">
                  <a:avLst/>
                </a:prstGeom>
              </p:spPr>
            </p:pic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21E6E9AE-D9AB-7929-88C9-DE2A801890A0}"/>
                    </a:ext>
                  </a:extLst>
                </p:cNvPr>
                <p:cNvSpPr txBox="1"/>
                <p:nvPr/>
              </p:nvSpPr>
              <p:spPr>
                <a:xfrm rot="5400000">
                  <a:off x="2250056" y="6077111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0B754558-B39D-6778-8D99-04F0855B5A84}"/>
                    </a:ext>
                  </a:extLst>
                </p:cNvPr>
                <p:cNvSpPr txBox="1"/>
                <p:nvPr/>
              </p:nvSpPr>
              <p:spPr>
                <a:xfrm rot="5400000">
                  <a:off x="1887950" y="6077111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0F8EE221-1F4D-45F1-EB57-5A5604E10437}"/>
                    </a:ext>
                  </a:extLst>
                </p:cNvPr>
                <p:cNvSpPr txBox="1"/>
                <p:nvPr/>
              </p:nvSpPr>
              <p:spPr>
                <a:xfrm rot="5400000">
                  <a:off x="1700069" y="6077111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8A85D659-20D1-79BD-313E-A43931F2FE1A}"/>
                    </a:ext>
                  </a:extLst>
                </p:cNvPr>
                <p:cNvSpPr txBox="1"/>
                <p:nvPr/>
              </p:nvSpPr>
              <p:spPr>
                <a:xfrm rot="5400000">
                  <a:off x="2432774" y="6077111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6D09625B-76FD-C46F-89A8-0F7599A5D3E2}"/>
                  </a:ext>
                </a:extLst>
              </p:cNvPr>
              <p:cNvGrpSpPr/>
              <p:nvPr/>
            </p:nvGrpSpPr>
            <p:grpSpPr>
              <a:xfrm rot="16200000">
                <a:off x="4550498" y="1595475"/>
                <a:ext cx="1123951" cy="619142"/>
                <a:chOff x="3465816" y="5141462"/>
                <a:chExt cx="1123951" cy="619142"/>
              </a:xfrm>
            </p:grpSpPr>
            <p:pic>
              <p:nvPicPr>
                <p:cNvPr id="16" name="Picture 15" descr="A picture containing screenshot, colorfulness, purple, violet&#10;&#10;Description automatically generated">
                  <a:extLst>
                    <a:ext uri="{FF2B5EF4-FFF2-40B4-BE49-F238E27FC236}">
                      <a16:creationId xmlns:a16="http://schemas.microsoft.com/office/drawing/2014/main" id="{B435BC51-7344-AA72-1968-CB23AE4B437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665217" y="5439806"/>
                  <a:ext cx="745472" cy="59104"/>
                </a:xfrm>
                <a:prstGeom prst="rect">
                  <a:avLst/>
                </a:prstGeom>
              </p:spPr>
            </p:pic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79099D9F-F7E1-F933-21B4-AC380061C939}"/>
                    </a:ext>
                  </a:extLst>
                </p:cNvPr>
                <p:cNvSpPr txBox="1"/>
                <p:nvPr/>
              </p:nvSpPr>
              <p:spPr>
                <a:xfrm rot="5400000">
                  <a:off x="3861139" y="5500597"/>
                  <a:ext cx="3353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25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DD50AD1F-5D02-5A53-BA46-E42E89AF5F1B}"/>
                    </a:ext>
                  </a:extLst>
                </p:cNvPr>
                <p:cNvSpPr txBox="1"/>
                <p:nvPr/>
              </p:nvSpPr>
              <p:spPr>
                <a:xfrm rot="5400000">
                  <a:off x="3568728" y="5446897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CBCB81DB-D894-D608-75F2-D6EE97BEFF22}"/>
                    </a:ext>
                  </a:extLst>
                </p:cNvPr>
                <p:cNvSpPr txBox="1"/>
                <p:nvPr/>
              </p:nvSpPr>
              <p:spPr>
                <a:xfrm rot="5400000">
                  <a:off x="4260951" y="5478956"/>
                  <a:ext cx="29206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5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CEFFAD54-53A8-91C2-8ACC-3A066317E631}"/>
                    </a:ext>
                  </a:extLst>
                </p:cNvPr>
                <p:cNvSpPr txBox="1"/>
                <p:nvPr/>
              </p:nvSpPr>
              <p:spPr>
                <a:xfrm>
                  <a:off x="3465816" y="5141462"/>
                  <a:ext cx="112395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Type Expression</a:t>
                  </a:r>
                </a:p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Raw expression)</a:t>
                  </a:r>
                </a:p>
              </p:txBody>
            </p:sp>
          </p:grpSp>
          <p:grpSp>
            <p:nvGrpSpPr>
              <p:cNvPr id="94" name="Group 93">
                <a:extLst>
                  <a:ext uri="{FF2B5EF4-FFF2-40B4-BE49-F238E27FC236}">
                    <a16:creationId xmlns:a16="http://schemas.microsoft.com/office/drawing/2014/main" id="{9AE72AEA-0944-FB25-336C-DF915EF456EF}"/>
                  </a:ext>
                </a:extLst>
              </p:cNvPr>
              <p:cNvGrpSpPr/>
              <p:nvPr/>
            </p:nvGrpSpPr>
            <p:grpSpPr>
              <a:xfrm rot="16200000">
                <a:off x="4526309" y="3786259"/>
                <a:ext cx="1051654" cy="511670"/>
                <a:chOff x="2733819" y="5771749"/>
                <a:chExt cx="1051654" cy="511670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A02E996A-8919-9FD1-50AE-F782058F1C41}"/>
                    </a:ext>
                  </a:extLst>
                </p:cNvPr>
                <p:cNvSpPr txBox="1"/>
                <p:nvPr/>
              </p:nvSpPr>
              <p:spPr>
                <a:xfrm>
                  <a:off x="2733819" y="5771749"/>
                  <a:ext cx="10516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CH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inding Sites</a:t>
                  </a:r>
                </a:p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#)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A15CC845-69EE-A7CD-F8F1-9151E5E04EF3}"/>
                    </a:ext>
                  </a:extLst>
                </p:cNvPr>
                <p:cNvSpPr txBox="1"/>
                <p:nvPr/>
              </p:nvSpPr>
              <p:spPr>
                <a:xfrm rot="5400000">
                  <a:off x="2888712" y="6077111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242FBCC5-4F99-14DE-E262-80E1A0EA639F}"/>
                    </a:ext>
                  </a:extLst>
                </p:cNvPr>
                <p:cNvSpPr txBox="1"/>
                <p:nvPr/>
              </p:nvSpPr>
              <p:spPr>
                <a:xfrm rot="5400000">
                  <a:off x="3066275" y="6077111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BACAD859-ED33-CEF4-482F-914C07DA8218}"/>
                    </a:ext>
                  </a:extLst>
                </p:cNvPr>
                <p:cNvSpPr txBox="1"/>
                <p:nvPr/>
              </p:nvSpPr>
              <p:spPr>
                <a:xfrm rot="5400000">
                  <a:off x="3246610" y="6077112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pic>
              <p:nvPicPr>
                <p:cNvPr id="21" name="Picture 20" descr="A picture containing screenshot, colorfulness, text, design&#10;&#10;Description automatically generated">
                  <a:extLst>
                    <a:ext uri="{FF2B5EF4-FFF2-40B4-BE49-F238E27FC236}">
                      <a16:creationId xmlns:a16="http://schemas.microsoft.com/office/drawing/2014/main" id="{3CC7FF14-30C7-CEAA-965D-D95D076850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8" cstate="hq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5400000">
                  <a:off x="3230720" y="5691492"/>
                  <a:ext cx="71577" cy="817484"/>
                </a:xfrm>
                <a:prstGeom prst="rect">
                  <a:avLst/>
                </a:prstGeom>
              </p:spPr>
            </p:pic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17D48E8B-4E2B-437C-B52A-2298727366D4}"/>
                    </a:ext>
                  </a:extLst>
                </p:cNvPr>
                <p:cNvSpPr txBox="1"/>
                <p:nvPr/>
              </p:nvSpPr>
              <p:spPr>
                <a:xfrm rot="5400000">
                  <a:off x="3426554" y="6077111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pic>
            <p:nvPicPr>
              <p:cNvPr id="24" name="Picture 23" descr="A picture containing colorfulness, screenshot, art, design&#10;&#10;Description automatically generated">
                <a:extLst>
                  <a:ext uri="{FF2B5EF4-FFF2-40B4-BE49-F238E27FC236}">
                    <a16:creationId xmlns:a16="http://schemas.microsoft.com/office/drawing/2014/main" id="{631568F1-CF48-87D5-4E0C-922E3C98E9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313873" y="546728"/>
                <a:ext cx="161925" cy="5187831"/>
              </a:xfrm>
              <a:prstGeom prst="rect">
                <a:avLst/>
              </a:prstGeom>
            </p:spPr>
          </p:pic>
          <p:pic>
            <p:nvPicPr>
              <p:cNvPr id="25" name="Picture 24" descr="A picture containing screenshot, colorfulness, text, design&#10;&#10;Description automatically generated">
                <a:extLst>
                  <a:ext uri="{FF2B5EF4-FFF2-40B4-BE49-F238E27FC236}">
                    <a16:creationId xmlns:a16="http://schemas.microsoft.com/office/drawing/2014/main" id="{32C36483-FD2F-EBF0-AE31-E6760DF3DBD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475796" y="551174"/>
                <a:ext cx="321889" cy="5187829"/>
              </a:xfrm>
              <a:prstGeom prst="rect">
                <a:avLst/>
              </a:prstGeom>
            </p:spPr>
          </p:pic>
          <p:pic>
            <p:nvPicPr>
              <p:cNvPr id="26" name="Picture 25" descr="A picture containing screenshot, colorfulness, purple, violet&#10;&#10;Description automatically generated">
                <a:extLst>
                  <a:ext uri="{FF2B5EF4-FFF2-40B4-BE49-F238E27FC236}">
                    <a16:creationId xmlns:a16="http://schemas.microsoft.com/office/drawing/2014/main" id="{EBB2F309-2F18-AD82-DC74-87084839F1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01796" y="330131"/>
                <a:ext cx="3317519" cy="5408874"/>
              </a:xfrm>
              <a:prstGeom prst="rect">
                <a:avLst/>
              </a:prstGeom>
            </p:spPr>
          </p:pic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EB93F7F4-4CFC-A858-7399-3A593D2476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5081" y="339387"/>
                <a:ext cx="0" cy="540887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FCE5902F-B535-D189-BC2E-634247A8D09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51932" y="339387"/>
                <a:ext cx="0" cy="540887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A956B497-1CD8-1B40-E5D1-D0ED873543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59735" y="339387"/>
                <a:ext cx="0" cy="540887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644E5112-D0D4-69DF-D0B8-23160DDBCA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37262" y="339387"/>
                <a:ext cx="0" cy="540887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A153A875-45EA-C001-C047-DEA5FDAE1E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46273" y="339387"/>
                <a:ext cx="0" cy="5408875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03CBA662-565E-39E5-B18C-68F58561F93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27988" y="3140506"/>
                <a:ext cx="323724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C0C519BD-51B7-0174-13EB-623FE336152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27989" y="2274901"/>
                <a:ext cx="323724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D325DF02-56E5-123B-2A07-2F7DFC6DDA2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27988" y="4003515"/>
                <a:ext cx="323724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FE6FE004-8254-F578-E432-91B3835F16B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27987" y="4866155"/>
                <a:ext cx="323724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7F8CC0C5-4FDF-3703-68C7-B5717739864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27992" y="1405773"/>
                <a:ext cx="323724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6AA7B24-59F8-6E35-E1EA-FB7F0ADC5696}"/>
                  </a:ext>
                </a:extLst>
              </p:cNvPr>
              <p:cNvSpPr txBox="1"/>
              <p:nvPr/>
            </p:nvSpPr>
            <p:spPr>
              <a:xfrm>
                <a:off x="791706" y="6807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CH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0F14DBBC-D5EB-7E37-39DF-CB9864205A6A}"/>
                  </a:ext>
                </a:extLst>
              </p:cNvPr>
              <p:cNvSpPr txBox="1"/>
              <p:nvPr/>
            </p:nvSpPr>
            <p:spPr>
              <a:xfrm>
                <a:off x="5541434" y="6807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CH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CH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088DC5E4-6F30-F531-9397-DB23DFDB1F20}"/>
                  </a:ext>
                </a:extLst>
              </p:cNvPr>
              <p:cNvGrpSpPr/>
              <p:nvPr/>
            </p:nvGrpSpPr>
            <p:grpSpPr>
              <a:xfrm>
                <a:off x="4804817" y="406507"/>
                <a:ext cx="755051" cy="973916"/>
                <a:chOff x="6891758" y="1925048"/>
                <a:chExt cx="755051" cy="973916"/>
              </a:xfrm>
            </p:grpSpPr>
            <p:grpSp>
              <p:nvGrpSpPr>
                <p:cNvPr id="77" name="Group 76">
                  <a:extLst>
                    <a:ext uri="{FF2B5EF4-FFF2-40B4-BE49-F238E27FC236}">
                      <a16:creationId xmlns:a16="http://schemas.microsoft.com/office/drawing/2014/main" id="{FBF2CEA5-A9BC-EDEA-0D04-1678415FDD1B}"/>
                    </a:ext>
                  </a:extLst>
                </p:cNvPr>
                <p:cNvGrpSpPr/>
                <p:nvPr/>
              </p:nvGrpSpPr>
              <p:grpSpPr>
                <a:xfrm>
                  <a:off x="7099888" y="2090144"/>
                  <a:ext cx="546921" cy="626291"/>
                  <a:chOff x="121465" y="1959747"/>
                  <a:chExt cx="546921" cy="626291"/>
                </a:xfrm>
              </p:grpSpPr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17F796B8-3491-434D-B047-BE576ADAFCA4}"/>
                      </a:ext>
                    </a:extLst>
                  </p:cNvPr>
                  <p:cNvSpPr txBox="1"/>
                  <p:nvPr/>
                </p:nvSpPr>
                <p:spPr>
                  <a:xfrm>
                    <a:off x="228620" y="1959747"/>
                    <a:ext cx="241987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RPC</a:t>
                    </a:r>
                  </a:p>
                </p:txBody>
              </p:sp>
              <p:sp>
                <p:nvSpPr>
                  <p:cNvPr id="80" name="TextBox 79">
                    <a:extLst>
                      <a:ext uri="{FF2B5EF4-FFF2-40B4-BE49-F238E27FC236}">
                        <a16:creationId xmlns:a16="http://schemas.microsoft.com/office/drawing/2014/main" id="{76D13472-2295-1870-477D-F8805FB144B8}"/>
                      </a:ext>
                    </a:extLst>
                  </p:cNvPr>
                  <p:cNvSpPr txBox="1"/>
                  <p:nvPr/>
                </p:nvSpPr>
                <p:spPr>
                  <a:xfrm>
                    <a:off x="228620" y="2063335"/>
                    <a:ext cx="233781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PC</a:t>
                    </a:r>
                  </a:p>
                </p:txBody>
              </p:sp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AD167D98-BA5C-4C6C-2AFC-5FDA06F433BF}"/>
                      </a:ext>
                    </a:extLst>
                  </p:cNvPr>
                  <p:cNvSpPr txBox="1"/>
                  <p:nvPr/>
                </p:nvSpPr>
                <p:spPr>
                  <a:xfrm>
                    <a:off x="228620" y="2166923"/>
                    <a:ext cx="439766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arly RGC</a:t>
                    </a:r>
                  </a:p>
                </p:txBody>
              </p:sp>
              <p:sp>
                <p:nvSpPr>
                  <p:cNvPr id="82" name="TextBox 81">
                    <a:extLst>
                      <a:ext uri="{FF2B5EF4-FFF2-40B4-BE49-F238E27FC236}">
                        <a16:creationId xmlns:a16="http://schemas.microsoft.com/office/drawing/2014/main" id="{4622091B-0BB7-448B-6B37-E3F2240756E3}"/>
                      </a:ext>
                    </a:extLst>
                  </p:cNvPr>
                  <p:cNvSpPr txBox="1"/>
                  <p:nvPr/>
                </p:nvSpPr>
                <p:spPr>
                  <a:xfrm>
                    <a:off x="228620" y="2270511"/>
                    <a:ext cx="416269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te RGC</a:t>
                    </a:r>
                  </a:p>
                </p:txBody>
              </p: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0CE20637-29A7-543C-BD2F-21EFE7A0F533}"/>
                      </a:ext>
                    </a:extLst>
                  </p:cNvPr>
                  <p:cNvSpPr txBox="1"/>
                  <p:nvPr/>
                </p:nvSpPr>
                <p:spPr>
                  <a:xfrm>
                    <a:off x="228620" y="2374099"/>
                    <a:ext cx="194236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&amp;A</a:t>
                    </a:r>
                  </a:p>
                </p:txBody>
              </p: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4C0B175D-8CD6-2FE5-7C93-56DF715F54DC}"/>
                      </a:ext>
                    </a:extLst>
                  </p:cNvPr>
                  <p:cNvSpPr txBox="1"/>
                  <p:nvPr/>
                </p:nvSpPr>
                <p:spPr>
                  <a:xfrm>
                    <a:off x="228620" y="2477689"/>
                    <a:ext cx="142542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</a:t>
                    </a:r>
                  </a:p>
                </p:txBody>
              </p:sp>
              <p:grpSp>
                <p:nvGrpSpPr>
                  <p:cNvPr id="85" name="Group 84">
                    <a:extLst>
                      <a:ext uri="{FF2B5EF4-FFF2-40B4-BE49-F238E27FC236}">
                        <a16:creationId xmlns:a16="http://schemas.microsoft.com/office/drawing/2014/main" id="{C9007D00-8C10-A3EA-93C5-8970DA5A7478}"/>
                      </a:ext>
                    </a:extLst>
                  </p:cNvPr>
                  <p:cNvGrpSpPr/>
                  <p:nvPr/>
                </p:nvGrpSpPr>
                <p:grpSpPr>
                  <a:xfrm>
                    <a:off x="121465" y="1960432"/>
                    <a:ext cx="83500" cy="625606"/>
                    <a:chOff x="396236" y="1686068"/>
                    <a:chExt cx="144000" cy="829214"/>
                  </a:xfrm>
                </p:grpSpPr>
                <p:sp>
                  <p:nvSpPr>
                    <p:cNvPr id="86" name="Rectangle 85">
                      <a:extLst>
                        <a:ext uri="{FF2B5EF4-FFF2-40B4-BE49-F238E27FC236}">
                          <a16:creationId xmlns:a16="http://schemas.microsoft.com/office/drawing/2014/main" id="{4D74E78D-2988-A9B5-FD1A-4480DE2F023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6236" y="1686068"/>
                      <a:ext cx="144000" cy="144000"/>
                    </a:xfrm>
                    <a:prstGeom prst="rect">
                      <a:avLst/>
                    </a:prstGeom>
                    <a:solidFill>
                      <a:srgbClr val="417505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/>
                    </a:p>
                  </p:txBody>
                </p:sp>
                <p:sp>
                  <p:nvSpPr>
                    <p:cNvPr id="87" name="Rectangle 86">
                      <a:extLst>
                        <a:ext uri="{FF2B5EF4-FFF2-40B4-BE49-F238E27FC236}">
                          <a16:creationId xmlns:a16="http://schemas.microsoft.com/office/drawing/2014/main" id="{FDA13D1B-5907-A256-5145-C6C8236EA29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6236" y="1826401"/>
                      <a:ext cx="144000" cy="144000"/>
                    </a:xfrm>
                    <a:prstGeom prst="rect">
                      <a:avLst/>
                    </a:prstGeom>
                    <a:solidFill>
                      <a:srgbClr val="F8E71C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/>
                    </a:p>
                  </p:txBody>
                </p:sp>
                <p:sp>
                  <p:nvSpPr>
                    <p:cNvPr id="88" name="Rectangle 87">
                      <a:extLst>
                        <a:ext uri="{FF2B5EF4-FFF2-40B4-BE49-F238E27FC236}">
                          <a16:creationId xmlns:a16="http://schemas.microsoft.com/office/drawing/2014/main" id="{E1B62AB3-0809-04F9-7AFA-45EF4832296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6236" y="1965529"/>
                      <a:ext cx="144000" cy="144000"/>
                    </a:xfrm>
                    <a:prstGeom prst="rect">
                      <a:avLst/>
                    </a:prstGeom>
                    <a:solidFill>
                      <a:srgbClr val="F5A623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/>
                    </a:p>
                  </p:txBody>
                </p:sp>
                <p:sp>
                  <p:nvSpPr>
                    <p:cNvPr id="89" name="Rectangle 88">
                      <a:extLst>
                        <a:ext uri="{FF2B5EF4-FFF2-40B4-BE49-F238E27FC236}">
                          <a16:creationId xmlns:a16="http://schemas.microsoft.com/office/drawing/2014/main" id="{A93AA4C9-9EDC-2479-E1FA-4A8DA2886D9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6236" y="2097842"/>
                      <a:ext cx="144000" cy="144000"/>
                    </a:xfrm>
                    <a:prstGeom prst="rect">
                      <a:avLst/>
                    </a:prstGeom>
                    <a:solidFill>
                      <a:srgbClr val="D0021B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/>
                    </a:p>
                  </p:txBody>
                </p:sp>
                <p:sp>
                  <p:nvSpPr>
                    <p:cNvPr id="90" name="Rectangle 89">
                      <a:extLst>
                        <a:ext uri="{FF2B5EF4-FFF2-40B4-BE49-F238E27FC236}">
                          <a16:creationId xmlns:a16="http://schemas.microsoft.com/office/drawing/2014/main" id="{A42288E9-B5B2-D772-8FFF-4D73844A68A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6236" y="2231523"/>
                      <a:ext cx="144000" cy="144000"/>
                    </a:xfrm>
                    <a:prstGeom prst="rect">
                      <a:avLst/>
                    </a:prstGeom>
                    <a:solidFill>
                      <a:srgbClr val="4A90E2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/>
                    </a:p>
                  </p:txBody>
                </p:sp>
                <p:sp>
                  <p:nvSpPr>
                    <p:cNvPr id="91" name="Rectangle 90">
                      <a:extLst>
                        <a:ext uri="{FF2B5EF4-FFF2-40B4-BE49-F238E27FC236}">
                          <a16:creationId xmlns:a16="http://schemas.microsoft.com/office/drawing/2014/main" id="{6B2D4C1F-8838-20E2-BFF9-6A2C6CF3D28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6236" y="2371282"/>
                      <a:ext cx="144000" cy="144000"/>
                    </a:xfrm>
                    <a:prstGeom prst="rect">
                      <a:avLst/>
                    </a:prstGeom>
                    <a:solidFill>
                      <a:srgbClr val="BD10E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/>
                    </a:p>
                  </p:txBody>
                </p:sp>
              </p:grpSp>
            </p:grp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683205EE-522D-D8B6-43C9-9F53329F44CB}"/>
                    </a:ext>
                  </a:extLst>
                </p:cNvPr>
                <p:cNvSpPr txBox="1"/>
                <p:nvPr/>
              </p:nvSpPr>
              <p:spPr>
                <a:xfrm rot="16200000">
                  <a:off x="6504828" y="2311978"/>
                  <a:ext cx="97391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Type Clusters</a:t>
                  </a:r>
                </a:p>
              </p:txBody>
            </p:sp>
          </p:grpSp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F4288D8D-FE25-39E5-91A8-C150A6E4AE9A}"/>
                  </a:ext>
                </a:extLst>
              </p:cNvPr>
              <p:cNvSpPr/>
              <p:nvPr/>
            </p:nvSpPr>
            <p:spPr>
              <a:xfrm>
                <a:off x="1002697" y="341792"/>
                <a:ext cx="676830" cy="1586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5A3E07F0-7A57-1675-5E05-CB2E9B91D5D2}"/>
                  </a:ext>
                </a:extLst>
              </p:cNvPr>
              <p:cNvSpPr txBox="1"/>
              <p:nvPr/>
            </p:nvSpPr>
            <p:spPr>
              <a:xfrm>
                <a:off x="1095689" y="350630"/>
                <a:ext cx="533426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+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619B7C2B-880A-B66E-F70E-E9C0B6D14CFF}"/>
                  </a:ext>
                </a:extLst>
              </p:cNvPr>
              <p:cNvSpPr txBox="1"/>
              <p:nvPr/>
            </p:nvSpPr>
            <p:spPr>
              <a:xfrm>
                <a:off x="6013192" y="3312121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S6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5736A2CD-5275-A013-AA83-083C8A185885}"/>
                  </a:ext>
                </a:extLst>
              </p:cNvPr>
              <p:cNvSpPr txBox="1"/>
              <p:nvPr/>
            </p:nvSpPr>
            <p:spPr>
              <a:xfrm>
                <a:off x="7002695" y="3312121"/>
                <a:ext cx="47185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FAP2A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C3B0BD80-C659-1B10-DBF5-34794AA7D772}"/>
                  </a:ext>
                </a:extLst>
              </p:cNvPr>
              <p:cNvSpPr txBox="1"/>
              <p:nvPr/>
            </p:nvSpPr>
            <p:spPr>
              <a:xfrm>
                <a:off x="7996558" y="3312121"/>
                <a:ext cx="37567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KI67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95590795-E32E-BF84-CD3E-0C13DD69E3B6}"/>
                  </a:ext>
                </a:extLst>
              </p:cNvPr>
              <p:cNvSpPr txBox="1"/>
              <p:nvPr/>
            </p:nvSpPr>
            <p:spPr>
              <a:xfrm>
                <a:off x="6010811" y="2333807"/>
                <a:ext cx="329184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LL1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94BE077A-EE9B-CC57-6DD7-C7581003BA37}"/>
                  </a:ext>
                </a:extLst>
              </p:cNvPr>
              <p:cNvSpPr txBox="1"/>
              <p:nvPr/>
            </p:nvSpPr>
            <p:spPr>
              <a:xfrm>
                <a:off x="7000314" y="2333807"/>
                <a:ext cx="410937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43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F1B21EDD-49A5-4C65-931B-69CE82E599BA}"/>
                  </a:ext>
                </a:extLst>
              </p:cNvPr>
              <p:cNvSpPr txBox="1"/>
              <p:nvPr/>
            </p:nvSpPr>
            <p:spPr>
              <a:xfrm>
                <a:off x="7994177" y="2333807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X6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91D4F2F5-DEE2-07E0-30E6-A2DF5DD82959}"/>
                  </a:ext>
                </a:extLst>
              </p:cNvPr>
              <p:cNvSpPr txBox="1"/>
              <p:nvPr/>
            </p:nvSpPr>
            <p:spPr>
              <a:xfrm>
                <a:off x="6012988" y="1352212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S1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24D4BF1F-888C-C00E-AC3A-3ED96FD4BE76}"/>
                  </a:ext>
                </a:extLst>
              </p:cNvPr>
              <p:cNvSpPr txBox="1"/>
              <p:nvPr/>
            </p:nvSpPr>
            <p:spPr>
              <a:xfrm>
                <a:off x="7002491" y="1352212"/>
                <a:ext cx="473454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U4F2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C74D0E7A-B9B3-F220-BDF0-22D0313F81B0}"/>
                  </a:ext>
                </a:extLst>
              </p:cNvPr>
              <p:cNvSpPr txBox="1"/>
              <p:nvPr/>
            </p:nvSpPr>
            <p:spPr>
              <a:xfrm>
                <a:off x="7996354" y="1352212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TX2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830613C0-5E12-B85C-FF8B-37DCDE8A2BCB}"/>
                  </a:ext>
                </a:extLst>
              </p:cNvPr>
              <p:cNvSpPr txBox="1"/>
              <p:nvPr/>
            </p:nvSpPr>
            <p:spPr>
              <a:xfrm>
                <a:off x="6013192" y="378291"/>
                <a:ext cx="404525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FRP2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AF4ADC5C-0B8C-138D-BA7B-6301827297C2}"/>
                  </a:ext>
                </a:extLst>
              </p:cNvPr>
              <p:cNvSpPr txBox="1"/>
              <p:nvPr/>
            </p:nvSpPr>
            <p:spPr>
              <a:xfrm>
                <a:off x="7002695" y="378291"/>
                <a:ext cx="563222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DD45A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41EC55D5-A1EF-547E-A4F9-11190601C4B1}"/>
                  </a:ext>
                </a:extLst>
              </p:cNvPr>
              <p:cNvSpPr txBox="1"/>
              <p:nvPr/>
            </p:nvSpPr>
            <p:spPr>
              <a:xfrm>
                <a:off x="7996558" y="378291"/>
                <a:ext cx="289109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X</a:t>
                </a:r>
              </a:p>
            </p:txBody>
          </p:sp>
          <p:grpSp>
            <p:nvGrpSpPr>
              <p:cNvPr id="235" name="Group 234">
                <a:extLst>
                  <a:ext uri="{FF2B5EF4-FFF2-40B4-BE49-F238E27FC236}">
                    <a16:creationId xmlns:a16="http://schemas.microsoft.com/office/drawing/2014/main" id="{88F6385A-6406-7361-EE6D-93220D78285C}"/>
                  </a:ext>
                </a:extLst>
              </p:cNvPr>
              <p:cNvGrpSpPr/>
              <p:nvPr/>
            </p:nvGrpSpPr>
            <p:grpSpPr>
              <a:xfrm>
                <a:off x="6377053" y="4447027"/>
                <a:ext cx="2089162" cy="1262151"/>
                <a:chOff x="6554364" y="4268855"/>
                <a:chExt cx="2089162" cy="1262151"/>
              </a:xfrm>
            </p:grpSpPr>
            <p:grpSp>
              <p:nvGrpSpPr>
                <p:cNvPr id="221" name="Group 220">
                  <a:extLst>
                    <a:ext uri="{FF2B5EF4-FFF2-40B4-BE49-F238E27FC236}">
                      <a16:creationId xmlns:a16="http://schemas.microsoft.com/office/drawing/2014/main" id="{B937C904-6248-6432-FD99-A1BC0F7DE183}"/>
                    </a:ext>
                  </a:extLst>
                </p:cNvPr>
                <p:cNvGrpSpPr/>
                <p:nvPr/>
              </p:nvGrpSpPr>
              <p:grpSpPr>
                <a:xfrm>
                  <a:off x="6601164" y="4490475"/>
                  <a:ext cx="1991670" cy="999625"/>
                  <a:chOff x="6108988" y="4490475"/>
                  <a:chExt cx="1991670" cy="999625"/>
                </a:xfrm>
              </p:grpSpPr>
              <p:pic>
                <p:nvPicPr>
                  <p:cNvPr id="150" name="Picture 149" descr="A colorful dots on a black background&#10;&#10;Description automatically generated">
                    <a:extLst>
                      <a:ext uri="{FF2B5EF4-FFF2-40B4-BE49-F238E27FC236}">
                        <a16:creationId xmlns:a16="http://schemas.microsoft.com/office/drawing/2014/main" id="{1106A7E8-6EDF-AE1F-ED91-04A7715548F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2" cstate="hqprint">
                    <a:extLst>
                      <a:ext uri="{BEBA8EAE-BF5A-486C-A8C5-ECC9F3942E4B}">
                        <a14:imgProps xmlns:a14="http://schemas.microsoft.com/office/drawing/2010/main">
                          <a14:imgLayer r:embed="rId33">
                            <a14:imgEffect>
                              <a14:brightnessContrast bright="35000" contrast="35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102878" y="4500100"/>
                    <a:ext cx="997780" cy="990000"/>
                  </a:xfrm>
                  <a:prstGeom prst="rect">
                    <a:avLst/>
                  </a:prstGeom>
                </p:spPr>
              </p:pic>
              <p:pic>
                <p:nvPicPr>
                  <p:cNvPr id="194" name="Picture 193" descr="A colorful dots on a black background&#10;&#10;Description automatically generated">
                    <a:extLst>
                      <a:ext uri="{FF2B5EF4-FFF2-40B4-BE49-F238E27FC236}">
                        <a16:creationId xmlns:a16="http://schemas.microsoft.com/office/drawing/2014/main" id="{6AF425E8-EB53-DE05-8EFF-7A951A40CFC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4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08988" y="4500100"/>
                    <a:ext cx="993890" cy="990000"/>
                  </a:xfrm>
                  <a:prstGeom prst="rect">
                    <a:avLst/>
                  </a:prstGeom>
                </p:spPr>
              </p:pic>
              <p:sp>
                <p:nvSpPr>
                  <p:cNvPr id="195" name="TextBox 194">
                    <a:extLst>
                      <a:ext uri="{FF2B5EF4-FFF2-40B4-BE49-F238E27FC236}">
                        <a16:creationId xmlns:a16="http://schemas.microsoft.com/office/drawing/2014/main" id="{B8E213E0-EA5F-ECF9-F616-042E8464F781}"/>
                      </a:ext>
                    </a:extLst>
                  </p:cNvPr>
                  <p:cNvSpPr txBox="1"/>
                  <p:nvPr/>
                </p:nvSpPr>
                <p:spPr>
                  <a:xfrm>
                    <a:off x="6193884" y="4503582"/>
                    <a:ext cx="231401" cy="19581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36000" rIns="36000" bIns="36000" rtlCol="0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en-US" sz="8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6" name="TextBox 195">
                    <a:extLst>
                      <a:ext uri="{FF2B5EF4-FFF2-40B4-BE49-F238E27FC236}">
                        <a16:creationId xmlns:a16="http://schemas.microsoft.com/office/drawing/2014/main" id="{CE54F00D-7782-08DF-F242-A312DD5D49CF}"/>
                      </a:ext>
                    </a:extLst>
                  </p:cNvPr>
                  <p:cNvSpPr txBox="1"/>
                  <p:nvPr/>
                </p:nvSpPr>
                <p:spPr>
                  <a:xfrm>
                    <a:off x="7197816" y="4490475"/>
                    <a:ext cx="479866" cy="19581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36000" rIns="36000" bIns="36000" rtlCol="0">
                    <a:spAutoFit/>
                  </a:bodyPr>
                  <a:lstStyle/>
                  <a:p>
                    <a:r>
                      <a:rPr lang="en-US" sz="800" b="1" i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TOH7+</a:t>
                    </a:r>
                  </a:p>
                </p:txBody>
              </p:sp>
            </p:grpSp>
            <p:grpSp>
              <p:nvGrpSpPr>
                <p:cNvPr id="224" name="Group 223">
                  <a:extLst>
                    <a:ext uri="{FF2B5EF4-FFF2-40B4-BE49-F238E27FC236}">
                      <a16:creationId xmlns:a16="http://schemas.microsoft.com/office/drawing/2014/main" id="{16A77D76-76DC-4363-44C6-17A3B31EBD32}"/>
                    </a:ext>
                  </a:extLst>
                </p:cNvPr>
                <p:cNvGrpSpPr/>
                <p:nvPr/>
              </p:nvGrpSpPr>
              <p:grpSpPr>
                <a:xfrm>
                  <a:off x="6554364" y="4268855"/>
                  <a:ext cx="2089162" cy="1262151"/>
                  <a:chOff x="6724739" y="4840276"/>
                  <a:chExt cx="3129463" cy="1262151"/>
                </a:xfrm>
              </p:grpSpPr>
              <p:sp>
                <p:nvSpPr>
                  <p:cNvPr id="227" name="Rectangle 226">
                    <a:extLst>
                      <a:ext uri="{FF2B5EF4-FFF2-40B4-BE49-F238E27FC236}">
                        <a16:creationId xmlns:a16="http://schemas.microsoft.com/office/drawing/2014/main" id="{DD802E8F-96BC-B60E-39F5-240EE9D46433}"/>
                      </a:ext>
                    </a:extLst>
                  </p:cNvPr>
                  <p:cNvSpPr/>
                  <p:nvPr/>
                </p:nvSpPr>
                <p:spPr>
                  <a:xfrm>
                    <a:off x="6724739" y="4848691"/>
                    <a:ext cx="3129463" cy="1253736"/>
                  </a:xfrm>
                  <a:prstGeom prst="rect">
                    <a:avLst/>
                  </a:prstGeom>
                  <a:noFill/>
                  <a:ln>
                    <a:prstDash val="sysDash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b="1" i="1"/>
                  </a:p>
                </p:txBody>
              </p:sp>
              <p:sp>
                <p:nvSpPr>
                  <p:cNvPr id="226" name="TextBox 225">
                    <a:extLst>
                      <a:ext uri="{FF2B5EF4-FFF2-40B4-BE49-F238E27FC236}">
                        <a16:creationId xmlns:a16="http://schemas.microsoft.com/office/drawing/2014/main" id="{11D8ADBF-9F3A-4C06-3925-7B8368D483DE}"/>
                      </a:ext>
                    </a:extLst>
                  </p:cNvPr>
                  <p:cNvSpPr txBox="1"/>
                  <p:nvPr/>
                </p:nvSpPr>
                <p:spPr>
                  <a:xfrm>
                    <a:off x="6737265" y="4840276"/>
                    <a:ext cx="3071188" cy="226591"/>
                  </a:xfrm>
                  <a:prstGeom prst="rect">
                    <a:avLst/>
                  </a:prstGeom>
                  <a:noFill/>
                </p:spPr>
                <p:txBody>
                  <a:bodyPr wrap="square" lIns="36000" tIns="36000" rIns="36000" bIns="36000" rtlCol="0">
                    <a:spAutoFit/>
                  </a:bodyPr>
                  <a:lstStyle/>
                  <a:p>
                    <a:pPr algn="ctr"/>
                    <a:r>
                      <a:rPr 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TOH7</a:t>
                    </a: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3335043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99060" y="184077"/>
            <a:ext cx="9932621" cy="6666902"/>
            <a:chOff x="-99060" y="184077"/>
            <a:chExt cx="9932621" cy="6666902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F482F7C-BE3B-4315-0DE2-0B9DC2F74072}"/>
                </a:ext>
              </a:extLst>
            </p:cNvPr>
            <p:cNvSpPr txBox="1"/>
            <p:nvPr/>
          </p:nvSpPr>
          <p:spPr>
            <a:xfrm>
              <a:off x="76632" y="6019982"/>
              <a:ext cx="9756929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10. All 469 identified ATOH7 target DEGs. 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eatmaps of annotated genes presenting relative expression per cell-type based on scRNA-seq data, differential expression between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and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cells, based on reporter-enriched mRNA-seq, and number of annotated ATOH7 binding loci identified by CUT&amp;RUN-seq, where the annotation is defined as either enhancer (&gt;5kb from TSS) or promoter (±5kb from TSS). The representative cell clusters are defined as naïve retinal progenitor cells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transient retinal progeni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early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arly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late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ate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horizontal and amacrine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&amp;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and photorecep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. A few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arget DEGs were not detected by scRNA-seq due to either absent expression of targeted RNA sequence or lack of specific hybridization probes (</a:t>
              </a:r>
              <a:r>
                <a:rPr lang="en-US" sz="800" b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*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.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UT&amp;RUN-seq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leavage under targets and release using nuclease sequenc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EG</a:t>
              </a:r>
              <a:r>
                <a:rPr lang="en-CH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differentially expressed gene</a:t>
              </a:r>
              <a:r>
                <a:rPr lang="en-CH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 between MUT-GFP and 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C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fluorescence-activated cell sort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mutant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cRNA-seq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single-cell RNA sequenc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S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transcription start sit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.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-99060" y="184077"/>
              <a:ext cx="9927113" cy="5774000"/>
              <a:chOff x="-99060" y="184077"/>
              <a:chExt cx="9927113" cy="5774000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007430" y="3143344"/>
                <a:ext cx="5868000" cy="1281594"/>
                <a:chOff x="931230" y="3136994"/>
                <a:chExt cx="5958157" cy="1281594"/>
              </a:xfrm>
            </p:grpSpPr>
            <p:pic>
              <p:nvPicPr>
                <p:cNvPr id="32" name="Picture 31" descr="A chart of different color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B2742750-0C7E-1D43-2720-901A341969B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16200000">
                  <a:off x="3593615" y="1122817"/>
                  <a:ext cx="633387" cy="5958156"/>
                </a:xfrm>
                <a:prstGeom prst="rect">
                  <a:avLst/>
                </a:prstGeom>
              </p:spPr>
            </p:pic>
            <p:pic>
              <p:nvPicPr>
                <p:cNvPr id="33" name="Picture 32" descr="A vertical line of black and purple squares&#10;&#10;Description automatically generated">
                  <a:extLst>
                    <a:ext uri="{FF2B5EF4-FFF2-40B4-BE49-F238E27FC236}">
                      <a16:creationId xmlns:a16="http://schemas.microsoft.com/office/drawing/2014/main" id="{D8E95741-FD33-D98D-EF76-1D444D2F7E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16200000">
                  <a:off x="3636483" y="432150"/>
                  <a:ext cx="547081" cy="5956769"/>
                </a:xfrm>
                <a:prstGeom prst="rect">
                  <a:avLst/>
                </a:prstGeom>
              </p:spPr>
            </p:pic>
            <p:pic>
              <p:nvPicPr>
                <p:cNvPr id="34" name="Picture 33" descr="A colorful striped object with a white background&#10;&#10;Description automatically generated">
                  <a:extLst>
                    <a:ext uri="{FF2B5EF4-FFF2-40B4-BE49-F238E27FC236}">
                      <a16:creationId xmlns:a16="http://schemas.microsoft.com/office/drawing/2014/main" id="{F1CB59B2-E2B2-0835-8ACE-9C4C487D2F3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16200000">
                  <a:off x="3857919" y="757101"/>
                  <a:ext cx="104778" cy="5958156"/>
                </a:xfrm>
                <a:prstGeom prst="rect">
                  <a:avLst/>
                </a:prstGeom>
              </p:spPr>
            </p:pic>
          </p:grpSp>
          <p:grpSp>
            <p:nvGrpSpPr>
              <p:cNvPr id="6" name="Group 5"/>
              <p:cNvGrpSpPr/>
              <p:nvPr/>
            </p:nvGrpSpPr>
            <p:grpSpPr>
              <a:xfrm>
                <a:off x="6912053" y="3188528"/>
                <a:ext cx="2916000" cy="1234306"/>
                <a:chOff x="6912053" y="3188528"/>
                <a:chExt cx="2977307" cy="1234306"/>
              </a:xfrm>
            </p:grpSpPr>
            <p:pic>
              <p:nvPicPr>
                <p:cNvPr id="36" name="Picture 35" descr="A colorful rectangular pattern with white text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56787B91-5285-C09B-BF1A-2BA4E573E7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16200000">
                  <a:off x="8081135" y="2614611"/>
                  <a:ext cx="639141" cy="2977305"/>
                </a:xfrm>
                <a:prstGeom prst="rect">
                  <a:avLst/>
                </a:prstGeom>
              </p:spPr>
            </p:pic>
            <p:pic>
              <p:nvPicPr>
                <p:cNvPr id="37" name="Picture 36" descr="A close-up of a chart&#10;&#10;Description automatically generated">
                  <a:extLst>
                    <a:ext uri="{FF2B5EF4-FFF2-40B4-BE49-F238E27FC236}">
                      <a16:creationId xmlns:a16="http://schemas.microsoft.com/office/drawing/2014/main" id="{BB2B66C1-6D2B-B4E6-68C6-5B95CA15315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16200000">
                  <a:off x="8152934" y="1947649"/>
                  <a:ext cx="495547" cy="2977305"/>
                </a:xfrm>
                <a:prstGeom prst="rect">
                  <a:avLst/>
                </a:prstGeom>
              </p:spPr>
            </p:pic>
            <p:pic>
              <p:nvPicPr>
                <p:cNvPr id="38" name="Picture 37" descr="A colorful striped object with a black and white background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09697E97-A47E-155F-0108-D859C5EA17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16200000">
                  <a:off x="8347129" y="2246337"/>
                  <a:ext cx="107156" cy="2977305"/>
                </a:xfrm>
                <a:prstGeom prst="rect">
                  <a:avLst/>
                </a:prstGeom>
              </p:spPr>
            </p:pic>
          </p:grpSp>
          <p:pic>
            <p:nvPicPr>
              <p:cNvPr id="40" name="Picture 39" descr="A chart of different colors&#10;&#10;Description automatically generated with medium confidence">
                <a:extLst>
                  <a:ext uri="{FF2B5EF4-FFF2-40B4-BE49-F238E27FC236}">
                    <a16:creationId xmlns:a16="http://schemas.microsoft.com/office/drawing/2014/main" id="{570BB201-B9C9-FA4C-E7C0-87AA7FC210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2861418" y="3420299"/>
                <a:ext cx="629501" cy="4322239"/>
              </a:xfrm>
              <a:prstGeom prst="rect">
                <a:avLst/>
              </a:prstGeom>
            </p:spPr>
          </p:pic>
          <p:pic>
            <p:nvPicPr>
              <p:cNvPr id="41" name="Picture 40" descr="A black and white rectangular object with text&#10;&#10;Description automatically generated with medium confidence">
                <a:extLst>
                  <a:ext uri="{FF2B5EF4-FFF2-40B4-BE49-F238E27FC236}">
                    <a16:creationId xmlns:a16="http://schemas.microsoft.com/office/drawing/2014/main" id="{34EC8E7A-1023-4498-7326-9A3181CF4B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2930230" y="2752586"/>
                <a:ext cx="491877" cy="4322239"/>
              </a:xfrm>
              <a:prstGeom prst="rect">
                <a:avLst/>
              </a:prstGeom>
            </p:spPr>
          </p:pic>
          <p:pic>
            <p:nvPicPr>
              <p:cNvPr id="42" name="Picture 41" descr="A colorful striped object on a white background&#10;&#10;Description automatically generated">
                <a:extLst>
                  <a:ext uri="{FF2B5EF4-FFF2-40B4-BE49-F238E27FC236}">
                    <a16:creationId xmlns:a16="http://schemas.microsoft.com/office/drawing/2014/main" id="{44018663-33E6-C02F-2B2D-1F57FC4DD9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3122978" y="3052236"/>
                <a:ext cx="106381" cy="4322239"/>
              </a:xfrm>
              <a:prstGeom prst="rect">
                <a:avLst/>
              </a:prstGeom>
            </p:spPr>
          </p:pic>
          <p:pic>
            <p:nvPicPr>
              <p:cNvPr id="44" name="Picture 43" descr="A close-up of a chart&#10;&#10;Description automatically generated">
                <a:extLst>
                  <a:ext uri="{FF2B5EF4-FFF2-40B4-BE49-F238E27FC236}">
                    <a16:creationId xmlns:a16="http://schemas.microsoft.com/office/drawing/2014/main" id="{539E3E06-E086-4F30-7332-8C42911FFA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6082101" y="3906506"/>
                <a:ext cx="526546" cy="1979732"/>
              </a:xfrm>
              <a:prstGeom prst="rect">
                <a:avLst/>
              </a:prstGeom>
            </p:spPr>
          </p:pic>
          <p:pic>
            <p:nvPicPr>
              <p:cNvPr id="45" name="Picture 44" descr="A graph with a rainbow colored line&#10;&#10;Description automatically generated with medium confidence">
                <a:extLst>
                  <a:ext uri="{FF2B5EF4-FFF2-40B4-BE49-F238E27FC236}">
                    <a16:creationId xmlns:a16="http://schemas.microsoft.com/office/drawing/2014/main" id="{0156EAC6-49F8-8032-FA36-F6ED70B8ED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6029385" y="4587906"/>
                <a:ext cx="631982" cy="1979735"/>
              </a:xfrm>
              <a:prstGeom prst="rect">
                <a:avLst/>
              </a:prstGeom>
            </p:spPr>
          </p:pic>
          <p:pic>
            <p:nvPicPr>
              <p:cNvPr id="46" name="Picture 45" descr="A colorful scale of a test&#10;&#10;Description automatically generated with medium confidence">
                <a:extLst>
                  <a:ext uri="{FF2B5EF4-FFF2-40B4-BE49-F238E27FC236}">
                    <a16:creationId xmlns:a16="http://schemas.microsoft.com/office/drawing/2014/main" id="{6D828101-DDCD-87BF-98B0-4FE35617D4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6292186" y="4223488"/>
                <a:ext cx="106377" cy="1979737"/>
              </a:xfrm>
              <a:prstGeom prst="rect">
                <a:avLst/>
              </a:prstGeom>
            </p:spPr>
          </p:pic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F98EDF3D-7E96-B579-DC89-54DF47CA6A37}"/>
                  </a:ext>
                </a:extLst>
              </p:cNvPr>
              <p:cNvGrpSpPr/>
              <p:nvPr/>
            </p:nvGrpSpPr>
            <p:grpSpPr>
              <a:xfrm rot="16200000">
                <a:off x="4456354" y="-1812352"/>
                <a:ext cx="1268472" cy="8177504"/>
                <a:chOff x="5811914" y="-980672"/>
                <a:chExt cx="1668475" cy="8295872"/>
              </a:xfrm>
            </p:grpSpPr>
            <p:pic>
              <p:nvPicPr>
                <p:cNvPr id="4" name="Picture 3" descr="A close-up of a chart&#10;&#10;Description automatically generated">
                  <a:extLst>
                    <a:ext uri="{FF2B5EF4-FFF2-40B4-BE49-F238E27FC236}">
                      <a16:creationId xmlns:a16="http://schemas.microsoft.com/office/drawing/2014/main" id="{63AADED7-F733-F00C-9783-F3D8F8B626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811914" y="-979200"/>
                  <a:ext cx="827441" cy="8294400"/>
                </a:xfrm>
                <a:prstGeom prst="rect">
                  <a:avLst/>
                </a:prstGeom>
              </p:spPr>
            </p:pic>
            <p:pic>
              <p:nvPicPr>
                <p:cNvPr id="5" name="Picture 4" descr="A black and white rectangular object with black and purple squares&#10;&#10;Description automatically generated">
                  <a:extLst>
                    <a:ext uri="{FF2B5EF4-FFF2-40B4-BE49-F238E27FC236}">
                      <a16:creationId xmlns:a16="http://schemas.microsoft.com/office/drawing/2014/main" id="{D81B933A-3280-4C6E-9F0E-25513BA167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773306" y="-980672"/>
                  <a:ext cx="707083" cy="8295863"/>
                </a:xfrm>
                <a:prstGeom prst="rect">
                  <a:avLst/>
                </a:prstGeom>
              </p:spPr>
            </p:pic>
            <p:pic>
              <p:nvPicPr>
                <p:cNvPr id="20" name="Picture 19" descr="A colorful striped object with black and orange stripes&#10;&#10;Description automatically generated">
                  <a:extLst>
                    <a:ext uri="{FF2B5EF4-FFF2-40B4-BE49-F238E27FC236}">
                      <a16:creationId xmlns:a16="http://schemas.microsoft.com/office/drawing/2014/main" id="{515A7499-EA35-4614-D807-AEED86A6FE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639363" y="-979202"/>
                  <a:ext cx="134682" cy="8294400"/>
                </a:xfrm>
                <a:prstGeom prst="rect">
                  <a:avLst/>
                </a:prstGeom>
              </p:spPr>
            </p:pic>
          </p:grpSp>
          <p:pic>
            <p:nvPicPr>
              <p:cNvPr id="25" name="Picture 24" descr="A chart of a number of cells&#10;&#10;Description automatically generated with medium confidence">
                <a:extLst>
                  <a:ext uri="{FF2B5EF4-FFF2-40B4-BE49-F238E27FC236}">
                    <a16:creationId xmlns:a16="http://schemas.microsoft.com/office/drawing/2014/main" id="{6675ABF5-AB2E-2325-A622-A555042609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2339079" y="-542976"/>
                <a:ext cx="635674" cy="3281273"/>
              </a:xfrm>
              <a:prstGeom prst="rect">
                <a:avLst/>
              </a:prstGeom>
            </p:spPr>
          </p:pic>
          <p:pic>
            <p:nvPicPr>
              <p:cNvPr id="26" name="Picture 25" descr="A black and purple crossword puzzle&#10;&#10;Description automatically generated">
                <a:extLst>
                  <a:ext uri="{FF2B5EF4-FFF2-40B4-BE49-F238E27FC236}">
                    <a16:creationId xmlns:a16="http://schemas.microsoft.com/office/drawing/2014/main" id="{5FC8F60E-0694-72EB-AEC5-570C9024E7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2412068" y="-1208064"/>
                <a:ext cx="494456" cy="3281273"/>
              </a:xfrm>
              <a:prstGeom prst="rect">
                <a:avLst/>
              </a:prstGeom>
            </p:spPr>
          </p:pic>
          <p:pic>
            <p:nvPicPr>
              <p:cNvPr id="27" name="Picture 26" descr="A colorful striped object with black and orange stripes&#10;&#10;Description automatically generated">
                <a:extLst>
                  <a:ext uri="{FF2B5EF4-FFF2-40B4-BE49-F238E27FC236}">
                    <a16:creationId xmlns:a16="http://schemas.microsoft.com/office/drawing/2014/main" id="{51F9D88B-06C2-85FE-ADEF-C92C30D258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2605211" y="-912011"/>
                <a:ext cx="102395" cy="3281275"/>
              </a:xfrm>
              <a:prstGeom prst="rect">
                <a:avLst/>
              </a:prstGeom>
            </p:spPr>
          </p:pic>
          <p:pic>
            <p:nvPicPr>
              <p:cNvPr id="22" name="Picture 21" descr="A chart of a number of dna&#10;&#10;Description automatically generated with medium confidence">
                <a:extLst>
                  <a:ext uri="{FF2B5EF4-FFF2-40B4-BE49-F238E27FC236}">
                    <a16:creationId xmlns:a16="http://schemas.microsoft.com/office/drawing/2014/main" id="{99C8EEE5-C68B-BF9A-B7F4-BAA50D54CE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5550021" y="-424525"/>
                <a:ext cx="629392" cy="3038089"/>
              </a:xfrm>
              <a:prstGeom prst="rect">
                <a:avLst/>
              </a:prstGeom>
            </p:spPr>
          </p:pic>
          <p:pic>
            <p:nvPicPr>
              <p:cNvPr id="23" name="Picture 22" descr="A black and purple rectangular chart&#10;&#10;Description automatically generated with medium confidence">
                <a:extLst>
                  <a:ext uri="{FF2B5EF4-FFF2-40B4-BE49-F238E27FC236}">
                    <a16:creationId xmlns:a16="http://schemas.microsoft.com/office/drawing/2014/main" id="{9BDDC1BE-7AD2-57F4-CBE0-2326433CFC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5616624" y="-1086876"/>
                <a:ext cx="495724" cy="3037630"/>
              </a:xfrm>
              <a:prstGeom prst="rect">
                <a:avLst/>
              </a:prstGeom>
            </p:spPr>
          </p:pic>
          <p:pic>
            <p:nvPicPr>
              <p:cNvPr id="24" name="Picture 23" descr="A colorful striped object with a black handle&#10;&#10;Description automatically generated">
                <a:extLst>
                  <a:ext uri="{FF2B5EF4-FFF2-40B4-BE49-F238E27FC236}">
                    <a16:creationId xmlns:a16="http://schemas.microsoft.com/office/drawing/2014/main" id="{0BCC0F43-8877-809F-1171-5F0DE825CF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16200000">
                <a:off x="5812978" y="-788998"/>
                <a:ext cx="100016" cy="3037630"/>
              </a:xfrm>
              <a:prstGeom prst="rect">
                <a:avLst/>
              </a:prstGeom>
            </p:spPr>
          </p:pic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6FF62160-4D2B-624B-0E66-3C270963DB15}"/>
                  </a:ext>
                </a:extLst>
              </p:cNvPr>
              <p:cNvGrpSpPr/>
              <p:nvPr/>
            </p:nvGrpSpPr>
            <p:grpSpPr>
              <a:xfrm>
                <a:off x="-38099" y="431477"/>
                <a:ext cx="1115064" cy="1034117"/>
                <a:chOff x="-205739" y="431477"/>
                <a:chExt cx="1115064" cy="1034117"/>
              </a:xfrm>
            </p:grpSpPr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BBFD5F77-D634-88C8-97CB-DF7A8884F8B8}"/>
                    </a:ext>
                  </a:extLst>
                </p:cNvPr>
                <p:cNvSpPr txBox="1"/>
                <p:nvPr/>
              </p:nvSpPr>
              <p:spPr>
                <a:xfrm>
                  <a:off x="-205739" y="642770"/>
                  <a:ext cx="111506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UT-GFP vs. WT-GFP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C5C4C6FA-B9FD-C312-4B9A-E8A1D3629221}"/>
                    </a:ext>
                  </a:extLst>
                </p:cNvPr>
                <p:cNvSpPr txBox="1"/>
                <p:nvPr/>
              </p:nvSpPr>
              <p:spPr>
                <a:xfrm>
                  <a:off x="217261" y="534742"/>
                  <a:ext cx="69206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hancer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E346E8B9-4E5D-0773-4125-61A106A79895}"/>
                    </a:ext>
                  </a:extLst>
                </p:cNvPr>
                <p:cNvSpPr txBox="1"/>
                <p:nvPr/>
              </p:nvSpPr>
              <p:spPr>
                <a:xfrm>
                  <a:off x="217261" y="431477"/>
                  <a:ext cx="69206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moter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97E58594-7310-8293-E48C-61C9EDF5832F}"/>
                    </a:ext>
                  </a:extLst>
                </p:cNvPr>
                <p:cNvSpPr txBox="1"/>
                <p:nvPr/>
              </p:nvSpPr>
              <p:spPr>
                <a:xfrm>
                  <a:off x="318670" y="1265539"/>
                  <a:ext cx="59065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RPC</a:t>
                  </a: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7E190595-D4F3-02B2-591E-6C58E1C95051}"/>
                    </a:ext>
                  </a:extLst>
                </p:cNvPr>
                <p:cNvSpPr txBox="1"/>
                <p:nvPr/>
              </p:nvSpPr>
              <p:spPr>
                <a:xfrm>
                  <a:off x="439075" y="1161479"/>
                  <a:ext cx="4702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C</a:t>
                  </a: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0133ACB9-4D72-AEED-FAF2-B6DC074B3A4B}"/>
                    </a:ext>
                  </a:extLst>
                </p:cNvPr>
                <p:cNvSpPr txBox="1"/>
                <p:nvPr/>
              </p:nvSpPr>
              <p:spPr>
                <a:xfrm>
                  <a:off x="186686" y="1057420"/>
                  <a:ext cx="72263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arly RGC</a:t>
                  </a:r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F3DFA016-4654-69E6-B459-F70A4D871DF4}"/>
                    </a:ext>
                  </a:extLst>
                </p:cNvPr>
                <p:cNvSpPr txBox="1"/>
                <p:nvPr/>
              </p:nvSpPr>
              <p:spPr>
                <a:xfrm>
                  <a:off x="249547" y="953361"/>
                  <a:ext cx="6597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te RGC</a:t>
                  </a:r>
                </a:p>
              </p:txBody>
            </p: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0EE455A6-2389-AA9D-F3F1-CFA9D81E9A19}"/>
                    </a:ext>
                  </a:extLst>
                </p:cNvPr>
                <p:cNvSpPr txBox="1"/>
                <p:nvPr/>
              </p:nvSpPr>
              <p:spPr>
                <a:xfrm>
                  <a:off x="439075" y="846921"/>
                  <a:ext cx="4702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&amp;A</a:t>
                  </a:r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F7396D62-0962-E37A-FF9F-6316637B7214}"/>
                    </a:ext>
                  </a:extLst>
                </p:cNvPr>
                <p:cNvSpPr txBox="1"/>
                <p:nvPr/>
              </p:nvSpPr>
              <p:spPr>
                <a:xfrm>
                  <a:off x="439075" y="745243"/>
                  <a:ext cx="4702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</a:t>
                  </a:r>
                </a:p>
              </p:txBody>
            </p:sp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id="{5382D291-EB18-5628-5876-F9814DE3AB47}"/>
                    </a:ext>
                  </a:extLst>
                </p:cNvPr>
                <p:cNvGrpSpPr/>
                <p:nvPr/>
              </p:nvGrpSpPr>
              <p:grpSpPr>
                <a:xfrm rot="16200000">
                  <a:off x="-27597" y="1033652"/>
                  <a:ext cx="578473" cy="237078"/>
                  <a:chOff x="575233" y="455440"/>
                  <a:chExt cx="835706" cy="227442"/>
                </a:xfrm>
              </p:grpSpPr>
              <p:sp>
                <p:nvSpPr>
                  <p:cNvPr id="153" name="TextBox 152">
                    <a:extLst>
                      <a:ext uri="{FF2B5EF4-FFF2-40B4-BE49-F238E27FC236}">
                        <a16:creationId xmlns:a16="http://schemas.microsoft.com/office/drawing/2014/main" id="{EA7CA819-6E9A-A03E-C07A-9F1A54C106C4}"/>
                      </a:ext>
                    </a:extLst>
                  </p:cNvPr>
                  <p:cNvSpPr txBox="1"/>
                  <p:nvPr/>
                </p:nvSpPr>
                <p:spPr>
                  <a:xfrm>
                    <a:off x="575233" y="455440"/>
                    <a:ext cx="835706" cy="191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 Type</a:t>
                    </a:r>
                  </a:p>
                </p:txBody>
              </p:sp>
              <p:grpSp>
                <p:nvGrpSpPr>
                  <p:cNvPr id="154" name="Group 153">
                    <a:extLst>
                      <a:ext uri="{FF2B5EF4-FFF2-40B4-BE49-F238E27FC236}">
                        <a16:creationId xmlns:a16="http://schemas.microsoft.com/office/drawing/2014/main" id="{1780BE16-F413-17C4-3E55-C1761401E2C0}"/>
                      </a:ext>
                    </a:extLst>
                  </p:cNvPr>
                  <p:cNvGrpSpPr/>
                  <p:nvPr/>
                </p:nvGrpSpPr>
                <p:grpSpPr>
                  <a:xfrm>
                    <a:off x="617655" y="613459"/>
                    <a:ext cx="742753" cy="69423"/>
                    <a:chOff x="2700216" y="4336724"/>
                    <a:chExt cx="934576" cy="69423"/>
                  </a:xfrm>
                </p:grpSpPr>
                <p:cxnSp>
                  <p:nvCxnSpPr>
                    <p:cNvPr id="155" name="Straight Connector 154">
                      <a:extLst>
                        <a:ext uri="{FF2B5EF4-FFF2-40B4-BE49-F238E27FC236}">
                          <a16:creationId xmlns:a16="http://schemas.microsoft.com/office/drawing/2014/main" id="{33D5CC27-E929-3722-DBA8-35976132A08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700216" y="4340430"/>
                      <a:ext cx="0" cy="65717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6" name="Straight Connector 155">
                      <a:extLst>
                        <a:ext uri="{FF2B5EF4-FFF2-40B4-BE49-F238E27FC236}">
                          <a16:creationId xmlns:a16="http://schemas.microsoft.com/office/drawing/2014/main" id="{A349F37E-C775-8315-2EDB-DC5445A946E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 flipV="1">
                      <a:off x="3166320" y="3906631"/>
                      <a:ext cx="1" cy="925897"/>
                    </a:xfrm>
                    <a:prstGeom prst="line">
                      <a:avLst/>
                    </a:prstGeom>
                    <a:ln w="12700" cap="sq">
                      <a:solidFill>
                        <a:schemeClr val="tx1"/>
                      </a:solidFill>
                      <a:headEnd type="none" w="sm" len="sm"/>
                      <a:tailEnd type="none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Straight Connector 156">
                      <a:extLst>
                        <a:ext uri="{FF2B5EF4-FFF2-40B4-BE49-F238E27FC236}">
                          <a16:creationId xmlns:a16="http://schemas.microsoft.com/office/drawing/2014/main" id="{DFA5CB18-B551-3421-C78A-878F077A89D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634792" y="4336724"/>
                      <a:ext cx="0" cy="65717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15E51815-0197-99EC-A38E-85D8520A8EB0}"/>
                  </a:ext>
                </a:extLst>
              </p:cNvPr>
              <p:cNvGrpSpPr/>
              <p:nvPr/>
            </p:nvGrpSpPr>
            <p:grpSpPr>
              <a:xfrm>
                <a:off x="7248417" y="4880246"/>
                <a:ext cx="2568367" cy="1077831"/>
                <a:chOff x="7251942" y="4743214"/>
                <a:chExt cx="2568367" cy="1077831"/>
              </a:xfrm>
            </p:grpSpPr>
            <p:grpSp>
              <p:nvGrpSpPr>
                <p:cNvPr id="183" name="Group 182">
                  <a:extLst>
                    <a:ext uri="{FF2B5EF4-FFF2-40B4-BE49-F238E27FC236}">
                      <a16:creationId xmlns:a16="http://schemas.microsoft.com/office/drawing/2014/main" id="{8A44EF66-3375-96CF-C35E-BAB55CABE5BD}"/>
                    </a:ext>
                  </a:extLst>
                </p:cNvPr>
                <p:cNvGrpSpPr/>
                <p:nvPr/>
              </p:nvGrpSpPr>
              <p:grpSpPr>
                <a:xfrm>
                  <a:off x="7251942" y="5303865"/>
                  <a:ext cx="1651381" cy="517180"/>
                  <a:chOff x="2933100" y="7993969"/>
                  <a:chExt cx="1651381" cy="517180"/>
                </a:xfrm>
              </p:grpSpPr>
              <p:sp>
                <p:nvSpPr>
                  <p:cNvPr id="199" name="TextBox 198">
                    <a:extLst>
                      <a:ext uri="{FF2B5EF4-FFF2-40B4-BE49-F238E27FC236}">
                        <a16:creationId xmlns:a16="http://schemas.microsoft.com/office/drawing/2014/main" id="{8394A7CF-98AC-7EBF-A840-6DBDA05EEA23}"/>
                      </a:ext>
                    </a:extLst>
                  </p:cNvPr>
                  <p:cNvSpPr txBox="1"/>
                  <p:nvPr/>
                </p:nvSpPr>
                <p:spPr>
                  <a:xfrm>
                    <a:off x="2933100" y="7993969"/>
                    <a:ext cx="165138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fferential Expression</a:t>
                    </a:r>
                  </a:p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z-score)</a:t>
                    </a:r>
                  </a:p>
                </p:txBody>
              </p:sp>
              <p:sp>
                <p:nvSpPr>
                  <p:cNvPr id="200" name="TextBox 199">
                    <a:extLst>
                      <a:ext uri="{FF2B5EF4-FFF2-40B4-BE49-F238E27FC236}">
                        <a16:creationId xmlns:a16="http://schemas.microsoft.com/office/drawing/2014/main" id="{7D261AF0-45A3-224D-F9C8-B9DFA13A2BA6}"/>
                      </a:ext>
                    </a:extLst>
                  </p:cNvPr>
                  <p:cNvSpPr txBox="1"/>
                  <p:nvPr/>
                </p:nvSpPr>
                <p:spPr>
                  <a:xfrm>
                    <a:off x="3640730" y="8311094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pic>
                <p:nvPicPr>
                  <p:cNvPr id="201" name="Picture 200" descr="A picture containing screenshot, text, colorfulness, diagram&#10;&#10;Description automatically generated">
                    <a:extLst>
                      <a:ext uri="{FF2B5EF4-FFF2-40B4-BE49-F238E27FC236}">
                        <a16:creationId xmlns:a16="http://schemas.microsoft.com/office/drawing/2014/main" id="{1403FBA6-CF09-6952-566E-E85BDB4508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3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 rot="5400000">
                    <a:off x="3758224" y="7859440"/>
                    <a:ext cx="77339" cy="954966"/>
                  </a:xfrm>
                  <a:prstGeom prst="rect">
                    <a:avLst/>
                  </a:prstGeom>
                </p:spPr>
              </p:pic>
              <p:sp>
                <p:nvSpPr>
                  <p:cNvPr id="202" name="TextBox 201">
                    <a:extLst>
                      <a:ext uri="{FF2B5EF4-FFF2-40B4-BE49-F238E27FC236}">
                        <a16:creationId xmlns:a16="http://schemas.microsoft.com/office/drawing/2014/main" id="{F12CEF3F-DF0E-2B38-6128-0470691B539F}"/>
                      </a:ext>
                    </a:extLst>
                  </p:cNvPr>
                  <p:cNvSpPr txBox="1"/>
                  <p:nvPr/>
                </p:nvSpPr>
                <p:spPr>
                  <a:xfrm>
                    <a:off x="3815911" y="8311094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03" name="TextBox 202">
                    <a:extLst>
                      <a:ext uri="{FF2B5EF4-FFF2-40B4-BE49-F238E27FC236}">
                        <a16:creationId xmlns:a16="http://schemas.microsoft.com/office/drawing/2014/main" id="{8D4FE25F-9894-395C-FF03-18B3E46E53C1}"/>
                      </a:ext>
                    </a:extLst>
                  </p:cNvPr>
                  <p:cNvSpPr txBox="1"/>
                  <p:nvPr/>
                </p:nvSpPr>
                <p:spPr>
                  <a:xfrm>
                    <a:off x="3453805" y="8311094"/>
                    <a:ext cx="26481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1</a:t>
                    </a:r>
                  </a:p>
                </p:txBody>
              </p:sp>
              <p:sp>
                <p:nvSpPr>
                  <p:cNvPr id="204" name="TextBox 203">
                    <a:extLst>
                      <a:ext uri="{FF2B5EF4-FFF2-40B4-BE49-F238E27FC236}">
                        <a16:creationId xmlns:a16="http://schemas.microsoft.com/office/drawing/2014/main" id="{7EAF9E2A-CFBC-C04D-DEC6-D4158FE744AB}"/>
                      </a:ext>
                    </a:extLst>
                  </p:cNvPr>
                  <p:cNvSpPr txBox="1"/>
                  <p:nvPr/>
                </p:nvSpPr>
                <p:spPr>
                  <a:xfrm>
                    <a:off x="3265924" y="8311094"/>
                    <a:ext cx="26481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2</a:t>
                    </a:r>
                  </a:p>
                </p:txBody>
              </p:sp>
              <p:sp>
                <p:nvSpPr>
                  <p:cNvPr id="205" name="TextBox 204">
                    <a:extLst>
                      <a:ext uri="{FF2B5EF4-FFF2-40B4-BE49-F238E27FC236}">
                        <a16:creationId xmlns:a16="http://schemas.microsoft.com/office/drawing/2014/main" id="{D387859D-0218-EA08-0773-23753FE38745}"/>
                      </a:ext>
                    </a:extLst>
                  </p:cNvPr>
                  <p:cNvSpPr txBox="1"/>
                  <p:nvPr/>
                </p:nvSpPr>
                <p:spPr>
                  <a:xfrm>
                    <a:off x="4004410" y="8307809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</p:grpSp>
            <p:grpSp>
              <p:nvGrpSpPr>
                <p:cNvPr id="184" name="Group 183">
                  <a:extLst>
                    <a:ext uri="{FF2B5EF4-FFF2-40B4-BE49-F238E27FC236}">
                      <a16:creationId xmlns:a16="http://schemas.microsoft.com/office/drawing/2014/main" id="{9613E5D5-A1C7-8DBF-869A-005FD22D6FF4}"/>
                    </a:ext>
                  </a:extLst>
                </p:cNvPr>
                <p:cNvGrpSpPr/>
                <p:nvPr/>
              </p:nvGrpSpPr>
              <p:grpSpPr>
                <a:xfrm>
                  <a:off x="8517841" y="5303460"/>
                  <a:ext cx="1302468" cy="514650"/>
                  <a:chOff x="2157112" y="8992761"/>
                  <a:chExt cx="1302468" cy="514650"/>
                </a:xfrm>
              </p:grpSpPr>
              <p:sp>
                <p:nvSpPr>
                  <p:cNvPr id="193" name="TextBox 192">
                    <a:extLst>
                      <a:ext uri="{FF2B5EF4-FFF2-40B4-BE49-F238E27FC236}">
                        <a16:creationId xmlns:a16="http://schemas.microsoft.com/office/drawing/2014/main" id="{65CB02E6-469A-AE9B-3301-3C617F16B35C}"/>
                      </a:ext>
                    </a:extLst>
                  </p:cNvPr>
                  <p:cNvSpPr txBox="1"/>
                  <p:nvPr/>
                </p:nvSpPr>
                <p:spPr>
                  <a:xfrm>
                    <a:off x="2157112" y="8992761"/>
                    <a:ext cx="1302468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CH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nding Sites</a:t>
                    </a:r>
                  </a:p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#)</a:t>
                    </a:r>
                  </a:p>
                </p:txBody>
              </p:sp>
              <p:sp>
                <p:nvSpPr>
                  <p:cNvPr id="194" name="TextBox 193">
                    <a:extLst>
                      <a:ext uri="{FF2B5EF4-FFF2-40B4-BE49-F238E27FC236}">
                        <a16:creationId xmlns:a16="http://schemas.microsoft.com/office/drawing/2014/main" id="{284832BB-BCA4-E844-A632-5EF11602D453}"/>
                      </a:ext>
                    </a:extLst>
                  </p:cNvPr>
                  <p:cNvSpPr txBox="1"/>
                  <p:nvPr/>
                </p:nvSpPr>
                <p:spPr>
                  <a:xfrm>
                    <a:off x="2425892" y="9307356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95" name="TextBox 194">
                    <a:extLst>
                      <a:ext uri="{FF2B5EF4-FFF2-40B4-BE49-F238E27FC236}">
                        <a16:creationId xmlns:a16="http://schemas.microsoft.com/office/drawing/2014/main" id="{DD4124A7-2678-E0D5-2823-1F9F495D835B}"/>
                      </a:ext>
                    </a:extLst>
                  </p:cNvPr>
                  <p:cNvSpPr txBox="1"/>
                  <p:nvPr/>
                </p:nvSpPr>
                <p:spPr>
                  <a:xfrm>
                    <a:off x="2603455" y="9307356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96" name="TextBox 195">
                    <a:extLst>
                      <a:ext uri="{FF2B5EF4-FFF2-40B4-BE49-F238E27FC236}">
                        <a16:creationId xmlns:a16="http://schemas.microsoft.com/office/drawing/2014/main" id="{93882186-F31F-ADE2-DEFF-39D2E7797134}"/>
                      </a:ext>
                    </a:extLst>
                  </p:cNvPr>
                  <p:cNvSpPr txBox="1"/>
                  <p:nvPr/>
                </p:nvSpPr>
                <p:spPr>
                  <a:xfrm>
                    <a:off x="2783790" y="9307356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pic>
                <p:nvPicPr>
                  <p:cNvPr id="197" name="Picture 196" descr="A picture containing screenshot, colorfulness, text, design&#10;&#10;Description automatically generated">
                    <a:extLst>
                      <a:ext uri="{FF2B5EF4-FFF2-40B4-BE49-F238E27FC236}">
                        <a16:creationId xmlns:a16="http://schemas.microsoft.com/office/drawing/2014/main" id="{8BFEAA74-7A56-31BB-263D-F767352C4BA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4" cstate="hqprint">
                    <a:clrChange>
                      <a:clrFrom>
                        <a:srgbClr val="FFFFFF"/>
                      </a:clrFrom>
                      <a:clrTo>
                        <a:srgbClr val="FFFFFF">
                          <a:alpha val="0"/>
                        </a:srgbClr>
                      </a:clrTo>
                    </a:clrChange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 rot="5400000">
                    <a:off x="2767900" y="8926500"/>
                    <a:ext cx="71577" cy="817484"/>
                  </a:xfrm>
                  <a:prstGeom prst="rect">
                    <a:avLst/>
                  </a:prstGeom>
                </p:spPr>
              </p:pic>
              <p:sp>
                <p:nvSpPr>
                  <p:cNvPr id="198" name="TextBox 197">
                    <a:extLst>
                      <a:ext uri="{FF2B5EF4-FFF2-40B4-BE49-F238E27FC236}">
                        <a16:creationId xmlns:a16="http://schemas.microsoft.com/office/drawing/2014/main" id="{6E3A0C95-7158-7FA7-A388-67B33F4562B1}"/>
                      </a:ext>
                    </a:extLst>
                  </p:cNvPr>
                  <p:cNvSpPr txBox="1"/>
                  <p:nvPr/>
                </p:nvSpPr>
                <p:spPr>
                  <a:xfrm>
                    <a:off x="2963734" y="9307356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</p:grpSp>
            <p:grpSp>
              <p:nvGrpSpPr>
                <p:cNvPr id="185" name="Group 184">
                  <a:extLst>
                    <a:ext uri="{FF2B5EF4-FFF2-40B4-BE49-F238E27FC236}">
                      <a16:creationId xmlns:a16="http://schemas.microsoft.com/office/drawing/2014/main" id="{19A92C5C-9D30-6EEB-E5EB-3423E45C050D}"/>
                    </a:ext>
                  </a:extLst>
                </p:cNvPr>
                <p:cNvGrpSpPr/>
                <p:nvPr/>
              </p:nvGrpSpPr>
              <p:grpSpPr>
                <a:xfrm>
                  <a:off x="7850692" y="4743214"/>
                  <a:ext cx="1592182" cy="515234"/>
                  <a:chOff x="1951631" y="7995134"/>
                  <a:chExt cx="1592182" cy="515234"/>
                </a:xfrm>
              </p:grpSpPr>
              <p:pic>
                <p:nvPicPr>
                  <p:cNvPr id="186" name="Picture 185" descr="A picture containing text, screenshot, colorfulness, diagram&#10;&#10;Description automatically generated">
                    <a:extLst>
                      <a:ext uri="{FF2B5EF4-FFF2-40B4-BE49-F238E27FC236}">
                        <a16:creationId xmlns:a16="http://schemas.microsoft.com/office/drawing/2014/main" id="{D84D21BB-339E-1200-09F7-7CBE616FD01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5" cstate="hqprint">
                    <a:clrChange>
                      <a:clrFrom>
                        <a:srgbClr val="FFFFFF"/>
                      </a:clrFrom>
                      <a:clrTo>
                        <a:srgbClr val="FFFFFF">
                          <a:alpha val="0"/>
                        </a:srgbClr>
                      </a:clrTo>
                    </a:clrChange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 rot="5400000">
                    <a:off x="2703866" y="7897740"/>
                    <a:ext cx="71579" cy="876299"/>
                  </a:xfrm>
                  <a:prstGeom prst="rect">
                    <a:avLst/>
                  </a:prstGeom>
                </p:spPr>
              </p:pic>
              <p:sp>
                <p:nvSpPr>
                  <p:cNvPr id="187" name="TextBox 186">
                    <a:extLst>
                      <a:ext uri="{FF2B5EF4-FFF2-40B4-BE49-F238E27FC236}">
                        <a16:creationId xmlns:a16="http://schemas.microsoft.com/office/drawing/2014/main" id="{4C0F1237-F510-5359-D43F-59A2D896EAB3}"/>
                      </a:ext>
                    </a:extLst>
                  </p:cNvPr>
                  <p:cNvSpPr txBox="1"/>
                  <p:nvPr/>
                </p:nvSpPr>
                <p:spPr>
                  <a:xfrm>
                    <a:off x="2635181" y="8310313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188" name="TextBox 187">
                    <a:extLst>
                      <a:ext uri="{FF2B5EF4-FFF2-40B4-BE49-F238E27FC236}">
                        <a16:creationId xmlns:a16="http://schemas.microsoft.com/office/drawing/2014/main" id="{4597D3A0-EF8E-D918-CC1E-4ABB25F061B2}"/>
                      </a:ext>
                    </a:extLst>
                  </p:cNvPr>
                  <p:cNvSpPr txBox="1"/>
                  <p:nvPr/>
                </p:nvSpPr>
                <p:spPr>
                  <a:xfrm>
                    <a:off x="2810362" y="8310313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89" name="TextBox 188">
                    <a:extLst>
                      <a:ext uri="{FF2B5EF4-FFF2-40B4-BE49-F238E27FC236}">
                        <a16:creationId xmlns:a16="http://schemas.microsoft.com/office/drawing/2014/main" id="{6D03F3A0-B5E3-B9C9-1E89-029D173E4D56}"/>
                      </a:ext>
                    </a:extLst>
                  </p:cNvPr>
                  <p:cNvSpPr txBox="1"/>
                  <p:nvPr/>
                </p:nvSpPr>
                <p:spPr>
                  <a:xfrm>
                    <a:off x="2448256" y="8310313"/>
                    <a:ext cx="26481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1</a:t>
                    </a:r>
                  </a:p>
                </p:txBody>
              </p:sp>
              <p:sp>
                <p:nvSpPr>
                  <p:cNvPr id="190" name="TextBox 189">
                    <a:extLst>
                      <a:ext uri="{FF2B5EF4-FFF2-40B4-BE49-F238E27FC236}">
                        <a16:creationId xmlns:a16="http://schemas.microsoft.com/office/drawing/2014/main" id="{F4032FA7-9D2F-1FAE-2F9F-3BEC3354E56D}"/>
                      </a:ext>
                    </a:extLst>
                  </p:cNvPr>
                  <p:cNvSpPr txBox="1"/>
                  <p:nvPr/>
                </p:nvSpPr>
                <p:spPr>
                  <a:xfrm>
                    <a:off x="2260375" y="8310313"/>
                    <a:ext cx="26481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2</a:t>
                    </a:r>
                  </a:p>
                </p:txBody>
              </p:sp>
              <p:sp>
                <p:nvSpPr>
                  <p:cNvPr id="191" name="TextBox 190">
                    <a:extLst>
                      <a:ext uri="{FF2B5EF4-FFF2-40B4-BE49-F238E27FC236}">
                        <a16:creationId xmlns:a16="http://schemas.microsoft.com/office/drawing/2014/main" id="{D7C81203-BE4A-1EBB-FA14-CEE83C50C12C}"/>
                      </a:ext>
                    </a:extLst>
                  </p:cNvPr>
                  <p:cNvSpPr txBox="1"/>
                  <p:nvPr/>
                </p:nvSpPr>
                <p:spPr>
                  <a:xfrm>
                    <a:off x="2997842" y="8310313"/>
                    <a:ext cx="234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92" name="TextBox 191">
                    <a:extLst>
                      <a:ext uri="{FF2B5EF4-FFF2-40B4-BE49-F238E27FC236}">
                        <a16:creationId xmlns:a16="http://schemas.microsoft.com/office/drawing/2014/main" id="{8CEF0259-F1BC-76F4-585C-41C013698063}"/>
                      </a:ext>
                    </a:extLst>
                  </p:cNvPr>
                  <p:cNvSpPr txBox="1"/>
                  <p:nvPr/>
                </p:nvSpPr>
                <p:spPr>
                  <a:xfrm>
                    <a:off x="1951631" y="7995134"/>
                    <a:ext cx="159218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 Type Expression</a:t>
                    </a:r>
                  </a:p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z-score)</a:t>
                    </a:r>
                  </a:p>
                </p:txBody>
              </p:sp>
            </p:grpSp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67A38B2-E890-4F54-9C7D-0B055B676F3E}"/>
                  </a:ext>
                </a:extLst>
              </p:cNvPr>
              <p:cNvSpPr txBox="1"/>
              <p:nvPr/>
            </p:nvSpPr>
            <p:spPr>
              <a:xfrm>
                <a:off x="5355505" y="5349529"/>
                <a:ext cx="197973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3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D17427E-2137-13D6-C264-38EEF122020A}"/>
                  </a:ext>
                </a:extLst>
              </p:cNvPr>
              <p:cNvSpPr txBox="1"/>
              <p:nvPr/>
            </p:nvSpPr>
            <p:spPr>
              <a:xfrm>
                <a:off x="-99060" y="2122319"/>
                <a:ext cx="117347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CH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1D7F40E-8E0C-574E-A137-A52518619E8D}"/>
                  </a:ext>
                </a:extLst>
              </p:cNvPr>
              <p:cNvSpPr txBox="1"/>
              <p:nvPr/>
            </p:nvSpPr>
            <p:spPr>
              <a:xfrm>
                <a:off x="384901" y="2021911"/>
                <a:ext cx="69206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hancer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56D45D5-7D2B-DF6B-134A-26EB2FECB6C4}"/>
                  </a:ext>
                </a:extLst>
              </p:cNvPr>
              <p:cNvSpPr txBox="1"/>
              <p:nvPr/>
            </p:nvSpPr>
            <p:spPr>
              <a:xfrm>
                <a:off x="384901" y="1918646"/>
                <a:ext cx="69206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moter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BD44A8A-7349-7683-6532-00D122761D7B}"/>
                  </a:ext>
                </a:extLst>
              </p:cNvPr>
              <p:cNvSpPr txBox="1"/>
              <p:nvPr/>
            </p:nvSpPr>
            <p:spPr>
              <a:xfrm>
                <a:off x="486310" y="2752708"/>
                <a:ext cx="5906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0F708AC-3838-BEE0-9588-710E61F32863}"/>
                  </a:ext>
                </a:extLst>
              </p:cNvPr>
              <p:cNvSpPr txBox="1"/>
              <p:nvPr/>
            </p:nvSpPr>
            <p:spPr>
              <a:xfrm>
                <a:off x="606715" y="2648648"/>
                <a:ext cx="47024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F072A0D-1121-6D1B-A8CB-3396684074A8}"/>
                  </a:ext>
                </a:extLst>
              </p:cNvPr>
              <p:cNvSpPr txBox="1"/>
              <p:nvPr/>
            </p:nvSpPr>
            <p:spPr>
              <a:xfrm>
                <a:off x="354326" y="2544589"/>
                <a:ext cx="72263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438EFE2-37BB-C279-6C04-3DF5FD0E7C31}"/>
                  </a:ext>
                </a:extLst>
              </p:cNvPr>
              <p:cNvSpPr txBox="1"/>
              <p:nvPr/>
            </p:nvSpPr>
            <p:spPr>
              <a:xfrm>
                <a:off x="417187" y="2440530"/>
                <a:ext cx="65977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8A13A10-558A-33FD-DAD4-369BD28B4F8E}"/>
                  </a:ext>
                </a:extLst>
              </p:cNvPr>
              <p:cNvSpPr txBox="1"/>
              <p:nvPr/>
            </p:nvSpPr>
            <p:spPr>
              <a:xfrm>
                <a:off x="606715" y="2334090"/>
                <a:ext cx="47024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A582A034-E1D9-3B08-C61B-2B9B32189752}"/>
                  </a:ext>
                </a:extLst>
              </p:cNvPr>
              <p:cNvSpPr txBox="1"/>
              <p:nvPr/>
            </p:nvSpPr>
            <p:spPr>
              <a:xfrm>
                <a:off x="606715" y="2232412"/>
                <a:ext cx="47024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319E6064-4C30-B817-72BB-F5B437CB6C41}"/>
                  </a:ext>
                </a:extLst>
              </p:cNvPr>
              <p:cNvGrpSpPr/>
              <p:nvPr/>
            </p:nvGrpSpPr>
            <p:grpSpPr>
              <a:xfrm rot="16200000">
                <a:off x="140043" y="2520821"/>
                <a:ext cx="578473" cy="237078"/>
                <a:chOff x="575233" y="455440"/>
                <a:chExt cx="835706" cy="227442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6FF29EF5-85CE-C437-E969-EA8D0CD3FD36}"/>
                    </a:ext>
                  </a:extLst>
                </p:cNvPr>
                <p:cNvSpPr txBox="1"/>
                <p:nvPr/>
              </p:nvSpPr>
              <p:spPr>
                <a:xfrm>
                  <a:off x="575233" y="455440"/>
                  <a:ext cx="835706" cy="1919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Type</a:t>
                  </a:r>
                </a:p>
              </p:txBody>
            </p:sp>
            <p:grpSp>
              <p:nvGrpSpPr>
                <p:cNvPr id="48" name="Group 47">
                  <a:extLst>
                    <a:ext uri="{FF2B5EF4-FFF2-40B4-BE49-F238E27FC236}">
                      <a16:creationId xmlns:a16="http://schemas.microsoft.com/office/drawing/2014/main" id="{4EF28D04-8218-4A63-856B-7ECABF80316B}"/>
                    </a:ext>
                  </a:extLst>
                </p:cNvPr>
                <p:cNvGrpSpPr/>
                <p:nvPr/>
              </p:nvGrpSpPr>
              <p:grpSpPr>
                <a:xfrm>
                  <a:off x="617655" y="613459"/>
                  <a:ext cx="742753" cy="69423"/>
                  <a:chOff x="2700216" y="4336724"/>
                  <a:chExt cx="934576" cy="69423"/>
                </a:xfrm>
              </p:grpSpPr>
              <p:cxnSp>
                <p:nvCxnSpPr>
                  <p:cNvPr id="49" name="Straight Connector 48">
                    <a:extLst>
                      <a:ext uri="{FF2B5EF4-FFF2-40B4-BE49-F238E27FC236}">
                        <a16:creationId xmlns:a16="http://schemas.microsoft.com/office/drawing/2014/main" id="{A8A6DE36-CCA3-CC5E-1CF4-D95E0CC6758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700216" y="4340430"/>
                    <a:ext cx="0" cy="657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Straight Connector 49">
                    <a:extLst>
                      <a:ext uri="{FF2B5EF4-FFF2-40B4-BE49-F238E27FC236}">
                        <a16:creationId xmlns:a16="http://schemas.microsoft.com/office/drawing/2014/main" id="{0FD73675-E949-04DA-9144-2DB79F8525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 flipV="1">
                    <a:off x="3166320" y="3906631"/>
                    <a:ext cx="1" cy="925897"/>
                  </a:xfrm>
                  <a:prstGeom prst="line">
                    <a:avLst/>
                  </a:prstGeom>
                  <a:ln w="12700" cap="sq">
                    <a:solidFill>
                      <a:schemeClr val="tx1"/>
                    </a:solidFill>
                    <a:headEnd type="none" w="sm" len="sm"/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Straight Connector 50">
                    <a:extLst>
                      <a:ext uri="{FF2B5EF4-FFF2-40B4-BE49-F238E27FC236}">
                        <a16:creationId xmlns:a16="http://schemas.microsoft.com/office/drawing/2014/main" id="{0743BA57-EF5D-F50C-9499-44F1E2BE90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34792" y="4336724"/>
                    <a:ext cx="0" cy="657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90D2AC77-8EEC-4C01-9437-0EFEECCB2303}"/>
                  </a:ext>
                </a:extLst>
              </p:cNvPr>
              <p:cNvSpPr txBox="1"/>
              <p:nvPr/>
            </p:nvSpPr>
            <p:spPr>
              <a:xfrm>
                <a:off x="-53340" y="3635715"/>
                <a:ext cx="112775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CH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365509A-7E69-2322-7AC0-3ADE917C983B}"/>
                  </a:ext>
                </a:extLst>
              </p:cNvPr>
              <p:cNvSpPr txBox="1"/>
              <p:nvPr/>
            </p:nvSpPr>
            <p:spPr>
              <a:xfrm>
                <a:off x="377281" y="3527687"/>
                <a:ext cx="69206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hancer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4641C1A-7B3B-5B88-1624-B6F958AAFD14}"/>
                  </a:ext>
                </a:extLst>
              </p:cNvPr>
              <p:cNvSpPr txBox="1"/>
              <p:nvPr/>
            </p:nvSpPr>
            <p:spPr>
              <a:xfrm>
                <a:off x="377281" y="3424422"/>
                <a:ext cx="69206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moter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652A8DD5-5DC0-7670-7694-23D5C1E67E52}"/>
                  </a:ext>
                </a:extLst>
              </p:cNvPr>
              <p:cNvSpPr txBox="1"/>
              <p:nvPr/>
            </p:nvSpPr>
            <p:spPr>
              <a:xfrm>
                <a:off x="478690" y="4258484"/>
                <a:ext cx="5906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64E04677-024B-8DFD-29AD-135BA0AAF88E}"/>
                  </a:ext>
                </a:extLst>
              </p:cNvPr>
              <p:cNvSpPr txBox="1"/>
              <p:nvPr/>
            </p:nvSpPr>
            <p:spPr>
              <a:xfrm>
                <a:off x="599095" y="4154424"/>
                <a:ext cx="47024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66BB3270-E577-FFF6-21CC-FA23FA461941}"/>
                  </a:ext>
                </a:extLst>
              </p:cNvPr>
              <p:cNvSpPr txBox="1"/>
              <p:nvPr/>
            </p:nvSpPr>
            <p:spPr>
              <a:xfrm>
                <a:off x="346706" y="4050365"/>
                <a:ext cx="72263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A2F262B4-17CC-3DA8-468A-A4CBF12106AD}"/>
                  </a:ext>
                </a:extLst>
              </p:cNvPr>
              <p:cNvSpPr txBox="1"/>
              <p:nvPr/>
            </p:nvSpPr>
            <p:spPr>
              <a:xfrm>
                <a:off x="409567" y="3946306"/>
                <a:ext cx="65977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12A2CD80-3CC7-CEE5-457B-ED4DC9FD64FE}"/>
                  </a:ext>
                </a:extLst>
              </p:cNvPr>
              <p:cNvSpPr txBox="1"/>
              <p:nvPr/>
            </p:nvSpPr>
            <p:spPr>
              <a:xfrm>
                <a:off x="599095" y="3839866"/>
                <a:ext cx="47024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397BC79-91FC-A113-D518-9FADF6307E2F}"/>
                  </a:ext>
                </a:extLst>
              </p:cNvPr>
              <p:cNvSpPr txBox="1"/>
              <p:nvPr/>
            </p:nvSpPr>
            <p:spPr>
              <a:xfrm>
                <a:off x="599095" y="3738188"/>
                <a:ext cx="47024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7137F8EA-8A3B-5B3E-1776-98C70D68DC64}"/>
                  </a:ext>
                </a:extLst>
              </p:cNvPr>
              <p:cNvGrpSpPr/>
              <p:nvPr/>
            </p:nvGrpSpPr>
            <p:grpSpPr>
              <a:xfrm rot="16200000">
                <a:off x="132423" y="4026597"/>
                <a:ext cx="578473" cy="237078"/>
                <a:chOff x="575233" y="455440"/>
                <a:chExt cx="835706" cy="227442"/>
              </a:xfrm>
            </p:grpSpPr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2B82DBE4-0FDF-9AA1-A9EC-70FDADD1F940}"/>
                    </a:ext>
                  </a:extLst>
                </p:cNvPr>
                <p:cNvSpPr txBox="1"/>
                <p:nvPr/>
              </p:nvSpPr>
              <p:spPr>
                <a:xfrm>
                  <a:off x="575233" y="455440"/>
                  <a:ext cx="835706" cy="1919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Type</a:t>
                  </a:r>
                </a:p>
              </p:txBody>
            </p:sp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CE07F998-79CF-4493-E565-446D50AC5A47}"/>
                    </a:ext>
                  </a:extLst>
                </p:cNvPr>
                <p:cNvGrpSpPr/>
                <p:nvPr/>
              </p:nvGrpSpPr>
              <p:grpSpPr>
                <a:xfrm>
                  <a:off x="617655" y="613459"/>
                  <a:ext cx="742753" cy="69423"/>
                  <a:chOff x="2700216" y="4336724"/>
                  <a:chExt cx="934576" cy="69423"/>
                </a:xfrm>
              </p:grpSpPr>
              <p:cxnSp>
                <p:nvCxnSpPr>
                  <p:cNvPr id="79" name="Straight Connector 78">
                    <a:extLst>
                      <a:ext uri="{FF2B5EF4-FFF2-40B4-BE49-F238E27FC236}">
                        <a16:creationId xmlns:a16="http://schemas.microsoft.com/office/drawing/2014/main" id="{3ED9DC04-EDD7-02B5-6AEC-5A004217CD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700216" y="4340430"/>
                    <a:ext cx="0" cy="657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" name="Straight Connector 79">
                    <a:extLst>
                      <a:ext uri="{FF2B5EF4-FFF2-40B4-BE49-F238E27FC236}">
                        <a16:creationId xmlns:a16="http://schemas.microsoft.com/office/drawing/2014/main" id="{0F660286-E197-7D34-2B2A-98E38E09249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 flipV="1">
                    <a:off x="3166320" y="3906631"/>
                    <a:ext cx="1" cy="925897"/>
                  </a:xfrm>
                  <a:prstGeom prst="line">
                    <a:avLst/>
                  </a:prstGeom>
                  <a:ln w="12700" cap="sq">
                    <a:solidFill>
                      <a:schemeClr val="tx1"/>
                    </a:solidFill>
                    <a:headEnd type="none" w="sm" len="sm"/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" name="Straight Connector 80">
                    <a:extLst>
                      <a:ext uri="{FF2B5EF4-FFF2-40B4-BE49-F238E27FC236}">
                        <a16:creationId xmlns:a16="http://schemas.microsoft.com/office/drawing/2014/main" id="{B3BF0B18-3C9A-04D0-95D0-2A383B13A8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34792" y="4336724"/>
                    <a:ext cx="0" cy="657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FFCC0D38-B2E2-923E-7532-DEE69F4F854E}"/>
                  </a:ext>
                </a:extLst>
              </p:cNvPr>
              <p:cNvGrpSpPr/>
              <p:nvPr/>
            </p:nvGrpSpPr>
            <p:grpSpPr>
              <a:xfrm>
                <a:off x="-38099" y="4904579"/>
                <a:ext cx="1115064" cy="1034117"/>
                <a:chOff x="-205739" y="431477"/>
                <a:chExt cx="1115064" cy="1034117"/>
              </a:xfrm>
            </p:grpSpPr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56F963AD-AF79-3F33-0EBA-033A9525650D}"/>
                    </a:ext>
                  </a:extLst>
                </p:cNvPr>
                <p:cNvSpPr txBox="1"/>
                <p:nvPr/>
              </p:nvSpPr>
              <p:spPr>
                <a:xfrm>
                  <a:off x="-205739" y="642770"/>
                  <a:ext cx="111506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CH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EGs</a:t>
                  </a:r>
                  <a:endParaRPr 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30C95872-67F9-C673-EFFD-3531B98FD653}"/>
                    </a:ext>
                  </a:extLst>
                </p:cNvPr>
                <p:cNvSpPr txBox="1"/>
                <p:nvPr/>
              </p:nvSpPr>
              <p:spPr>
                <a:xfrm>
                  <a:off x="217261" y="534742"/>
                  <a:ext cx="69206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hancer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25CFCA4D-9F99-FB19-15FD-101DA1E386C9}"/>
                    </a:ext>
                  </a:extLst>
                </p:cNvPr>
                <p:cNvSpPr txBox="1"/>
                <p:nvPr/>
              </p:nvSpPr>
              <p:spPr>
                <a:xfrm>
                  <a:off x="217261" y="431477"/>
                  <a:ext cx="69206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moter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39A2CA0D-E6F1-3EBF-81DA-3C76AD8B1C20}"/>
                    </a:ext>
                  </a:extLst>
                </p:cNvPr>
                <p:cNvSpPr txBox="1"/>
                <p:nvPr/>
              </p:nvSpPr>
              <p:spPr>
                <a:xfrm>
                  <a:off x="318670" y="1265539"/>
                  <a:ext cx="59065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RPC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5C2C5BC8-ACC3-D3EF-E0B8-5FB6E9DFCC69}"/>
                    </a:ext>
                  </a:extLst>
                </p:cNvPr>
                <p:cNvSpPr txBox="1"/>
                <p:nvPr/>
              </p:nvSpPr>
              <p:spPr>
                <a:xfrm>
                  <a:off x="439075" y="1161479"/>
                  <a:ext cx="4702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C</a:t>
                  </a: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9C96B177-286E-AEB9-39A3-A3EC6B047C01}"/>
                    </a:ext>
                  </a:extLst>
                </p:cNvPr>
                <p:cNvSpPr txBox="1"/>
                <p:nvPr/>
              </p:nvSpPr>
              <p:spPr>
                <a:xfrm>
                  <a:off x="186686" y="1057420"/>
                  <a:ext cx="72263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arly RGC</a:t>
                  </a:r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131FB4E3-E1C3-3A54-4B83-34DDD28EF35B}"/>
                    </a:ext>
                  </a:extLst>
                </p:cNvPr>
                <p:cNvSpPr txBox="1"/>
                <p:nvPr/>
              </p:nvSpPr>
              <p:spPr>
                <a:xfrm>
                  <a:off x="249547" y="953361"/>
                  <a:ext cx="65977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te RGC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AB369C16-CED5-AB9B-1789-CBF453507E93}"/>
                    </a:ext>
                  </a:extLst>
                </p:cNvPr>
                <p:cNvSpPr txBox="1"/>
                <p:nvPr/>
              </p:nvSpPr>
              <p:spPr>
                <a:xfrm>
                  <a:off x="439075" y="846921"/>
                  <a:ext cx="4702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&amp;A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56162EB9-F649-C0FD-9F42-4EBEB4BC348F}"/>
                    </a:ext>
                  </a:extLst>
                </p:cNvPr>
                <p:cNvSpPr txBox="1"/>
                <p:nvPr/>
              </p:nvSpPr>
              <p:spPr>
                <a:xfrm>
                  <a:off x="439075" y="745243"/>
                  <a:ext cx="4702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</a:t>
                  </a:r>
                </a:p>
              </p:txBody>
            </p:sp>
            <p:grpSp>
              <p:nvGrpSpPr>
                <p:cNvPr id="116" name="Group 115">
                  <a:extLst>
                    <a:ext uri="{FF2B5EF4-FFF2-40B4-BE49-F238E27FC236}">
                      <a16:creationId xmlns:a16="http://schemas.microsoft.com/office/drawing/2014/main" id="{66106899-3FBD-4A20-D610-4D3BE07060C9}"/>
                    </a:ext>
                  </a:extLst>
                </p:cNvPr>
                <p:cNvGrpSpPr/>
                <p:nvPr/>
              </p:nvGrpSpPr>
              <p:grpSpPr>
                <a:xfrm rot="16200000">
                  <a:off x="-27597" y="1033652"/>
                  <a:ext cx="578473" cy="237078"/>
                  <a:chOff x="575233" y="455440"/>
                  <a:chExt cx="835706" cy="227442"/>
                </a:xfrm>
              </p:grpSpPr>
              <p:sp>
                <p:nvSpPr>
                  <p:cNvPr id="117" name="TextBox 116">
                    <a:extLst>
                      <a:ext uri="{FF2B5EF4-FFF2-40B4-BE49-F238E27FC236}">
                        <a16:creationId xmlns:a16="http://schemas.microsoft.com/office/drawing/2014/main" id="{831348AE-83CD-93C9-7027-F0D73D505C25}"/>
                      </a:ext>
                    </a:extLst>
                  </p:cNvPr>
                  <p:cNvSpPr txBox="1"/>
                  <p:nvPr/>
                </p:nvSpPr>
                <p:spPr>
                  <a:xfrm>
                    <a:off x="575233" y="455440"/>
                    <a:ext cx="835706" cy="191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 Type</a:t>
                    </a:r>
                  </a:p>
                </p:txBody>
              </p:sp>
              <p:grpSp>
                <p:nvGrpSpPr>
                  <p:cNvPr id="118" name="Group 117">
                    <a:extLst>
                      <a:ext uri="{FF2B5EF4-FFF2-40B4-BE49-F238E27FC236}">
                        <a16:creationId xmlns:a16="http://schemas.microsoft.com/office/drawing/2014/main" id="{94B1EC62-2014-DEFA-C337-A850A16067EF}"/>
                      </a:ext>
                    </a:extLst>
                  </p:cNvPr>
                  <p:cNvGrpSpPr/>
                  <p:nvPr/>
                </p:nvGrpSpPr>
                <p:grpSpPr>
                  <a:xfrm>
                    <a:off x="617655" y="613459"/>
                    <a:ext cx="742753" cy="69423"/>
                    <a:chOff x="2700216" y="4336724"/>
                    <a:chExt cx="934576" cy="69423"/>
                  </a:xfrm>
                </p:grpSpPr>
                <p:cxnSp>
                  <p:nvCxnSpPr>
                    <p:cNvPr id="119" name="Straight Connector 118">
                      <a:extLst>
                        <a:ext uri="{FF2B5EF4-FFF2-40B4-BE49-F238E27FC236}">
                          <a16:creationId xmlns:a16="http://schemas.microsoft.com/office/drawing/2014/main" id="{BA19EECA-B703-A21D-0D61-1FD93E12F53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700216" y="4340430"/>
                      <a:ext cx="0" cy="65717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0" name="Straight Connector 119">
                      <a:extLst>
                        <a:ext uri="{FF2B5EF4-FFF2-40B4-BE49-F238E27FC236}">
                          <a16:creationId xmlns:a16="http://schemas.microsoft.com/office/drawing/2014/main" id="{CB196B76-C86E-24E8-79F6-00D8573F264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 flipV="1">
                      <a:off x="3166320" y="3906631"/>
                      <a:ext cx="1" cy="925897"/>
                    </a:xfrm>
                    <a:prstGeom prst="line">
                      <a:avLst/>
                    </a:prstGeom>
                    <a:ln w="12700" cap="sq">
                      <a:solidFill>
                        <a:schemeClr val="tx1"/>
                      </a:solidFill>
                      <a:headEnd type="none" w="sm" len="sm"/>
                      <a:tailEnd type="none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0" name="Straight Connector 129">
                      <a:extLst>
                        <a:ext uri="{FF2B5EF4-FFF2-40B4-BE49-F238E27FC236}">
                          <a16:creationId xmlns:a16="http://schemas.microsoft.com/office/drawing/2014/main" id="{ED20314A-AF23-3256-FBB9-758D4D3FD0F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634792" y="4336724"/>
                      <a:ext cx="0" cy="65717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val="262018182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958C4C2-29B9-0584-E029-EF6B6588F193}"/>
              </a:ext>
            </a:extLst>
          </p:cNvPr>
          <p:cNvGrpSpPr/>
          <p:nvPr/>
        </p:nvGrpSpPr>
        <p:grpSpPr>
          <a:xfrm>
            <a:off x="142875" y="8808"/>
            <a:ext cx="9544050" cy="6847674"/>
            <a:chOff x="142875" y="8808"/>
            <a:chExt cx="9544050" cy="6847674"/>
          </a:xfrm>
        </p:grpSpPr>
        <p:pic>
          <p:nvPicPr>
            <p:cNvPr id="5" name="Picture 4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7AFAE60C-1474-CCB9-E035-5F5AFA24CF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41118" y="1427384"/>
              <a:ext cx="1355071" cy="1095963"/>
            </a:xfrm>
            <a:prstGeom prst="rect">
              <a:avLst/>
            </a:prstGeom>
          </p:spPr>
        </p:pic>
        <p:pic>
          <p:nvPicPr>
            <p:cNvPr id="6" name="Picture 5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F12A13A2-5B25-C2BC-987C-6673962F5A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4413" y="1420790"/>
              <a:ext cx="1347933" cy="1102557"/>
            </a:xfrm>
            <a:prstGeom prst="rect">
              <a:avLst/>
            </a:prstGeom>
          </p:spPr>
        </p:pic>
        <p:pic>
          <p:nvPicPr>
            <p:cNvPr id="7" name="Picture 6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D837883F-73ED-8690-9D94-76BAD9EAEE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423" y="1424246"/>
              <a:ext cx="1355071" cy="1099101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F993C2A-E3DA-EF63-1553-72E4FC281D4E}"/>
                </a:ext>
              </a:extLst>
            </p:cNvPr>
            <p:cNvSpPr txBox="1"/>
            <p:nvPr/>
          </p:nvSpPr>
          <p:spPr>
            <a:xfrm rot="16200000">
              <a:off x="-154290" y="1833569"/>
              <a:ext cx="1102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FAP1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Picture 9" descr="A chart of different colored drops&#10;&#10;Description automatically generated">
              <a:extLst>
                <a:ext uri="{FF2B5EF4-FFF2-40B4-BE49-F238E27FC236}">
                  <a16:creationId xmlns:a16="http://schemas.microsoft.com/office/drawing/2014/main" id="{1DE128F7-0BC0-522A-71E5-CDF87F237F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4413" y="2534511"/>
              <a:ext cx="1353475" cy="1097610"/>
            </a:xfrm>
            <a:prstGeom prst="rect">
              <a:avLst/>
            </a:prstGeom>
          </p:spPr>
        </p:pic>
        <p:pic>
          <p:nvPicPr>
            <p:cNvPr id="11" name="Picture 10" descr="A chart of different colored drops&#10;&#10;Description automatically generated">
              <a:extLst>
                <a:ext uri="{FF2B5EF4-FFF2-40B4-BE49-F238E27FC236}">
                  <a16:creationId xmlns:a16="http://schemas.microsoft.com/office/drawing/2014/main" id="{7321EAD8-C4AD-32B4-23F3-78E3F02008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41118" y="2534511"/>
              <a:ext cx="1347933" cy="109761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613A0B8-7CA4-534E-1F7D-B976537FC061}"/>
                </a:ext>
              </a:extLst>
            </p:cNvPr>
            <p:cNvSpPr txBox="1"/>
            <p:nvPr/>
          </p:nvSpPr>
          <p:spPr>
            <a:xfrm rot="16200000">
              <a:off x="-151818" y="2944815"/>
              <a:ext cx="1097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SCL1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Picture 1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C251AE30-37B6-1D9F-1FE0-DB1A1F6272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423" y="2533021"/>
              <a:ext cx="1353475" cy="1099100"/>
            </a:xfrm>
            <a:prstGeom prst="rect">
              <a:avLst/>
            </a:prstGeom>
          </p:spPr>
        </p:pic>
        <p:pic>
          <p:nvPicPr>
            <p:cNvPr id="20" name="Picture 19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976443BD-0394-19AD-B59E-28FF947191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41118" y="318322"/>
              <a:ext cx="1358238" cy="1095963"/>
            </a:xfrm>
            <a:prstGeom prst="rect">
              <a:avLst/>
            </a:prstGeom>
          </p:spPr>
        </p:pic>
        <p:pic>
          <p:nvPicPr>
            <p:cNvPr id="21" name="Picture 20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EB9557FE-6149-6881-B880-862FFEC5FF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4413" y="318322"/>
              <a:ext cx="1355717" cy="1095963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50DF49E-C7CA-A2C3-1774-75AF02758809}"/>
                </a:ext>
              </a:extLst>
            </p:cNvPr>
            <p:cNvSpPr txBox="1"/>
            <p:nvPr/>
          </p:nvSpPr>
          <p:spPr>
            <a:xfrm rot="16200000">
              <a:off x="-154358" y="724440"/>
              <a:ext cx="11026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DAM11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Picture 2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5142CD15-AF4B-0E6F-79DA-0A91A2A5EF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-1"/>
            <a:stretch/>
          </p:blipFill>
          <p:spPr>
            <a:xfrm>
              <a:off x="559423" y="315089"/>
              <a:ext cx="1355717" cy="1099196"/>
            </a:xfrm>
            <a:prstGeom prst="rect">
              <a:avLst/>
            </a:prstGeom>
          </p:spPr>
        </p:pic>
        <p:pic>
          <p:nvPicPr>
            <p:cNvPr id="25" name="Picture 24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55FE181F-544C-00B0-ECEE-39C74DD778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4413" y="3632294"/>
              <a:ext cx="1349032" cy="1102372"/>
            </a:xfrm>
            <a:prstGeom prst="rect">
              <a:avLst/>
            </a:prstGeom>
          </p:spPr>
        </p:pic>
        <p:pic>
          <p:nvPicPr>
            <p:cNvPr id="26" name="Picture 25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9E31320D-5119-BBD2-9491-6933316C84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41118" y="3635469"/>
              <a:ext cx="1349529" cy="1099197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B59250E-5156-86CA-423B-2FD88920E823}"/>
                </a:ext>
              </a:extLst>
            </p:cNvPr>
            <p:cNvSpPr txBox="1"/>
            <p:nvPr/>
          </p:nvSpPr>
          <p:spPr>
            <a:xfrm rot="16200000">
              <a:off x="-154290" y="4044888"/>
              <a:ext cx="1102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BCL2L1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Picture 27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E79F97ED-F443-7ECC-631B-E7C412554F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423" y="3635470"/>
              <a:ext cx="1353399" cy="1099196"/>
            </a:xfrm>
            <a:prstGeom prst="rect">
              <a:avLst/>
            </a:prstGeom>
          </p:spPr>
        </p:pic>
        <p:pic>
          <p:nvPicPr>
            <p:cNvPr id="30" name="Picture 29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6C2FF8CA-A94E-882B-2B4A-2ED22C4D60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7547" y="311352"/>
              <a:ext cx="1355071" cy="1102933"/>
            </a:xfrm>
            <a:prstGeom prst="rect">
              <a:avLst/>
            </a:prstGeom>
          </p:spPr>
        </p:pic>
        <p:pic>
          <p:nvPicPr>
            <p:cNvPr id="31" name="Picture 30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4AAD51E7-979D-3569-E442-D797E7F14E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1595" y="311352"/>
              <a:ext cx="1355071" cy="1102933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A8D6BC0-5A55-28A1-9E5D-8C0B719CE5CE}"/>
                </a:ext>
              </a:extLst>
            </p:cNvPr>
            <p:cNvSpPr txBox="1"/>
            <p:nvPr/>
          </p:nvSpPr>
          <p:spPr>
            <a:xfrm rot="16200000">
              <a:off x="4680849" y="727804"/>
              <a:ext cx="1095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GF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3" name="Picture 32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7CE0054A-B2AE-5BB5-EBC7-182B577E31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90447" y="308214"/>
              <a:ext cx="1353268" cy="1106071"/>
            </a:xfrm>
            <a:prstGeom prst="rect">
              <a:avLst/>
            </a:prstGeom>
          </p:spPr>
        </p:pic>
        <p:pic>
          <p:nvPicPr>
            <p:cNvPr id="34" name="Picture 33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BE12F790-1803-98DB-D866-2FA075E57C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41118" y="4743812"/>
              <a:ext cx="1349529" cy="1095964"/>
            </a:xfrm>
            <a:prstGeom prst="rect">
              <a:avLst/>
            </a:prstGeom>
          </p:spPr>
        </p:pic>
        <p:pic>
          <p:nvPicPr>
            <p:cNvPr id="35" name="Picture 34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BD1BCD69-34C0-897A-D9EC-4D230D1EBB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4413" y="4743812"/>
              <a:ext cx="1355071" cy="1095964"/>
            </a:xfrm>
            <a:prstGeom prst="rect">
              <a:avLst/>
            </a:prstGeom>
          </p:spPr>
        </p:pic>
        <p:pic>
          <p:nvPicPr>
            <p:cNvPr id="36" name="Picture 35" descr="A chart of different colors&#10;&#10;Description automatically generated">
              <a:extLst>
                <a:ext uri="{FF2B5EF4-FFF2-40B4-BE49-F238E27FC236}">
                  <a16:creationId xmlns:a16="http://schemas.microsoft.com/office/drawing/2014/main" id="{285B9E56-CE86-5C73-3AC6-0996D2DE32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423" y="4743813"/>
              <a:ext cx="1353268" cy="1095963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8E63C94-6C27-8D3D-1C45-8F5CAC90C993}"/>
                </a:ext>
              </a:extLst>
            </p:cNvPr>
            <p:cNvSpPr txBox="1"/>
            <p:nvPr/>
          </p:nvSpPr>
          <p:spPr>
            <a:xfrm rot="16200000">
              <a:off x="-150993" y="5153295"/>
              <a:ext cx="1095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FNA4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Picture 39" descr="A chart of different colored drops&#10;&#10;Description automatically generated">
              <a:extLst>
                <a:ext uri="{FF2B5EF4-FFF2-40B4-BE49-F238E27FC236}">
                  <a16:creationId xmlns:a16="http://schemas.microsoft.com/office/drawing/2014/main" id="{15FFAD4C-E5BB-9CEB-5C78-7CA2012836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1595" y="1416271"/>
              <a:ext cx="1355071" cy="1107075"/>
            </a:xfrm>
            <a:prstGeom prst="rect">
              <a:avLst/>
            </a:prstGeom>
          </p:spPr>
        </p:pic>
        <p:pic>
          <p:nvPicPr>
            <p:cNvPr id="41" name="Picture 40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A7B86F20-2CBC-809B-0E1B-20E3E75C99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7547" y="1420790"/>
              <a:ext cx="1355071" cy="1102557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C5952D8-AD79-AEC8-BB32-6CE3D123BC25}"/>
                </a:ext>
              </a:extLst>
            </p:cNvPr>
            <p:cNvSpPr txBox="1"/>
            <p:nvPr/>
          </p:nvSpPr>
          <p:spPr>
            <a:xfrm rot="16200000">
              <a:off x="4677644" y="1833662"/>
              <a:ext cx="11023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YA2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Picture 4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C3A7ECF2-3F7C-F9FB-3B33-B8C354EBDF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90447" y="1417276"/>
              <a:ext cx="1353268" cy="1106071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97B6A72-D43B-4F7C-769F-3CB2D746083E}"/>
                </a:ext>
              </a:extLst>
            </p:cNvPr>
            <p:cNvSpPr txBox="1"/>
            <p:nvPr/>
          </p:nvSpPr>
          <p:spPr>
            <a:xfrm>
              <a:off x="559423" y="8808"/>
              <a:ext cx="13981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2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E502A88-7D72-3A70-AC9A-EB5442FED34F}"/>
                </a:ext>
              </a:extLst>
            </p:cNvPr>
            <p:cNvSpPr txBox="1"/>
            <p:nvPr/>
          </p:nvSpPr>
          <p:spPr>
            <a:xfrm>
              <a:off x="1954413" y="8808"/>
              <a:ext cx="13452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B3D5985-A06A-4099-17FE-0F985C190CB7}"/>
                </a:ext>
              </a:extLst>
            </p:cNvPr>
            <p:cNvSpPr txBox="1"/>
            <p:nvPr/>
          </p:nvSpPr>
          <p:spPr>
            <a:xfrm>
              <a:off x="3341118" y="8808"/>
              <a:ext cx="13532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1085814-993D-F40E-B5E3-D187380F92D2}"/>
                </a:ext>
              </a:extLst>
            </p:cNvPr>
            <p:cNvSpPr txBox="1"/>
            <p:nvPr/>
          </p:nvSpPr>
          <p:spPr>
            <a:xfrm>
              <a:off x="5390447" y="8808"/>
              <a:ext cx="13532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2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62C96C3-D536-822B-5B1B-BD997165D21E}"/>
                </a:ext>
              </a:extLst>
            </p:cNvPr>
            <p:cNvSpPr txBox="1"/>
            <p:nvPr/>
          </p:nvSpPr>
          <p:spPr>
            <a:xfrm>
              <a:off x="6777547" y="8808"/>
              <a:ext cx="13532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E61BEA6-38DB-DBE8-12C0-CE4F19F7EA98}"/>
                </a:ext>
              </a:extLst>
            </p:cNvPr>
            <p:cNvSpPr txBox="1"/>
            <p:nvPr/>
          </p:nvSpPr>
          <p:spPr>
            <a:xfrm>
              <a:off x="8161595" y="8808"/>
              <a:ext cx="13532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6E129F1-177B-929A-7B10-4875D76BA085}"/>
                </a:ext>
              </a:extLst>
            </p:cNvPr>
            <p:cNvSpPr txBox="1"/>
            <p:nvPr/>
          </p:nvSpPr>
          <p:spPr>
            <a:xfrm>
              <a:off x="142875" y="6271707"/>
              <a:ext cx="954405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11. Expression distribution of selected genes in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cell type-specific scRNA-seq clusters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.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Entire week-7 retinal organoids were analyzed by hybridization-based fixed RNA profiling. Violin plots show raw expression distribution in for cells originating from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organoids, </a:t>
              </a:r>
              <a:r>
                <a:rPr lang="en-US" sz="800" i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organoids, and WT organoid-derived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positive cells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b="1" baseline="300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+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. Each expressing cell is marked by a black point.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he representative cell clusters are defined as naïve retinal progenitor cells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transient retinal progeni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early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arly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late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ate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horizontal and amacrine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&amp;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and photorecep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.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knockout; </a:t>
              </a:r>
              <a:r>
                <a:rPr lang="en-US" sz="800" b="1" dirty="0" err="1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scRNA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seq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; single-cell RNA sequencing; 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wildtype.</a:t>
              </a:r>
              <a:endParaRPr lang="en-US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" name="Picture 54" descr="A graph of a cell set&#10;&#10;Description automatically generated with medium confidence">
              <a:extLst>
                <a:ext uri="{FF2B5EF4-FFF2-40B4-BE49-F238E27FC236}">
                  <a16:creationId xmlns:a16="http://schemas.microsoft.com/office/drawing/2014/main" id="{E5A2E50E-7CD6-73F3-AAA1-8F0745E53C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7547" y="2529188"/>
              <a:ext cx="1355071" cy="1102933"/>
            </a:xfrm>
            <a:prstGeom prst="rect">
              <a:avLst/>
            </a:prstGeom>
          </p:spPr>
        </p:pic>
        <p:pic>
          <p:nvPicPr>
            <p:cNvPr id="56" name="Picture 55" descr="A graph of a custom cell sets&#10;&#10;Description automatically generated">
              <a:extLst>
                <a:ext uri="{FF2B5EF4-FFF2-40B4-BE49-F238E27FC236}">
                  <a16:creationId xmlns:a16="http://schemas.microsoft.com/office/drawing/2014/main" id="{9D276128-B2DE-5E9B-03CA-3B6ECA7304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1595" y="2537444"/>
              <a:ext cx="1345962" cy="1094677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522F771-7AB8-3113-A790-52FEEAF39681}"/>
                </a:ext>
              </a:extLst>
            </p:cNvPr>
            <p:cNvSpPr txBox="1"/>
            <p:nvPr/>
          </p:nvSpPr>
          <p:spPr>
            <a:xfrm rot="16200000">
              <a:off x="4690367" y="2955159"/>
              <a:ext cx="10769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GF5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8" name="Picture 57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B1BCB979-FC5D-F51E-DD99-67DA2784A6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90447" y="2536157"/>
              <a:ext cx="1354087" cy="1095964"/>
            </a:xfrm>
            <a:prstGeom prst="rect">
              <a:avLst/>
            </a:prstGeom>
          </p:spPr>
        </p:pic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00F71EF4-04A8-0242-2935-B8838B1C07D5}"/>
                </a:ext>
              </a:extLst>
            </p:cNvPr>
            <p:cNvSpPr txBox="1"/>
            <p:nvPr/>
          </p:nvSpPr>
          <p:spPr>
            <a:xfrm rot="19500000">
              <a:off x="549162" y="5913610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E825D90C-11A8-CDF2-890C-D23AA21A6B69}"/>
                </a:ext>
              </a:extLst>
            </p:cNvPr>
            <p:cNvSpPr txBox="1"/>
            <p:nvPr/>
          </p:nvSpPr>
          <p:spPr>
            <a:xfrm rot="19500000">
              <a:off x="767959" y="5908146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D361FBAA-59AB-ABC5-3C29-5E81ABCA0BC5}"/>
                </a:ext>
              </a:extLst>
            </p:cNvPr>
            <p:cNvSpPr txBox="1"/>
            <p:nvPr/>
          </p:nvSpPr>
          <p:spPr>
            <a:xfrm rot="19500000">
              <a:off x="755531" y="5976970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6205BD4B-7AD9-A09D-052F-528A22C1CA29}"/>
                </a:ext>
              </a:extLst>
            </p:cNvPr>
            <p:cNvSpPr txBox="1"/>
            <p:nvPr/>
          </p:nvSpPr>
          <p:spPr>
            <a:xfrm rot="19500000">
              <a:off x="1002857" y="5963185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6FEBC70-73C6-08C4-0449-29FFB6307B3A}"/>
                </a:ext>
              </a:extLst>
            </p:cNvPr>
            <p:cNvSpPr txBox="1"/>
            <p:nvPr/>
          </p:nvSpPr>
          <p:spPr>
            <a:xfrm rot="19500000">
              <a:off x="1423414" y="5892353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ED7539C6-B481-9E99-DF57-3B6636367A3A}"/>
                </a:ext>
              </a:extLst>
            </p:cNvPr>
            <p:cNvSpPr txBox="1"/>
            <p:nvPr/>
          </p:nvSpPr>
          <p:spPr>
            <a:xfrm rot="19500000">
              <a:off x="1681886" y="5874124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pic>
          <p:nvPicPr>
            <p:cNvPr id="199" name="Picture 198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A2687CF5-C130-A859-88BE-C97C6A9A20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1595" y="3631710"/>
              <a:ext cx="1351408" cy="1102956"/>
            </a:xfrm>
            <a:prstGeom prst="rect">
              <a:avLst/>
            </a:prstGeom>
          </p:spPr>
        </p:pic>
        <p:pic>
          <p:nvPicPr>
            <p:cNvPr id="200" name="Picture 199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A65544D4-8B59-8EEB-A7B2-49EE199B3E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7547" y="3631711"/>
              <a:ext cx="1351408" cy="1102955"/>
            </a:xfrm>
            <a:prstGeom prst="rect">
              <a:avLst/>
            </a:prstGeom>
          </p:spPr>
        </p:pic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1BC9F2E5-BDDA-00A6-84DF-EE5FF87FA840}"/>
                </a:ext>
              </a:extLst>
            </p:cNvPr>
            <p:cNvSpPr txBox="1"/>
            <p:nvPr/>
          </p:nvSpPr>
          <p:spPr>
            <a:xfrm rot="16200000">
              <a:off x="4679674" y="4047010"/>
              <a:ext cx="10983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OXN4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2" name="Picture 201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1596AEB3-00E1-B487-F3D5-0FC658BCD9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90447" y="3631714"/>
              <a:ext cx="1351408" cy="1102952"/>
            </a:xfrm>
            <a:prstGeom prst="rect">
              <a:avLst/>
            </a:prstGeom>
          </p:spPr>
        </p:pic>
        <p:pic>
          <p:nvPicPr>
            <p:cNvPr id="203" name="Picture 20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00B40CF2-3691-184D-DF11-B4441018AF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7547" y="4737296"/>
              <a:ext cx="1351408" cy="1102480"/>
            </a:xfrm>
            <a:prstGeom prst="rect">
              <a:avLst/>
            </a:prstGeom>
          </p:spPr>
        </p:pic>
        <p:pic>
          <p:nvPicPr>
            <p:cNvPr id="204" name="Picture 203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F68A3FCB-492D-8628-F118-840974DE31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1595" y="4736820"/>
              <a:ext cx="1351408" cy="1102956"/>
            </a:xfrm>
            <a:prstGeom prst="rect">
              <a:avLst/>
            </a:prstGeom>
          </p:spPr>
        </p:pic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2F990BD4-61C1-50E1-B938-53F7667D89B3}"/>
                </a:ext>
              </a:extLst>
            </p:cNvPr>
            <p:cNvSpPr txBox="1"/>
            <p:nvPr/>
          </p:nvSpPr>
          <p:spPr>
            <a:xfrm rot="16200000">
              <a:off x="4674087" y="5146533"/>
              <a:ext cx="1109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ES2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6" name="Picture 205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609A42D3-D478-7905-F303-87952C35C8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90447" y="4742715"/>
              <a:ext cx="1351408" cy="1097061"/>
            </a:xfrm>
            <a:prstGeom prst="rect">
              <a:avLst/>
            </a:prstGeom>
          </p:spPr>
        </p:pic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DF224384-1EE7-66F5-1254-B835F93CCDF1}"/>
                </a:ext>
              </a:extLst>
            </p:cNvPr>
            <p:cNvSpPr txBox="1"/>
            <p:nvPr/>
          </p:nvSpPr>
          <p:spPr>
            <a:xfrm rot="19500000">
              <a:off x="1948728" y="5914317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DEA25516-7687-87EF-BDAD-0ACC385D54F1}"/>
                </a:ext>
              </a:extLst>
            </p:cNvPr>
            <p:cNvSpPr txBox="1"/>
            <p:nvPr/>
          </p:nvSpPr>
          <p:spPr>
            <a:xfrm rot="19500000">
              <a:off x="2167525" y="5908853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4768ACA8-0683-FEFD-6C4D-86EBFD120AEB}"/>
                </a:ext>
              </a:extLst>
            </p:cNvPr>
            <p:cNvSpPr txBox="1"/>
            <p:nvPr/>
          </p:nvSpPr>
          <p:spPr>
            <a:xfrm rot="19500000">
              <a:off x="2155097" y="5977677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3B667EA7-D422-CE73-222F-04BF8F0F9B19}"/>
                </a:ext>
              </a:extLst>
            </p:cNvPr>
            <p:cNvSpPr txBox="1"/>
            <p:nvPr/>
          </p:nvSpPr>
          <p:spPr>
            <a:xfrm rot="19500000">
              <a:off x="2402423" y="5963892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991FC2D1-9502-AC99-037F-43233E8D7BFF}"/>
                </a:ext>
              </a:extLst>
            </p:cNvPr>
            <p:cNvSpPr txBox="1"/>
            <p:nvPr/>
          </p:nvSpPr>
          <p:spPr>
            <a:xfrm rot="19500000">
              <a:off x="2822980" y="5893060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0AFFA537-93F1-90B9-DF7B-43804D5C85C2}"/>
                </a:ext>
              </a:extLst>
            </p:cNvPr>
            <p:cNvSpPr txBox="1"/>
            <p:nvPr/>
          </p:nvSpPr>
          <p:spPr>
            <a:xfrm rot="19500000">
              <a:off x="3081452" y="5874831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174E3C92-6601-BFCB-AA29-6D6EB727017D}"/>
                </a:ext>
              </a:extLst>
            </p:cNvPr>
            <p:cNvSpPr txBox="1"/>
            <p:nvPr/>
          </p:nvSpPr>
          <p:spPr>
            <a:xfrm rot="19500000">
              <a:off x="3329349" y="5905051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78F7F9A0-5A61-488D-F0FC-D57F48912C85}"/>
                </a:ext>
              </a:extLst>
            </p:cNvPr>
            <p:cNvSpPr txBox="1"/>
            <p:nvPr/>
          </p:nvSpPr>
          <p:spPr>
            <a:xfrm rot="19500000">
              <a:off x="3548146" y="5899587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C58AB1D0-E3B9-6EA6-7F0E-13EE21B96CDA}"/>
                </a:ext>
              </a:extLst>
            </p:cNvPr>
            <p:cNvSpPr txBox="1"/>
            <p:nvPr/>
          </p:nvSpPr>
          <p:spPr>
            <a:xfrm rot="19500000">
              <a:off x="3535718" y="5968411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35C96583-99A3-BEC8-F130-C99CE753F880}"/>
                </a:ext>
              </a:extLst>
            </p:cNvPr>
            <p:cNvSpPr txBox="1"/>
            <p:nvPr/>
          </p:nvSpPr>
          <p:spPr>
            <a:xfrm rot="19500000">
              <a:off x="3783044" y="5954626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CA3EB6E4-9DA2-9456-06B6-A8116C76A880}"/>
                </a:ext>
              </a:extLst>
            </p:cNvPr>
            <p:cNvSpPr txBox="1"/>
            <p:nvPr/>
          </p:nvSpPr>
          <p:spPr>
            <a:xfrm rot="19500000">
              <a:off x="4203601" y="5883794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6C1374FF-62F0-2B16-BE8F-63670DD2F2FF}"/>
                </a:ext>
              </a:extLst>
            </p:cNvPr>
            <p:cNvSpPr txBox="1"/>
            <p:nvPr/>
          </p:nvSpPr>
          <p:spPr>
            <a:xfrm rot="19500000">
              <a:off x="4462073" y="5865565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5509C554-3D19-65CD-473B-4C5C2B1590C9}"/>
                </a:ext>
              </a:extLst>
            </p:cNvPr>
            <p:cNvSpPr txBox="1"/>
            <p:nvPr/>
          </p:nvSpPr>
          <p:spPr>
            <a:xfrm rot="19500000">
              <a:off x="5380033" y="5914360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50964329-1404-424E-F90D-4387132B7D9B}"/>
                </a:ext>
              </a:extLst>
            </p:cNvPr>
            <p:cNvSpPr txBox="1"/>
            <p:nvPr/>
          </p:nvSpPr>
          <p:spPr>
            <a:xfrm rot="19500000">
              <a:off x="5598830" y="5908896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35329C17-A6A1-E930-9939-A5F817710603}"/>
                </a:ext>
              </a:extLst>
            </p:cNvPr>
            <p:cNvSpPr txBox="1"/>
            <p:nvPr/>
          </p:nvSpPr>
          <p:spPr>
            <a:xfrm rot="19500000">
              <a:off x="5586402" y="5977720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FB74F7DC-E73B-7A1B-F060-9E7DE5C59035}"/>
                </a:ext>
              </a:extLst>
            </p:cNvPr>
            <p:cNvSpPr txBox="1"/>
            <p:nvPr/>
          </p:nvSpPr>
          <p:spPr>
            <a:xfrm rot="19500000">
              <a:off x="5833728" y="5963935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64470BBA-FBDE-49D7-67AF-3DE73D763FD4}"/>
                </a:ext>
              </a:extLst>
            </p:cNvPr>
            <p:cNvSpPr txBox="1"/>
            <p:nvPr/>
          </p:nvSpPr>
          <p:spPr>
            <a:xfrm rot="19500000">
              <a:off x="6254285" y="5893103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1554727A-86A7-24E4-1A99-BEBA17B210F0}"/>
                </a:ext>
              </a:extLst>
            </p:cNvPr>
            <p:cNvSpPr txBox="1"/>
            <p:nvPr/>
          </p:nvSpPr>
          <p:spPr>
            <a:xfrm rot="19500000">
              <a:off x="6512757" y="5874874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DB2B7D64-D7B0-8AC2-E525-7ECAC2E8DB59}"/>
                </a:ext>
              </a:extLst>
            </p:cNvPr>
            <p:cNvSpPr txBox="1"/>
            <p:nvPr/>
          </p:nvSpPr>
          <p:spPr>
            <a:xfrm rot="19500000">
              <a:off x="6765312" y="5915067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263C3E3E-4EDA-376E-AB41-36FEADB3B9D7}"/>
                </a:ext>
              </a:extLst>
            </p:cNvPr>
            <p:cNvSpPr txBox="1"/>
            <p:nvPr/>
          </p:nvSpPr>
          <p:spPr>
            <a:xfrm rot="19500000">
              <a:off x="6984109" y="5909603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B4607DC8-A99B-F915-2FB8-FFABCC2B547F}"/>
                </a:ext>
              </a:extLst>
            </p:cNvPr>
            <p:cNvSpPr txBox="1"/>
            <p:nvPr/>
          </p:nvSpPr>
          <p:spPr>
            <a:xfrm rot="19500000">
              <a:off x="6971681" y="5976046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A15A3698-7DEB-90FA-4DA8-6D9B01A219FF}"/>
                </a:ext>
              </a:extLst>
            </p:cNvPr>
            <p:cNvSpPr txBox="1"/>
            <p:nvPr/>
          </p:nvSpPr>
          <p:spPr>
            <a:xfrm rot="19500000">
              <a:off x="7219007" y="5962261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334C7E75-CDEB-F251-92DB-5EF75515FA5B}"/>
                </a:ext>
              </a:extLst>
            </p:cNvPr>
            <p:cNvSpPr txBox="1"/>
            <p:nvPr/>
          </p:nvSpPr>
          <p:spPr>
            <a:xfrm rot="19500000">
              <a:off x="7639564" y="5893810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D7CD8C08-3671-CFBF-2EAD-D087ECF6050B}"/>
                </a:ext>
              </a:extLst>
            </p:cNvPr>
            <p:cNvSpPr txBox="1"/>
            <p:nvPr/>
          </p:nvSpPr>
          <p:spPr>
            <a:xfrm rot="19500000">
              <a:off x="7898036" y="5875581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A27F3E75-953F-F303-7C4C-D4157276309E}"/>
                </a:ext>
              </a:extLst>
            </p:cNvPr>
            <p:cNvSpPr txBox="1"/>
            <p:nvPr/>
          </p:nvSpPr>
          <p:spPr>
            <a:xfrm rot="19500000">
              <a:off x="8155458" y="5905801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B0C106CB-9D62-029A-460E-388683FC86C9}"/>
                </a:ext>
              </a:extLst>
            </p:cNvPr>
            <p:cNvSpPr txBox="1"/>
            <p:nvPr/>
          </p:nvSpPr>
          <p:spPr>
            <a:xfrm rot="19500000">
              <a:off x="8374255" y="5900337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6DD41F53-CD4F-B0B0-11CF-2AD06A5FA621}"/>
                </a:ext>
              </a:extLst>
            </p:cNvPr>
            <p:cNvSpPr txBox="1"/>
            <p:nvPr/>
          </p:nvSpPr>
          <p:spPr>
            <a:xfrm rot="19500000">
              <a:off x="8361827" y="5969161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EE055B90-E1C5-F64C-7E6E-5AC7A4F09BE4}"/>
                </a:ext>
              </a:extLst>
            </p:cNvPr>
            <p:cNvSpPr txBox="1"/>
            <p:nvPr/>
          </p:nvSpPr>
          <p:spPr>
            <a:xfrm rot="19500000">
              <a:off x="8609153" y="5955376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6C7EFE12-6766-5433-180A-2393ACBD0B40}"/>
                </a:ext>
              </a:extLst>
            </p:cNvPr>
            <p:cNvSpPr txBox="1"/>
            <p:nvPr/>
          </p:nvSpPr>
          <p:spPr>
            <a:xfrm rot="19500000">
              <a:off x="9029710" y="5884544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B1BC5532-3256-7247-B6C2-8E8737EDF6A5}"/>
                </a:ext>
              </a:extLst>
            </p:cNvPr>
            <p:cNvSpPr txBox="1"/>
            <p:nvPr/>
          </p:nvSpPr>
          <p:spPr>
            <a:xfrm rot="19500000">
              <a:off x="9288182" y="5866315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91233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230F323B-64A1-174D-6555-668CDB68151B}"/>
              </a:ext>
            </a:extLst>
          </p:cNvPr>
          <p:cNvGrpSpPr/>
          <p:nvPr/>
        </p:nvGrpSpPr>
        <p:grpSpPr>
          <a:xfrm>
            <a:off x="142875" y="11328"/>
            <a:ext cx="9544050" cy="6845154"/>
            <a:chOff x="142875" y="11328"/>
            <a:chExt cx="9544050" cy="6845154"/>
          </a:xfrm>
        </p:grpSpPr>
        <p:pic>
          <p:nvPicPr>
            <p:cNvPr id="15" name="Picture 14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21170992-6616-B823-BC62-D5F40A6FB8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2732" y="2505614"/>
              <a:ext cx="1351408" cy="1108973"/>
            </a:xfrm>
            <a:prstGeom prst="rect">
              <a:avLst/>
            </a:prstGeom>
          </p:spPr>
        </p:pic>
        <p:pic>
          <p:nvPicPr>
            <p:cNvPr id="16" name="Picture 15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EA59217C-0391-48BC-487F-03A169174A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38868" y="2508842"/>
              <a:ext cx="1351408" cy="1105745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CC68A0C-B275-1322-3BD5-EF8688F0E416}"/>
                </a:ext>
              </a:extLst>
            </p:cNvPr>
            <p:cNvSpPr txBox="1"/>
            <p:nvPr/>
          </p:nvSpPr>
          <p:spPr>
            <a:xfrm rot="16200000">
              <a:off x="-128139" y="2919961"/>
              <a:ext cx="11122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EYL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Picture 17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E7D508D0-D254-B59E-F9E8-C917A2AA2A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6702" y="2510025"/>
              <a:ext cx="1351408" cy="1104562"/>
            </a:xfrm>
            <a:prstGeom prst="rect">
              <a:avLst/>
            </a:prstGeom>
          </p:spPr>
        </p:pic>
        <p:pic>
          <p:nvPicPr>
            <p:cNvPr id="20" name="Picture 19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5B1B3CA1-A4CB-16F0-24C1-126C43B393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2732" y="1404164"/>
              <a:ext cx="1351408" cy="1098745"/>
            </a:xfrm>
            <a:prstGeom prst="rect">
              <a:avLst/>
            </a:prstGeom>
          </p:spPr>
        </p:pic>
        <p:pic>
          <p:nvPicPr>
            <p:cNvPr id="21" name="Picture 20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210B022E-80EF-227A-A5B1-496E41EBFC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38868" y="1399953"/>
              <a:ext cx="1351408" cy="1102956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D5CAB8F-FE22-02F1-EAC9-206661479A65}"/>
                </a:ext>
              </a:extLst>
            </p:cNvPr>
            <p:cNvSpPr txBox="1"/>
            <p:nvPr/>
          </p:nvSpPr>
          <p:spPr>
            <a:xfrm rot="16200000">
              <a:off x="-121385" y="1815036"/>
              <a:ext cx="10987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ES6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Picture 22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86158C69-75C7-B0C3-C694-E928B0AB35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6702" y="1402282"/>
              <a:ext cx="1351408" cy="1100627"/>
            </a:xfrm>
            <a:prstGeom prst="rect">
              <a:avLst/>
            </a:prstGeom>
          </p:spPr>
        </p:pic>
        <p:pic>
          <p:nvPicPr>
            <p:cNvPr id="30" name="Picture 29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B2C8D626-C375-EFC3-69B5-A5F72EBA53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2732" y="292005"/>
              <a:ext cx="1351408" cy="1106183"/>
            </a:xfrm>
            <a:prstGeom prst="rect">
              <a:avLst/>
            </a:prstGeom>
          </p:spPr>
        </p:pic>
        <p:pic>
          <p:nvPicPr>
            <p:cNvPr id="31" name="Picture 30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01F2D14F-E0F6-EE74-7CA8-96BB7A9049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38868" y="288580"/>
              <a:ext cx="1351408" cy="1109608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ED65D2A-0D99-C7DD-B175-1E8AED37DE5E}"/>
                </a:ext>
              </a:extLst>
            </p:cNvPr>
            <p:cNvSpPr txBox="1"/>
            <p:nvPr/>
          </p:nvSpPr>
          <p:spPr>
            <a:xfrm rot="16200000">
              <a:off x="-121171" y="710530"/>
              <a:ext cx="1098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ES5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3" name="Picture 32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2BA8CDCF-B2FC-9004-BD27-B05C24A72C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6702" y="295233"/>
              <a:ext cx="1351408" cy="1102955"/>
            </a:xfrm>
            <a:prstGeom prst="rect">
              <a:avLst/>
            </a:prstGeom>
          </p:spPr>
        </p:pic>
        <p:pic>
          <p:nvPicPr>
            <p:cNvPr id="35" name="Picture 34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C220C2B6-EA60-89A6-E21A-4A2147C9BD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2732" y="4720212"/>
              <a:ext cx="1354235" cy="1109485"/>
            </a:xfrm>
            <a:prstGeom prst="rect">
              <a:avLst/>
            </a:prstGeom>
          </p:spPr>
        </p:pic>
        <p:pic>
          <p:nvPicPr>
            <p:cNvPr id="36" name="Picture 35" descr="A chart of different colors&#10;&#10;Description automatically generated">
              <a:extLst>
                <a:ext uri="{FF2B5EF4-FFF2-40B4-BE49-F238E27FC236}">
                  <a16:creationId xmlns:a16="http://schemas.microsoft.com/office/drawing/2014/main" id="{30F8D3AB-C7A7-EB5C-1E28-9153B7CEC3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38868" y="4720212"/>
              <a:ext cx="1354451" cy="1109485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303C90A-DD2A-5FFB-B83C-874A544F2F88}"/>
                </a:ext>
              </a:extLst>
            </p:cNvPr>
            <p:cNvSpPr txBox="1"/>
            <p:nvPr/>
          </p:nvSpPr>
          <p:spPr>
            <a:xfrm rot="16200000">
              <a:off x="-107113" y="5156096"/>
              <a:ext cx="10702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IAA1217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8" name="Picture 37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FD01FBCD-2993-ACA9-BC96-07FAE9F358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6702" y="4723778"/>
              <a:ext cx="1354235" cy="1105919"/>
            </a:xfrm>
            <a:prstGeom prst="rect">
              <a:avLst/>
            </a:prstGeom>
          </p:spPr>
        </p:pic>
        <p:pic>
          <p:nvPicPr>
            <p:cNvPr id="40" name="Picture 39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9DC0B1F7-2885-861F-CA6E-E973DE31BB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38868" y="3617243"/>
              <a:ext cx="1359190" cy="1097912"/>
            </a:xfrm>
            <a:prstGeom prst="rect">
              <a:avLst/>
            </a:prstGeom>
          </p:spPr>
        </p:pic>
        <p:pic>
          <p:nvPicPr>
            <p:cNvPr id="41" name="Picture 40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58E35897-011C-6CDC-BE02-65FC1F8D35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2732" y="3617243"/>
              <a:ext cx="1354235" cy="1093627"/>
            </a:xfrm>
            <a:prstGeom prst="rect">
              <a:avLst/>
            </a:prstGeom>
          </p:spPr>
        </p:pic>
        <p:pic>
          <p:nvPicPr>
            <p:cNvPr id="42" name="Picture 41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0F374A11-5B6C-3E98-5220-74E1E39EA7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6702" y="3617596"/>
              <a:ext cx="1360412" cy="1102368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64F7BC9-14B2-C40F-42F8-44058BACAD8C}"/>
                </a:ext>
              </a:extLst>
            </p:cNvPr>
            <p:cNvSpPr txBox="1"/>
            <p:nvPr/>
          </p:nvSpPr>
          <p:spPr>
            <a:xfrm rot="16200000">
              <a:off x="-112093" y="4041383"/>
              <a:ext cx="1080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ISL1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E4AE68B-60BF-8507-7FEF-1AA38751F403}"/>
                </a:ext>
              </a:extLst>
            </p:cNvPr>
            <p:cNvSpPr txBox="1"/>
            <p:nvPr/>
          </p:nvSpPr>
          <p:spPr>
            <a:xfrm>
              <a:off x="566702" y="11328"/>
              <a:ext cx="1485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2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1444E46C-8F1D-D0C6-FC51-5585BF795DD7}"/>
                </a:ext>
              </a:extLst>
            </p:cNvPr>
            <p:cNvSpPr txBox="1"/>
            <p:nvPr/>
          </p:nvSpPr>
          <p:spPr>
            <a:xfrm>
              <a:off x="1952732" y="11328"/>
              <a:ext cx="14338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2D4FA77-4BCC-158D-B2E1-3A8362744423}"/>
                </a:ext>
              </a:extLst>
            </p:cNvPr>
            <p:cNvSpPr txBox="1"/>
            <p:nvPr/>
          </p:nvSpPr>
          <p:spPr>
            <a:xfrm>
              <a:off x="3338868" y="11328"/>
              <a:ext cx="13761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8932C3B-CF92-1F72-6D7C-64D58A9D023B}"/>
                </a:ext>
              </a:extLst>
            </p:cNvPr>
            <p:cNvSpPr txBox="1"/>
            <p:nvPr/>
          </p:nvSpPr>
          <p:spPr>
            <a:xfrm>
              <a:off x="5389515" y="11328"/>
              <a:ext cx="13514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2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D67EDA9-AE47-3402-21E2-CB83EE02CB47}"/>
                </a:ext>
              </a:extLst>
            </p:cNvPr>
            <p:cNvSpPr txBox="1"/>
            <p:nvPr/>
          </p:nvSpPr>
          <p:spPr>
            <a:xfrm>
              <a:off x="6778077" y="11328"/>
              <a:ext cx="14105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1FD13926-31AA-542B-D371-971C14E1035E}"/>
                </a:ext>
              </a:extLst>
            </p:cNvPr>
            <p:cNvSpPr txBox="1"/>
            <p:nvPr/>
          </p:nvSpPr>
          <p:spPr>
            <a:xfrm>
              <a:off x="8166843" y="11328"/>
              <a:ext cx="13514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pic>
          <p:nvPicPr>
            <p:cNvPr id="52" name="Picture 51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C0DD4816-B9CC-4322-14DA-79DCC91394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6843" y="288703"/>
              <a:ext cx="1354451" cy="1109485"/>
            </a:xfrm>
            <a:prstGeom prst="rect">
              <a:avLst/>
            </a:prstGeom>
          </p:spPr>
        </p:pic>
        <p:pic>
          <p:nvPicPr>
            <p:cNvPr id="53" name="Picture 5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84E6F57A-24B2-4677-3713-FE70AC31C0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8077" y="295472"/>
              <a:ext cx="1354235" cy="1102716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4FD4A89-11A6-ADE5-F0D3-FC1E6BE67E49}"/>
                </a:ext>
              </a:extLst>
            </p:cNvPr>
            <p:cNvSpPr txBox="1"/>
            <p:nvPr/>
          </p:nvSpPr>
          <p:spPr>
            <a:xfrm rot="16200000">
              <a:off x="4695620" y="710685"/>
              <a:ext cx="10980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DB3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" name="Picture 54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EB2D278F-36BE-DBF6-0581-7C87D7E2CB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9515" y="292269"/>
              <a:ext cx="1354235" cy="1105919"/>
            </a:xfrm>
            <a:prstGeom prst="rect">
              <a:avLst/>
            </a:prstGeom>
          </p:spPr>
        </p:pic>
        <p:pic>
          <p:nvPicPr>
            <p:cNvPr id="56" name="Picture 55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33236057-CA74-7C49-041C-467BED7F1D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8077" y="1393937"/>
              <a:ext cx="1354235" cy="1108972"/>
            </a:xfrm>
            <a:prstGeom prst="rect">
              <a:avLst/>
            </a:prstGeom>
          </p:spPr>
        </p:pic>
        <p:pic>
          <p:nvPicPr>
            <p:cNvPr id="57" name="Picture 56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24A996DC-D913-1B1D-B223-4EC67393E0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6843" y="1388902"/>
              <a:ext cx="1354451" cy="1114007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FBE75AB-EA56-E12E-CE94-3E3E9E1204F5}"/>
                </a:ext>
              </a:extLst>
            </p:cNvPr>
            <p:cNvSpPr txBox="1"/>
            <p:nvPr/>
          </p:nvSpPr>
          <p:spPr>
            <a:xfrm rot="16200000">
              <a:off x="4705842" y="1825627"/>
              <a:ext cx="10775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EUROD4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9" name="Picture 58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62095672-F773-2340-FF7A-ADE19D2850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9515" y="1391276"/>
              <a:ext cx="1354235" cy="1111633"/>
            </a:xfrm>
            <a:prstGeom prst="rect">
              <a:avLst/>
            </a:prstGeom>
          </p:spPr>
        </p:pic>
        <p:pic>
          <p:nvPicPr>
            <p:cNvPr id="60" name="Picture 59" descr="A chart with different colored shapes&#10;&#10;Description automatically generated">
              <a:extLst>
                <a:ext uri="{FF2B5EF4-FFF2-40B4-BE49-F238E27FC236}">
                  <a16:creationId xmlns:a16="http://schemas.microsoft.com/office/drawing/2014/main" id="{D4303A35-EB4B-79B5-AF22-2993CF83E2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8077" y="2508841"/>
              <a:ext cx="1354235" cy="1105746"/>
            </a:xfrm>
            <a:prstGeom prst="rect">
              <a:avLst/>
            </a:prstGeom>
          </p:spPr>
        </p:pic>
        <p:pic>
          <p:nvPicPr>
            <p:cNvPr id="61" name="Picture 60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1348DB16-3323-1CA3-96B7-CF57CF0693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6843" y="2505613"/>
              <a:ext cx="1354451" cy="1106563"/>
            </a:xfrm>
            <a:prstGeom prst="rect">
              <a:avLst/>
            </a:prstGeom>
          </p:spPr>
        </p:pic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5F3ABCC6-5EB0-2A48-9C86-828FA1B85396}"/>
                </a:ext>
              </a:extLst>
            </p:cNvPr>
            <p:cNvSpPr txBox="1"/>
            <p:nvPr/>
          </p:nvSpPr>
          <p:spPr>
            <a:xfrm rot="16200000">
              <a:off x="4708145" y="2939609"/>
              <a:ext cx="10729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EUROG1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Picture 62" descr="A chart with different colored shapes&#10;&#10;Description automatically generated">
              <a:extLst>
                <a:ext uri="{FF2B5EF4-FFF2-40B4-BE49-F238E27FC236}">
                  <a16:creationId xmlns:a16="http://schemas.microsoft.com/office/drawing/2014/main" id="{3D1C1C40-94A3-D8ED-42A8-683AF85092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9515" y="2507129"/>
              <a:ext cx="1354235" cy="1107458"/>
            </a:xfrm>
            <a:prstGeom prst="rect">
              <a:avLst/>
            </a:prstGeom>
          </p:spPr>
        </p:pic>
        <p:pic>
          <p:nvPicPr>
            <p:cNvPr id="113" name="Picture 11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F8839C70-0BD0-E6FB-8D0A-DCC0C2AA86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6843" y="3607199"/>
              <a:ext cx="1351415" cy="1112765"/>
            </a:xfrm>
            <a:prstGeom prst="rect">
              <a:avLst/>
            </a:prstGeom>
          </p:spPr>
        </p:pic>
        <p:pic>
          <p:nvPicPr>
            <p:cNvPr id="114" name="Picture 113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5DB9A714-1B46-B336-27BD-12704C42D2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8077" y="3613965"/>
              <a:ext cx="1351422" cy="1105999"/>
            </a:xfrm>
            <a:prstGeom prst="rect">
              <a:avLst/>
            </a:prstGeom>
          </p:spPr>
        </p:pic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475A225B-03C3-FBDB-6CCD-EF06363CF9F2}"/>
                </a:ext>
              </a:extLst>
            </p:cNvPr>
            <p:cNvSpPr txBox="1"/>
            <p:nvPr/>
          </p:nvSpPr>
          <p:spPr>
            <a:xfrm rot="16200000">
              <a:off x="4691624" y="4028465"/>
              <a:ext cx="1105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OTCH1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6" name="Picture 115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1C0B012F-16E7-9270-64F9-9C134C0C2E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9515" y="3613966"/>
              <a:ext cx="1351429" cy="1105998"/>
            </a:xfrm>
            <a:prstGeom prst="rect">
              <a:avLst/>
            </a:prstGeom>
          </p:spPr>
        </p:pic>
        <p:pic>
          <p:nvPicPr>
            <p:cNvPr id="117" name="Picture 116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FA18521D-E826-F3D8-5D1D-82F156F67F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66843" y="4723695"/>
              <a:ext cx="1351415" cy="1106002"/>
            </a:xfrm>
            <a:prstGeom prst="rect">
              <a:avLst/>
            </a:prstGeom>
          </p:spPr>
        </p:pic>
        <p:pic>
          <p:nvPicPr>
            <p:cNvPr id="118" name="Picture 117" descr="A chart of different colored drops&#10;&#10;Description automatically generated">
              <a:extLst>
                <a:ext uri="{FF2B5EF4-FFF2-40B4-BE49-F238E27FC236}">
                  <a16:creationId xmlns:a16="http://schemas.microsoft.com/office/drawing/2014/main" id="{12703AF6-7E75-FDAF-2871-379FF30747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78077" y="4715118"/>
              <a:ext cx="1351415" cy="1114580"/>
            </a:xfrm>
            <a:prstGeom prst="rect">
              <a:avLst/>
            </a:prstGeom>
          </p:spPr>
        </p:pic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36D2E6B2-6F61-AAC8-696C-9A7DD3325EA0}"/>
                </a:ext>
              </a:extLst>
            </p:cNvPr>
            <p:cNvSpPr txBox="1"/>
            <p:nvPr/>
          </p:nvSpPr>
          <p:spPr>
            <a:xfrm rot="16200000">
              <a:off x="4691623" y="5138197"/>
              <a:ext cx="1106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DE6B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0" name="Picture 119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56CD634D-E924-AEE5-BA24-B100EE9247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9515" y="4717248"/>
              <a:ext cx="1351415" cy="1112449"/>
            </a:xfrm>
            <a:prstGeom prst="rect">
              <a:avLst/>
            </a:prstGeom>
          </p:spPr>
        </p:pic>
        <p:grpSp>
          <p:nvGrpSpPr>
            <p:cNvPr id="218" name="Group 217">
              <a:extLst>
                <a:ext uri="{FF2B5EF4-FFF2-40B4-BE49-F238E27FC236}">
                  <a16:creationId xmlns:a16="http://schemas.microsoft.com/office/drawing/2014/main" id="{3A84283C-1AA6-AC5B-553A-6B53AC708706}"/>
                </a:ext>
              </a:extLst>
            </p:cNvPr>
            <p:cNvGrpSpPr/>
            <p:nvPr/>
          </p:nvGrpSpPr>
          <p:grpSpPr>
            <a:xfrm>
              <a:off x="549162" y="5868548"/>
              <a:ext cx="8903147" cy="235266"/>
              <a:chOff x="549162" y="5865565"/>
              <a:chExt cx="8903147" cy="235266"/>
            </a:xfrm>
          </p:grpSpPr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E8236528-83EC-94A0-4E60-F7BD0821CDE9}"/>
                  </a:ext>
                </a:extLst>
              </p:cNvPr>
              <p:cNvSpPr txBox="1"/>
              <p:nvPr/>
            </p:nvSpPr>
            <p:spPr>
              <a:xfrm rot="19500000">
                <a:off x="549162" y="5913610"/>
                <a:ext cx="30181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28B79C96-5332-B3A8-605E-3167B40AB0DC}"/>
                  </a:ext>
                </a:extLst>
              </p:cNvPr>
              <p:cNvSpPr txBox="1"/>
              <p:nvPr/>
            </p:nvSpPr>
            <p:spPr>
              <a:xfrm rot="19500000">
                <a:off x="767959" y="5908146"/>
                <a:ext cx="28276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2211F361-1B50-87D4-B443-607D433757B9}"/>
                  </a:ext>
                </a:extLst>
              </p:cNvPr>
              <p:cNvSpPr txBox="1"/>
              <p:nvPr/>
            </p:nvSpPr>
            <p:spPr>
              <a:xfrm rot="19500000">
                <a:off x="755531" y="5976970"/>
                <a:ext cx="51728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E8E28182-EA46-08AA-B72F-88440EA243C2}"/>
                  </a:ext>
                </a:extLst>
              </p:cNvPr>
              <p:cNvSpPr txBox="1"/>
              <p:nvPr/>
            </p:nvSpPr>
            <p:spPr>
              <a:xfrm rot="19500000">
                <a:off x="1002857" y="5963185"/>
                <a:ext cx="46921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D7086B79-A7E0-CA2A-1627-5300003614C3}"/>
                  </a:ext>
                </a:extLst>
              </p:cNvPr>
              <p:cNvSpPr txBox="1"/>
              <p:nvPr/>
            </p:nvSpPr>
            <p:spPr>
              <a:xfrm rot="19500000">
                <a:off x="1423414" y="5892353"/>
                <a:ext cx="22769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5BDFDD1F-BC27-CFB6-BA97-5F568BD9B55B}"/>
                  </a:ext>
                </a:extLst>
              </p:cNvPr>
              <p:cNvSpPr txBox="1"/>
              <p:nvPr/>
            </p:nvSpPr>
            <p:spPr>
              <a:xfrm rot="19500000">
                <a:off x="1681886" y="5874124"/>
                <a:ext cx="16412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10CF0214-A5B3-F975-C966-B7FD2CC77448}"/>
                  </a:ext>
                </a:extLst>
              </p:cNvPr>
              <p:cNvSpPr txBox="1"/>
              <p:nvPr/>
            </p:nvSpPr>
            <p:spPr>
              <a:xfrm rot="19500000">
                <a:off x="1948728" y="5914317"/>
                <a:ext cx="30181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B7704B22-936C-E6B2-4A9F-D85855718792}"/>
                  </a:ext>
                </a:extLst>
              </p:cNvPr>
              <p:cNvSpPr txBox="1"/>
              <p:nvPr/>
            </p:nvSpPr>
            <p:spPr>
              <a:xfrm rot="19500000">
                <a:off x="2167525" y="5908853"/>
                <a:ext cx="28276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0CEC655C-D2C7-5081-68C9-BE8911B92668}"/>
                  </a:ext>
                </a:extLst>
              </p:cNvPr>
              <p:cNvSpPr txBox="1"/>
              <p:nvPr/>
            </p:nvSpPr>
            <p:spPr>
              <a:xfrm rot="19500000">
                <a:off x="2155097" y="5977677"/>
                <a:ext cx="51728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2259808C-1A7A-DCF4-F365-FEA71258F3ED}"/>
                  </a:ext>
                </a:extLst>
              </p:cNvPr>
              <p:cNvSpPr txBox="1"/>
              <p:nvPr/>
            </p:nvSpPr>
            <p:spPr>
              <a:xfrm rot="19500000">
                <a:off x="2402423" y="5963892"/>
                <a:ext cx="46921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00B5E8B3-705E-60BC-FDEB-020F5D2086CA}"/>
                  </a:ext>
                </a:extLst>
              </p:cNvPr>
              <p:cNvSpPr txBox="1"/>
              <p:nvPr/>
            </p:nvSpPr>
            <p:spPr>
              <a:xfrm rot="19500000">
                <a:off x="2822980" y="5893060"/>
                <a:ext cx="22769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B1E24818-ECF8-0D28-90A2-8E72862E445A}"/>
                  </a:ext>
                </a:extLst>
              </p:cNvPr>
              <p:cNvSpPr txBox="1"/>
              <p:nvPr/>
            </p:nvSpPr>
            <p:spPr>
              <a:xfrm rot="19500000">
                <a:off x="3081452" y="5874831"/>
                <a:ext cx="16412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BDA23046-3907-71DB-B303-DD8F8F85C66C}"/>
                  </a:ext>
                </a:extLst>
              </p:cNvPr>
              <p:cNvSpPr txBox="1"/>
              <p:nvPr/>
            </p:nvSpPr>
            <p:spPr>
              <a:xfrm rot="19500000">
                <a:off x="3329349" y="5905051"/>
                <a:ext cx="30181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276E1346-F1FB-FB9E-EDB7-225E3FB550AA}"/>
                  </a:ext>
                </a:extLst>
              </p:cNvPr>
              <p:cNvSpPr txBox="1"/>
              <p:nvPr/>
            </p:nvSpPr>
            <p:spPr>
              <a:xfrm rot="19500000">
                <a:off x="3548146" y="5899587"/>
                <a:ext cx="28276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D78AD0F1-7A5C-70CC-5E5C-8EDA3A82B964}"/>
                  </a:ext>
                </a:extLst>
              </p:cNvPr>
              <p:cNvSpPr txBox="1"/>
              <p:nvPr/>
            </p:nvSpPr>
            <p:spPr>
              <a:xfrm rot="19500000">
                <a:off x="3535718" y="5968411"/>
                <a:ext cx="51728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197" name="TextBox 196">
                <a:extLst>
                  <a:ext uri="{FF2B5EF4-FFF2-40B4-BE49-F238E27FC236}">
                    <a16:creationId xmlns:a16="http://schemas.microsoft.com/office/drawing/2014/main" id="{B7CAA5C1-A20D-33E6-BFB0-487D33D1BA0F}"/>
                  </a:ext>
                </a:extLst>
              </p:cNvPr>
              <p:cNvSpPr txBox="1"/>
              <p:nvPr/>
            </p:nvSpPr>
            <p:spPr>
              <a:xfrm rot="19500000">
                <a:off x="3783044" y="5954626"/>
                <a:ext cx="46921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id="{A3580AC9-C5F2-D0CC-9403-B789D2057E20}"/>
                  </a:ext>
                </a:extLst>
              </p:cNvPr>
              <p:cNvSpPr txBox="1"/>
              <p:nvPr/>
            </p:nvSpPr>
            <p:spPr>
              <a:xfrm rot="19500000">
                <a:off x="4203601" y="5883794"/>
                <a:ext cx="22769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E484CED3-C3FE-CE0B-AF34-E5D4331FCC09}"/>
                  </a:ext>
                </a:extLst>
              </p:cNvPr>
              <p:cNvSpPr txBox="1"/>
              <p:nvPr/>
            </p:nvSpPr>
            <p:spPr>
              <a:xfrm rot="19500000">
                <a:off x="4462073" y="5865565"/>
                <a:ext cx="16412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CE607658-7B99-3496-D31C-F989CB33680F}"/>
                  </a:ext>
                </a:extLst>
              </p:cNvPr>
              <p:cNvSpPr txBox="1"/>
              <p:nvPr/>
            </p:nvSpPr>
            <p:spPr>
              <a:xfrm rot="19500000">
                <a:off x="5380033" y="5914360"/>
                <a:ext cx="30181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1DC901C6-A85A-CBE5-09A0-E49867A51466}"/>
                  </a:ext>
                </a:extLst>
              </p:cNvPr>
              <p:cNvSpPr txBox="1"/>
              <p:nvPr/>
            </p:nvSpPr>
            <p:spPr>
              <a:xfrm rot="19500000">
                <a:off x="5598830" y="5908896"/>
                <a:ext cx="28276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5C241D98-9B13-BD6E-2D2D-8A87AB96C830}"/>
                  </a:ext>
                </a:extLst>
              </p:cNvPr>
              <p:cNvSpPr txBox="1"/>
              <p:nvPr/>
            </p:nvSpPr>
            <p:spPr>
              <a:xfrm rot="19500000">
                <a:off x="5586402" y="5977720"/>
                <a:ext cx="51728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6CA98F02-7B90-6865-02E6-349038712219}"/>
                  </a:ext>
                </a:extLst>
              </p:cNvPr>
              <p:cNvSpPr txBox="1"/>
              <p:nvPr/>
            </p:nvSpPr>
            <p:spPr>
              <a:xfrm rot="19500000">
                <a:off x="5833728" y="5963935"/>
                <a:ext cx="46921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F573DB1D-BE02-D2E0-00FF-DC7662F12078}"/>
                  </a:ext>
                </a:extLst>
              </p:cNvPr>
              <p:cNvSpPr txBox="1"/>
              <p:nvPr/>
            </p:nvSpPr>
            <p:spPr>
              <a:xfrm rot="19500000">
                <a:off x="6254285" y="5893103"/>
                <a:ext cx="22769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26C0F99E-B489-157B-1F90-92C223A63C1C}"/>
                  </a:ext>
                </a:extLst>
              </p:cNvPr>
              <p:cNvSpPr txBox="1"/>
              <p:nvPr/>
            </p:nvSpPr>
            <p:spPr>
              <a:xfrm rot="19500000">
                <a:off x="6512757" y="5874874"/>
                <a:ext cx="16412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7C889CAE-639F-A86F-B46A-6FFBC9CFD110}"/>
                  </a:ext>
                </a:extLst>
              </p:cNvPr>
              <p:cNvSpPr txBox="1"/>
              <p:nvPr/>
            </p:nvSpPr>
            <p:spPr>
              <a:xfrm rot="19500000">
                <a:off x="6765312" y="5915067"/>
                <a:ext cx="30181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826012FC-22FF-3316-8BCF-93A6BC833AE2}"/>
                  </a:ext>
                </a:extLst>
              </p:cNvPr>
              <p:cNvSpPr txBox="1"/>
              <p:nvPr/>
            </p:nvSpPr>
            <p:spPr>
              <a:xfrm rot="19500000">
                <a:off x="6984109" y="5909603"/>
                <a:ext cx="28276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2E63BA03-E8EF-413E-06F6-92681A1066BE}"/>
                  </a:ext>
                </a:extLst>
              </p:cNvPr>
              <p:cNvSpPr txBox="1"/>
              <p:nvPr/>
            </p:nvSpPr>
            <p:spPr>
              <a:xfrm rot="19500000">
                <a:off x="6971681" y="5976046"/>
                <a:ext cx="51728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519596FD-1BBB-3392-4660-868813A0D366}"/>
                  </a:ext>
                </a:extLst>
              </p:cNvPr>
              <p:cNvSpPr txBox="1"/>
              <p:nvPr/>
            </p:nvSpPr>
            <p:spPr>
              <a:xfrm rot="19500000">
                <a:off x="7219007" y="5962261"/>
                <a:ext cx="46921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210" name="TextBox 209">
                <a:extLst>
                  <a:ext uri="{FF2B5EF4-FFF2-40B4-BE49-F238E27FC236}">
                    <a16:creationId xmlns:a16="http://schemas.microsoft.com/office/drawing/2014/main" id="{F932C9DB-C378-90F2-D043-CFCAA42D15D5}"/>
                  </a:ext>
                </a:extLst>
              </p:cNvPr>
              <p:cNvSpPr txBox="1"/>
              <p:nvPr/>
            </p:nvSpPr>
            <p:spPr>
              <a:xfrm rot="19500000">
                <a:off x="7639564" y="5893810"/>
                <a:ext cx="22769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E311C619-6AD3-BF0D-8988-EE0F47393C4C}"/>
                  </a:ext>
                </a:extLst>
              </p:cNvPr>
              <p:cNvSpPr txBox="1"/>
              <p:nvPr/>
            </p:nvSpPr>
            <p:spPr>
              <a:xfrm rot="19500000">
                <a:off x="7898036" y="5875581"/>
                <a:ext cx="16412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00290379-D25C-8B28-EEC2-B2FAEFBC4328}"/>
                  </a:ext>
                </a:extLst>
              </p:cNvPr>
              <p:cNvSpPr txBox="1"/>
              <p:nvPr/>
            </p:nvSpPr>
            <p:spPr>
              <a:xfrm rot="19500000">
                <a:off x="8155458" y="5905801"/>
                <a:ext cx="30181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12533DA2-3C88-E17C-6E0B-53C254F7C9D3}"/>
                  </a:ext>
                </a:extLst>
              </p:cNvPr>
              <p:cNvSpPr txBox="1"/>
              <p:nvPr/>
            </p:nvSpPr>
            <p:spPr>
              <a:xfrm rot="19500000">
                <a:off x="8374255" y="5900337"/>
                <a:ext cx="28276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A0A6E052-BAA3-27C0-C107-F4B0EF4C3D78}"/>
                  </a:ext>
                </a:extLst>
              </p:cNvPr>
              <p:cNvSpPr txBox="1"/>
              <p:nvPr/>
            </p:nvSpPr>
            <p:spPr>
              <a:xfrm rot="19500000">
                <a:off x="8361827" y="5969161"/>
                <a:ext cx="51728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A970F262-B413-5D1E-A585-6E5474B7F25D}"/>
                  </a:ext>
                </a:extLst>
              </p:cNvPr>
              <p:cNvSpPr txBox="1"/>
              <p:nvPr/>
            </p:nvSpPr>
            <p:spPr>
              <a:xfrm rot="19500000">
                <a:off x="8609153" y="5955376"/>
                <a:ext cx="469215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538B47F6-7091-877B-7F8A-3F12273610A1}"/>
                  </a:ext>
                </a:extLst>
              </p:cNvPr>
              <p:cNvSpPr txBox="1"/>
              <p:nvPr/>
            </p:nvSpPr>
            <p:spPr>
              <a:xfrm rot="19500000">
                <a:off x="9029710" y="5884544"/>
                <a:ext cx="22769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F40B6A7B-253C-1784-488E-5221DF076AFE}"/>
                  </a:ext>
                </a:extLst>
              </p:cNvPr>
              <p:cNvSpPr txBox="1"/>
              <p:nvPr/>
            </p:nvSpPr>
            <p:spPr>
              <a:xfrm rot="19500000">
                <a:off x="9288182" y="5866315"/>
                <a:ext cx="164127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48E4839-0F1F-63AD-D8A4-F369A8751184}"/>
                </a:ext>
              </a:extLst>
            </p:cNvPr>
            <p:cNvSpPr txBox="1"/>
            <p:nvPr/>
          </p:nvSpPr>
          <p:spPr>
            <a:xfrm>
              <a:off x="142875" y="6271707"/>
              <a:ext cx="954405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11 continued. Expression distribution of selected genes in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cell type-specific scRNA-seq clusters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.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Entire week-7 retinal organoids were analyzed by hybridization-based fixed RNA profiling. Violin plots show raw expression distribution in for cells originating from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organoids, </a:t>
              </a:r>
              <a:r>
                <a:rPr lang="en-US" sz="800" i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organoids, and WT organoid-derived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positive cells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b="1" baseline="300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+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. Each expressing cell is marked by a black point.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he representative cell clusters are defined as naïve retinal progenitor cells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transient retinal progeni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early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arly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late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ate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horizontal and amacrine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&amp;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and photorecep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.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knockout; </a:t>
              </a:r>
              <a:r>
                <a:rPr lang="en-US" sz="800" b="1" dirty="0" err="1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scRNA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seq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; single-cell RNA sequencing; 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wildtype.</a:t>
              </a:r>
              <a:endParaRPr lang="en-US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7039787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40860BC-399E-F35A-5F47-C6A6C1247262}"/>
              </a:ext>
            </a:extLst>
          </p:cNvPr>
          <p:cNvGrpSpPr/>
          <p:nvPr/>
        </p:nvGrpSpPr>
        <p:grpSpPr>
          <a:xfrm>
            <a:off x="142875" y="-4106"/>
            <a:ext cx="9544050" cy="6860588"/>
            <a:chOff x="142875" y="-4106"/>
            <a:chExt cx="9544050" cy="6860588"/>
          </a:xfrm>
        </p:grpSpPr>
        <p:pic>
          <p:nvPicPr>
            <p:cNvPr id="35" name="Picture 34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0DF832AD-BCE5-0D7E-10D0-90C71EF837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607" y="279657"/>
              <a:ext cx="1351434" cy="1099446"/>
            </a:xfrm>
            <a:prstGeom prst="rect">
              <a:avLst/>
            </a:prstGeom>
          </p:spPr>
        </p:pic>
        <p:pic>
          <p:nvPicPr>
            <p:cNvPr id="36" name="Picture 35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97E4D19D-C472-96F7-F92F-98B75FA799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06284" y="279657"/>
              <a:ext cx="1351434" cy="1099445"/>
            </a:xfrm>
            <a:prstGeom prst="rect">
              <a:avLst/>
            </a:prstGeom>
          </p:spPr>
        </p:pic>
        <p:pic>
          <p:nvPicPr>
            <p:cNvPr id="37" name="Picture 36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9ED4D4EB-DB93-2619-047E-CC44B2A677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16807" y="279657"/>
              <a:ext cx="1351429" cy="1099446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5565506-8AB3-F32D-9439-CED6B748CD17}"/>
                </a:ext>
              </a:extLst>
            </p:cNvPr>
            <p:cNvSpPr txBox="1"/>
            <p:nvPr/>
          </p:nvSpPr>
          <p:spPr>
            <a:xfrm rot="16200000">
              <a:off x="2324483" y="699755"/>
              <a:ext cx="1117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OU4F2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Picture 39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E9F955CD-C9B2-C185-7C99-07B3A516F7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607" y="1381611"/>
              <a:ext cx="1351434" cy="1105453"/>
            </a:xfrm>
            <a:prstGeom prst="rect">
              <a:avLst/>
            </a:prstGeom>
          </p:spPr>
        </p:pic>
        <p:pic>
          <p:nvPicPr>
            <p:cNvPr id="41" name="Picture 40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7647046C-3574-2A59-D9E4-3380671D38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06284" y="1381611"/>
              <a:ext cx="1351434" cy="1105452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5719E47-91E6-A3DF-0BB5-286AFB32B983}"/>
                </a:ext>
              </a:extLst>
            </p:cNvPr>
            <p:cNvSpPr txBox="1"/>
            <p:nvPr/>
          </p:nvSpPr>
          <p:spPr>
            <a:xfrm rot="16200000">
              <a:off x="2326852" y="1799340"/>
              <a:ext cx="1112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P1R1A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Picture 4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15168835-0754-0BE1-BC94-849D453B99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16807" y="1381611"/>
              <a:ext cx="1351434" cy="1105423"/>
            </a:xfrm>
            <a:prstGeom prst="rect">
              <a:avLst/>
            </a:prstGeom>
          </p:spPr>
        </p:pic>
        <p:pic>
          <p:nvPicPr>
            <p:cNvPr id="52" name="Picture 51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89776765-FE7A-C073-FA05-67BC081B07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607" y="2487714"/>
              <a:ext cx="1352736" cy="1099445"/>
            </a:xfrm>
            <a:prstGeom prst="rect">
              <a:avLst/>
            </a:prstGeom>
          </p:spPr>
        </p:pic>
        <p:pic>
          <p:nvPicPr>
            <p:cNvPr id="53" name="Picture 52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EB04FA97-EBAB-B3F0-B405-AAF29AA6B5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06284" y="2487714"/>
              <a:ext cx="1352729" cy="1104849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60D0256-E36D-A59E-7DF1-79BF0BB1C198}"/>
                </a:ext>
              </a:extLst>
            </p:cNvPr>
            <p:cNvSpPr txBox="1"/>
            <p:nvPr/>
          </p:nvSpPr>
          <p:spPr>
            <a:xfrm rot="16200000">
              <a:off x="2325289" y="2904824"/>
              <a:ext cx="11112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HH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" name="Picture 54" descr="A graph of a cell set&#10;&#10;Description automatically generated with medium confidence">
              <a:extLst>
                <a:ext uri="{FF2B5EF4-FFF2-40B4-BE49-F238E27FC236}">
                  <a16:creationId xmlns:a16="http://schemas.microsoft.com/office/drawing/2014/main" id="{B0FA261E-C229-AE86-2BDD-013E151572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16807" y="2487714"/>
              <a:ext cx="1352729" cy="1106000"/>
            </a:xfrm>
            <a:prstGeom prst="rect">
              <a:avLst/>
            </a:prstGeom>
          </p:spPr>
        </p:pic>
        <p:pic>
          <p:nvPicPr>
            <p:cNvPr id="56" name="Picture 55" descr="A graph of different colored shapes&#10;&#10;Description automatically generated">
              <a:extLst>
                <a:ext uri="{FF2B5EF4-FFF2-40B4-BE49-F238E27FC236}">
                  <a16:creationId xmlns:a16="http://schemas.microsoft.com/office/drawing/2014/main" id="{CB512AEA-51D3-340A-E13B-4317D314E6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607" y="3597821"/>
              <a:ext cx="1352736" cy="1096934"/>
            </a:xfrm>
            <a:prstGeom prst="rect">
              <a:avLst/>
            </a:prstGeom>
          </p:spPr>
        </p:pic>
        <p:pic>
          <p:nvPicPr>
            <p:cNvPr id="57" name="Picture 56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941F5742-21CE-FF90-0676-7AC1AFD518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06284" y="3597821"/>
              <a:ext cx="1352729" cy="1096933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F8735B7-18D1-ED33-DF8C-28158AF12B44}"/>
                </a:ext>
              </a:extLst>
            </p:cNvPr>
            <p:cNvSpPr txBox="1"/>
            <p:nvPr/>
          </p:nvSpPr>
          <p:spPr>
            <a:xfrm rot="16200000">
              <a:off x="2333906" y="4015546"/>
              <a:ext cx="1112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TGFA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9" name="Picture 58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6FD98B0E-C76D-653D-C6E8-5717CD993A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16807" y="3597821"/>
              <a:ext cx="1352728" cy="1096933"/>
            </a:xfrm>
            <a:prstGeom prst="rect">
              <a:avLst/>
            </a:prstGeom>
          </p:spPr>
        </p:pic>
        <p:pic>
          <p:nvPicPr>
            <p:cNvPr id="60" name="Picture 59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C6930752-DD78-BCC2-8319-A4F7578A1B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06284" y="4694755"/>
              <a:ext cx="1352729" cy="1113450"/>
            </a:xfrm>
            <a:prstGeom prst="rect">
              <a:avLst/>
            </a:prstGeom>
          </p:spPr>
        </p:pic>
        <p:pic>
          <p:nvPicPr>
            <p:cNvPr id="61" name="Picture 60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52CBF075-A089-2893-6CE2-452083610B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607" y="4691575"/>
              <a:ext cx="1352729" cy="1116629"/>
            </a:xfrm>
            <a:prstGeom prst="rect">
              <a:avLst/>
            </a:prstGeom>
          </p:spPr>
        </p:pic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319E910-69B1-18CF-42FF-66CFD7E5904F}"/>
                </a:ext>
              </a:extLst>
            </p:cNvPr>
            <p:cNvSpPr txBox="1"/>
            <p:nvPr/>
          </p:nvSpPr>
          <p:spPr>
            <a:xfrm rot="16200000">
              <a:off x="2335890" y="5115465"/>
              <a:ext cx="1108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VXN</a:t>
              </a:r>
              <a:endPara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Picture 62" descr="A chart of different colored shapes&#10;&#10;Description automatically generated">
              <a:extLst>
                <a:ext uri="{FF2B5EF4-FFF2-40B4-BE49-F238E27FC236}">
                  <a16:creationId xmlns:a16="http://schemas.microsoft.com/office/drawing/2014/main" id="{1890259F-C65D-49A6-21B1-4566CFE066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16807" y="4695393"/>
              <a:ext cx="1352729" cy="1112811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98F46B2-754F-290E-F7F4-397C502B2091}"/>
                </a:ext>
              </a:extLst>
            </p:cNvPr>
            <p:cNvSpPr txBox="1"/>
            <p:nvPr/>
          </p:nvSpPr>
          <p:spPr>
            <a:xfrm>
              <a:off x="3016807" y="-4106"/>
              <a:ext cx="14038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2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CCAD61B-A551-C017-A57D-337563597093}"/>
                </a:ext>
              </a:extLst>
            </p:cNvPr>
            <p:cNvSpPr txBox="1"/>
            <p:nvPr/>
          </p:nvSpPr>
          <p:spPr>
            <a:xfrm>
              <a:off x="4406284" y="-4106"/>
              <a:ext cx="14157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B6C76BB-64CF-4687-E7EE-392C9BB38F39}"/>
                </a:ext>
              </a:extLst>
            </p:cNvPr>
            <p:cNvSpPr txBox="1"/>
            <p:nvPr/>
          </p:nvSpPr>
          <p:spPr>
            <a:xfrm>
              <a:off x="5793607" y="-4106"/>
              <a:ext cx="13357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B79ABEFC-CEFB-BF61-75BA-85EA738608FF}"/>
                </a:ext>
              </a:extLst>
            </p:cNvPr>
            <p:cNvSpPr txBox="1"/>
            <p:nvPr/>
          </p:nvSpPr>
          <p:spPr>
            <a:xfrm rot="19500000">
              <a:off x="3002643" y="5895917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8E17B6B-E6AF-C497-F707-B91954982DFE}"/>
                </a:ext>
              </a:extLst>
            </p:cNvPr>
            <p:cNvSpPr txBox="1"/>
            <p:nvPr/>
          </p:nvSpPr>
          <p:spPr>
            <a:xfrm rot="19500000">
              <a:off x="3221440" y="5890453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9EAF055-656E-1AF0-31C5-B11B0BB70AB5}"/>
                </a:ext>
              </a:extLst>
            </p:cNvPr>
            <p:cNvSpPr txBox="1"/>
            <p:nvPr/>
          </p:nvSpPr>
          <p:spPr>
            <a:xfrm rot="19500000">
              <a:off x="3209012" y="5959277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195D8CD4-161C-2AC3-EF94-2F0730816AF8}"/>
                </a:ext>
              </a:extLst>
            </p:cNvPr>
            <p:cNvSpPr txBox="1"/>
            <p:nvPr/>
          </p:nvSpPr>
          <p:spPr>
            <a:xfrm rot="19500000">
              <a:off x="3456338" y="5945492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2F2D9A8-4FF1-F768-E8FC-FAFDDFAFB345}"/>
                </a:ext>
              </a:extLst>
            </p:cNvPr>
            <p:cNvSpPr txBox="1"/>
            <p:nvPr/>
          </p:nvSpPr>
          <p:spPr>
            <a:xfrm rot="19500000">
              <a:off x="3876895" y="5874660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CE805A72-C2DA-EC02-7755-78717C28F8E3}"/>
                </a:ext>
              </a:extLst>
            </p:cNvPr>
            <p:cNvSpPr txBox="1"/>
            <p:nvPr/>
          </p:nvSpPr>
          <p:spPr>
            <a:xfrm rot="19500000">
              <a:off x="4135367" y="5856431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2AD69469-F5D9-9443-9304-07DDF92FEAEE}"/>
                </a:ext>
              </a:extLst>
            </p:cNvPr>
            <p:cNvSpPr txBox="1"/>
            <p:nvPr/>
          </p:nvSpPr>
          <p:spPr>
            <a:xfrm rot="19500000">
              <a:off x="4402209" y="5896624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D7AD0DF1-884A-6A63-519A-4130F8F7377C}"/>
                </a:ext>
              </a:extLst>
            </p:cNvPr>
            <p:cNvSpPr txBox="1"/>
            <p:nvPr/>
          </p:nvSpPr>
          <p:spPr>
            <a:xfrm rot="19500000">
              <a:off x="4621006" y="5891160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498F6871-4274-4E11-6364-9F57B0A7E996}"/>
                </a:ext>
              </a:extLst>
            </p:cNvPr>
            <p:cNvSpPr txBox="1"/>
            <p:nvPr/>
          </p:nvSpPr>
          <p:spPr>
            <a:xfrm rot="19500000">
              <a:off x="4608578" y="5959984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866E2F35-22E6-8D9B-3047-D85A0AFAACD4}"/>
                </a:ext>
              </a:extLst>
            </p:cNvPr>
            <p:cNvSpPr txBox="1"/>
            <p:nvPr/>
          </p:nvSpPr>
          <p:spPr>
            <a:xfrm rot="19500000">
              <a:off x="4855904" y="5946199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ECE1BB3-53BB-7371-8BA6-4DBD448B30AE}"/>
                </a:ext>
              </a:extLst>
            </p:cNvPr>
            <p:cNvSpPr txBox="1"/>
            <p:nvPr/>
          </p:nvSpPr>
          <p:spPr>
            <a:xfrm rot="19500000">
              <a:off x="5276461" y="5875367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2EB91AF6-519E-529B-DF88-6220362FBD84}"/>
                </a:ext>
              </a:extLst>
            </p:cNvPr>
            <p:cNvSpPr txBox="1"/>
            <p:nvPr/>
          </p:nvSpPr>
          <p:spPr>
            <a:xfrm rot="19500000">
              <a:off x="5534933" y="5857138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EDCF0AAA-2F36-D2CE-A74D-27203024C22E}"/>
                </a:ext>
              </a:extLst>
            </p:cNvPr>
            <p:cNvSpPr txBox="1"/>
            <p:nvPr/>
          </p:nvSpPr>
          <p:spPr>
            <a:xfrm rot="19500000">
              <a:off x="5782830" y="5887358"/>
              <a:ext cx="30181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PC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26CA42F6-9657-707C-B6DD-EE2EB507225D}"/>
                </a:ext>
              </a:extLst>
            </p:cNvPr>
            <p:cNvSpPr txBox="1"/>
            <p:nvPr/>
          </p:nvSpPr>
          <p:spPr>
            <a:xfrm rot="19500000">
              <a:off x="6001627" y="5881894"/>
              <a:ext cx="28276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RPC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2C737FF9-1929-164D-82D8-A83E6127728F}"/>
                </a:ext>
              </a:extLst>
            </p:cNvPr>
            <p:cNvSpPr txBox="1"/>
            <p:nvPr/>
          </p:nvSpPr>
          <p:spPr>
            <a:xfrm rot="19500000">
              <a:off x="5989199" y="5950718"/>
              <a:ext cx="51728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RGC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41A6F67A-A3BA-F29D-A13C-F30A5B2CA376}"/>
                </a:ext>
              </a:extLst>
            </p:cNvPr>
            <p:cNvSpPr txBox="1"/>
            <p:nvPr/>
          </p:nvSpPr>
          <p:spPr>
            <a:xfrm rot="19500000">
              <a:off x="6236525" y="5936933"/>
              <a:ext cx="46921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RGC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BB982C95-FDA2-EE6C-209C-D859398F44D7}"/>
                </a:ext>
              </a:extLst>
            </p:cNvPr>
            <p:cNvSpPr txBox="1"/>
            <p:nvPr/>
          </p:nvSpPr>
          <p:spPr>
            <a:xfrm rot="19500000">
              <a:off x="6657082" y="5866101"/>
              <a:ext cx="22769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&amp;A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8DB46F8C-C751-E175-45CF-678DDF77F428}"/>
                </a:ext>
              </a:extLst>
            </p:cNvPr>
            <p:cNvSpPr txBox="1"/>
            <p:nvPr/>
          </p:nvSpPr>
          <p:spPr>
            <a:xfrm rot="19500000">
              <a:off x="6915554" y="5847872"/>
              <a:ext cx="1641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F7A6E54-C5FA-4AF2-E993-52442C55C7A3}"/>
                </a:ext>
              </a:extLst>
            </p:cNvPr>
            <p:cNvSpPr txBox="1"/>
            <p:nvPr/>
          </p:nvSpPr>
          <p:spPr>
            <a:xfrm>
              <a:off x="142875" y="6271707"/>
              <a:ext cx="954405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11 continued. Expression distribution of selected genes in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cell type-specific scRNA-seq clusters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.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Entire week-7 retinal organoids were analyzed by hybridization-based fixed RNA profiling. Violin plots show raw expression distribution in for cells originating from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organoids, </a:t>
              </a:r>
              <a:r>
                <a:rPr lang="en-US" sz="800" i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organoids, and WT organoid-derived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positive cells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b="1" baseline="300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+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. Each expressing cell is marked by a black point.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he representative cell clusters are defined as naïve retinal progenitor cells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transient retinal progeni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P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early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arly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late retinal ganglion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ate RG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horizontal and amacrine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&amp;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, and photoreceptor cell (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.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knockout; </a:t>
              </a:r>
              <a:r>
                <a:rPr lang="en-US" sz="800" b="1" dirty="0" err="1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scRNA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seq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; single-cell RNA sequencing; 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wildtype.</a:t>
              </a:r>
              <a:endParaRPr lang="en-US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0684861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583DBD3-B00A-C995-1139-D0D91883DD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5772614"/>
              </p:ext>
            </p:extLst>
          </p:nvPr>
        </p:nvGraphicFramePr>
        <p:xfrm>
          <a:off x="1084757" y="793925"/>
          <a:ext cx="7736486" cy="227348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750888">
                  <a:extLst>
                    <a:ext uri="{9D8B030D-6E8A-4147-A177-3AD203B41FA5}">
                      <a16:colId xmlns:a16="http://schemas.microsoft.com/office/drawing/2014/main" val="3000278270"/>
                    </a:ext>
                  </a:extLst>
                </a:gridCol>
                <a:gridCol w="1886893">
                  <a:extLst>
                    <a:ext uri="{9D8B030D-6E8A-4147-A177-3AD203B41FA5}">
                      <a16:colId xmlns:a16="http://schemas.microsoft.com/office/drawing/2014/main" val="860536622"/>
                    </a:ext>
                  </a:extLst>
                </a:gridCol>
                <a:gridCol w="347018">
                  <a:extLst>
                    <a:ext uri="{9D8B030D-6E8A-4147-A177-3AD203B41FA5}">
                      <a16:colId xmlns:a16="http://schemas.microsoft.com/office/drawing/2014/main" val="977281893"/>
                    </a:ext>
                  </a:extLst>
                </a:gridCol>
                <a:gridCol w="785168">
                  <a:extLst>
                    <a:ext uri="{9D8B030D-6E8A-4147-A177-3AD203B41FA5}">
                      <a16:colId xmlns:a16="http://schemas.microsoft.com/office/drawing/2014/main" val="408271285"/>
                    </a:ext>
                  </a:extLst>
                </a:gridCol>
                <a:gridCol w="1181100">
                  <a:extLst>
                    <a:ext uri="{9D8B030D-6E8A-4147-A177-3AD203B41FA5}">
                      <a16:colId xmlns:a16="http://schemas.microsoft.com/office/drawing/2014/main" val="2497137764"/>
                    </a:ext>
                  </a:extLst>
                </a:gridCol>
                <a:gridCol w="871538">
                  <a:extLst>
                    <a:ext uri="{9D8B030D-6E8A-4147-A177-3AD203B41FA5}">
                      <a16:colId xmlns:a16="http://schemas.microsoft.com/office/drawing/2014/main" val="3891714788"/>
                    </a:ext>
                  </a:extLst>
                </a:gridCol>
                <a:gridCol w="455613">
                  <a:extLst>
                    <a:ext uri="{9D8B030D-6E8A-4147-A177-3AD203B41FA5}">
                      <a16:colId xmlns:a16="http://schemas.microsoft.com/office/drawing/2014/main" val="615012732"/>
                    </a:ext>
                  </a:extLst>
                </a:gridCol>
                <a:gridCol w="680393">
                  <a:extLst>
                    <a:ext uri="{9D8B030D-6E8A-4147-A177-3AD203B41FA5}">
                      <a16:colId xmlns:a16="http://schemas.microsoft.com/office/drawing/2014/main" val="1286454847"/>
                    </a:ext>
                  </a:extLst>
                </a:gridCol>
                <a:gridCol w="777875">
                  <a:extLst>
                    <a:ext uri="{9D8B030D-6E8A-4147-A177-3AD203B41FA5}">
                      <a16:colId xmlns:a16="http://schemas.microsoft.com/office/drawing/2014/main" val="99416036"/>
                    </a:ext>
                  </a:extLst>
                </a:gridCol>
              </a:tblGrid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M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or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osom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n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match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138162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RNA-5KO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CCCGGCCCCAAGCAGCG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179774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0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231693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8775837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CCCGCCCCCAAGCAGC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692867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8681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1643754610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CCACGGCCCCAAGCAGC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304964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3804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822409498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CCCCGTCCCCAAGCAGC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304964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349673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2957917990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CCTCGGCCCCAAGCAGCC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304964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06654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3864428149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CCCAGGCGCCAAGCAG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56791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427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1009283803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CGGCCCAAAGCAG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958172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2615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5500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2141457090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GCCCGCCCCAAGCAG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89191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0474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1672639272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CATCCCCAAGCAG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090335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9191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3825575421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CCCCGCCCCCAAGCAG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431603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1544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1301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2583344776"/>
                  </a:ext>
                </a:extLst>
              </a:tr>
              <a:tr h="1681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TCCCATCGCCAAGCAG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684322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157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09" marR="8409" marT="8409" marB="0" anchor="b"/>
                </a:tc>
                <a:extLst>
                  <a:ext uri="{0D108BD9-81ED-4DB2-BD59-A6C34878D82A}">
                    <a16:rowId xmlns:a16="http://schemas.microsoft.com/office/drawing/2014/main" val="1461618111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5A02E90-F9D4-5D7F-E85D-37F84753CC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5257042"/>
              </p:ext>
            </p:extLst>
          </p:nvPr>
        </p:nvGraphicFramePr>
        <p:xfrm>
          <a:off x="1084757" y="3629138"/>
          <a:ext cx="7778752" cy="230695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750888">
                  <a:extLst>
                    <a:ext uri="{9D8B030D-6E8A-4147-A177-3AD203B41FA5}">
                      <a16:colId xmlns:a16="http://schemas.microsoft.com/office/drawing/2014/main" val="3655308917"/>
                    </a:ext>
                  </a:extLst>
                </a:gridCol>
                <a:gridCol w="1922463">
                  <a:extLst>
                    <a:ext uri="{9D8B030D-6E8A-4147-A177-3AD203B41FA5}">
                      <a16:colId xmlns:a16="http://schemas.microsoft.com/office/drawing/2014/main" val="1950354892"/>
                    </a:ext>
                  </a:extLst>
                </a:gridCol>
                <a:gridCol w="349250">
                  <a:extLst>
                    <a:ext uri="{9D8B030D-6E8A-4147-A177-3AD203B41FA5}">
                      <a16:colId xmlns:a16="http://schemas.microsoft.com/office/drawing/2014/main" val="2902145425"/>
                    </a:ext>
                  </a:extLst>
                </a:gridCol>
                <a:gridCol w="787400">
                  <a:extLst>
                    <a:ext uri="{9D8B030D-6E8A-4147-A177-3AD203B41FA5}">
                      <a16:colId xmlns:a16="http://schemas.microsoft.com/office/drawing/2014/main" val="2829218355"/>
                    </a:ext>
                  </a:extLst>
                </a:gridCol>
                <a:gridCol w="1181100">
                  <a:extLst>
                    <a:ext uri="{9D8B030D-6E8A-4147-A177-3AD203B41FA5}">
                      <a16:colId xmlns:a16="http://schemas.microsoft.com/office/drawing/2014/main" val="1052768138"/>
                    </a:ext>
                  </a:extLst>
                </a:gridCol>
                <a:gridCol w="871538">
                  <a:extLst>
                    <a:ext uri="{9D8B030D-6E8A-4147-A177-3AD203B41FA5}">
                      <a16:colId xmlns:a16="http://schemas.microsoft.com/office/drawing/2014/main" val="825241191"/>
                    </a:ext>
                  </a:extLst>
                </a:gridCol>
                <a:gridCol w="455613">
                  <a:extLst>
                    <a:ext uri="{9D8B030D-6E8A-4147-A177-3AD203B41FA5}">
                      <a16:colId xmlns:a16="http://schemas.microsoft.com/office/drawing/2014/main" val="2251409093"/>
                    </a:ext>
                  </a:extLst>
                </a:gridCol>
                <a:gridCol w="682625">
                  <a:extLst>
                    <a:ext uri="{9D8B030D-6E8A-4147-A177-3AD203B41FA5}">
                      <a16:colId xmlns:a16="http://schemas.microsoft.com/office/drawing/2014/main" val="1599991363"/>
                    </a:ext>
                  </a:extLst>
                </a:gridCol>
                <a:gridCol w="777875">
                  <a:extLst>
                    <a:ext uri="{9D8B030D-6E8A-4147-A177-3AD203B41FA5}">
                      <a16:colId xmlns:a16="http://schemas.microsoft.com/office/drawing/2014/main" val="264528550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M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or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osom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n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match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591926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RNA-3KO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GGGCGCGCGCCTCCGCGG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179774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0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231205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040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GGCCGCTCGCCTCCGCGG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73734177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9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36440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775263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GCGCGCGCCCCTCCGCG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5023474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27138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96200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27376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GGCCCGCGACTCCGCG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031878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313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116694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GGCTTGGGCCTCCGCG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858763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22182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89062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251429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CTCACGCGCCTCCGC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1734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8258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11713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GGGAGAGCGCCTCCGC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71542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1216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514400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CAGCGCGCGCCTCCGC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6724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102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297872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AGCGAGCGGCTCCGC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06872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2242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440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97522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GACGTGCGCTTCCGC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60326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9782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67238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GGGCCCGCTCCTCCGC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8101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G000001287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2561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40478979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CDA0296-D2F6-436E-3C76-A42FB4E3BD38}"/>
              </a:ext>
            </a:extLst>
          </p:cNvPr>
          <p:cNvSpPr txBox="1"/>
          <p:nvPr/>
        </p:nvSpPr>
        <p:spPr>
          <a:xfrm>
            <a:off x="1127023" y="3090446"/>
            <a:ext cx="7736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able S</a:t>
            </a:r>
            <a:r>
              <a:rPr lang="en-US" sz="800" b="1" dirty="0">
                <a:solidFill>
                  <a:srgbClr val="262626"/>
                </a:solidFill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1A</a:t>
            </a:r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. CRSISPR/Cas9 guide design targeting upstream of ATOH7 CDS. </a:t>
            </a:r>
            <a:r>
              <a:rPr lang="en-US" sz="800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he on-target sequence for guide sgRNA-5KO and top 10 potential off-target sequences. Target score ranges from 0-100, where higher scores indicate greater likelihood of a cutting event.</a:t>
            </a:r>
            <a:endParaRPr lang="en-US" sz="8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5B14F5-91BC-22D1-5C06-9755FD1B30F2}"/>
              </a:ext>
            </a:extLst>
          </p:cNvPr>
          <p:cNvSpPr txBox="1"/>
          <p:nvPr/>
        </p:nvSpPr>
        <p:spPr>
          <a:xfrm>
            <a:off x="1084757" y="5948039"/>
            <a:ext cx="7736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able S1B. CRSISPR/Cas9 guide design targeting downstream of </a:t>
            </a:r>
            <a:r>
              <a:rPr lang="en-US" sz="800" b="1" i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ATOH7</a:t>
            </a:r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 CDS. </a:t>
            </a:r>
            <a:r>
              <a:rPr lang="en-US" sz="800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he on-target sequence for guide sgRNA-3KO and top 10 potential off-target sequences. Target score ranges from 0-100, where higher scores indicate greater likelihood of a cutting event.</a:t>
            </a:r>
            <a:endParaRPr lang="en-US" sz="8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272996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5E9D4C47-D71F-FF43-2C13-EF78FC8004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1219894"/>
              </p:ext>
            </p:extLst>
          </p:nvPr>
        </p:nvGraphicFramePr>
        <p:xfrm>
          <a:off x="2539185" y="1607171"/>
          <a:ext cx="4827631" cy="145732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652631">
                  <a:extLst>
                    <a:ext uri="{9D8B030D-6E8A-4147-A177-3AD203B41FA5}">
                      <a16:colId xmlns:a16="http://schemas.microsoft.com/office/drawing/2014/main" val="1008947641"/>
                    </a:ext>
                  </a:extLst>
                </a:gridCol>
                <a:gridCol w="530225">
                  <a:extLst>
                    <a:ext uri="{9D8B030D-6E8A-4147-A177-3AD203B41FA5}">
                      <a16:colId xmlns:a16="http://schemas.microsoft.com/office/drawing/2014/main" val="1758443354"/>
                    </a:ext>
                  </a:extLst>
                </a:gridCol>
                <a:gridCol w="527050">
                  <a:extLst>
                    <a:ext uri="{9D8B030D-6E8A-4147-A177-3AD203B41FA5}">
                      <a16:colId xmlns:a16="http://schemas.microsoft.com/office/drawing/2014/main" val="1269903471"/>
                    </a:ext>
                  </a:extLst>
                </a:gridCol>
                <a:gridCol w="1123950">
                  <a:extLst>
                    <a:ext uri="{9D8B030D-6E8A-4147-A177-3AD203B41FA5}">
                      <a16:colId xmlns:a16="http://schemas.microsoft.com/office/drawing/2014/main" val="2653858665"/>
                    </a:ext>
                  </a:extLst>
                </a:gridCol>
                <a:gridCol w="993775">
                  <a:extLst>
                    <a:ext uri="{9D8B030D-6E8A-4147-A177-3AD203B41FA5}">
                      <a16:colId xmlns:a16="http://schemas.microsoft.com/office/drawing/2014/main" val="3905550434"/>
                    </a:ext>
                  </a:extLst>
                </a:gridCol>
              </a:tblGrid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ufacture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 #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55779845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ATOH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us Bi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P1-8863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81817030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ATOH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5-7718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33825340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CRX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v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00001406-M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33852266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POU4F1/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39078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3860176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RBFOX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17748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86263877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RCVR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558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20874371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TAU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cke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757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35117438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TUBB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12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40025730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BEB25226-70A7-DC3C-C682-E7B4AE40114D}"/>
              </a:ext>
            </a:extLst>
          </p:cNvPr>
          <p:cNvSpPr txBox="1"/>
          <p:nvPr/>
        </p:nvSpPr>
        <p:spPr>
          <a:xfrm>
            <a:off x="2539185" y="3072885"/>
            <a:ext cx="48276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able S2A. Primary antibodies.</a:t>
            </a:r>
            <a:r>
              <a:rPr lang="en-US" sz="800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 D</a:t>
            </a:r>
            <a:r>
              <a:rPr lang="en-US" sz="800" dirty="0">
                <a:solidFill>
                  <a:srgbClr val="262626"/>
                </a:solidFill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ilutions used for immunostaining experiments are indicated.</a:t>
            </a:r>
            <a:endParaRPr lang="en-US" sz="8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297A689D-C7BD-6E62-5C19-12B72935DA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1498222"/>
              </p:ext>
            </p:extLst>
          </p:nvPr>
        </p:nvGraphicFramePr>
        <p:xfrm>
          <a:off x="2536971" y="3654656"/>
          <a:ext cx="4832059" cy="129540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649413">
                  <a:extLst>
                    <a:ext uri="{9D8B030D-6E8A-4147-A177-3AD203B41FA5}">
                      <a16:colId xmlns:a16="http://schemas.microsoft.com/office/drawing/2014/main" val="1008947641"/>
                    </a:ext>
                  </a:extLst>
                </a:gridCol>
                <a:gridCol w="530225">
                  <a:extLst>
                    <a:ext uri="{9D8B030D-6E8A-4147-A177-3AD203B41FA5}">
                      <a16:colId xmlns:a16="http://schemas.microsoft.com/office/drawing/2014/main" val="1758443354"/>
                    </a:ext>
                  </a:extLst>
                </a:gridCol>
                <a:gridCol w="527050">
                  <a:extLst>
                    <a:ext uri="{9D8B030D-6E8A-4147-A177-3AD203B41FA5}">
                      <a16:colId xmlns:a16="http://schemas.microsoft.com/office/drawing/2014/main" val="1269903471"/>
                    </a:ext>
                  </a:extLst>
                </a:gridCol>
                <a:gridCol w="1123950">
                  <a:extLst>
                    <a:ext uri="{9D8B030D-6E8A-4147-A177-3AD203B41FA5}">
                      <a16:colId xmlns:a16="http://schemas.microsoft.com/office/drawing/2014/main" val="2653858665"/>
                    </a:ext>
                  </a:extLst>
                </a:gridCol>
                <a:gridCol w="1001421">
                  <a:extLst>
                    <a:ext uri="{9D8B030D-6E8A-4147-A177-3AD203B41FA5}">
                      <a16:colId xmlns:a16="http://schemas.microsoft.com/office/drawing/2014/main" val="3905550434"/>
                    </a:ext>
                  </a:extLst>
                </a:gridCol>
              </a:tblGrid>
              <a:tr h="9067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ufacture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 #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55779845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488 anti-mous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110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81817030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488 anti-rabbi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1100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33825340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488 anti-shee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ke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1101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33852266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568 anti-go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ke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1101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3860176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647 anti-chicke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2144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86263877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647 anti-mous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2123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20874371"/>
                  </a:ext>
                </a:extLst>
              </a:tr>
              <a:tr h="1574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647 anti-rabbi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hermo Fisher Sci.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2124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35117438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51676C6E-9245-F7CA-5712-BBE3CBC8B8F3}"/>
              </a:ext>
            </a:extLst>
          </p:cNvPr>
          <p:cNvSpPr txBox="1"/>
          <p:nvPr/>
        </p:nvSpPr>
        <p:spPr>
          <a:xfrm>
            <a:off x="2539184" y="4955555"/>
            <a:ext cx="4827630" cy="2145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able S</a:t>
            </a:r>
            <a:r>
              <a:rPr lang="en-US" sz="800" b="1" dirty="0">
                <a:solidFill>
                  <a:srgbClr val="262626"/>
                </a:solidFill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2</a:t>
            </a:r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B. Secondary antibodies.</a:t>
            </a:r>
            <a:r>
              <a:rPr lang="en-US" sz="800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 D</a:t>
            </a:r>
            <a:r>
              <a:rPr lang="en-US" sz="800" dirty="0">
                <a:solidFill>
                  <a:srgbClr val="262626"/>
                </a:solidFill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ilutions used for immunostaining experiments are indicated.</a:t>
            </a:r>
            <a:endParaRPr lang="en-US" sz="8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551699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54E9D6D-CB48-9801-DBFF-4CBB657EB6A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245938"/>
              </p:ext>
            </p:extLst>
          </p:nvPr>
        </p:nvGraphicFramePr>
        <p:xfrm>
          <a:off x="2993231" y="991551"/>
          <a:ext cx="3919538" cy="480822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34750">
                  <a:extLst>
                    <a:ext uri="{9D8B030D-6E8A-4147-A177-3AD203B41FA5}">
                      <a16:colId xmlns:a16="http://schemas.microsoft.com/office/drawing/2014/main" val="3955560433"/>
                    </a:ext>
                  </a:extLst>
                </a:gridCol>
                <a:gridCol w="2784788">
                  <a:extLst>
                    <a:ext uri="{9D8B030D-6E8A-4147-A177-3AD203B41FA5}">
                      <a16:colId xmlns:a16="http://schemas.microsoft.com/office/drawing/2014/main" val="371883906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09109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1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CTCGAACAACACTCAA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196733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2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CTGTGGTGCCTTCACA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838492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3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AGTCAGCCAGGCTTC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413817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4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CCCACTAATACCCACCCT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794676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1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CAAGTTCGGGTCCCAC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311659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2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CGCTACGCCTGAAAAC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345647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3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ACTGCAGACTCCTCG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622030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4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TGAGACAGGTCAGGACG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428297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1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AGCAAATTGCGGAGG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831541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2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CCTCTCTGCTTGTT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23390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3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TTGGTCCTGGGT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226922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5_4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TCAGCTTCATGAGCCAC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561089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1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AGGAAGCACAAAGACG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013446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2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CCTCTTAACCCTTCTG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308506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3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CCAAAACTGCGACCTT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93814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3_4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GTCTACAGCCTCCCTT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68759001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Ex1_F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CAGGGGCTCAACAC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48421320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Ex1_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TGCGAATAAAGGTAATCTG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79810367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LR_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GGTCTTGTGGCCTTACTGAGGTCTGGC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57827988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LR_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TCTCCCAAATGCATGCACCACTCT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28849649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scr_F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CAGCCACACCAAACTC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17421939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scr_R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CCGAACAGGACAAACTC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31672054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qPCR_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TCCACTGTGAGCACTT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17794592"/>
                  </a:ext>
                </a:extLst>
              </a:tr>
              <a:tr h="11407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H7_qPCR_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AGGCTTCTGGGCTACTTG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6487209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6E5CBBB-D2D3-3599-CDE8-5A69789A803F}"/>
              </a:ext>
            </a:extLst>
          </p:cNvPr>
          <p:cNvSpPr txBox="1"/>
          <p:nvPr/>
        </p:nvSpPr>
        <p:spPr>
          <a:xfrm>
            <a:off x="2993231" y="5799771"/>
            <a:ext cx="39195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able S3. Primer sequences. </a:t>
            </a:r>
            <a:r>
              <a:rPr lang="en-US" sz="800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The direction of sequences is shown from 5’ to 3’.</a:t>
            </a:r>
            <a:endParaRPr lang="en-US" sz="8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8514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AAE26BA-1778-EE89-AFA7-D4D7CF35FA01}"/>
              </a:ext>
            </a:extLst>
          </p:cNvPr>
          <p:cNvGrpSpPr/>
          <p:nvPr/>
        </p:nvGrpSpPr>
        <p:grpSpPr>
          <a:xfrm>
            <a:off x="338093" y="232817"/>
            <a:ext cx="9253577" cy="6488728"/>
            <a:chOff x="338093" y="232817"/>
            <a:chExt cx="9253577" cy="6488728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E015D39-C42C-425E-7678-A54EC640CC0A}"/>
                </a:ext>
              </a:extLst>
            </p:cNvPr>
            <p:cNvSpPr txBox="1"/>
            <p:nvPr/>
          </p:nvSpPr>
          <p:spPr>
            <a:xfrm>
              <a:off x="338093" y="6136770"/>
              <a:ext cx="925357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2. Example electropherograms of edited human iPSC lines.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Genomic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DNA from s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tem cell colonies was amplified using primer pair ATOH7_scr_F2/R2 (Table S3). Sanger sequencing was performed using primer ATOH7_Ex1_F2 (</a:t>
              </a:r>
              <a:r>
                <a:rPr lang="en-US" sz="800" dirty="0" err="1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wd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 and primer ATOH7_Ex1_R (Rev) (Table S3). Sequences from wildtype and mutant lines were aligned to a canonical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reference (GRCh38p14), whereas sequences from wildtype and mutant reporter lines were aligned to the constructed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CH" sz="800" i="1" baseline="300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-GFP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reference. Alignments were visualized using </a:t>
              </a:r>
              <a:r>
                <a:rPr lang="en-US" sz="800" dirty="0" err="1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Benchling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(https://www.benchling.com).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CDS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coding sequence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iPS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induced pluripotent stem cell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knockout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.</a:t>
              </a:r>
            </a:p>
          </p:txBody>
        </p:sp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FA26B8C4-380C-EA11-7DCB-DB24F4A117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98962" y="1248945"/>
              <a:ext cx="3710367" cy="9231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5B49797B-B855-5002-D6A3-3337EC4E82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99355" y="250825"/>
              <a:ext cx="3710367" cy="9231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C63B4EE9-4531-8A12-7CB9-E518ACAB8B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03084" y="4918573"/>
              <a:ext cx="3710367" cy="119803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9EBCE84A-7EB3-E434-08F4-791E4F2FB1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98962" y="2364356"/>
              <a:ext cx="3710368" cy="11980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76150ECC-6B32-1AF8-E6E9-CA5A03B253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03084" y="3638238"/>
              <a:ext cx="3710368" cy="11980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1E12027-731F-C176-2F71-8DB75F8F030B}"/>
                </a:ext>
              </a:extLst>
            </p:cNvPr>
            <p:cNvSpPr txBox="1"/>
            <p:nvPr/>
          </p:nvSpPr>
          <p:spPr>
            <a:xfrm rot="16200000">
              <a:off x="484625" y="558505"/>
              <a:ext cx="923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’ CDS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B898C01E-AF08-C647-5A14-EEDE70639975}"/>
                </a:ext>
              </a:extLst>
            </p:cNvPr>
            <p:cNvSpPr txBox="1"/>
            <p:nvPr/>
          </p:nvSpPr>
          <p:spPr>
            <a:xfrm rot="16200000">
              <a:off x="484624" y="1556628"/>
              <a:ext cx="9231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’ CDS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5A54333E-9893-8AE6-E3CC-0D4757DCBD5B}"/>
                </a:ext>
              </a:extLst>
            </p:cNvPr>
            <p:cNvSpPr txBox="1"/>
            <p:nvPr/>
          </p:nvSpPr>
          <p:spPr>
            <a:xfrm rot="16200000">
              <a:off x="329480" y="4075000"/>
              <a:ext cx="1198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2A-eGFP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78160DE-E036-DB59-07F8-F37D40C5BF60}"/>
                </a:ext>
              </a:extLst>
            </p:cNvPr>
            <p:cNvSpPr txBox="1"/>
            <p:nvPr/>
          </p:nvSpPr>
          <p:spPr>
            <a:xfrm rot="16200000">
              <a:off x="329480" y="2816127"/>
              <a:ext cx="1198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’ CDS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CF1E4161-F1A4-A135-1CC7-5717FF5160C1}"/>
                </a:ext>
              </a:extLst>
            </p:cNvPr>
            <p:cNvSpPr txBox="1"/>
            <p:nvPr/>
          </p:nvSpPr>
          <p:spPr>
            <a:xfrm rot="16200000">
              <a:off x="329481" y="5357600"/>
              <a:ext cx="1198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’ CDS</a:t>
              </a:r>
            </a:p>
          </p:txBody>
        </p: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F6856B66-0034-B877-40C7-2705170EB032}"/>
                </a:ext>
              </a:extLst>
            </p:cNvPr>
            <p:cNvCxnSpPr/>
            <p:nvPr/>
          </p:nvCxnSpPr>
          <p:spPr>
            <a:xfrm>
              <a:off x="720320" y="247170"/>
              <a:ext cx="0" cy="1921264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5EC8B800-53C1-7CA9-4EF6-AFF9C428C96A}"/>
                </a:ext>
              </a:extLst>
            </p:cNvPr>
            <p:cNvCxnSpPr>
              <a:cxnSpLocks/>
            </p:cNvCxnSpPr>
            <p:nvPr/>
          </p:nvCxnSpPr>
          <p:spPr>
            <a:xfrm>
              <a:off x="717316" y="2362610"/>
              <a:ext cx="0" cy="3747227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1BE3FF30-0D15-737E-CB2B-C8AB461EAF24}"/>
                </a:ext>
              </a:extLst>
            </p:cNvPr>
            <p:cNvSpPr txBox="1"/>
            <p:nvPr/>
          </p:nvSpPr>
          <p:spPr>
            <a:xfrm rot="16200000">
              <a:off x="-392325" y="1065391"/>
              <a:ext cx="19212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5B921B35-7624-DD71-6811-FCAB07DD4EEF}"/>
                </a:ext>
              </a:extLst>
            </p:cNvPr>
            <p:cNvSpPr txBox="1"/>
            <p:nvPr/>
          </p:nvSpPr>
          <p:spPr>
            <a:xfrm rot="16200000">
              <a:off x="-1287831" y="4085632"/>
              <a:ext cx="3721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-GFP</a:t>
              </a:r>
            </a:p>
          </p:txBody>
        </p:sp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5ADC0079-5B12-4355-F737-BDEAB9467A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012" y="247170"/>
              <a:ext cx="3710365" cy="9231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C1917226-013F-CFF0-1392-E621961E5F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683" y="1248947"/>
              <a:ext cx="3710366" cy="9231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59BB7293-8F28-BB88-DE0E-13EADA3EDB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012" y="4918573"/>
              <a:ext cx="3710367" cy="11996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0AF571AB-1557-1408-FCD9-CC47344ECA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752" y="2364356"/>
              <a:ext cx="3710370" cy="11996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C534BA91-4597-EEB2-9169-721E62247C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93013" y="3638238"/>
              <a:ext cx="3710368" cy="11996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10708EAA-B845-2DF4-6AA9-3BBEF4637994}"/>
                </a:ext>
              </a:extLst>
            </p:cNvPr>
            <p:cNvSpPr txBox="1"/>
            <p:nvPr/>
          </p:nvSpPr>
          <p:spPr>
            <a:xfrm rot="16200000">
              <a:off x="5167796" y="566330"/>
              <a:ext cx="923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’ CDS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DB65926B-3450-104A-ECB3-CD0217DD9CF2}"/>
                </a:ext>
              </a:extLst>
            </p:cNvPr>
            <p:cNvSpPr txBox="1"/>
            <p:nvPr/>
          </p:nvSpPr>
          <p:spPr>
            <a:xfrm rot="16200000">
              <a:off x="5167797" y="1564453"/>
              <a:ext cx="9231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’ CDS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A193371-6735-0B3D-FF59-7E10A6D1B0C2}"/>
                </a:ext>
              </a:extLst>
            </p:cNvPr>
            <p:cNvSpPr txBox="1"/>
            <p:nvPr/>
          </p:nvSpPr>
          <p:spPr>
            <a:xfrm rot="16200000">
              <a:off x="5030350" y="4082825"/>
              <a:ext cx="1198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2A-eGFP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DFE12BBF-D6A7-0C13-012A-303CC9475879}"/>
                </a:ext>
              </a:extLst>
            </p:cNvPr>
            <p:cNvSpPr txBox="1"/>
            <p:nvPr/>
          </p:nvSpPr>
          <p:spPr>
            <a:xfrm rot="16200000">
              <a:off x="5030350" y="2823952"/>
              <a:ext cx="1198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’ CDS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E43CC13-E65C-7505-C36D-1AE7CAD8EF69}"/>
                </a:ext>
              </a:extLst>
            </p:cNvPr>
            <p:cNvSpPr txBox="1"/>
            <p:nvPr/>
          </p:nvSpPr>
          <p:spPr>
            <a:xfrm rot="16200000">
              <a:off x="5030350" y="5365425"/>
              <a:ext cx="1198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’ CDS</a:t>
              </a: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67809666-BC59-8F23-C348-BBF10303728A}"/>
                </a:ext>
              </a:extLst>
            </p:cNvPr>
            <p:cNvCxnSpPr/>
            <p:nvPr/>
          </p:nvCxnSpPr>
          <p:spPr>
            <a:xfrm>
              <a:off x="5438888" y="247170"/>
              <a:ext cx="0" cy="1921264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D1B5612A-6E51-E1B7-9CC4-C4F9D37EDF17}"/>
                </a:ext>
              </a:extLst>
            </p:cNvPr>
            <p:cNvCxnSpPr>
              <a:cxnSpLocks/>
            </p:cNvCxnSpPr>
            <p:nvPr/>
          </p:nvCxnSpPr>
          <p:spPr>
            <a:xfrm>
              <a:off x="5437968" y="2352992"/>
              <a:ext cx="0" cy="3747227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601A16DC-80AB-4ABF-7154-C0227D390FE0}"/>
                </a:ext>
              </a:extLst>
            </p:cNvPr>
            <p:cNvSpPr txBox="1"/>
            <p:nvPr/>
          </p:nvSpPr>
          <p:spPr>
            <a:xfrm rot="16200000">
              <a:off x="4325047" y="1039560"/>
              <a:ext cx="19212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C147ED6B-EAD9-B3BF-8A10-C50466F22682}"/>
                </a:ext>
              </a:extLst>
            </p:cNvPr>
            <p:cNvSpPr txBox="1"/>
            <p:nvPr/>
          </p:nvSpPr>
          <p:spPr>
            <a:xfrm rot="16200000">
              <a:off x="3429541" y="4059801"/>
              <a:ext cx="3721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D50AA276-DFDA-0A03-AEA5-59245DCFE5F4}"/>
                </a:ext>
              </a:extLst>
            </p:cNvPr>
            <p:cNvSpPr txBox="1"/>
            <p:nvPr/>
          </p:nvSpPr>
          <p:spPr>
            <a:xfrm>
              <a:off x="1096205" y="484225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D12D37E8-7095-4A7B-3C0F-1AE00F5A80C4}"/>
                </a:ext>
              </a:extLst>
            </p:cNvPr>
            <p:cNvSpPr txBox="1"/>
            <p:nvPr/>
          </p:nvSpPr>
          <p:spPr>
            <a:xfrm>
              <a:off x="1096205" y="838620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44B1D291-54EC-2CF1-F483-A2F93DF48DA9}"/>
                </a:ext>
              </a:extLst>
            </p:cNvPr>
            <p:cNvSpPr txBox="1"/>
            <p:nvPr/>
          </p:nvSpPr>
          <p:spPr>
            <a:xfrm>
              <a:off x="1096205" y="1473269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C38C40E2-2DED-3ABB-066A-877813C83120}"/>
                </a:ext>
              </a:extLst>
            </p:cNvPr>
            <p:cNvSpPr txBox="1"/>
            <p:nvPr/>
          </p:nvSpPr>
          <p:spPr>
            <a:xfrm>
              <a:off x="1096205" y="1808614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6DD1C1C-B4FC-8CF2-033B-74B6EB30E92E}"/>
                </a:ext>
              </a:extLst>
            </p:cNvPr>
            <p:cNvSpPr txBox="1"/>
            <p:nvPr/>
          </p:nvSpPr>
          <p:spPr>
            <a:xfrm>
              <a:off x="1096205" y="2836642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B450B631-5DA0-B20D-F956-811C32647586}"/>
                </a:ext>
              </a:extLst>
            </p:cNvPr>
            <p:cNvSpPr txBox="1"/>
            <p:nvPr/>
          </p:nvSpPr>
          <p:spPr>
            <a:xfrm>
              <a:off x="1096205" y="3203737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0F4F6BCF-14F7-D49E-700A-1522D25092D9}"/>
                </a:ext>
              </a:extLst>
            </p:cNvPr>
            <p:cNvSpPr txBox="1"/>
            <p:nvPr/>
          </p:nvSpPr>
          <p:spPr>
            <a:xfrm>
              <a:off x="1096205" y="4106010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14578B03-FA01-22A5-786B-E0BBFE0CA599}"/>
                </a:ext>
              </a:extLst>
            </p:cNvPr>
            <p:cNvSpPr txBox="1"/>
            <p:nvPr/>
          </p:nvSpPr>
          <p:spPr>
            <a:xfrm>
              <a:off x="1096205" y="4460405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36116685-0A63-8EEC-899C-A2ADBC88D177}"/>
                </a:ext>
              </a:extLst>
            </p:cNvPr>
            <p:cNvSpPr txBox="1"/>
            <p:nvPr/>
          </p:nvSpPr>
          <p:spPr>
            <a:xfrm>
              <a:off x="1096205" y="5405683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A093B659-F39D-8659-9161-0B1EFF372FBB}"/>
                </a:ext>
              </a:extLst>
            </p:cNvPr>
            <p:cNvSpPr txBox="1"/>
            <p:nvPr/>
          </p:nvSpPr>
          <p:spPr>
            <a:xfrm>
              <a:off x="1096205" y="5741028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956950B9-00BB-4D6E-372B-AE52F972CD86}"/>
                </a:ext>
              </a:extLst>
            </p:cNvPr>
            <p:cNvSpPr txBox="1"/>
            <p:nvPr/>
          </p:nvSpPr>
          <p:spPr>
            <a:xfrm>
              <a:off x="5800950" y="471105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E07162F2-B36F-DE7D-6030-169FA3573690}"/>
                </a:ext>
              </a:extLst>
            </p:cNvPr>
            <p:cNvSpPr txBox="1"/>
            <p:nvPr/>
          </p:nvSpPr>
          <p:spPr>
            <a:xfrm>
              <a:off x="5800950" y="857250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67DBA0F9-B675-41A9-8722-9678CB78CB9D}"/>
                </a:ext>
              </a:extLst>
            </p:cNvPr>
            <p:cNvSpPr txBox="1"/>
            <p:nvPr/>
          </p:nvSpPr>
          <p:spPr>
            <a:xfrm>
              <a:off x="5800950" y="1466499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A0780196-6114-C3F0-1268-47407032596A}"/>
                </a:ext>
              </a:extLst>
            </p:cNvPr>
            <p:cNvSpPr txBox="1"/>
            <p:nvPr/>
          </p:nvSpPr>
          <p:spPr>
            <a:xfrm>
              <a:off x="5800950" y="1808194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BC9641E1-3276-E768-B73F-95092CA8ED10}"/>
                </a:ext>
              </a:extLst>
            </p:cNvPr>
            <p:cNvSpPr txBox="1"/>
            <p:nvPr/>
          </p:nvSpPr>
          <p:spPr>
            <a:xfrm>
              <a:off x="5800950" y="2848922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8A875D73-64A8-94B5-FA8E-EAC9636796CA}"/>
                </a:ext>
              </a:extLst>
            </p:cNvPr>
            <p:cNvSpPr txBox="1"/>
            <p:nvPr/>
          </p:nvSpPr>
          <p:spPr>
            <a:xfrm>
              <a:off x="5800950" y="3216017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007F2E3-A903-4074-C783-100D5A95F29F}"/>
                </a:ext>
              </a:extLst>
            </p:cNvPr>
            <p:cNvSpPr txBox="1"/>
            <p:nvPr/>
          </p:nvSpPr>
          <p:spPr>
            <a:xfrm>
              <a:off x="5800950" y="4124640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8954FF55-6956-1DF4-1A54-747CD14DB7F5}"/>
                </a:ext>
              </a:extLst>
            </p:cNvPr>
            <p:cNvSpPr txBox="1"/>
            <p:nvPr/>
          </p:nvSpPr>
          <p:spPr>
            <a:xfrm>
              <a:off x="5800950" y="4472685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1A791006-7E5A-83ED-C855-4B5D853175E1}"/>
                </a:ext>
              </a:extLst>
            </p:cNvPr>
            <p:cNvSpPr txBox="1"/>
            <p:nvPr/>
          </p:nvSpPr>
          <p:spPr>
            <a:xfrm>
              <a:off x="5800950" y="5411613"/>
              <a:ext cx="1939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wd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14BFF8AE-6414-87C5-3FA8-64E0B211C7EF}"/>
                </a:ext>
              </a:extLst>
            </p:cNvPr>
            <p:cNvSpPr txBox="1"/>
            <p:nvPr/>
          </p:nvSpPr>
          <p:spPr>
            <a:xfrm>
              <a:off x="5800950" y="5759658"/>
              <a:ext cx="18274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v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96D705B8-977B-ACAC-47E6-69CA5613ACDE}"/>
                </a:ext>
              </a:extLst>
            </p:cNvPr>
            <p:cNvSpPr/>
            <p:nvPr/>
          </p:nvSpPr>
          <p:spPr>
            <a:xfrm>
              <a:off x="1103084" y="3796274"/>
              <a:ext cx="1655904" cy="889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P2A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1FDA35DD-A113-6BB2-0FCA-F6A27ECA1BD4}"/>
                </a:ext>
              </a:extLst>
            </p:cNvPr>
            <p:cNvSpPr/>
            <p:nvPr/>
          </p:nvSpPr>
          <p:spPr>
            <a:xfrm>
              <a:off x="2760684" y="3796274"/>
              <a:ext cx="2052340" cy="889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81BE1635-F8D0-3D61-3618-5D5841963282}"/>
                </a:ext>
              </a:extLst>
            </p:cNvPr>
            <p:cNvSpPr/>
            <p:nvPr/>
          </p:nvSpPr>
          <p:spPr>
            <a:xfrm>
              <a:off x="1103084" y="5092252"/>
              <a:ext cx="1689052" cy="91472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28C0BAA-0670-0043-8B89-5B2DD15F6D24}"/>
                </a:ext>
              </a:extLst>
            </p:cNvPr>
            <p:cNvSpPr/>
            <p:nvPr/>
          </p:nvSpPr>
          <p:spPr>
            <a:xfrm>
              <a:off x="2937374" y="2519698"/>
              <a:ext cx="1871955" cy="889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TOH7 CDS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A1B7460-3E56-4A10-CB9D-A125439E5B17}"/>
                </a:ext>
              </a:extLst>
            </p:cNvPr>
            <p:cNvSpPr/>
            <p:nvPr/>
          </p:nvSpPr>
          <p:spPr>
            <a:xfrm>
              <a:off x="5794509" y="3797171"/>
              <a:ext cx="1668845" cy="889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P2A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CA7393A4-101A-11F1-7680-426FB4D56723}"/>
                </a:ext>
              </a:extLst>
            </p:cNvPr>
            <p:cNvSpPr/>
            <p:nvPr/>
          </p:nvSpPr>
          <p:spPr>
            <a:xfrm>
              <a:off x="7468116" y="3797171"/>
              <a:ext cx="2036333" cy="889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3F2A7EB-1A48-C387-985E-D2964A77250B}"/>
                </a:ext>
              </a:extLst>
            </p:cNvPr>
            <p:cNvSpPr/>
            <p:nvPr/>
          </p:nvSpPr>
          <p:spPr>
            <a:xfrm>
              <a:off x="5796891" y="5093149"/>
              <a:ext cx="1656939" cy="91472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D3396B83-B7BD-E2A8-BB7E-84E1E9E225BD}"/>
                </a:ext>
              </a:extLst>
            </p:cNvPr>
            <p:cNvSpPr/>
            <p:nvPr/>
          </p:nvSpPr>
          <p:spPr>
            <a:xfrm>
              <a:off x="7660999" y="2520595"/>
              <a:ext cx="1842137" cy="889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TOH7 CD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571547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CCB9EAE-73AD-5764-69AC-3F56F79CC8FB}"/>
              </a:ext>
            </a:extLst>
          </p:cNvPr>
          <p:cNvGrpSpPr/>
          <p:nvPr/>
        </p:nvGrpSpPr>
        <p:grpSpPr>
          <a:xfrm>
            <a:off x="478970" y="98355"/>
            <a:ext cx="9202059" cy="6735640"/>
            <a:chOff x="478970" y="98355"/>
            <a:chExt cx="9202059" cy="6735640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F865556-343C-FB22-44B5-E336D7CA88F6}"/>
                </a:ext>
              </a:extLst>
            </p:cNvPr>
            <p:cNvSpPr txBox="1"/>
            <p:nvPr/>
          </p:nvSpPr>
          <p:spPr>
            <a:xfrm>
              <a:off x="478970" y="6126109"/>
              <a:ext cx="920205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3. Example electropherograms of top off-target sites in an </a:t>
              </a:r>
              <a:r>
                <a:rPr lang="en-US" sz="800" b="1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b="1" i="1" baseline="300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iPSC line.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Genomic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DNA from s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tem cell colonies was amplified using primer pairs OT5_1-4F/R and OT3_1-4F/R (Table S3), targeting top off-target sites for CRISPR/Cas9 guides sgRNA-5KO and sgRNA-3KO (Table S1). Sanger sequencing was performed using primer using a single primer of the pair. Sequences were aligned to GRCh38p14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reference where the predicted off-target cut site is centered and demarked by a vertical line, the predicted off-target sequence is shown in orange, the corresponding PAM site in blue, and any gene elements are shown in green.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lignments were visualized using </a:t>
              </a:r>
              <a:r>
                <a:rPr lang="en-US" sz="800" dirty="0" err="1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Benchling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(https://www.benchling.com).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iPS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induced pluripotent stem cell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knockout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PAM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protospacer adjacent motif.</a:t>
              </a:r>
              <a:endParaRPr lang="en-US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41165B0-486B-EA07-50B9-395048EB87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7978" y="98355"/>
              <a:ext cx="3979997" cy="13479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527E9E6-DEBC-64C1-DFA4-5FF2DDA1E7A7}"/>
                </a:ext>
              </a:extLst>
            </p:cNvPr>
            <p:cNvSpPr txBox="1"/>
            <p:nvPr/>
          </p:nvSpPr>
          <p:spPr>
            <a:xfrm>
              <a:off x="7717258" y="374865"/>
              <a:ext cx="59183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ZFAND5 gene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A26F236-2E12-6136-025E-2EA28F19F938}"/>
                </a:ext>
              </a:extLst>
            </p:cNvPr>
            <p:cNvSpPr txBox="1"/>
            <p:nvPr/>
          </p:nvSpPr>
          <p:spPr>
            <a:xfrm rot="16200000">
              <a:off x="4755632" y="618419"/>
              <a:ext cx="13479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3-1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EF6A120-8B8C-FDBB-4561-48BE0E7386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7981" y="1535916"/>
              <a:ext cx="3979996" cy="13479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ED7EB06-50B0-5A5F-5666-B11B7AD4E9D7}"/>
                </a:ext>
              </a:extLst>
            </p:cNvPr>
            <p:cNvSpPr txBox="1"/>
            <p:nvPr/>
          </p:nvSpPr>
          <p:spPr>
            <a:xfrm>
              <a:off x="7595808" y="1806834"/>
              <a:ext cx="85472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OC101928120 ncRNA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574C109-CA47-CB42-C7F9-AE5CCF93C503}"/>
                </a:ext>
              </a:extLst>
            </p:cNvPr>
            <p:cNvSpPr txBox="1"/>
            <p:nvPr/>
          </p:nvSpPr>
          <p:spPr>
            <a:xfrm>
              <a:off x="7627067" y="1907911"/>
              <a:ext cx="7922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OC101928120 gene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08C0011-71CE-CA6D-45DA-50193B650460}"/>
                </a:ext>
              </a:extLst>
            </p:cNvPr>
            <p:cNvSpPr txBox="1"/>
            <p:nvPr/>
          </p:nvSpPr>
          <p:spPr>
            <a:xfrm rot="16200000">
              <a:off x="4755632" y="2055979"/>
              <a:ext cx="13479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3-2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B533406-9DCB-93B3-C1EA-B948723A5A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7982" y="2973477"/>
              <a:ext cx="3979996" cy="13479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1F3EE14-2B80-5D32-FBBC-E5248617CC74}"/>
                </a:ext>
              </a:extLst>
            </p:cNvPr>
            <p:cNvSpPr txBox="1"/>
            <p:nvPr/>
          </p:nvSpPr>
          <p:spPr>
            <a:xfrm>
              <a:off x="7717664" y="3236111"/>
              <a:ext cx="60465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MYH10 mRNA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8C338E9-8246-3FE1-A42C-BEF9D84FF623}"/>
                </a:ext>
              </a:extLst>
            </p:cNvPr>
            <p:cNvSpPr txBox="1"/>
            <p:nvPr/>
          </p:nvSpPr>
          <p:spPr>
            <a:xfrm>
              <a:off x="7741710" y="3343538"/>
              <a:ext cx="5565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MYH10 gene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DEB69E3-2BEE-B903-8989-7DE09C18EA28}"/>
                </a:ext>
              </a:extLst>
            </p:cNvPr>
            <p:cNvSpPr txBox="1"/>
            <p:nvPr/>
          </p:nvSpPr>
          <p:spPr>
            <a:xfrm rot="16200000">
              <a:off x="4755632" y="3493540"/>
              <a:ext cx="13479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3-3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64B20EC-3D1C-28A6-28E9-09195AE24B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97982" y="4411036"/>
              <a:ext cx="3979994" cy="17032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D0616E1-6AB2-A9BC-762E-9E7D948E41ED}"/>
                </a:ext>
              </a:extLst>
            </p:cNvPr>
            <p:cNvSpPr txBox="1"/>
            <p:nvPr/>
          </p:nvSpPr>
          <p:spPr>
            <a:xfrm>
              <a:off x="6767788" y="5019910"/>
              <a:ext cx="65274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C6orf226 mRNA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8E7225E-8CD7-10B9-AFEC-6C7AA676A792}"/>
                </a:ext>
              </a:extLst>
            </p:cNvPr>
            <p:cNvSpPr txBox="1"/>
            <p:nvPr/>
          </p:nvSpPr>
          <p:spPr>
            <a:xfrm>
              <a:off x="6791832" y="5127651"/>
              <a:ext cx="60465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C6orf226 gene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795F44C-E7E0-CE1E-82CA-236B08E2074D}"/>
                </a:ext>
              </a:extLst>
            </p:cNvPr>
            <p:cNvSpPr txBox="1"/>
            <p:nvPr/>
          </p:nvSpPr>
          <p:spPr>
            <a:xfrm rot="16200000">
              <a:off x="4587733" y="5118558"/>
              <a:ext cx="16837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3-4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F14E284F-F01C-C93D-72CD-0FF6B58073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48303" y="98355"/>
              <a:ext cx="3979998" cy="13479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029321E-75D6-EC60-5542-CB4BE7FD16B7}"/>
                </a:ext>
              </a:extLst>
            </p:cNvPr>
            <p:cNvSpPr txBox="1"/>
            <p:nvPr/>
          </p:nvSpPr>
          <p:spPr>
            <a:xfrm rot="16200000">
              <a:off x="10951" y="621973"/>
              <a:ext cx="13479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5-1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2AD46B90-AC45-72C1-48FE-13F4E5625E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48307" y="1654602"/>
              <a:ext cx="3979994" cy="13479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1A64CBA-5808-DBD4-82DA-C45A4A6EC599}"/>
                </a:ext>
              </a:extLst>
            </p:cNvPr>
            <p:cNvSpPr txBox="1"/>
            <p:nvPr/>
          </p:nvSpPr>
          <p:spPr>
            <a:xfrm>
              <a:off x="2055757" y="1919170"/>
              <a:ext cx="5645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ESS2 mRN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B16EE28-2CB7-AE38-F20F-F62299B5F7D1}"/>
                </a:ext>
              </a:extLst>
            </p:cNvPr>
            <p:cNvSpPr txBox="1"/>
            <p:nvPr/>
          </p:nvSpPr>
          <p:spPr>
            <a:xfrm>
              <a:off x="2055757" y="2020486"/>
              <a:ext cx="51488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ESS2 gene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EF04DBD-2CCF-145A-BA4B-B8E4D470EBDE}"/>
                </a:ext>
              </a:extLst>
            </p:cNvPr>
            <p:cNvSpPr txBox="1"/>
            <p:nvPr/>
          </p:nvSpPr>
          <p:spPr>
            <a:xfrm rot="16200000">
              <a:off x="10951" y="2178219"/>
              <a:ext cx="13479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5-2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13F276C4-0731-A138-9889-358532D578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48312" y="3210848"/>
              <a:ext cx="3979989" cy="13479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B07439B-6813-E0F4-BE9A-9F090A9744F1}"/>
                </a:ext>
              </a:extLst>
            </p:cNvPr>
            <p:cNvSpPr txBox="1"/>
            <p:nvPr/>
          </p:nvSpPr>
          <p:spPr>
            <a:xfrm rot="16200000">
              <a:off x="10951" y="3734465"/>
              <a:ext cx="13479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5-3</a:t>
              </a:r>
            </a:p>
          </p:txBody>
        </p: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3FECAA32-298E-3D7F-6839-B25E4E9D29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48303" y="4767094"/>
              <a:ext cx="3979989" cy="13479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90BEA90-3E81-40C1-8E66-E55E44E06C68}"/>
                </a:ext>
              </a:extLst>
            </p:cNvPr>
            <p:cNvSpPr txBox="1"/>
            <p:nvPr/>
          </p:nvSpPr>
          <p:spPr>
            <a:xfrm>
              <a:off x="2047325" y="5038814"/>
              <a:ext cx="60144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SPRYD3 gene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8223AAC-3B3B-4AD7-DB1C-58CE9E3D0BF9}"/>
                </a:ext>
              </a:extLst>
            </p:cNvPr>
            <p:cNvSpPr txBox="1"/>
            <p:nvPr/>
          </p:nvSpPr>
          <p:spPr>
            <a:xfrm rot="16200000">
              <a:off x="22510" y="5298714"/>
              <a:ext cx="13247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T5-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9166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C2C6DCC-771D-8D59-706B-2E6051EA0143}"/>
              </a:ext>
            </a:extLst>
          </p:cNvPr>
          <p:cNvGrpSpPr/>
          <p:nvPr/>
        </p:nvGrpSpPr>
        <p:grpSpPr>
          <a:xfrm>
            <a:off x="152060" y="391963"/>
            <a:ext cx="9570274" cy="6077857"/>
            <a:chOff x="152060" y="391963"/>
            <a:chExt cx="9570274" cy="6077857"/>
          </a:xfrm>
        </p:grpSpPr>
        <p:pic>
          <p:nvPicPr>
            <p:cNvPr id="59" name="Picture 58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AE8CF166-0458-D8C1-9433-A395CD4DC6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2342" y="982640"/>
              <a:ext cx="4320000" cy="19252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0" name="Picture 59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59BF757D-6841-EB8A-FCFB-47A2A0EE0B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2342" y="2915086"/>
              <a:ext cx="4320000" cy="19252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Picture 60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90B1DCC5-A3AD-1627-0E00-3F4C399702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0759" y="987718"/>
              <a:ext cx="4320000" cy="19252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2" name="Picture 61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EE600BB7-82C2-AF28-E041-19692CE5E9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0759" y="2922265"/>
              <a:ext cx="4320000" cy="19170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80AB2A73-10FE-3836-E43D-5909140F4B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2342" y="707732"/>
              <a:ext cx="4320000" cy="2640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Picture 19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947777EE-CEFB-727F-4EA2-F8D2B1782B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2342" y="4850073"/>
              <a:ext cx="4320000" cy="9006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56451931-44EE-FF4D-9DB9-E9B433B44DA7}"/>
                </a:ext>
              </a:extLst>
            </p:cNvPr>
            <p:cNvGrpSpPr/>
            <p:nvPr/>
          </p:nvGrpSpPr>
          <p:grpSpPr>
            <a:xfrm>
              <a:off x="449313" y="4799692"/>
              <a:ext cx="631233" cy="934119"/>
              <a:chOff x="2272289" y="5936179"/>
              <a:chExt cx="597758" cy="884582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85E6880-C195-798B-3568-168618B72A50}"/>
                  </a:ext>
                </a:extLst>
              </p:cNvPr>
              <p:cNvSpPr txBox="1"/>
              <p:nvPr/>
            </p:nvSpPr>
            <p:spPr>
              <a:xfrm>
                <a:off x="2272289" y="6075206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S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829850B-E0E7-FC96-F9FE-1193D95207DD}"/>
                  </a:ext>
                </a:extLst>
              </p:cNvPr>
              <p:cNvSpPr txBox="1"/>
              <p:nvPr/>
            </p:nvSpPr>
            <p:spPr>
              <a:xfrm>
                <a:off x="2272289" y="6214233"/>
                <a:ext cx="479349" cy="189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MYC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A70C2E9-B79B-384F-1269-B760C97B0D90}"/>
                  </a:ext>
                </a:extLst>
              </p:cNvPr>
              <p:cNvSpPr txBox="1"/>
              <p:nvPr/>
            </p:nvSpPr>
            <p:spPr>
              <a:xfrm>
                <a:off x="2272289" y="6353260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2A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3F2599D-9C3F-0AAC-0BCF-57EED62E8614}"/>
                  </a:ext>
                </a:extLst>
              </p:cNvPr>
              <p:cNvSpPr txBox="1"/>
              <p:nvPr/>
            </p:nvSpPr>
            <p:spPr>
              <a:xfrm>
                <a:off x="2272289" y="6492287"/>
                <a:ext cx="597758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P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1A7643A-B15D-ACFE-8E7A-85007138D7A9}"/>
                  </a:ext>
                </a:extLst>
              </p:cNvPr>
              <p:cNvSpPr txBox="1"/>
              <p:nvPr/>
            </p:nvSpPr>
            <p:spPr>
              <a:xfrm>
                <a:off x="2272289" y="6631315"/>
                <a:ext cx="597758" cy="189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-HA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D77256A-2A04-EBA2-4941-6E44540B9ED2}"/>
                  </a:ext>
                </a:extLst>
              </p:cNvPr>
              <p:cNvSpPr txBox="1"/>
              <p:nvPr/>
            </p:nvSpPr>
            <p:spPr>
              <a:xfrm>
                <a:off x="2272289" y="5936179"/>
                <a:ext cx="597758" cy="189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’-HA</a:t>
                </a:r>
              </a:p>
            </p:txBody>
          </p:sp>
        </p:grpSp>
        <p:pic>
          <p:nvPicPr>
            <p:cNvPr id="12" name="Picture 11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B6F1D7B9-07B7-AE95-A054-707F0179C3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0759" y="711955"/>
              <a:ext cx="4320000" cy="2640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Picture 28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F6569E35-2DD4-FC11-214A-55F123F85C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80759" y="4851457"/>
              <a:ext cx="4320000" cy="9056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0C8C8AD8-D683-DE12-BE53-1220F10AF77E}"/>
                </a:ext>
              </a:extLst>
            </p:cNvPr>
            <p:cNvGrpSpPr/>
            <p:nvPr/>
          </p:nvGrpSpPr>
          <p:grpSpPr>
            <a:xfrm>
              <a:off x="5333162" y="4801076"/>
              <a:ext cx="631233" cy="934119"/>
              <a:chOff x="2272289" y="5936179"/>
              <a:chExt cx="597758" cy="884582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A2941069-FA1C-9B1E-B297-E3373EF450B5}"/>
                  </a:ext>
                </a:extLst>
              </p:cNvPr>
              <p:cNvSpPr txBox="1"/>
              <p:nvPr/>
            </p:nvSpPr>
            <p:spPr>
              <a:xfrm>
                <a:off x="2272289" y="6075206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S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B56836AC-66BB-55C8-E3E2-40E64BE22068}"/>
                  </a:ext>
                </a:extLst>
              </p:cNvPr>
              <p:cNvSpPr txBox="1"/>
              <p:nvPr/>
            </p:nvSpPr>
            <p:spPr>
              <a:xfrm>
                <a:off x="2272289" y="6214233"/>
                <a:ext cx="479349" cy="189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MYC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A1A049F-1F9B-3F2A-8E66-98A0DD031086}"/>
                  </a:ext>
                </a:extLst>
              </p:cNvPr>
              <p:cNvSpPr txBox="1"/>
              <p:nvPr/>
            </p:nvSpPr>
            <p:spPr>
              <a:xfrm>
                <a:off x="2272289" y="6353260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2A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04BF666A-4E0C-406D-9D7B-FEB1F42EB666}"/>
                  </a:ext>
                </a:extLst>
              </p:cNvPr>
              <p:cNvSpPr txBox="1"/>
              <p:nvPr/>
            </p:nvSpPr>
            <p:spPr>
              <a:xfrm>
                <a:off x="2272289" y="6492287"/>
                <a:ext cx="597758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P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84872E9-1F72-11E9-5938-C214452B51B1}"/>
                  </a:ext>
                </a:extLst>
              </p:cNvPr>
              <p:cNvSpPr txBox="1"/>
              <p:nvPr/>
            </p:nvSpPr>
            <p:spPr>
              <a:xfrm>
                <a:off x="2272289" y="6631315"/>
                <a:ext cx="597758" cy="189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-H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AF3CD29-ADAC-A0B1-9731-52365444D105}"/>
                  </a:ext>
                </a:extLst>
              </p:cNvPr>
              <p:cNvSpPr txBox="1"/>
              <p:nvPr/>
            </p:nvSpPr>
            <p:spPr>
              <a:xfrm>
                <a:off x="2272289" y="5936179"/>
                <a:ext cx="597758" cy="1894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’-HA</a:t>
                </a:r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9A2BFA5-CEFA-2D3A-708E-C62DFC18E203}"/>
                </a:ext>
              </a:extLst>
            </p:cNvPr>
            <p:cNvSpPr txBox="1"/>
            <p:nvPr/>
          </p:nvSpPr>
          <p:spPr>
            <a:xfrm>
              <a:off x="482342" y="391963"/>
              <a:ext cx="43080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eference: </a:t>
              </a:r>
              <a:r>
                <a:rPr kumimoji="0" lang="en-US" sz="14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TOH7</a:t>
              </a:r>
              <a:r>
                <a:rPr kumimoji="0" lang="en-US" sz="1400" b="1" i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lasmid donor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F27AD4F-83B9-AEF3-B4D7-A2D1F9A5B1E8}"/>
                </a:ext>
              </a:extLst>
            </p:cNvPr>
            <p:cNvSpPr txBox="1"/>
            <p:nvPr/>
          </p:nvSpPr>
          <p:spPr>
            <a:xfrm>
              <a:off x="5389398" y="391963"/>
              <a:ext cx="43080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eference: </a:t>
              </a:r>
              <a:r>
                <a:rPr kumimoji="0" lang="en-US" sz="14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TOH7</a:t>
              </a:r>
              <a:r>
                <a:rPr kumimoji="0" lang="en-US" sz="1400" b="1" i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lasmid donor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AFEFBD1-8791-8AF1-935D-8CA67E54E253}"/>
                </a:ext>
              </a:extLst>
            </p:cNvPr>
            <p:cNvSpPr txBox="1"/>
            <p:nvPr/>
          </p:nvSpPr>
          <p:spPr>
            <a:xfrm rot="16200000">
              <a:off x="-649400" y="1791605"/>
              <a:ext cx="19247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1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6070026-78BC-EA20-3C9B-0B4997C0D0BF}"/>
                </a:ext>
              </a:extLst>
            </p:cNvPr>
            <p:cNvSpPr txBox="1"/>
            <p:nvPr/>
          </p:nvSpPr>
          <p:spPr>
            <a:xfrm rot="16200000">
              <a:off x="-655509" y="3720504"/>
              <a:ext cx="19229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2)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5EF09630-025B-7185-50DF-732C23DC269D}"/>
                </a:ext>
              </a:extLst>
            </p:cNvPr>
            <p:cNvSpPr txBox="1"/>
            <p:nvPr/>
          </p:nvSpPr>
          <p:spPr>
            <a:xfrm rot="16200000">
              <a:off x="4241754" y="1785537"/>
              <a:ext cx="1922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3)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1434705-CE4F-E4D6-7757-33DE34C298E3}"/>
                </a:ext>
              </a:extLst>
            </p:cNvPr>
            <p:cNvSpPr txBox="1"/>
            <p:nvPr/>
          </p:nvSpPr>
          <p:spPr>
            <a:xfrm rot="16200000">
              <a:off x="4244596" y="3712508"/>
              <a:ext cx="19170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4)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3FC2D78-4624-0A96-0047-3CF3FE017439}"/>
                </a:ext>
              </a:extLst>
            </p:cNvPr>
            <p:cNvSpPr txBox="1"/>
            <p:nvPr/>
          </p:nvSpPr>
          <p:spPr>
            <a:xfrm>
              <a:off x="488859" y="961084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D820450-CA50-989F-371A-E64C975B2FEE}"/>
                </a:ext>
              </a:extLst>
            </p:cNvPr>
            <p:cNvSpPr txBox="1"/>
            <p:nvPr/>
          </p:nvSpPr>
          <p:spPr>
            <a:xfrm>
              <a:off x="488859" y="1714188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ense alignment 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7F5DCB9-F1FA-DD1D-82C1-EACBC35FABFF}"/>
                </a:ext>
              </a:extLst>
            </p:cNvPr>
            <p:cNvSpPr txBox="1"/>
            <p:nvPr/>
          </p:nvSpPr>
          <p:spPr>
            <a:xfrm>
              <a:off x="488859" y="4647982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567C539-E0F7-3885-6B48-33A4124FDB64}"/>
                </a:ext>
              </a:extLst>
            </p:cNvPr>
            <p:cNvSpPr txBox="1"/>
            <p:nvPr/>
          </p:nvSpPr>
          <p:spPr>
            <a:xfrm>
              <a:off x="488859" y="3683491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ense alignment 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4642E8F-4B4C-97FE-1367-C8889B6B5A62}"/>
                </a:ext>
              </a:extLst>
            </p:cNvPr>
            <p:cNvSpPr txBox="1"/>
            <p:nvPr/>
          </p:nvSpPr>
          <p:spPr>
            <a:xfrm>
              <a:off x="488859" y="2883847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EB07773-39BE-7599-C916-0B946A11F65A}"/>
                </a:ext>
              </a:extLst>
            </p:cNvPr>
            <p:cNvSpPr txBox="1"/>
            <p:nvPr/>
          </p:nvSpPr>
          <p:spPr>
            <a:xfrm>
              <a:off x="488859" y="2713267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3557269-BD2C-6037-68F3-19B5FACA5E2F}"/>
                </a:ext>
              </a:extLst>
            </p:cNvPr>
            <p:cNvSpPr txBox="1"/>
            <p:nvPr/>
          </p:nvSpPr>
          <p:spPr>
            <a:xfrm>
              <a:off x="5380760" y="978045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B257AFF-5847-2194-5889-26B8ED400EE8}"/>
                </a:ext>
              </a:extLst>
            </p:cNvPr>
            <p:cNvSpPr txBox="1"/>
            <p:nvPr/>
          </p:nvSpPr>
          <p:spPr>
            <a:xfrm>
              <a:off x="5380760" y="1714188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ense alignment 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B9C29904-80E3-CBAC-92BE-342ADD6683A6}"/>
                </a:ext>
              </a:extLst>
            </p:cNvPr>
            <p:cNvSpPr txBox="1"/>
            <p:nvPr/>
          </p:nvSpPr>
          <p:spPr>
            <a:xfrm>
              <a:off x="5380760" y="4647982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B58B10C-3E1D-0EF9-DA24-EC4860397586}"/>
                </a:ext>
              </a:extLst>
            </p:cNvPr>
            <p:cNvSpPr txBox="1"/>
            <p:nvPr/>
          </p:nvSpPr>
          <p:spPr>
            <a:xfrm>
              <a:off x="5380760" y="3683491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ense alignment 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1BEAADD-AB32-8028-46FE-C48E50B00F36}"/>
                </a:ext>
              </a:extLst>
            </p:cNvPr>
            <p:cNvSpPr txBox="1"/>
            <p:nvPr/>
          </p:nvSpPr>
          <p:spPr>
            <a:xfrm>
              <a:off x="5380760" y="2900808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E847102-09E2-6030-FF53-3D418A1F95F0}"/>
                </a:ext>
              </a:extLst>
            </p:cNvPr>
            <p:cNvSpPr txBox="1"/>
            <p:nvPr/>
          </p:nvSpPr>
          <p:spPr>
            <a:xfrm>
              <a:off x="5380760" y="2713267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29565FB-D01A-972C-9829-558A96B88D1B}"/>
                </a:ext>
              </a:extLst>
            </p:cNvPr>
            <p:cNvSpPr txBox="1"/>
            <p:nvPr/>
          </p:nvSpPr>
          <p:spPr>
            <a:xfrm>
              <a:off x="209980" y="5761934"/>
              <a:ext cx="951235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4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. Alignment of mRNA sequences from reporter organoids.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equences from both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and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reporter organoids were aligned to the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eference to investigate proper plasmid donor insertion at the target site.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equencing libraries were prepared by </a:t>
              </a:r>
              <a:r>
                <a:rPr lang="en-US" sz="800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useq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Stranded mRNA, which generates reads in antisense orientation. Reads from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organoids aligned in sense orientation to the </a:t>
              </a:r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CDS are inverted sequences, which resulted from additional NHEJ during the intended plasmid-mediated HR. The different motifs of the references are marked below the alignments. Alignments are visualized in IGV version 2.15.4.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D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oding sequenc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enhanced green fluorescent protein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homology arm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GV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integrative genomics view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HEJ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nonhomologous end join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2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porcine teschovirus-1 2A self-cleaving peptid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90346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D99BAAA-9BDF-F277-C9FF-147D6B7FD4AD}"/>
              </a:ext>
            </a:extLst>
          </p:cNvPr>
          <p:cNvGrpSpPr/>
          <p:nvPr/>
        </p:nvGrpSpPr>
        <p:grpSpPr>
          <a:xfrm>
            <a:off x="189940" y="222921"/>
            <a:ext cx="9545537" cy="6408071"/>
            <a:chOff x="189940" y="222921"/>
            <a:chExt cx="9545537" cy="6408071"/>
          </a:xfrm>
        </p:grpSpPr>
        <p:pic>
          <p:nvPicPr>
            <p:cNvPr id="83" name="Picture 82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B2A250AE-2B36-5FC2-16E7-0B546978B0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15477" y="814882"/>
              <a:ext cx="4320000" cy="20339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4" name="Picture 83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56405D62-E9BF-1C25-59A1-0C94B510E5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15477" y="2843311"/>
              <a:ext cx="4320000" cy="19934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2" name="Picture 81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44A79263-1014-DB7B-D6A2-78EEF56A6A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9934" y="2851391"/>
              <a:ext cx="4320000" cy="19881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1" name="Picture 80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508E158C-AD82-8314-8722-7AC3DCE3F6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9934" y="814882"/>
              <a:ext cx="4318108" cy="202723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EAECE9A-2D63-7006-64BD-50F5D41BB5BE}"/>
                </a:ext>
              </a:extLst>
            </p:cNvPr>
            <p:cNvSpPr txBox="1"/>
            <p:nvPr/>
          </p:nvSpPr>
          <p:spPr>
            <a:xfrm rot="16200000">
              <a:off x="-662773" y="1674608"/>
              <a:ext cx="20272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1)</a:t>
              </a:r>
            </a:p>
          </p:txBody>
        </p:sp>
        <p:pic>
          <p:nvPicPr>
            <p:cNvPr id="25" name="Picture 24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5D4EEAD1-1FF2-C8C8-1735-240CAD114A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9934" y="536459"/>
              <a:ext cx="4320000" cy="2640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Picture 23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FDD71DFF-F333-4450-DFCE-1DFA57584B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9934" y="4842235"/>
              <a:ext cx="4320000" cy="9146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57FDB92A-A3EC-EF65-8BE1-1C7BD214B507}"/>
                </a:ext>
              </a:extLst>
            </p:cNvPr>
            <p:cNvGrpSpPr/>
            <p:nvPr/>
          </p:nvGrpSpPr>
          <p:grpSpPr>
            <a:xfrm>
              <a:off x="460233" y="4791796"/>
              <a:ext cx="625682" cy="934939"/>
              <a:chOff x="2272289" y="5936179"/>
              <a:chExt cx="597758" cy="884370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7EE1C488-A8DD-CD3B-0F8E-0B99AEC82D1B}"/>
                  </a:ext>
                </a:extLst>
              </p:cNvPr>
              <p:cNvSpPr txBox="1"/>
              <p:nvPr/>
            </p:nvSpPr>
            <p:spPr>
              <a:xfrm>
                <a:off x="2272289" y="6075206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S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E7CC798-3CF0-06F0-F1AA-92461AFEA100}"/>
                  </a:ext>
                </a:extLst>
              </p:cNvPr>
              <p:cNvSpPr txBox="1"/>
              <p:nvPr/>
            </p:nvSpPr>
            <p:spPr>
              <a:xfrm>
                <a:off x="2272289" y="6214233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G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B19B6D3-78CF-D79F-187F-6E7B7C03F108}"/>
                  </a:ext>
                </a:extLst>
              </p:cNvPr>
              <p:cNvSpPr txBox="1"/>
              <p:nvPr/>
            </p:nvSpPr>
            <p:spPr>
              <a:xfrm>
                <a:off x="2272289" y="6353260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2A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C54F6047-D6BD-B713-C0DB-F4001E7BBA0F}"/>
                  </a:ext>
                </a:extLst>
              </p:cNvPr>
              <p:cNvSpPr txBox="1"/>
              <p:nvPr/>
            </p:nvSpPr>
            <p:spPr>
              <a:xfrm>
                <a:off x="2272289" y="6492287"/>
                <a:ext cx="597758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P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53F7DE62-55DC-D651-54EE-1B77F8AE6551}"/>
                  </a:ext>
                </a:extLst>
              </p:cNvPr>
              <p:cNvSpPr txBox="1"/>
              <p:nvPr/>
            </p:nvSpPr>
            <p:spPr>
              <a:xfrm>
                <a:off x="2272289" y="6631315"/>
                <a:ext cx="597758" cy="1892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-HA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DC1C432E-7A3A-0B09-9D08-F4E0DCCB8C69}"/>
                  </a:ext>
                </a:extLst>
              </p:cNvPr>
              <p:cNvSpPr txBox="1"/>
              <p:nvPr/>
            </p:nvSpPr>
            <p:spPr>
              <a:xfrm>
                <a:off x="2272289" y="5936179"/>
                <a:ext cx="597758" cy="1892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’-HA</a:t>
                </a:r>
              </a:p>
            </p:txBody>
          </p:sp>
        </p:grpSp>
        <p:pic>
          <p:nvPicPr>
            <p:cNvPr id="27" name="Picture 26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F1056590-F886-66B5-BBA1-A493B04078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15477" y="536459"/>
              <a:ext cx="4313873" cy="2636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" name="Picture 52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955F3070-C4FC-765C-C152-D23C626ACC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15477" y="4845982"/>
              <a:ext cx="4315549" cy="9046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324A5AA7-0299-0F8E-36B1-8EC218A41802}"/>
                </a:ext>
              </a:extLst>
            </p:cNvPr>
            <p:cNvGrpSpPr/>
            <p:nvPr/>
          </p:nvGrpSpPr>
          <p:grpSpPr>
            <a:xfrm>
              <a:off x="5367826" y="4795542"/>
              <a:ext cx="631939" cy="934940"/>
              <a:chOff x="2272289" y="5936179"/>
              <a:chExt cx="597758" cy="884370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93D0A06C-BA2F-3274-C779-F8856DB0B34C}"/>
                  </a:ext>
                </a:extLst>
              </p:cNvPr>
              <p:cNvSpPr txBox="1"/>
              <p:nvPr/>
            </p:nvSpPr>
            <p:spPr>
              <a:xfrm>
                <a:off x="2272289" y="6075206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S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26E9EDB3-4012-7AAC-05C1-CE0B46E97F2E}"/>
                  </a:ext>
                </a:extLst>
              </p:cNvPr>
              <p:cNvSpPr txBox="1"/>
              <p:nvPr/>
            </p:nvSpPr>
            <p:spPr>
              <a:xfrm>
                <a:off x="2272289" y="6214233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G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9B126F5A-9616-A80E-927E-C1116937796D}"/>
                  </a:ext>
                </a:extLst>
              </p:cNvPr>
              <p:cNvSpPr txBox="1"/>
              <p:nvPr/>
            </p:nvSpPr>
            <p:spPr>
              <a:xfrm>
                <a:off x="2272289" y="6353260"/>
                <a:ext cx="47934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2A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CAC67202-38F5-6315-81CD-47A3CB1EE014}"/>
                  </a:ext>
                </a:extLst>
              </p:cNvPr>
              <p:cNvSpPr txBox="1"/>
              <p:nvPr/>
            </p:nvSpPr>
            <p:spPr>
              <a:xfrm>
                <a:off x="2272289" y="6492287"/>
                <a:ext cx="597758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P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A4210608-03A9-38D8-0258-04BBE7035BC4}"/>
                  </a:ext>
                </a:extLst>
              </p:cNvPr>
              <p:cNvSpPr txBox="1"/>
              <p:nvPr/>
            </p:nvSpPr>
            <p:spPr>
              <a:xfrm>
                <a:off x="2272289" y="6631315"/>
                <a:ext cx="597758" cy="1892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-HA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6DA75488-97F1-A2AC-6C23-359C8BC1B51A}"/>
                  </a:ext>
                </a:extLst>
              </p:cNvPr>
              <p:cNvSpPr txBox="1"/>
              <p:nvPr/>
            </p:nvSpPr>
            <p:spPr>
              <a:xfrm>
                <a:off x="2272289" y="5936179"/>
                <a:ext cx="597758" cy="1892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’-HA</a:t>
                </a:r>
              </a:p>
            </p:txBody>
          </p:sp>
        </p:grp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73473A31-022D-FD19-497A-AD588BCEA892}"/>
                </a:ext>
              </a:extLst>
            </p:cNvPr>
            <p:cNvSpPr txBox="1"/>
            <p:nvPr/>
          </p:nvSpPr>
          <p:spPr>
            <a:xfrm rot="16200000">
              <a:off x="-677570" y="3669585"/>
              <a:ext cx="20427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2)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AB54166-81A4-8A5F-0701-8C813BE9A77A}"/>
                </a:ext>
              </a:extLst>
            </p:cNvPr>
            <p:cNvSpPr txBox="1"/>
            <p:nvPr/>
          </p:nvSpPr>
          <p:spPr>
            <a:xfrm rot="16200000">
              <a:off x="4256089" y="1676862"/>
              <a:ext cx="20338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3)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51B90B9-9851-DB46-66B9-F06E9990A187}"/>
                </a:ext>
              </a:extLst>
            </p:cNvPr>
            <p:cNvSpPr txBox="1"/>
            <p:nvPr/>
          </p:nvSpPr>
          <p:spPr>
            <a:xfrm rot="16200000">
              <a:off x="4244625" y="3707294"/>
              <a:ext cx="20427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#4)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D6C5191-A387-03A9-A61F-61ED61DB936B}"/>
                </a:ext>
              </a:extLst>
            </p:cNvPr>
            <p:cNvSpPr txBox="1"/>
            <p:nvPr/>
          </p:nvSpPr>
          <p:spPr>
            <a:xfrm>
              <a:off x="484651" y="783219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46BF1886-B996-6272-33B0-BB270ADAC774}"/>
                </a:ext>
              </a:extLst>
            </p:cNvPr>
            <p:cNvSpPr txBox="1"/>
            <p:nvPr/>
          </p:nvSpPr>
          <p:spPr>
            <a:xfrm>
              <a:off x="484651" y="2639731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E9E5DD3-1AE1-DF4A-5D6C-7BCCF012F40B}"/>
                </a:ext>
              </a:extLst>
            </p:cNvPr>
            <p:cNvSpPr txBox="1"/>
            <p:nvPr/>
          </p:nvSpPr>
          <p:spPr>
            <a:xfrm>
              <a:off x="507884" y="5755055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 Sense alignment 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A68A4127-5ED4-D246-2640-4F6957721F00}"/>
                </a:ext>
              </a:extLst>
            </p:cNvPr>
            <p:cNvSpPr txBox="1"/>
            <p:nvPr/>
          </p:nvSpPr>
          <p:spPr>
            <a:xfrm>
              <a:off x="484651" y="4644820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0C74A64-43F1-8523-884F-FEAD026A725D}"/>
                </a:ext>
              </a:extLst>
            </p:cNvPr>
            <p:cNvSpPr txBox="1"/>
            <p:nvPr/>
          </p:nvSpPr>
          <p:spPr>
            <a:xfrm>
              <a:off x="497574" y="861864"/>
              <a:ext cx="253379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 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8717D9FC-4DC9-8C07-7EF5-74EF0745FD26}"/>
                </a:ext>
              </a:extLst>
            </p:cNvPr>
            <p:cNvSpPr txBox="1"/>
            <p:nvPr/>
          </p:nvSpPr>
          <p:spPr>
            <a:xfrm>
              <a:off x="507394" y="222921"/>
              <a:ext cx="43080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eference: </a:t>
              </a:r>
              <a:r>
                <a:rPr kumimoji="0" lang="en-US" sz="14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TOH7</a:t>
              </a:r>
              <a:r>
                <a:rPr kumimoji="0" lang="en-US" sz="1400" b="1" i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lasmid donor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9AA8636-0A80-4607-CE6D-00AB2A97ADEC}"/>
                </a:ext>
              </a:extLst>
            </p:cNvPr>
            <p:cNvSpPr txBox="1"/>
            <p:nvPr/>
          </p:nvSpPr>
          <p:spPr>
            <a:xfrm>
              <a:off x="5404523" y="222921"/>
              <a:ext cx="43080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eference: </a:t>
              </a:r>
              <a:r>
                <a:rPr kumimoji="0" lang="en-US" sz="14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TOH7</a:t>
              </a:r>
              <a:r>
                <a:rPr kumimoji="0" lang="en-US" sz="1400" b="1" i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-GFP</a:t>
              </a:r>
              <a:r>
                <a:rPr lang="en-US" sz="14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lasmid donor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4A00699-30F7-5096-D158-F3BA5684E2D5}"/>
                </a:ext>
              </a:extLst>
            </p:cNvPr>
            <p:cNvSpPr txBox="1"/>
            <p:nvPr/>
          </p:nvSpPr>
          <p:spPr>
            <a:xfrm>
              <a:off x="484651" y="2806557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E62A507-BCD6-D7E3-EFA0-14D55A525D45}"/>
                </a:ext>
              </a:extLst>
            </p:cNvPr>
            <p:cNvSpPr txBox="1"/>
            <p:nvPr/>
          </p:nvSpPr>
          <p:spPr>
            <a:xfrm>
              <a:off x="499664" y="2884537"/>
              <a:ext cx="253379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 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E7CC3DB3-AE41-5746-83AA-43CF19AF59EC}"/>
                </a:ext>
              </a:extLst>
            </p:cNvPr>
            <p:cNvSpPr txBox="1"/>
            <p:nvPr/>
          </p:nvSpPr>
          <p:spPr>
            <a:xfrm>
              <a:off x="5414962" y="5747185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 Sense alignment 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CD0316AA-A11B-52F2-A142-2B89DAE82872}"/>
                </a:ext>
              </a:extLst>
            </p:cNvPr>
            <p:cNvSpPr txBox="1"/>
            <p:nvPr/>
          </p:nvSpPr>
          <p:spPr>
            <a:xfrm>
              <a:off x="5420116" y="784419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3EF7C23-672E-BAC8-8A59-62F34350C098}"/>
                </a:ext>
              </a:extLst>
            </p:cNvPr>
            <p:cNvSpPr txBox="1"/>
            <p:nvPr/>
          </p:nvSpPr>
          <p:spPr>
            <a:xfrm>
              <a:off x="5420116" y="2640931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EE3D99D6-81DB-0731-A789-B8A97211F92A}"/>
                </a:ext>
              </a:extLst>
            </p:cNvPr>
            <p:cNvSpPr txBox="1"/>
            <p:nvPr/>
          </p:nvSpPr>
          <p:spPr>
            <a:xfrm>
              <a:off x="5420116" y="4653911"/>
              <a:ext cx="108241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ntisense alignment 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3714533-851A-2F27-4B98-E1070D81C4AD}"/>
                </a:ext>
              </a:extLst>
            </p:cNvPr>
            <p:cNvSpPr txBox="1"/>
            <p:nvPr/>
          </p:nvSpPr>
          <p:spPr>
            <a:xfrm>
              <a:off x="5433039" y="863064"/>
              <a:ext cx="253379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 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008B0403-369E-BE59-C9D6-CB62F982CD7D}"/>
                </a:ext>
              </a:extLst>
            </p:cNvPr>
            <p:cNvSpPr txBox="1"/>
            <p:nvPr/>
          </p:nvSpPr>
          <p:spPr>
            <a:xfrm>
              <a:off x="5420116" y="2815648"/>
              <a:ext cx="597758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verage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01E98BAD-9FA4-6B2B-87E5-81877EE2138D}"/>
                </a:ext>
              </a:extLst>
            </p:cNvPr>
            <p:cNvSpPr txBox="1"/>
            <p:nvPr/>
          </p:nvSpPr>
          <p:spPr>
            <a:xfrm>
              <a:off x="5435129" y="2923445"/>
              <a:ext cx="253379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* 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2DC008B-B52C-9DBE-39DD-ABA5055E2648}"/>
                </a:ext>
              </a:extLst>
            </p:cNvPr>
            <p:cNvSpPr txBox="1"/>
            <p:nvPr/>
          </p:nvSpPr>
          <p:spPr>
            <a:xfrm>
              <a:off x="209980" y="5923106"/>
              <a:ext cx="951235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4 continued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. Alignment of mRNA sequences from reporter organoids.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equences from both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and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reporter organoids were aligned to the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eference to investigate proper plasmid donor insertion at the target site.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equencing libraries were prepared by </a:t>
              </a:r>
              <a:r>
                <a:rPr lang="en-US" sz="800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useq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Stranded mRNA, which generates reads in antisense orientation. Reads from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organoids aligned in sense orientation to the </a:t>
              </a:r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CDS are inverted sequences, which resulted from additional NHEJ during the intended plasmid-mediated HR. The different motifs of the references are marked below the alignments. Alignments are visualized in IGV version 2.15.4.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D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oding sequenc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enhanced green fluorescent protein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homology arm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GV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integrative genomics view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HEJ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nonhomologous end join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2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porcine teschovirus-1 2A self-cleaving peptid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745890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84744" y="220841"/>
            <a:ext cx="9637590" cy="6359100"/>
            <a:chOff x="84744" y="220841"/>
            <a:chExt cx="9637590" cy="6359100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6932941-9A9A-C7EB-F19C-AD5DFC49E029}"/>
                </a:ext>
              </a:extLst>
            </p:cNvPr>
            <p:cNvSpPr txBox="1"/>
            <p:nvPr/>
          </p:nvSpPr>
          <p:spPr>
            <a:xfrm>
              <a:off x="209980" y="5872055"/>
              <a:ext cx="951235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5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. Reconstruction of the </a:t>
              </a:r>
              <a:r>
                <a:rPr lang="en-US" sz="800" b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ctual </a:t>
              </a:r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b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sequence based on mRNA-seq.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ased on inspection of unaligned overhangs of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mRNA-seq in figure S4, a manual reconstruction of the actual sequence in edited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lines was performed. A) Overview of the reconstructed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locus. B) Alignment of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mRNA-seq using the manually reconstructed actual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equence as reference. Unedited </a:t>
              </a:r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locus sequences flanking the edited region are shown in black, the inverted </a:t>
              </a:r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CDS sequence is shown in red and the inserted donor plasmid sequence with its motifs is shown in blue. Alignments are visualized in IGV version 2.15.4.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D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oding sequenc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enhanced green fluorescent protein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homology arm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GV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integrative genomics view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2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porcine teschovirus-1 2A self-cleaving peptide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reporter.</a:t>
              </a:r>
              <a:endParaRPr lang="en-US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84744" y="220841"/>
              <a:ext cx="8725840" cy="1274376"/>
              <a:chOff x="84744" y="220841"/>
              <a:chExt cx="8725840" cy="1274376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303762" y="228460"/>
                <a:ext cx="7506822" cy="1266757"/>
                <a:chOff x="1303762" y="228460"/>
                <a:chExt cx="7506822" cy="1266757"/>
              </a:xfrm>
            </p:grpSpPr>
            <p:grpSp>
              <p:nvGrpSpPr>
                <p:cNvPr id="127" name="Group 126">
                  <a:extLst>
                    <a:ext uri="{FF2B5EF4-FFF2-40B4-BE49-F238E27FC236}">
                      <a16:creationId xmlns:a16="http://schemas.microsoft.com/office/drawing/2014/main" id="{6323BC2D-E36C-A127-655D-9DFBA20B4589}"/>
                    </a:ext>
                  </a:extLst>
                </p:cNvPr>
                <p:cNvGrpSpPr/>
                <p:nvPr/>
              </p:nvGrpSpPr>
              <p:grpSpPr>
                <a:xfrm>
                  <a:off x="3254826" y="228460"/>
                  <a:ext cx="3604694" cy="524551"/>
                  <a:chOff x="3387249" y="3907795"/>
                  <a:chExt cx="3604694" cy="524551"/>
                </a:xfrm>
              </p:grpSpPr>
              <p:sp>
                <p:nvSpPr>
                  <p:cNvPr id="128" name="Rectangle 127">
                    <a:extLst>
                      <a:ext uri="{FF2B5EF4-FFF2-40B4-BE49-F238E27FC236}">
                        <a16:creationId xmlns:a16="http://schemas.microsoft.com/office/drawing/2014/main" id="{417D675D-9D5C-59E7-8916-BA8FB0109D03}"/>
                      </a:ext>
                    </a:extLst>
                  </p:cNvPr>
                  <p:cNvSpPr/>
                  <p:nvPr/>
                </p:nvSpPr>
                <p:spPr>
                  <a:xfrm>
                    <a:off x="4698241" y="4088924"/>
                    <a:ext cx="983431" cy="125050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de-CH" sz="900" b="1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TOH7</a:t>
                    </a:r>
                    <a:r>
                      <a:rPr lang="de-CH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DS</a:t>
                    </a:r>
                    <a:endParaRPr lang="en-CH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9" name="Rectangle 128">
                    <a:extLst>
                      <a:ext uri="{FF2B5EF4-FFF2-40B4-BE49-F238E27FC236}">
                        <a16:creationId xmlns:a16="http://schemas.microsoft.com/office/drawing/2014/main" id="{4CF08B44-AB07-ACE9-8EA1-4A2ECC01471F}"/>
                      </a:ext>
                    </a:extLst>
                  </p:cNvPr>
                  <p:cNvSpPr/>
                  <p:nvPr/>
                </p:nvSpPr>
                <p:spPr>
                  <a:xfrm>
                    <a:off x="3387249" y="4088924"/>
                    <a:ext cx="1310992" cy="125050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’ 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</a:t>
                    </a:r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endParaRPr lang="en-CH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" name="Rectangle 129">
                    <a:extLst>
                      <a:ext uri="{FF2B5EF4-FFF2-40B4-BE49-F238E27FC236}">
                        <a16:creationId xmlns:a16="http://schemas.microsoft.com/office/drawing/2014/main" id="{0F10E326-56A7-9CB7-FC42-D882AECC1DF6}"/>
                      </a:ext>
                    </a:extLst>
                  </p:cNvPr>
                  <p:cNvSpPr/>
                  <p:nvPr/>
                </p:nvSpPr>
                <p:spPr>
                  <a:xfrm>
                    <a:off x="5680951" y="4088924"/>
                    <a:ext cx="1310992" cy="125050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’ 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</a:t>
                    </a:r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endParaRPr lang="en-CH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31" name="Group 130">
                    <a:extLst>
                      <a:ext uri="{FF2B5EF4-FFF2-40B4-BE49-F238E27FC236}">
                        <a16:creationId xmlns:a16="http://schemas.microsoft.com/office/drawing/2014/main" id="{2B31EBE3-EA65-B6F2-47C8-332B81B05BB8}"/>
                      </a:ext>
                    </a:extLst>
                  </p:cNvPr>
                  <p:cNvGrpSpPr/>
                  <p:nvPr/>
                </p:nvGrpSpPr>
                <p:grpSpPr>
                  <a:xfrm>
                    <a:off x="4456806" y="3907795"/>
                    <a:ext cx="423041" cy="352392"/>
                    <a:chOff x="2729620" y="1538776"/>
                    <a:chExt cx="478016" cy="398186"/>
                  </a:xfrm>
                </p:grpSpPr>
                <p:sp>
                  <p:nvSpPr>
                    <p:cNvPr id="136" name="TextBox 135">
                      <a:extLst>
                        <a:ext uri="{FF2B5EF4-FFF2-40B4-BE49-F238E27FC236}">
                          <a16:creationId xmlns:a16="http://schemas.microsoft.com/office/drawing/2014/main" id="{E103AC37-483F-F463-4FC7-12157CAE14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9620" y="1538776"/>
                      <a:ext cx="478016" cy="20005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S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S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5’</a:t>
                      </a:r>
                      <a:endParaRPr lang="en-CH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37" name="Straight Connector 136">
                      <a:extLst>
                        <a:ext uri="{FF2B5EF4-FFF2-40B4-BE49-F238E27FC236}">
                          <a16:creationId xmlns:a16="http://schemas.microsoft.com/office/drawing/2014/main" id="{2F45E6E6-78DD-DE45-BD47-70CA4F0461A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968628" y="1684962"/>
                      <a:ext cx="0" cy="25200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  <a:prstDash val="sys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32" name="Group 131">
                    <a:extLst>
                      <a:ext uri="{FF2B5EF4-FFF2-40B4-BE49-F238E27FC236}">
                        <a16:creationId xmlns:a16="http://schemas.microsoft.com/office/drawing/2014/main" id="{58974427-8DCA-9920-6BED-C6481BE9D6A7}"/>
                      </a:ext>
                    </a:extLst>
                  </p:cNvPr>
                  <p:cNvGrpSpPr/>
                  <p:nvPr/>
                </p:nvGrpSpPr>
                <p:grpSpPr>
                  <a:xfrm>
                    <a:off x="5500983" y="3907795"/>
                    <a:ext cx="423041" cy="352392"/>
                    <a:chOff x="2729620" y="1538776"/>
                    <a:chExt cx="478016" cy="398186"/>
                  </a:xfrm>
                </p:grpSpPr>
                <p:sp>
                  <p:nvSpPr>
                    <p:cNvPr id="134" name="TextBox 133">
                      <a:extLst>
                        <a:ext uri="{FF2B5EF4-FFF2-40B4-BE49-F238E27FC236}">
                          <a16:creationId xmlns:a16="http://schemas.microsoft.com/office/drawing/2014/main" id="{638617E1-4A40-D30E-84FD-F1A3BBB28E8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29620" y="1538776"/>
                      <a:ext cx="478016" cy="20005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S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S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S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en-CH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35" name="Straight Connector 134">
                      <a:extLst>
                        <a:ext uri="{FF2B5EF4-FFF2-40B4-BE49-F238E27FC236}">
                          <a16:creationId xmlns:a16="http://schemas.microsoft.com/office/drawing/2014/main" id="{E535B8DA-87A6-4D01-B282-BCE6507F074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968628" y="1684962"/>
                      <a:ext cx="0" cy="25200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  <a:prstDash val="sys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3" name="TextBox 132">
                    <a:extLst>
                      <a:ext uri="{FF2B5EF4-FFF2-40B4-BE49-F238E27FC236}">
                        <a16:creationId xmlns:a16="http://schemas.microsoft.com/office/drawing/2014/main" id="{255F6F17-62D9-C1B3-0F87-FF406F0A9D53}"/>
                      </a:ext>
                    </a:extLst>
                  </p:cNvPr>
                  <p:cNvSpPr txBox="1"/>
                  <p:nvPr/>
                </p:nvSpPr>
                <p:spPr>
                  <a:xfrm>
                    <a:off x="3387249" y="4228061"/>
                    <a:ext cx="3604693" cy="20428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enomic locus </a:t>
                    </a:r>
                    <a:r>
                      <a:rPr lang="en-US" sz="900" b="0" i="0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q21.3–22.1</a:t>
                    </a:r>
                    <a:endParaRPr lang="en-CH" sz="9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38" name="Group 137">
                  <a:extLst>
                    <a:ext uri="{FF2B5EF4-FFF2-40B4-BE49-F238E27FC236}">
                      <a16:creationId xmlns:a16="http://schemas.microsoft.com/office/drawing/2014/main" id="{2BE8F964-966D-221D-F4F7-85BB5421247C}"/>
                    </a:ext>
                  </a:extLst>
                </p:cNvPr>
                <p:cNvGrpSpPr/>
                <p:nvPr/>
              </p:nvGrpSpPr>
              <p:grpSpPr>
                <a:xfrm>
                  <a:off x="1303762" y="948244"/>
                  <a:ext cx="7506822" cy="309456"/>
                  <a:chOff x="1454229" y="5051262"/>
                  <a:chExt cx="7506822" cy="309456"/>
                </a:xfrm>
              </p:grpSpPr>
              <p:sp>
                <p:nvSpPr>
                  <p:cNvPr id="139" name="Rectangle 138">
                    <a:extLst>
                      <a:ext uri="{FF2B5EF4-FFF2-40B4-BE49-F238E27FC236}">
                        <a16:creationId xmlns:a16="http://schemas.microsoft.com/office/drawing/2014/main" id="{A2DB9608-CF2B-BA28-A32C-623B3E617A13}"/>
                      </a:ext>
                    </a:extLst>
                  </p:cNvPr>
                  <p:cNvSpPr/>
                  <p:nvPr/>
                </p:nvSpPr>
                <p:spPr>
                  <a:xfrm>
                    <a:off x="6339067" y="5051262"/>
                    <a:ext cx="1310992" cy="125050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9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’</a:t>
                    </a:r>
                    <a:r>
                      <a:rPr lang="sv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A</a:t>
                    </a:r>
                    <a:endParaRPr lang="en-CH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Rectangle 139">
                    <a:extLst>
                      <a:ext uri="{FF2B5EF4-FFF2-40B4-BE49-F238E27FC236}">
                        <a16:creationId xmlns:a16="http://schemas.microsoft.com/office/drawing/2014/main" id="{289C9E00-DBF4-6773-DFE7-B773B6A84428}"/>
                      </a:ext>
                    </a:extLst>
                  </p:cNvPr>
                  <p:cNvSpPr/>
                  <p:nvPr/>
                </p:nvSpPr>
                <p:spPr>
                  <a:xfrm>
                    <a:off x="1454229" y="5051262"/>
                    <a:ext cx="1310992" cy="125050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’ 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</a:t>
                    </a:r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endParaRPr lang="en-CH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Rectangle 140">
                    <a:extLst>
                      <a:ext uri="{FF2B5EF4-FFF2-40B4-BE49-F238E27FC236}">
                        <a16:creationId xmlns:a16="http://schemas.microsoft.com/office/drawing/2014/main" id="{EB824981-B1CB-4579-ED11-3832D3DCB80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77228" y="5051262"/>
                    <a:ext cx="983431" cy="125050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de-CH" sz="900" b="1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TOH7</a:t>
                    </a:r>
                    <a:r>
                      <a:rPr lang="de-CH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DS</a:t>
                    </a:r>
                    <a:endParaRPr lang="en-CH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2" name="Rectangle 141">
                    <a:extLst>
                      <a:ext uri="{FF2B5EF4-FFF2-40B4-BE49-F238E27FC236}">
                        <a16:creationId xmlns:a16="http://schemas.microsoft.com/office/drawing/2014/main" id="{04BB1709-79EC-1B6E-E169-621428EB73D8}"/>
                      </a:ext>
                    </a:extLst>
                  </p:cNvPr>
                  <p:cNvSpPr/>
                  <p:nvPr/>
                </p:nvSpPr>
                <p:spPr>
                  <a:xfrm>
                    <a:off x="3757524" y="5051262"/>
                    <a:ext cx="1310992" cy="125050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9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’</a:t>
                    </a:r>
                    <a:r>
                      <a:rPr lang="sv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HA</a:t>
                    </a:r>
                    <a:endParaRPr lang="en-CH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3" name="Rectangle 142">
                    <a:extLst>
                      <a:ext uri="{FF2B5EF4-FFF2-40B4-BE49-F238E27FC236}">
                        <a16:creationId xmlns:a16="http://schemas.microsoft.com/office/drawing/2014/main" id="{941A1AA7-2E67-C431-351C-7E1DB77A9BE3}"/>
                      </a:ext>
                    </a:extLst>
                  </p:cNvPr>
                  <p:cNvSpPr/>
                  <p:nvPr/>
                </p:nvSpPr>
                <p:spPr>
                  <a:xfrm>
                    <a:off x="5068255" y="5051262"/>
                    <a:ext cx="1267747" cy="125050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</a:t>
                    </a:r>
                    <a:r>
                      <a:rPr lang="en-S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</a:t>
                    </a:r>
                    <a:r>
                      <a:rPr lang="en-SE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reporter</a:t>
                    </a:r>
                    <a:endParaRPr lang="en-CH" sz="9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0455A65E-02E0-8C67-1042-E3904A914611}"/>
                      </a:ext>
                    </a:extLst>
                  </p:cNvPr>
                  <p:cNvSpPr txBox="1"/>
                  <p:nvPr/>
                </p:nvSpPr>
                <p:spPr>
                  <a:xfrm>
                    <a:off x="4775158" y="5183671"/>
                    <a:ext cx="513834" cy="17704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.</a:t>
                    </a:r>
                    <a:endParaRPr lang="en-CH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" name="TextBox 144">
                    <a:extLst>
                      <a:ext uri="{FF2B5EF4-FFF2-40B4-BE49-F238E27FC236}">
                        <a16:creationId xmlns:a16="http://schemas.microsoft.com/office/drawing/2014/main" id="{70A69098-BA5E-21F3-49B5-3E7A445B5CA6}"/>
                      </a:ext>
                    </a:extLst>
                  </p:cNvPr>
                  <p:cNvSpPr txBox="1"/>
                  <p:nvPr/>
                </p:nvSpPr>
                <p:spPr>
                  <a:xfrm>
                    <a:off x="6119040" y="5183671"/>
                    <a:ext cx="513834" cy="17704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</a:t>
                    </a: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SE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.</a:t>
                    </a:r>
                    <a:endParaRPr lang="en-CH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Rectangle 145">
                    <a:extLst>
                      <a:ext uri="{FF2B5EF4-FFF2-40B4-BE49-F238E27FC236}">
                        <a16:creationId xmlns:a16="http://schemas.microsoft.com/office/drawing/2014/main" id="{5BF50C6A-B754-7D42-89BE-4976A6CCDDA6}"/>
                      </a:ext>
                    </a:extLst>
                  </p:cNvPr>
                  <p:cNvSpPr/>
                  <p:nvPr/>
                </p:nvSpPr>
                <p:spPr>
                  <a:xfrm>
                    <a:off x="5021217" y="5051262"/>
                    <a:ext cx="15930" cy="12505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H" sz="9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Rectangle 146">
                    <a:extLst>
                      <a:ext uri="{FF2B5EF4-FFF2-40B4-BE49-F238E27FC236}">
                        <a16:creationId xmlns:a16="http://schemas.microsoft.com/office/drawing/2014/main" id="{79B88E90-10ED-537E-281F-0333BE1C4FE2}"/>
                      </a:ext>
                    </a:extLst>
                  </p:cNvPr>
                  <p:cNvSpPr/>
                  <p:nvPr/>
                </p:nvSpPr>
                <p:spPr>
                  <a:xfrm>
                    <a:off x="6367282" y="5051262"/>
                    <a:ext cx="15930" cy="12505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H" sz="9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Rectangle 147">
                    <a:extLst>
                      <a:ext uri="{FF2B5EF4-FFF2-40B4-BE49-F238E27FC236}">
                        <a16:creationId xmlns:a16="http://schemas.microsoft.com/office/drawing/2014/main" id="{0CA0353E-91C4-9E0B-15D3-8CFC1FC4E5AF}"/>
                      </a:ext>
                    </a:extLst>
                  </p:cNvPr>
                  <p:cNvSpPr/>
                  <p:nvPr/>
                </p:nvSpPr>
                <p:spPr>
                  <a:xfrm>
                    <a:off x="7650059" y="5051262"/>
                    <a:ext cx="1310992" cy="125050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’ 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</a:t>
                    </a:r>
                    <a:r>
                      <a:rPr lang="en-SE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endParaRPr lang="en-CH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49" name="Straight Connector 148">
                  <a:extLst>
                    <a:ext uri="{FF2B5EF4-FFF2-40B4-BE49-F238E27FC236}">
                      <a16:creationId xmlns:a16="http://schemas.microsoft.com/office/drawing/2014/main" id="{4C4B2D1E-7390-B24C-E0B9-A1004D3BF63B}"/>
                    </a:ext>
                  </a:extLst>
                </p:cNvPr>
                <p:cNvCxnSpPr>
                  <a:cxnSpLocks/>
                  <a:stCxn id="140" idx="0"/>
                  <a:endCxn id="129" idx="2"/>
                </p:cNvCxnSpPr>
                <p:nvPr/>
              </p:nvCxnSpPr>
              <p:spPr>
                <a:xfrm flipV="1">
                  <a:off x="1959258" y="534639"/>
                  <a:ext cx="1951064" cy="41360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0" name="Straight Connector 149">
                  <a:extLst>
                    <a:ext uri="{FF2B5EF4-FFF2-40B4-BE49-F238E27FC236}">
                      <a16:creationId xmlns:a16="http://schemas.microsoft.com/office/drawing/2014/main" id="{DDCC9741-E2BA-5E6C-BD50-18E99AE786FA}"/>
                    </a:ext>
                  </a:extLst>
                </p:cNvPr>
                <p:cNvCxnSpPr>
                  <a:cxnSpLocks/>
                  <a:stCxn id="148" idx="0"/>
                  <a:endCxn id="130" idx="2"/>
                </p:cNvCxnSpPr>
                <p:nvPr/>
              </p:nvCxnSpPr>
              <p:spPr>
                <a:xfrm flipH="1" flipV="1">
                  <a:off x="6204024" y="534639"/>
                  <a:ext cx="1951064" cy="41360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1" name="TextBox 150">
                  <a:extLst>
                    <a:ext uri="{FF2B5EF4-FFF2-40B4-BE49-F238E27FC236}">
                      <a16:creationId xmlns:a16="http://schemas.microsoft.com/office/drawing/2014/main" id="{253D8363-4D41-409C-2085-A918EA573E3D}"/>
                    </a:ext>
                  </a:extLst>
                </p:cNvPr>
                <p:cNvSpPr txBox="1"/>
                <p:nvPr/>
              </p:nvSpPr>
              <p:spPr>
                <a:xfrm>
                  <a:off x="3995981" y="1264385"/>
                  <a:ext cx="2122382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constructed </a:t>
                  </a:r>
                  <a:r>
                    <a:rPr lang="en-GB" sz="9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OH7</a:t>
                  </a:r>
                  <a:r>
                    <a:rPr lang="en-GB" sz="9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UT-GFP</a:t>
                  </a:r>
                  <a:r>
                    <a:rPr lang="en-GB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locus</a:t>
                  </a:r>
                </a:p>
              </p:txBody>
            </p:sp>
          </p:grp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C9105AF1-4E89-15E6-6A3D-E8EE8ACD94D1}"/>
                  </a:ext>
                </a:extLst>
              </p:cNvPr>
              <p:cNvSpPr txBox="1"/>
              <p:nvPr/>
            </p:nvSpPr>
            <p:spPr>
              <a:xfrm>
                <a:off x="84744" y="220841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152982" y="1582484"/>
              <a:ext cx="9479064" cy="4266655"/>
              <a:chOff x="152982" y="1582484"/>
              <a:chExt cx="9479064" cy="4266655"/>
            </a:xfrm>
          </p:grpSpPr>
          <p:pic>
            <p:nvPicPr>
              <p:cNvPr id="96" name="Picture 95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B08426D9-B1AD-4AA2-0A50-9FBA99F553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28516" y="2237854"/>
                <a:ext cx="4320000" cy="12622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8" name="Picture 97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99538240-A5EE-8250-32FE-F31071975E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28518" y="3500131"/>
                <a:ext cx="4320000" cy="12622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0" name="Picture 99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C0B497E0-02D0-E28F-AE97-F6715950BCC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12045" y="2230233"/>
                <a:ext cx="4320000" cy="12622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2" name="Picture 101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6D89DAF4-D4D3-64C9-5780-7F772F5009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12045" y="3500131"/>
                <a:ext cx="4320000" cy="12622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3" name="Picture 102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C7BB106C-9009-67B9-FDC2-6C4AAA1459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28516" y="4762408"/>
                <a:ext cx="4320000" cy="108336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4" name="Picture 103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759E0C90-53A4-6C4E-D5EF-6D28D78FD2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12045" y="4762408"/>
                <a:ext cx="4320000" cy="108336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3C76BEAD-506D-4D22-CA5D-0103D6642096}"/>
                  </a:ext>
                </a:extLst>
              </p:cNvPr>
              <p:cNvSpPr txBox="1"/>
              <p:nvPr/>
            </p:nvSpPr>
            <p:spPr>
              <a:xfrm rot="16200000">
                <a:off x="-325341" y="2709474"/>
                <a:ext cx="1480833" cy="269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en-US" sz="115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UT-GFP</a:t>
                </a:r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1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)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B0DC8DC8-8527-6BE5-97DE-0A0ABEE79F86}"/>
                  </a:ext>
                </a:extLst>
              </p:cNvPr>
              <p:cNvSpPr txBox="1"/>
              <p:nvPr/>
            </p:nvSpPr>
            <p:spPr>
              <a:xfrm rot="16200000">
                <a:off x="-301159" y="4007654"/>
                <a:ext cx="1432467" cy="269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en-US" sz="115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UT-GFP</a:t>
                </a:r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1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2)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A2215663-CAFB-CC11-4103-BE9AE304F1FF}"/>
                  </a:ext>
                </a:extLst>
              </p:cNvPr>
              <p:cNvSpPr txBox="1"/>
              <p:nvPr/>
            </p:nvSpPr>
            <p:spPr>
              <a:xfrm rot="16200000">
                <a:off x="4443528" y="2708252"/>
                <a:ext cx="1479413" cy="269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en-US" sz="115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UT-GFP</a:t>
                </a:r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1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3)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53B43611-3DB1-2268-1CA4-7EB3FDA62371}"/>
                  </a:ext>
                </a:extLst>
              </p:cNvPr>
              <p:cNvSpPr txBox="1"/>
              <p:nvPr/>
            </p:nvSpPr>
            <p:spPr>
              <a:xfrm rot="16200000">
                <a:off x="4455608" y="3991304"/>
                <a:ext cx="14629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en-US" sz="115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UT-GFP</a:t>
                </a:r>
                <a:r>
                  <a:rPr lang="en-US" sz="11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1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4)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3A060F9E-E011-57CF-5698-C3341771BAA0}"/>
                  </a:ext>
                </a:extLst>
              </p:cNvPr>
              <p:cNvSpPr txBox="1"/>
              <p:nvPr/>
            </p:nvSpPr>
            <p:spPr>
              <a:xfrm>
                <a:off x="497343" y="4849014"/>
                <a:ext cx="938150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S Inversion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0DF0DF22-564D-B385-7950-2B9824564D1D}"/>
                  </a:ext>
                </a:extLst>
              </p:cNvPr>
              <p:cNvSpPr txBox="1"/>
              <p:nvPr/>
            </p:nvSpPr>
            <p:spPr>
              <a:xfrm>
                <a:off x="497343" y="5008526"/>
                <a:ext cx="979505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nor sequence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70D8FE76-2440-4891-44F3-8521BD0CE886}"/>
                  </a:ext>
                </a:extLst>
              </p:cNvPr>
              <p:cNvSpPr txBox="1"/>
              <p:nvPr/>
            </p:nvSpPr>
            <p:spPr>
              <a:xfrm>
                <a:off x="497343" y="5168039"/>
                <a:ext cx="1600608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 downstream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E6CB7D54-326D-225B-6517-D36F01856EC0}"/>
                  </a:ext>
                </a:extLst>
              </p:cNvPr>
              <p:cNvSpPr txBox="1"/>
              <p:nvPr/>
            </p:nvSpPr>
            <p:spPr>
              <a:xfrm>
                <a:off x="497343" y="5318026"/>
                <a:ext cx="6312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´-HA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446DB89B-23AA-FC80-3AF1-B20F75EE8F74}"/>
                  </a:ext>
                </a:extLst>
              </p:cNvPr>
              <p:cNvSpPr txBox="1"/>
              <p:nvPr/>
            </p:nvSpPr>
            <p:spPr>
              <a:xfrm>
                <a:off x="497343" y="5477540"/>
                <a:ext cx="6312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P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18315CE6-E70F-8944-4E81-D604B380738F}"/>
                  </a:ext>
                </a:extLst>
              </p:cNvPr>
              <p:cNvSpPr txBox="1"/>
              <p:nvPr/>
            </p:nvSpPr>
            <p:spPr>
              <a:xfrm>
                <a:off x="497343" y="4705376"/>
                <a:ext cx="12037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 upstream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F760345C-631C-2F84-6B68-61C55AB00A7A}"/>
                  </a:ext>
                </a:extLst>
              </p:cNvPr>
              <p:cNvSpPr txBox="1"/>
              <p:nvPr/>
            </p:nvSpPr>
            <p:spPr>
              <a:xfrm>
                <a:off x="504360" y="5639365"/>
                <a:ext cx="6312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-HA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49B7AFC2-783B-6531-DA0C-DF81D7E15CFD}"/>
                  </a:ext>
                </a:extLst>
              </p:cNvPr>
              <p:cNvSpPr txBox="1"/>
              <p:nvPr/>
            </p:nvSpPr>
            <p:spPr>
              <a:xfrm>
                <a:off x="5275467" y="4858733"/>
                <a:ext cx="938150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S Inversion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F64DB005-FF53-E97E-A6C7-5CDB3DDF8A31}"/>
                  </a:ext>
                </a:extLst>
              </p:cNvPr>
              <p:cNvSpPr txBox="1"/>
              <p:nvPr/>
            </p:nvSpPr>
            <p:spPr>
              <a:xfrm>
                <a:off x="5275467" y="5018245"/>
                <a:ext cx="979505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nor sequence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AE75B2CB-36A6-6B2C-2E6C-8073821A22BF}"/>
                  </a:ext>
                </a:extLst>
              </p:cNvPr>
              <p:cNvSpPr txBox="1"/>
              <p:nvPr/>
            </p:nvSpPr>
            <p:spPr>
              <a:xfrm>
                <a:off x="5275467" y="5177758"/>
                <a:ext cx="1600608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 downstream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7517E094-002D-F0E1-18C8-ED11B1BB3149}"/>
                  </a:ext>
                </a:extLst>
              </p:cNvPr>
              <p:cNvSpPr txBox="1"/>
              <p:nvPr/>
            </p:nvSpPr>
            <p:spPr>
              <a:xfrm>
                <a:off x="5275467" y="5327745"/>
                <a:ext cx="6312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´-HA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1F31732A-1725-6A2B-B222-5921BADB830A}"/>
                  </a:ext>
                </a:extLst>
              </p:cNvPr>
              <p:cNvSpPr txBox="1"/>
              <p:nvPr/>
            </p:nvSpPr>
            <p:spPr>
              <a:xfrm>
                <a:off x="5275467" y="5487259"/>
                <a:ext cx="6312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P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FDA54FAB-0895-731B-772C-CFABDA4B7DB1}"/>
                  </a:ext>
                </a:extLst>
              </p:cNvPr>
              <p:cNvSpPr txBox="1"/>
              <p:nvPr/>
            </p:nvSpPr>
            <p:spPr>
              <a:xfrm>
                <a:off x="5275467" y="4715095"/>
                <a:ext cx="12037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 upstream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127FA50E-D34C-34F3-4767-F736A36BA1DA}"/>
                  </a:ext>
                </a:extLst>
              </p:cNvPr>
              <p:cNvSpPr txBox="1"/>
              <p:nvPr/>
            </p:nvSpPr>
            <p:spPr>
              <a:xfrm>
                <a:off x="5282484" y="5649084"/>
                <a:ext cx="631233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-HA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F94F529A-2C31-C23A-4A0C-ACF542F7D17E}"/>
                  </a:ext>
                </a:extLst>
              </p:cNvPr>
              <p:cNvSpPr txBox="1"/>
              <p:nvPr/>
            </p:nvSpPr>
            <p:spPr>
              <a:xfrm>
                <a:off x="532936" y="1951816"/>
                <a:ext cx="430808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ference: Reconstructed </a:t>
                </a:r>
                <a:r>
                  <a:rPr lang="en-GB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en-GB" sz="14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UT-GFP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2BB062AA-625F-A46F-154E-503F62A36BD9}"/>
                  </a:ext>
                </a:extLst>
              </p:cNvPr>
              <p:cNvSpPr txBox="1"/>
              <p:nvPr/>
            </p:nvSpPr>
            <p:spPr>
              <a:xfrm>
                <a:off x="5312046" y="1950051"/>
                <a:ext cx="432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ference: Reconstructed </a:t>
                </a:r>
                <a:r>
                  <a:rPr lang="en-GB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  <a:r>
                  <a:rPr lang="en-GB" sz="14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UT-GFP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BA2D5EC5-9305-F587-3357-0CC56D640D7B}"/>
                  </a:ext>
                </a:extLst>
              </p:cNvPr>
              <p:cNvSpPr txBox="1"/>
              <p:nvPr/>
            </p:nvSpPr>
            <p:spPr>
              <a:xfrm>
                <a:off x="152982" y="1582484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744091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DDDBF22-E5EB-371C-D24C-F52A192173C4}"/>
              </a:ext>
            </a:extLst>
          </p:cNvPr>
          <p:cNvGrpSpPr/>
          <p:nvPr/>
        </p:nvGrpSpPr>
        <p:grpSpPr>
          <a:xfrm>
            <a:off x="1366948" y="77018"/>
            <a:ext cx="6819351" cy="6690220"/>
            <a:chOff x="1366948" y="77018"/>
            <a:chExt cx="6819351" cy="669022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40499F1-4D4B-B4DB-10EF-EF21075F1438}"/>
                </a:ext>
              </a:extLst>
            </p:cNvPr>
            <p:cNvSpPr txBox="1"/>
            <p:nvPr/>
          </p:nvSpPr>
          <p:spPr>
            <a:xfrm>
              <a:off x="1366948" y="6059352"/>
              <a:ext cx="6819351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6. Gating of FACS-enriched ATOH7-positive reporter cells.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eek-7 organoids derived from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and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iPSCs were dissociated and eGFP-expressing (represented by FITC) singlet cells were enriched by FACS using predefined gates as demonstrated by example images. Cells derived from non-reporter wildtype organoids were used as a negative control. Cells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ith eGFP expression within the upper quartile were selected for downstream experiments.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C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fluorescence-activated cell sorting;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FITC-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Fluorescein isothiocyanate area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SC-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forward scatter area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SC-A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side scatter area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</a:t>
              </a: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mutant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.</a:t>
              </a:r>
            </a:p>
          </p:txBody>
        </p:sp>
        <p:pic>
          <p:nvPicPr>
            <p:cNvPr id="6" name="Picture 5" descr="A screen shot of a cell&#10;&#10;Description automatically generated">
              <a:extLst>
                <a:ext uri="{FF2B5EF4-FFF2-40B4-BE49-F238E27FC236}">
                  <a16:creationId xmlns:a16="http://schemas.microsoft.com/office/drawing/2014/main" id="{1C5970A4-0860-6595-5B77-3B0B9CD1DF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4811" y="3978614"/>
              <a:ext cx="1951669" cy="1985931"/>
            </a:xfrm>
            <a:prstGeom prst="rect">
              <a:avLst/>
            </a:prstGeom>
          </p:spPr>
        </p:pic>
        <p:pic>
          <p:nvPicPr>
            <p:cNvPr id="8" name="Picture 7" descr="A screen shot of a cell&#10;&#10;Description automatically generated">
              <a:extLst>
                <a:ext uri="{FF2B5EF4-FFF2-40B4-BE49-F238E27FC236}">
                  <a16:creationId xmlns:a16="http://schemas.microsoft.com/office/drawing/2014/main" id="{E501B88F-6E04-F026-8D00-371F66F531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37527" y="3978615"/>
              <a:ext cx="1995867" cy="1945998"/>
            </a:xfrm>
            <a:prstGeom prst="rect">
              <a:avLst/>
            </a:prstGeom>
          </p:spPr>
        </p:pic>
        <p:pic>
          <p:nvPicPr>
            <p:cNvPr id="10" name="Picture 9" descr="A diagram of a single cell&#10;&#10;Description automatically generated">
              <a:extLst>
                <a:ext uri="{FF2B5EF4-FFF2-40B4-BE49-F238E27FC236}">
                  <a16:creationId xmlns:a16="http://schemas.microsoft.com/office/drawing/2014/main" id="{EA639B40-1DAE-E9C1-6E6B-CBEF76CBE5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31561" y="3978614"/>
              <a:ext cx="1982705" cy="1945997"/>
            </a:xfrm>
            <a:prstGeom prst="rect">
              <a:avLst/>
            </a:prstGeom>
          </p:spPr>
        </p:pic>
        <p:pic>
          <p:nvPicPr>
            <p:cNvPr id="19" name="Picture 18" descr="A screen shot of a cell&#10;&#10;Description automatically generated">
              <a:extLst>
                <a:ext uri="{FF2B5EF4-FFF2-40B4-BE49-F238E27FC236}">
                  <a16:creationId xmlns:a16="http://schemas.microsoft.com/office/drawing/2014/main" id="{869B0A81-19F1-75FD-A832-288ED67C44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37527" y="2023015"/>
              <a:ext cx="2014789" cy="1945997"/>
            </a:xfrm>
            <a:prstGeom prst="rect">
              <a:avLst/>
            </a:prstGeom>
          </p:spPr>
        </p:pic>
        <p:pic>
          <p:nvPicPr>
            <p:cNvPr id="23" name="Picture 22" descr="A diagram of a single cell&#10;&#10;Description automatically generated">
              <a:extLst>
                <a:ext uri="{FF2B5EF4-FFF2-40B4-BE49-F238E27FC236}">
                  <a16:creationId xmlns:a16="http://schemas.microsoft.com/office/drawing/2014/main" id="{9DD5EA41-1958-6200-B80E-2463971991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31561" y="2023015"/>
              <a:ext cx="2001627" cy="1945997"/>
            </a:xfrm>
            <a:prstGeom prst="rect">
              <a:avLst/>
            </a:prstGeom>
          </p:spPr>
        </p:pic>
        <p:pic>
          <p:nvPicPr>
            <p:cNvPr id="27" name="Picture 26" descr="A screenshot of a cell&#10;&#10;Description automatically generated">
              <a:extLst>
                <a:ext uri="{FF2B5EF4-FFF2-40B4-BE49-F238E27FC236}">
                  <a16:creationId xmlns:a16="http://schemas.microsoft.com/office/drawing/2014/main" id="{DE290AD1-A21E-4198-7272-D68694CB54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4812" y="2023015"/>
              <a:ext cx="1967115" cy="1955599"/>
            </a:xfrm>
            <a:prstGeom prst="rect">
              <a:avLst/>
            </a:prstGeom>
          </p:spPr>
        </p:pic>
        <p:pic>
          <p:nvPicPr>
            <p:cNvPr id="29" name="Picture 28" descr="A blue and green splatter on a white background&#10;&#10;Description automatically generated">
              <a:extLst>
                <a:ext uri="{FF2B5EF4-FFF2-40B4-BE49-F238E27FC236}">
                  <a16:creationId xmlns:a16="http://schemas.microsoft.com/office/drawing/2014/main" id="{3C6540CE-5BC9-566F-8575-E841F90257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4812" y="77018"/>
              <a:ext cx="1981487" cy="1945997"/>
            </a:xfrm>
            <a:prstGeom prst="rect">
              <a:avLst/>
            </a:prstGeom>
          </p:spPr>
        </p:pic>
        <p:pic>
          <p:nvPicPr>
            <p:cNvPr id="31" name="Picture 30" descr="A screen shot of a cell&#10;&#10;Description automatically generated">
              <a:extLst>
                <a:ext uri="{FF2B5EF4-FFF2-40B4-BE49-F238E27FC236}">
                  <a16:creationId xmlns:a16="http://schemas.microsoft.com/office/drawing/2014/main" id="{ED6459E8-3BED-8A46-A4A8-429E2C4648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23156" y="77018"/>
              <a:ext cx="2029160" cy="1945997"/>
            </a:xfrm>
            <a:prstGeom prst="rect">
              <a:avLst/>
            </a:prstGeom>
          </p:spPr>
        </p:pic>
        <p:pic>
          <p:nvPicPr>
            <p:cNvPr id="33" name="Picture 32" descr="A diagram of a single cell&#10;&#10;Description automatically generated">
              <a:extLst>
                <a:ext uri="{FF2B5EF4-FFF2-40B4-BE49-F238E27FC236}">
                  <a16:creationId xmlns:a16="http://schemas.microsoft.com/office/drawing/2014/main" id="{F0D3C318-B184-B253-62DD-1CF9A13791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37381" y="77018"/>
              <a:ext cx="1995807" cy="1945997"/>
            </a:xfrm>
            <a:prstGeom prst="rect">
              <a:avLst/>
            </a:prstGeom>
          </p:spPr>
        </p:pic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B1D553D8-41A1-9A30-7386-AF40CEB28E3E}"/>
                </a:ext>
              </a:extLst>
            </p:cNvPr>
            <p:cNvCxnSpPr/>
            <p:nvPr/>
          </p:nvCxnSpPr>
          <p:spPr>
            <a:xfrm>
              <a:off x="7037013" y="168458"/>
              <a:ext cx="0" cy="1728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86491895-83EC-B717-8201-088F3FFE3C03}"/>
                </a:ext>
              </a:extLst>
            </p:cNvPr>
            <p:cNvCxnSpPr/>
            <p:nvPr/>
          </p:nvCxnSpPr>
          <p:spPr>
            <a:xfrm>
              <a:off x="7037013" y="2126798"/>
              <a:ext cx="0" cy="1728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24EEC5FC-D9B5-6406-99CA-360FFD5C2A41}"/>
                </a:ext>
              </a:extLst>
            </p:cNvPr>
            <p:cNvCxnSpPr/>
            <p:nvPr/>
          </p:nvCxnSpPr>
          <p:spPr>
            <a:xfrm>
              <a:off x="7037013" y="4077518"/>
              <a:ext cx="0" cy="172800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BBFF0AF-7160-C990-7166-17DE67DF7934}"/>
                </a:ext>
              </a:extLst>
            </p:cNvPr>
            <p:cNvSpPr txBox="1"/>
            <p:nvPr/>
          </p:nvSpPr>
          <p:spPr>
            <a:xfrm rot="16200000">
              <a:off x="624337" y="926459"/>
              <a:ext cx="18545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FB88884-E270-383E-9210-6AC761240A56}"/>
                </a:ext>
              </a:extLst>
            </p:cNvPr>
            <p:cNvSpPr txBox="1"/>
            <p:nvPr/>
          </p:nvSpPr>
          <p:spPr>
            <a:xfrm rot="16200000">
              <a:off x="687615" y="4766706"/>
              <a:ext cx="17280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GB" sz="1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UT-GFP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3962279-D7C7-FA51-BE5B-17E953F65698}"/>
                </a:ext>
              </a:extLst>
            </p:cNvPr>
            <p:cNvSpPr txBox="1"/>
            <p:nvPr/>
          </p:nvSpPr>
          <p:spPr>
            <a:xfrm rot="16200000">
              <a:off x="687615" y="2821521"/>
              <a:ext cx="172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GB" sz="1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-GFP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A5D4A42-CDBE-50BF-BA45-8D445086A6E2}"/>
                </a:ext>
              </a:extLst>
            </p:cNvPr>
            <p:cNvSpPr txBox="1"/>
            <p:nvPr/>
          </p:nvSpPr>
          <p:spPr>
            <a:xfrm rot="16200000">
              <a:off x="885364" y="965155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F57466B-EEA0-0ACC-A668-08FD3DD07D44}"/>
                </a:ext>
              </a:extLst>
            </p:cNvPr>
            <p:cNvSpPr txBox="1"/>
            <p:nvPr/>
          </p:nvSpPr>
          <p:spPr>
            <a:xfrm rot="16200000">
              <a:off x="885364" y="2888292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4BFD927-A46F-A7A5-46B3-404EBFF258BD}"/>
                </a:ext>
              </a:extLst>
            </p:cNvPr>
            <p:cNvSpPr txBox="1"/>
            <p:nvPr/>
          </p:nvSpPr>
          <p:spPr>
            <a:xfrm rot="16200000">
              <a:off x="885364" y="4865228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4491A3C-08BD-7376-1AE9-2930F1E3E73F}"/>
                </a:ext>
              </a:extLst>
            </p:cNvPr>
            <p:cNvSpPr txBox="1"/>
            <p:nvPr/>
          </p:nvSpPr>
          <p:spPr>
            <a:xfrm rot="16200000">
              <a:off x="3064250" y="962146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078D682-5A6A-B254-C8D1-019C18410B3D}"/>
                </a:ext>
              </a:extLst>
            </p:cNvPr>
            <p:cNvSpPr txBox="1"/>
            <p:nvPr/>
          </p:nvSpPr>
          <p:spPr>
            <a:xfrm rot="16200000">
              <a:off x="3064250" y="2885283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B2A1B88-B976-EA05-89D6-284692180418}"/>
                </a:ext>
              </a:extLst>
            </p:cNvPr>
            <p:cNvSpPr txBox="1"/>
            <p:nvPr/>
          </p:nvSpPr>
          <p:spPr>
            <a:xfrm rot="16200000">
              <a:off x="3064250" y="4862219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A777E1A-4D95-1722-0995-F3BA452E97DD}"/>
                </a:ext>
              </a:extLst>
            </p:cNvPr>
            <p:cNvSpPr txBox="1"/>
            <p:nvPr/>
          </p:nvSpPr>
          <p:spPr>
            <a:xfrm rot="16200000">
              <a:off x="5250664" y="961115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-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D7C3119-591D-BCC0-D9B6-8FA35F921C89}"/>
                </a:ext>
              </a:extLst>
            </p:cNvPr>
            <p:cNvSpPr txBox="1"/>
            <p:nvPr/>
          </p:nvSpPr>
          <p:spPr>
            <a:xfrm rot="16200000">
              <a:off x="5250664" y="2884252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-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8BC93E9-D153-9C0C-907E-B1A1EBEB688E}"/>
                </a:ext>
              </a:extLst>
            </p:cNvPr>
            <p:cNvSpPr txBox="1"/>
            <p:nvPr/>
          </p:nvSpPr>
          <p:spPr>
            <a:xfrm rot="16200000">
              <a:off x="5250664" y="4861188"/>
              <a:ext cx="18088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-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3EE42DD-A174-0BD8-4463-E6C4D8A24CB8}"/>
                </a:ext>
              </a:extLst>
            </p:cNvPr>
            <p:cNvSpPr txBox="1"/>
            <p:nvPr/>
          </p:nvSpPr>
          <p:spPr>
            <a:xfrm>
              <a:off x="1984897" y="5853782"/>
              <a:ext cx="17617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6214D05-AF69-97B8-CD95-B594E9EAD465}"/>
                </a:ext>
              </a:extLst>
            </p:cNvPr>
            <p:cNvSpPr txBox="1"/>
            <p:nvPr/>
          </p:nvSpPr>
          <p:spPr>
            <a:xfrm>
              <a:off x="4186643" y="5879434"/>
              <a:ext cx="17617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4FEEF7D-F8A5-9405-6578-42413DA116D6}"/>
                </a:ext>
              </a:extLst>
            </p:cNvPr>
            <p:cNvSpPr txBox="1"/>
            <p:nvPr/>
          </p:nvSpPr>
          <p:spPr>
            <a:xfrm>
              <a:off x="6323878" y="5849292"/>
              <a:ext cx="17617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ITC-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678288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27C8470-2DCE-B0E8-8127-8022D21C99A1}"/>
              </a:ext>
            </a:extLst>
          </p:cNvPr>
          <p:cNvGrpSpPr/>
          <p:nvPr/>
        </p:nvGrpSpPr>
        <p:grpSpPr>
          <a:xfrm>
            <a:off x="16778" y="258430"/>
            <a:ext cx="9840286" cy="6535781"/>
            <a:chOff x="16778" y="258430"/>
            <a:chExt cx="9840286" cy="6535781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4039316-858E-F1F5-5AB0-6BBDB8C69CBB}"/>
                </a:ext>
              </a:extLst>
            </p:cNvPr>
            <p:cNvSpPr txBox="1"/>
            <p:nvPr/>
          </p:nvSpPr>
          <p:spPr>
            <a:xfrm rot="16200000">
              <a:off x="-397067" y="1852286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443E5B9-4D81-B454-41D0-18D042026C03}"/>
                </a:ext>
              </a:extLst>
            </p:cNvPr>
            <p:cNvSpPr txBox="1"/>
            <p:nvPr/>
          </p:nvSpPr>
          <p:spPr>
            <a:xfrm rot="16200000">
              <a:off x="-397066" y="687966"/>
              <a:ext cx="1101052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HS6ST1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A25B48C-9A67-DD35-C357-A085E035613B}"/>
                </a:ext>
              </a:extLst>
            </p:cNvPr>
            <p:cNvSpPr txBox="1"/>
            <p:nvPr/>
          </p:nvSpPr>
          <p:spPr>
            <a:xfrm rot="16200000">
              <a:off x="-397067" y="2998022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POU4F2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FB20A9E-68A4-7B22-189E-CB30F7916A79}"/>
                </a:ext>
              </a:extLst>
            </p:cNvPr>
            <p:cNvSpPr txBox="1"/>
            <p:nvPr/>
          </p:nvSpPr>
          <p:spPr>
            <a:xfrm rot="16200000">
              <a:off x="-397067" y="5346522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ISL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7A33759-8358-CE0C-53CB-A86A0CAD1BA1}"/>
                </a:ext>
              </a:extLst>
            </p:cNvPr>
            <p:cNvSpPr txBox="1"/>
            <p:nvPr/>
          </p:nvSpPr>
          <p:spPr>
            <a:xfrm>
              <a:off x="16778" y="6086325"/>
              <a:ext cx="984028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7. Examples of identified consensus peaks in 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CUT&amp;RUN-seq.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eek-7</a:t>
              </a:r>
              <a:r>
                <a:rPr lang="en-US" sz="800" b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organoids derived from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iPSCs were dissociated and retinal cells were enriched by FACS according to eGFP-signal. CUT&amp;RUN-seq was performed using eGFP-positive cells treated by anti-ATOH7 antibodies (target, blue tracks), eGFP-negative cells treated by anti-ATOH7 antibodies (negative control, red tracks), and eGFP-positive cells treated by non-immune IgG (background control, black track). Alignments against GRCh38p14 were visualized in IGV using binned coverages (25 bp). Identified target consensus peaks are displayed as annotation (blue).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UT&amp;RUN-seq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cleavage under targets and release using nuclease sequenc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CS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fluorescence-activated cell sorting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GV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integrative genomics viewer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PSC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induced pluripotent stem cell; </a:t>
              </a:r>
              <a:r>
                <a:rPr lang="en-US" sz="8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-GFP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, wildtype reporter.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E9D12B9-328D-5F0C-C7AD-F63D30559666}"/>
                </a:ext>
              </a:extLst>
            </p:cNvPr>
            <p:cNvSpPr txBox="1"/>
            <p:nvPr/>
          </p:nvSpPr>
          <p:spPr>
            <a:xfrm rot="16200000">
              <a:off x="4544172" y="1856154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CNTN2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7F7C068-FC0B-36BF-3B80-F6235AB4E10B}"/>
                </a:ext>
              </a:extLst>
            </p:cNvPr>
            <p:cNvSpPr txBox="1"/>
            <p:nvPr/>
          </p:nvSpPr>
          <p:spPr>
            <a:xfrm rot="16200000">
              <a:off x="4544172" y="691834"/>
              <a:ext cx="1101052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EFNA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587BE31-36D8-DFE1-FFD1-F00D5176608B}"/>
                </a:ext>
              </a:extLst>
            </p:cNvPr>
            <p:cNvSpPr txBox="1"/>
            <p:nvPr/>
          </p:nvSpPr>
          <p:spPr>
            <a:xfrm rot="16200000">
              <a:off x="4544172" y="3031100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TUBB3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BB0862C4-D376-B5E1-1203-D6C5837DF7E2}"/>
                </a:ext>
              </a:extLst>
            </p:cNvPr>
            <p:cNvSpPr txBox="1"/>
            <p:nvPr/>
          </p:nvSpPr>
          <p:spPr>
            <a:xfrm rot="16200000">
              <a:off x="4544172" y="4156590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HDAC2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FCE0F80B-81A6-C8B6-747E-1CC87E2C837E}"/>
                </a:ext>
              </a:extLst>
            </p:cNvPr>
            <p:cNvSpPr txBox="1"/>
            <p:nvPr/>
          </p:nvSpPr>
          <p:spPr>
            <a:xfrm rot="16200000">
              <a:off x="-397067" y="4160599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EYA2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3613C88C-992B-3298-BDE4-75E22A200668}"/>
                </a:ext>
              </a:extLst>
            </p:cNvPr>
            <p:cNvSpPr txBox="1"/>
            <p:nvPr/>
          </p:nvSpPr>
          <p:spPr>
            <a:xfrm rot="16200000">
              <a:off x="4544172" y="5329209"/>
              <a:ext cx="1101053" cy="24198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TLE4</a:t>
              </a:r>
            </a:p>
          </p:txBody>
        </p:sp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7D32C290-459B-936F-5128-CC65637060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4450" y="1410870"/>
              <a:ext cx="4555136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DAA774CF-C4EC-04FB-52CC-341028ED7A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4450" y="258430"/>
              <a:ext cx="4553758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F851D4BE-E5F1-B814-F988-1FA1877825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4450" y="2563310"/>
              <a:ext cx="4555136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9" name="Picture 88">
              <a:extLst>
                <a:ext uri="{FF2B5EF4-FFF2-40B4-BE49-F238E27FC236}">
                  <a16:creationId xmlns:a16="http://schemas.microsoft.com/office/drawing/2014/main" id="{16FFF773-C8F6-D02C-AA1F-D24430D51F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9817" t="8546" r="1125" b="47649"/>
            <a:stretch/>
          </p:blipFill>
          <p:spPr>
            <a:xfrm>
              <a:off x="274450" y="4868189"/>
              <a:ext cx="4554669" cy="12134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B1A4FDA7-28EC-EB5F-DE2C-E3E3909A16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4450" y="3715750"/>
              <a:ext cx="4554669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B4CA9B16-F10E-F77B-ABED-BF1C91FE41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22671" y="1410870"/>
              <a:ext cx="4553169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F421FEE0-85F9-B66B-5112-1A2DA941AE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22671" y="2563310"/>
              <a:ext cx="4554669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FC93C146-0866-D45C-A008-5F5B715E9E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22671" y="4868189"/>
              <a:ext cx="4554669" cy="12095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DD9C73A5-9076-8EC9-A082-B199FEABA4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22671" y="258430"/>
              <a:ext cx="4553169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3E5BBCE7-62D5-4DA0-0664-B70FCA660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9904" t="8461" r="1038" b="51630"/>
            <a:stretch/>
          </p:blipFill>
          <p:spPr>
            <a:xfrm>
              <a:off x="5222671" y="3715750"/>
              <a:ext cx="4554669" cy="1105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8986707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426C25DE-D8BB-3C4C-FBB9-D3A68A9FEF31}"/>
              </a:ext>
            </a:extLst>
          </p:cNvPr>
          <p:cNvGrpSpPr/>
          <p:nvPr/>
        </p:nvGrpSpPr>
        <p:grpSpPr>
          <a:xfrm>
            <a:off x="0" y="34716"/>
            <a:ext cx="9906000" cy="6830832"/>
            <a:chOff x="0" y="34716"/>
            <a:chExt cx="9906000" cy="6830832"/>
          </a:xfrm>
        </p:grpSpPr>
        <p:pic>
          <p:nvPicPr>
            <p:cNvPr id="3" name="Picture 2" descr="A picture containing screenshot, colorfulness, purple, violet&#10;&#10;Description automatically generated">
              <a:extLst>
                <a:ext uri="{FF2B5EF4-FFF2-40B4-BE49-F238E27FC236}">
                  <a16:creationId xmlns:a16="http://schemas.microsoft.com/office/drawing/2014/main" id="{F802F127-4592-E4D1-E4BA-E5255B8F3D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-7027"/>
            <a:stretch/>
          </p:blipFill>
          <p:spPr>
            <a:xfrm>
              <a:off x="5265" y="743020"/>
              <a:ext cx="3546719" cy="5412243"/>
            </a:xfrm>
            <a:prstGeom prst="rect">
              <a:avLst/>
            </a:prstGeom>
          </p:spPr>
        </p:pic>
        <p:pic>
          <p:nvPicPr>
            <p:cNvPr id="5" name="Picture 4" descr="A picture containing screenshot, colorfulness, purple, violet&#10;&#10;Description automatically generated">
              <a:extLst>
                <a:ext uri="{FF2B5EF4-FFF2-40B4-BE49-F238E27FC236}">
                  <a16:creationId xmlns:a16="http://schemas.microsoft.com/office/drawing/2014/main" id="{8AEAC962-BF3B-561C-3C22-89740AA2C5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35119" y="741305"/>
              <a:ext cx="3313827" cy="5413961"/>
            </a:xfrm>
            <a:prstGeom prst="rect">
              <a:avLst/>
            </a:prstGeom>
          </p:spPr>
        </p:pic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D3110F68-55A9-370B-45F6-D8C1D55278C7}"/>
                </a:ext>
              </a:extLst>
            </p:cNvPr>
            <p:cNvSpPr txBox="1"/>
            <p:nvPr/>
          </p:nvSpPr>
          <p:spPr>
            <a:xfrm>
              <a:off x="0" y="6157662"/>
              <a:ext cx="99060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Figure S8. Top cell type-specific marker genes in retinal organoids.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Entire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 and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eek-7 retinal organoids were analyzed by hybridization-based PFA-fixed scRNA-seq. The representative cell type-specific clusters are defined as naïve retinal progenitor cells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nRP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transient retinal progenitor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tRP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early retinal ganglion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early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RG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late retinal ganglion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late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RGC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horizontal and amacrine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H&amp;A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, and photoreceptor cell (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PR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).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)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Heatmaps representing raw expression of identified marker genes amongst cell clusters in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WT and </a:t>
              </a:r>
              <a:r>
                <a:rPr lang="en-US" sz="8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TOH7</a:t>
              </a:r>
              <a:r>
                <a:rPr lang="en-US" sz="800" i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organoids. </a:t>
              </a:r>
              <a:r>
                <a:rPr lang="en-US" sz="800" i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B) 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UMAPs representing selected genes in integrated organoid samples. 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No </a:t>
              </a:r>
              <a:r>
                <a:rPr lang="en-US" sz="800" i="1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ATOH7</a:t>
              </a:r>
              <a:r>
                <a:rPr lang="en-US" sz="800" dirty="0">
                  <a:solidFill>
                    <a:srgbClr val="262626"/>
                  </a:solidFill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expression was detected in KO organoids.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INT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integrated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KO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knockout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PFA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paraformaldehyde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scRNA-seq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single-cell RNA sequencing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UMAP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uniform manifold approximation and projection; </a:t>
              </a:r>
              <a:r>
                <a:rPr lang="en-US" sz="800" b="1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WT</a:t>
              </a:r>
              <a:r>
                <a:rPr lang="en-US" sz="800" dirty="0">
                  <a:solidFill>
                    <a:srgbClr val="262626"/>
                  </a:solidFill>
                  <a:effectLst/>
                  <a:latin typeface="Arial" panose="020B0604020202020204" pitchFamily="34" charset="0"/>
                  <a:ea typeface="Yu Gothic Light" panose="020B0300000000000000" pitchFamily="34" charset="-128"/>
                  <a:cs typeface="Arial" panose="020B0604020202020204" pitchFamily="34" charset="0"/>
                </a:rPr>
                <a:t>, wildtype.</a:t>
              </a:r>
              <a:endParaRPr lang="en-US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CF2BAEE5-6221-1D1D-83BA-D92A977BEC46}"/>
                </a:ext>
              </a:extLst>
            </p:cNvPr>
            <p:cNvSpPr txBox="1"/>
            <p:nvPr/>
          </p:nvSpPr>
          <p:spPr>
            <a:xfrm>
              <a:off x="36464" y="350979"/>
              <a:ext cx="386608" cy="406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66F66112-DE6C-AE19-541C-B1187AB86DF3}"/>
                </a:ext>
              </a:extLst>
            </p:cNvPr>
            <p:cNvCxnSpPr>
              <a:cxnSpLocks/>
            </p:cNvCxnSpPr>
            <p:nvPr/>
          </p:nvCxnSpPr>
          <p:spPr>
            <a:xfrm>
              <a:off x="5575598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E5EBE34A-2AAC-D8BA-C431-31C7F5DF3DBC}"/>
                </a:ext>
              </a:extLst>
            </p:cNvPr>
            <p:cNvCxnSpPr>
              <a:cxnSpLocks/>
            </p:cNvCxnSpPr>
            <p:nvPr/>
          </p:nvCxnSpPr>
          <p:spPr>
            <a:xfrm>
              <a:off x="5956160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FB59D4EE-30FA-19ED-12FB-9F9DBD4D7755}"/>
                </a:ext>
              </a:extLst>
            </p:cNvPr>
            <p:cNvCxnSpPr>
              <a:cxnSpLocks/>
            </p:cNvCxnSpPr>
            <p:nvPr/>
          </p:nvCxnSpPr>
          <p:spPr>
            <a:xfrm>
              <a:off x="6102830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C7ED2C9-711F-F597-30DE-A252A0872852}"/>
                </a:ext>
              </a:extLst>
            </p:cNvPr>
            <p:cNvCxnSpPr>
              <a:cxnSpLocks/>
            </p:cNvCxnSpPr>
            <p:nvPr/>
          </p:nvCxnSpPr>
          <p:spPr>
            <a:xfrm>
              <a:off x="6171718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BBC3AF00-8B12-937C-AECA-3739092460BE}"/>
                </a:ext>
              </a:extLst>
            </p:cNvPr>
            <p:cNvCxnSpPr>
              <a:cxnSpLocks/>
            </p:cNvCxnSpPr>
            <p:nvPr/>
          </p:nvCxnSpPr>
          <p:spPr>
            <a:xfrm>
              <a:off x="6369499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208CE678-3728-2ACA-1F01-A528382F5C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685" y="1824646"/>
              <a:ext cx="270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A77AD9C3-8530-C4E7-72AD-E5D143B221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681" y="3542078"/>
              <a:ext cx="270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0E5EB7EB-EDC3-9B24-F377-2479B751D5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682" y="2680214"/>
              <a:ext cx="270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CCE29178-384F-CA49-47A0-31DDE31C0D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681" y="4395796"/>
              <a:ext cx="270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D3EAD06E-8DD3-4916-28F9-972BECFB3E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1680" y="5260253"/>
              <a:ext cx="270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BB7A4D07-78FF-BE20-E309-8AE86F5EEF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0726" y="6144151"/>
              <a:ext cx="2855685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9B0A8379-0F1D-45F4-F02B-FA08282B1AE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6641" y="956551"/>
              <a:ext cx="2855685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4090E69F-7BBE-A1F3-9981-44039C1F265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58660" y="938762"/>
              <a:ext cx="2855685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1C74C905-98A0-9375-BBDB-DE529DBF3F0E}"/>
                </a:ext>
              </a:extLst>
            </p:cNvPr>
            <p:cNvSpPr txBox="1"/>
            <p:nvPr/>
          </p:nvSpPr>
          <p:spPr>
            <a:xfrm>
              <a:off x="6692197" y="343365"/>
              <a:ext cx="386608" cy="406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66" name="Group 165">
              <a:extLst>
                <a:ext uri="{FF2B5EF4-FFF2-40B4-BE49-F238E27FC236}">
                  <a16:creationId xmlns:a16="http://schemas.microsoft.com/office/drawing/2014/main" id="{56667E44-6CFC-7E67-930B-341925DD544E}"/>
                </a:ext>
              </a:extLst>
            </p:cNvPr>
            <p:cNvGrpSpPr/>
            <p:nvPr/>
          </p:nvGrpSpPr>
          <p:grpSpPr>
            <a:xfrm>
              <a:off x="888687" y="141877"/>
              <a:ext cx="979476" cy="473910"/>
              <a:chOff x="772951" y="5968549"/>
              <a:chExt cx="979476" cy="473910"/>
            </a:xfrm>
          </p:grpSpPr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A22B4645-8AEF-6F68-666E-E447301ED456}"/>
                  </a:ext>
                </a:extLst>
              </p:cNvPr>
              <p:cNvSpPr txBox="1"/>
              <p:nvPr/>
            </p:nvSpPr>
            <p:spPr>
              <a:xfrm rot="19500000">
                <a:off x="772951" y="6293405"/>
                <a:ext cx="241987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RPC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B50DD53A-952A-213A-95C8-AD0359FE970C}"/>
                  </a:ext>
                </a:extLst>
              </p:cNvPr>
              <p:cNvSpPr txBox="1"/>
              <p:nvPr/>
            </p:nvSpPr>
            <p:spPr>
              <a:xfrm rot="19500000">
                <a:off x="905684" y="6291051"/>
                <a:ext cx="23378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tRPC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85F66138-7588-1F05-9C94-FA1A2487CCC9}"/>
                  </a:ext>
                </a:extLst>
              </p:cNvPr>
              <p:cNvSpPr txBox="1"/>
              <p:nvPr/>
            </p:nvSpPr>
            <p:spPr>
              <a:xfrm rot="19500000">
                <a:off x="845391" y="6350126"/>
                <a:ext cx="439766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Early RGC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B1D35547-0963-F6B0-1018-691428502E65}"/>
                  </a:ext>
                </a:extLst>
              </p:cNvPr>
              <p:cNvSpPr txBox="1"/>
              <p:nvPr/>
            </p:nvSpPr>
            <p:spPr>
              <a:xfrm rot="19500000">
                <a:off x="996545" y="6343387"/>
                <a:ext cx="416269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Late RGC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C35C2380-56E2-2368-E4EC-F5424E63ECB2}"/>
                  </a:ext>
                </a:extLst>
              </p:cNvPr>
              <p:cNvSpPr txBox="1"/>
              <p:nvPr/>
            </p:nvSpPr>
            <p:spPr>
              <a:xfrm rot="19500000">
                <a:off x="1327942" y="6279710"/>
                <a:ext cx="194236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&amp;A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98A9DA7A-4FA3-9AA3-BFC5-F4398B2B796A}"/>
                  </a:ext>
                </a:extLst>
              </p:cNvPr>
              <p:cNvSpPr txBox="1"/>
              <p:nvPr/>
            </p:nvSpPr>
            <p:spPr>
              <a:xfrm rot="19500000">
                <a:off x="1517398" y="6260716"/>
                <a:ext cx="12800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PR</a:t>
                </a:r>
              </a:p>
            </p:txBody>
          </p:sp>
          <p:grpSp>
            <p:nvGrpSpPr>
              <p:cNvPr id="122" name="Group 121">
                <a:extLst>
                  <a:ext uri="{FF2B5EF4-FFF2-40B4-BE49-F238E27FC236}">
                    <a16:creationId xmlns:a16="http://schemas.microsoft.com/office/drawing/2014/main" id="{B2E7C376-952A-E8B7-8500-8ECE8CCD4E49}"/>
                  </a:ext>
                </a:extLst>
              </p:cNvPr>
              <p:cNvGrpSpPr/>
              <p:nvPr/>
            </p:nvGrpSpPr>
            <p:grpSpPr>
              <a:xfrm rot="16200000">
                <a:off x="1265936" y="5809356"/>
                <a:ext cx="49638" cy="780823"/>
                <a:chOff x="396224" y="1686059"/>
                <a:chExt cx="144014" cy="829223"/>
              </a:xfrm>
            </p:grpSpPr>
            <p:sp>
              <p:nvSpPr>
                <p:cNvPr id="115" name="Rectangle 114">
                  <a:extLst>
                    <a:ext uri="{FF2B5EF4-FFF2-40B4-BE49-F238E27FC236}">
                      <a16:creationId xmlns:a16="http://schemas.microsoft.com/office/drawing/2014/main" id="{46BA04A5-E9C5-DD8F-4D44-A33663087149}"/>
                    </a:ext>
                  </a:extLst>
                </p:cNvPr>
                <p:cNvSpPr/>
                <p:nvPr/>
              </p:nvSpPr>
              <p:spPr>
                <a:xfrm>
                  <a:off x="396224" y="1686059"/>
                  <a:ext cx="143995" cy="144000"/>
                </a:xfrm>
                <a:prstGeom prst="rect">
                  <a:avLst/>
                </a:prstGeom>
                <a:solidFill>
                  <a:srgbClr val="417505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/>
                </a:p>
              </p:txBody>
            </p:sp>
            <p:sp>
              <p:nvSpPr>
                <p:cNvPr id="117" name="Rectangle 116">
                  <a:extLst>
                    <a:ext uri="{FF2B5EF4-FFF2-40B4-BE49-F238E27FC236}">
                      <a16:creationId xmlns:a16="http://schemas.microsoft.com/office/drawing/2014/main" id="{021AA479-9E8D-C70C-8F2D-82FFFF706129}"/>
                    </a:ext>
                  </a:extLst>
                </p:cNvPr>
                <p:cNvSpPr/>
                <p:nvPr/>
              </p:nvSpPr>
              <p:spPr>
                <a:xfrm>
                  <a:off x="396230" y="1826392"/>
                  <a:ext cx="143997" cy="144000"/>
                </a:xfrm>
                <a:prstGeom prst="rect">
                  <a:avLst/>
                </a:prstGeom>
                <a:solidFill>
                  <a:srgbClr val="F8E71C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/>
                </a:p>
              </p:txBody>
            </p:sp>
            <p:sp>
              <p:nvSpPr>
                <p:cNvPr id="118" name="Rectangle 117">
                  <a:extLst>
                    <a:ext uri="{FF2B5EF4-FFF2-40B4-BE49-F238E27FC236}">
                      <a16:creationId xmlns:a16="http://schemas.microsoft.com/office/drawing/2014/main" id="{29A07617-992E-CA64-514C-ED3A041E1910}"/>
                    </a:ext>
                  </a:extLst>
                </p:cNvPr>
                <p:cNvSpPr/>
                <p:nvPr/>
              </p:nvSpPr>
              <p:spPr>
                <a:xfrm>
                  <a:off x="396237" y="1965519"/>
                  <a:ext cx="144001" cy="144000"/>
                </a:xfrm>
                <a:prstGeom prst="rect">
                  <a:avLst/>
                </a:prstGeom>
                <a:solidFill>
                  <a:srgbClr val="F5A62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/>
                </a:p>
              </p:txBody>
            </p:sp>
            <p:sp>
              <p:nvSpPr>
                <p:cNvPr id="119" name="Rectangle 118">
                  <a:extLst>
                    <a:ext uri="{FF2B5EF4-FFF2-40B4-BE49-F238E27FC236}">
                      <a16:creationId xmlns:a16="http://schemas.microsoft.com/office/drawing/2014/main" id="{4E2275C7-B340-5E7A-CA46-D6CE02C3DDF0}"/>
                    </a:ext>
                  </a:extLst>
                </p:cNvPr>
                <p:cNvSpPr/>
                <p:nvPr/>
              </p:nvSpPr>
              <p:spPr>
                <a:xfrm>
                  <a:off x="396232" y="2097830"/>
                  <a:ext cx="144001" cy="144000"/>
                </a:xfrm>
                <a:prstGeom prst="rect">
                  <a:avLst/>
                </a:prstGeom>
                <a:solidFill>
                  <a:srgbClr val="D0021B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/>
                </a:p>
              </p:txBody>
            </p:sp>
            <p:sp>
              <p:nvSpPr>
                <p:cNvPr id="120" name="Rectangle 119">
                  <a:extLst>
                    <a:ext uri="{FF2B5EF4-FFF2-40B4-BE49-F238E27FC236}">
                      <a16:creationId xmlns:a16="http://schemas.microsoft.com/office/drawing/2014/main" id="{F64B666C-203A-FB70-D549-82EA277408CC}"/>
                    </a:ext>
                  </a:extLst>
                </p:cNvPr>
                <p:cNvSpPr/>
                <p:nvPr/>
              </p:nvSpPr>
              <p:spPr>
                <a:xfrm>
                  <a:off x="396232" y="2231516"/>
                  <a:ext cx="144001" cy="144000"/>
                </a:xfrm>
                <a:prstGeom prst="rect">
                  <a:avLst/>
                </a:prstGeom>
                <a:solidFill>
                  <a:srgbClr val="4A90E2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/>
                </a:p>
              </p:txBody>
            </p:sp>
            <p:sp>
              <p:nvSpPr>
                <p:cNvPr id="121" name="Rectangle 120">
                  <a:extLst>
                    <a:ext uri="{FF2B5EF4-FFF2-40B4-BE49-F238E27FC236}">
                      <a16:creationId xmlns:a16="http://schemas.microsoft.com/office/drawing/2014/main" id="{7C4A4310-922B-3278-46C1-DF7AD077867A}"/>
                    </a:ext>
                  </a:extLst>
                </p:cNvPr>
                <p:cNvSpPr/>
                <p:nvPr/>
              </p:nvSpPr>
              <p:spPr>
                <a:xfrm>
                  <a:off x="396232" y="2371282"/>
                  <a:ext cx="144001" cy="144000"/>
                </a:xfrm>
                <a:prstGeom prst="rect">
                  <a:avLst/>
                </a:prstGeom>
                <a:solidFill>
                  <a:srgbClr val="BD10E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/>
                </a:p>
              </p:txBody>
            </p:sp>
          </p:grp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B604AEF6-4CB5-2863-2345-F3EF1DF40E7C}"/>
                  </a:ext>
                </a:extLst>
              </p:cNvPr>
              <p:cNvSpPr txBox="1"/>
              <p:nvPr/>
            </p:nvSpPr>
            <p:spPr>
              <a:xfrm>
                <a:off x="831054" y="5968549"/>
                <a:ext cx="92137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Type Clusters</a:t>
                </a:r>
              </a:p>
            </p:txBody>
          </p:sp>
        </p:grp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7A705CED-789E-85A0-D769-F674D15CFEC9}"/>
                </a:ext>
              </a:extLst>
            </p:cNvPr>
            <p:cNvSpPr/>
            <p:nvPr/>
          </p:nvSpPr>
          <p:spPr>
            <a:xfrm>
              <a:off x="3328421" y="744480"/>
              <a:ext cx="676829" cy="20903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8BFFF5AD-076B-5E49-C427-CC8E4EAAF1AC}"/>
                </a:ext>
              </a:extLst>
            </p:cNvPr>
            <p:cNvSpPr/>
            <p:nvPr/>
          </p:nvSpPr>
          <p:spPr>
            <a:xfrm>
              <a:off x="1386" y="752746"/>
              <a:ext cx="676830" cy="158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F279EFBC-3CA2-3B5F-0B81-8136FA86E1B2}"/>
                </a:ext>
              </a:extLst>
            </p:cNvPr>
            <p:cNvCxnSpPr>
              <a:cxnSpLocks/>
            </p:cNvCxnSpPr>
            <p:nvPr/>
          </p:nvCxnSpPr>
          <p:spPr>
            <a:xfrm>
              <a:off x="2018074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6FA0F0C3-E457-13B4-C02B-1398D83962CC}"/>
                </a:ext>
              </a:extLst>
            </p:cNvPr>
            <p:cNvCxnSpPr>
              <a:cxnSpLocks/>
            </p:cNvCxnSpPr>
            <p:nvPr/>
          </p:nvCxnSpPr>
          <p:spPr>
            <a:xfrm>
              <a:off x="2395857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AF3D724E-16CC-B1A1-07DE-B217B180A452}"/>
                </a:ext>
              </a:extLst>
            </p:cNvPr>
            <p:cNvCxnSpPr>
              <a:cxnSpLocks/>
            </p:cNvCxnSpPr>
            <p:nvPr/>
          </p:nvCxnSpPr>
          <p:spPr>
            <a:xfrm>
              <a:off x="2687529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6E4E5BFA-74B3-E0DD-0B23-D595761AEDDB}"/>
                </a:ext>
              </a:extLst>
            </p:cNvPr>
            <p:cNvCxnSpPr>
              <a:cxnSpLocks/>
            </p:cNvCxnSpPr>
            <p:nvPr/>
          </p:nvCxnSpPr>
          <p:spPr>
            <a:xfrm>
              <a:off x="2984755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1330F93-16BB-7D63-1958-2156DF028B14}"/>
                </a:ext>
              </a:extLst>
            </p:cNvPr>
            <p:cNvCxnSpPr>
              <a:cxnSpLocks/>
            </p:cNvCxnSpPr>
            <p:nvPr/>
          </p:nvCxnSpPr>
          <p:spPr>
            <a:xfrm>
              <a:off x="3113634" y="752409"/>
              <a:ext cx="0" cy="540285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FF4825DE-22D2-6685-68DA-DFBA8F15949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5273" y="1824646"/>
              <a:ext cx="285568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BD1B9124-4BF1-BD59-D639-52F9DC4CB7D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5270" y="3553189"/>
              <a:ext cx="285568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D62B7743-DC00-1D34-929D-2195DCA7A0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5271" y="2680214"/>
              <a:ext cx="285568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8395A8DA-B163-E624-6127-156AA98B733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5270" y="4406907"/>
              <a:ext cx="285568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9FDE38DA-AF58-5015-0B3A-44456D9809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5269" y="5260253"/>
              <a:ext cx="285568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AFF8FEF0-546B-33B7-214E-EF647C3EE7E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6349" y="6138414"/>
              <a:ext cx="2855685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084813F0-A0CF-B449-FF6A-5065D594F4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6232" y="949144"/>
              <a:ext cx="2855685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D38D62C-D485-CB82-8F2A-EAFF5E7B0C17}"/>
                </a:ext>
              </a:extLst>
            </p:cNvPr>
            <p:cNvSpPr txBox="1"/>
            <p:nvPr/>
          </p:nvSpPr>
          <p:spPr>
            <a:xfrm>
              <a:off x="421390" y="747892"/>
              <a:ext cx="200376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61E74B1-CB43-B7DA-B1CD-FCB8BCD0029F}"/>
                </a:ext>
              </a:extLst>
            </p:cNvPr>
            <p:cNvSpPr txBox="1"/>
            <p:nvPr/>
          </p:nvSpPr>
          <p:spPr>
            <a:xfrm>
              <a:off x="3664316" y="747892"/>
              <a:ext cx="27892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  <p:grpSp>
          <p:nvGrpSpPr>
            <p:cNvPr id="169" name="Group 168">
              <a:extLst>
                <a:ext uri="{FF2B5EF4-FFF2-40B4-BE49-F238E27FC236}">
                  <a16:creationId xmlns:a16="http://schemas.microsoft.com/office/drawing/2014/main" id="{5F7FBCD8-0861-F55B-114F-5677FEAA773E}"/>
                </a:ext>
              </a:extLst>
            </p:cNvPr>
            <p:cNvGrpSpPr/>
            <p:nvPr/>
          </p:nvGrpSpPr>
          <p:grpSpPr>
            <a:xfrm>
              <a:off x="6796469" y="752633"/>
              <a:ext cx="2975719" cy="3926001"/>
              <a:chOff x="6796469" y="400878"/>
              <a:chExt cx="2975719" cy="3926001"/>
            </a:xfrm>
          </p:grpSpPr>
          <p:pic>
            <p:nvPicPr>
              <p:cNvPr id="45" name="Picture 44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4206AE55-963E-EEE0-F233-03AE717F7E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787635" y="1380747"/>
                <a:ext cx="993383" cy="989494"/>
              </a:xfrm>
              <a:prstGeom prst="rect">
                <a:avLst/>
              </a:prstGeom>
            </p:spPr>
          </p:pic>
          <p:pic>
            <p:nvPicPr>
              <p:cNvPr id="52" name="Picture 51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A4FA10E5-8881-ED1E-1383-BFBB7A3C2F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787635" y="400878"/>
                <a:ext cx="993381" cy="989494"/>
              </a:xfrm>
              <a:prstGeom prst="rect">
                <a:avLst/>
              </a:prstGeom>
            </p:spPr>
          </p:pic>
          <p:pic>
            <p:nvPicPr>
              <p:cNvPr id="54" name="Picture 53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9DA55E0B-02CB-99E8-0414-0C9E939615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96469" y="3337385"/>
                <a:ext cx="993383" cy="989494"/>
              </a:xfrm>
              <a:prstGeom prst="rect">
                <a:avLst/>
              </a:prstGeom>
            </p:spPr>
          </p:pic>
          <p:pic>
            <p:nvPicPr>
              <p:cNvPr id="56" name="Picture 55" descr="A close-up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093C6882-4065-8789-DF35-C8813626E3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96469" y="2358402"/>
                <a:ext cx="993383" cy="989494"/>
              </a:xfrm>
              <a:prstGeom prst="rect">
                <a:avLst/>
              </a:prstGeom>
            </p:spPr>
          </p:pic>
          <p:pic>
            <p:nvPicPr>
              <p:cNvPr id="58" name="Picture 57" descr="A close-up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4D36D0BA-C9A1-A9EE-80E0-24BA94EE31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96469" y="1380747"/>
                <a:ext cx="993383" cy="989494"/>
              </a:xfrm>
              <a:prstGeom prst="rect">
                <a:avLst/>
              </a:prstGeom>
            </p:spPr>
          </p:pic>
          <p:pic>
            <p:nvPicPr>
              <p:cNvPr id="60" name="Picture 59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772CA9F8-E04D-EF53-8827-20952D8B97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96469" y="400878"/>
                <a:ext cx="993383" cy="989494"/>
              </a:xfrm>
              <a:prstGeom prst="rect">
                <a:avLst/>
              </a:prstGeom>
            </p:spPr>
          </p:pic>
          <p:pic>
            <p:nvPicPr>
              <p:cNvPr id="88" name="Picture 87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7FCD654E-8FC6-1FE9-1A8F-C31BBFD3ED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787635" y="2358402"/>
                <a:ext cx="993379" cy="989494"/>
              </a:xfrm>
              <a:prstGeom prst="rect">
                <a:avLst/>
              </a:prstGeom>
            </p:spPr>
          </p:pic>
          <p:pic>
            <p:nvPicPr>
              <p:cNvPr id="91" name="Picture 90" descr="A screen shot of a computer generated image&#10;&#10;Description automatically generated">
                <a:extLst>
                  <a:ext uri="{FF2B5EF4-FFF2-40B4-BE49-F238E27FC236}">
                    <a16:creationId xmlns:a16="http://schemas.microsoft.com/office/drawing/2014/main" id="{D49BDF65-7DB8-E3D8-8F2B-D67BBD1B95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787635" y="3337385"/>
                <a:ext cx="993383" cy="989494"/>
              </a:xfrm>
              <a:prstGeom prst="rect">
                <a:avLst/>
              </a:prstGeom>
            </p:spPr>
          </p:pic>
          <p:pic>
            <p:nvPicPr>
              <p:cNvPr id="101" name="Picture 100" descr="A close-up of a computer screen&#10;&#10;Description automatically generated">
                <a:extLst>
                  <a:ext uri="{FF2B5EF4-FFF2-40B4-BE49-F238E27FC236}">
                    <a16:creationId xmlns:a16="http://schemas.microsoft.com/office/drawing/2014/main" id="{B45477A2-AB77-C0C5-4FF5-1D48C0BCE0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778804" y="400878"/>
                <a:ext cx="993383" cy="989494"/>
              </a:xfrm>
              <a:prstGeom prst="rect">
                <a:avLst/>
              </a:prstGeom>
            </p:spPr>
          </p:pic>
          <p:pic>
            <p:nvPicPr>
              <p:cNvPr id="103" name="Picture 102" descr="A close-up of a computer screen&#10;&#10;Description automatically generated">
                <a:extLst>
                  <a:ext uri="{FF2B5EF4-FFF2-40B4-BE49-F238E27FC236}">
                    <a16:creationId xmlns:a16="http://schemas.microsoft.com/office/drawing/2014/main" id="{B467703B-910F-587E-1AE0-081B4AE68D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778804" y="1380747"/>
                <a:ext cx="993380" cy="989494"/>
              </a:xfrm>
              <a:prstGeom prst="rect">
                <a:avLst/>
              </a:prstGeom>
            </p:spPr>
          </p:pic>
          <p:pic>
            <p:nvPicPr>
              <p:cNvPr id="105" name="Picture 104" descr="A green and blue dotted image&#10;&#10;Description automatically generated with medium confidence">
                <a:extLst>
                  <a:ext uri="{FF2B5EF4-FFF2-40B4-BE49-F238E27FC236}">
                    <a16:creationId xmlns:a16="http://schemas.microsoft.com/office/drawing/2014/main" id="{26CB1F35-9CB0-8185-2B79-0F8287FB40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778804" y="2358402"/>
                <a:ext cx="993384" cy="989494"/>
              </a:xfrm>
              <a:prstGeom prst="rect">
                <a:avLst/>
              </a:prstGeom>
            </p:spPr>
          </p:pic>
          <p:pic>
            <p:nvPicPr>
              <p:cNvPr id="107" name="Picture 106" descr="A colorful image of a person's body&#10;&#10;Description automatically generated">
                <a:extLst>
                  <a:ext uri="{FF2B5EF4-FFF2-40B4-BE49-F238E27FC236}">
                    <a16:creationId xmlns:a16="http://schemas.microsoft.com/office/drawing/2014/main" id="{81B7CA1F-F66E-A20C-05B6-74FBD71599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778804" y="3337385"/>
                <a:ext cx="993381" cy="989494"/>
              </a:xfrm>
              <a:prstGeom prst="rect">
                <a:avLst/>
              </a:prstGeom>
            </p:spPr>
          </p:pic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82045D89-A9B4-2C38-7E6D-164970B9B5A6}"/>
                  </a:ext>
                </a:extLst>
              </p:cNvPr>
              <p:cNvSpPr txBox="1"/>
              <p:nvPr/>
            </p:nvSpPr>
            <p:spPr>
              <a:xfrm>
                <a:off x="6885425" y="3337176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S6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47C14F09-6484-232B-EA39-DA6BB2C060D2}"/>
                  </a:ext>
                </a:extLst>
              </p:cNvPr>
              <p:cNvSpPr txBox="1"/>
              <p:nvPr/>
            </p:nvSpPr>
            <p:spPr>
              <a:xfrm>
                <a:off x="7874928" y="3337176"/>
                <a:ext cx="47185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FAP2A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100C545B-C6F0-347D-933B-9CA58884EF63}"/>
                  </a:ext>
                </a:extLst>
              </p:cNvPr>
              <p:cNvSpPr txBox="1"/>
              <p:nvPr/>
            </p:nvSpPr>
            <p:spPr>
              <a:xfrm>
                <a:off x="8868791" y="3337176"/>
                <a:ext cx="37567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KI67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6CB2528C-6646-658E-FCFE-691C6698BB85}"/>
                  </a:ext>
                </a:extLst>
              </p:cNvPr>
              <p:cNvSpPr txBox="1"/>
              <p:nvPr/>
            </p:nvSpPr>
            <p:spPr>
              <a:xfrm>
                <a:off x="6883044" y="2358862"/>
                <a:ext cx="329184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LL1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5408E234-2B1C-8D3A-D5C6-515649C7E48F}"/>
                  </a:ext>
                </a:extLst>
              </p:cNvPr>
              <p:cNvSpPr txBox="1"/>
              <p:nvPr/>
            </p:nvSpPr>
            <p:spPr>
              <a:xfrm>
                <a:off x="7872547" y="2358862"/>
                <a:ext cx="410937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43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5BFE1B80-3D01-A8B0-BA82-5758021B0728}"/>
                  </a:ext>
                </a:extLst>
              </p:cNvPr>
              <p:cNvSpPr txBox="1"/>
              <p:nvPr/>
            </p:nvSpPr>
            <p:spPr>
              <a:xfrm>
                <a:off x="8866410" y="2358862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X6</a:t>
                </a: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B17CC461-6132-6A5E-CC29-9E4E1C86ED2B}"/>
                  </a:ext>
                </a:extLst>
              </p:cNvPr>
              <p:cNvSpPr txBox="1"/>
              <p:nvPr/>
            </p:nvSpPr>
            <p:spPr>
              <a:xfrm>
                <a:off x="6885221" y="1377267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S1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10C63B1E-BE8A-1C81-05DA-AF2A3E987425}"/>
                  </a:ext>
                </a:extLst>
              </p:cNvPr>
              <p:cNvSpPr txBox="1"/>
              <p:nvPr/>
            </p:nvSpPr>
            <p:spPr>
              <a:xfrm>
                <a:off x="7874724" y="1377267"/>
                <a:ext cx="473454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U4F2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22C0758D-027B-8D0F-98E8-1D8B39CC3F4F}"/>
                  </a:ext>
                </a:extLst>
              </p:cNvPr>
              <p:cNvSpPr txBox="1"/>
              <p:nvPr/>
            </p:nvSpPr>
            <p:spPr>
              <a:xfrm>
                <a:off x="8868587" y="1377267"/>
                <a:ext cx="342008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TX2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CE00335A-2667-3095-8DA4-3C1702593BDD}"/>
                  </a:ext>
                </a:extLst>
              </p:cNvPr>
              <p:cNvSpPr txBox="1"/>
              <p:nvPr/>
            </p:nvSpPr>
            <p:spPr>
              <a:xfrm>
                <a:off x="6885425" y="403346"/>
                <a:ext cx="404525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FRP2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9FB08FAF-364E-46C4-78E7-1BB6A9E7E872}"/>
                  </a:ext>
                </a:extLst>
              </p:cNvPr>
              <p:cNvSpPr txBox="1"/>
              <p:nvPr/>
            </p:nvSpPr>
            <p:spPr>
              <a:xfrm>
                <a:off x="7874928" y="403346"/>
                <a:ext cx="563222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DD45A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CF4DCEE0-80D8-85CC-E29D-8FD3F8B1E901}"/>
                  </a:ext>
                </a:extLst>
              </p:cNvPr>
              <p:cNvSpPr txBox="1"/>
              <p:nvPr/>
            </p:nvSpPr>
            <p:spPr>
              <a:xfrm>
                <a:off x="8868791" y="403346"/>
                <a:ext cx="289109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X</a:t>
                </a:r>
              </a:p>
            </p:txBody>
          </p:sp>
        </p:grpSp>
        <p:grpSp>
          <p:nvGrpSpPr>
            <p:cNvPr id="167" name="Group 166">
              <a:extLst>
                <a:ext uri="{FF2B5EF4-FFF2-40B4-BE49-F238E27FC236}">
                  <a16:creationId xmlns:a16="http://schemas.microsoft.com/office/drawing/2014/main" id="{64254EFF-8F1C-66A6-1E95-036B7AA863B4}"/>
                </a:ext>
              </a:extLst>
            </p:cNvPr>
            <p:cNvGrpSpPr/>
            <p:nvPr/>
          </p:nvGrpSpPr>
          <p:grpSpPr>
            <a:xfrm>
              <a:off x="1958097" y="34716"/>
              <a:ext cx="1132665" cy="517458"/>
              <a:chOff x="1747111" y="5861388"/>
              <a:chExt cx="1132665" cy="517458"/>
            </a:xfrm>
          </p:grpSpPr>
          <p:pic>
            <p:nvPicPr>
              <p:cNvPr id="47" name="Picture 46" descr="A picture containing text, screenshot, colorfulness, diagram&#10;&#10;Description automatically generated">
                <a:extLst>
                  <a:ext uri="{FF2B5EF4-FFF2-40B4-BE49-F238E27FC236}">
                    <a16:creationId xmlns:a16="http://schemas.microsoft.com/office/drawing/2014/main" id="{A85A94C0-8D8B-27AA-4E94-42556DF0F7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hq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2248725" y="5689173"/>
                <a:ext cx="83500" cy="1022237"/>
              </a:xfrm>
              <a:prstGeom prst="rect">
                <a:avLst/>
              </a:prstGeom>
            </p:spPr>
          </p:pic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08DD5F16-8094-3995-6C3C-116C6523584E}"/>
                  </a:ext>
                </a:extLst>
              </p:cNvPr>
              <p:cNvSpPr txBox="1"/>
              <p:nvPr/>
            </p:nvSpPr>
            <p:spPr>
              <a:xfrm>
                <a:off x="2148639" y="6194180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.25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77045793-2D7C-6CAB-79FD-E1B7CA810B46}"/>
                  </a:ext>
                </a:extLst>
              </p:cNvPr>
              <p:cNvSpPr txBox="1"/>
              <p:nvPr/>
            </p:nvSpPr>
            <p:spPr>
              <a:xfrm>
                <a:off x="1776583" y="6194180"/>
                <a:ext cx="22794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28E960FC-BF36-B9CE-24FE-F27A727848A9}"/>
                  </a:ext>
                </a:extLst>
              </p:cNvPr>
              <p:cNvSpPr txBox="1"/>
              <p:nvPr/>
            </p:nvSpPr>
            <p:spPr>
              <a:xfrm>
                <a:off x="2587708" y="6194180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</a:p>
            </p:txBody>
          </p:sp>
          <p:sp>
            <p:nvSpPr>
              <p:cNvPr id="163" name="TextBox 162">
                <a:extLst>
                  <a:ext uri="{FF2B5EF4-FFF2-40B4-BE49-F238E27FC236}">
                    <a16:creationId xmlns:a16="http://schemas.microsoft.com/office/drawing/2014/main" id="{EB46DE52-0728-5160-3B6D-239648059FD9}"/>
                  </a:ext>
                </a:extLst>
              </p:cNvPr>
              <p:cNvSpPr txBox="1"/>
              <p:nvPr/>
            </p:nvSpPr>
            <p:spPr>
              <a:xfrm>
                <a:off x="1747111" y="5861388"/>
                <a:ext cx="112956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Type Expression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(Raw expression)</a:t>
                </a:r>
              </a:p>
            </p:txBody>
          </p:sp>
        </p:grp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B5A6E17F-4151-8155-5151-7EDCD4422067}"/>
                </a:ext>
              </a:extLst>
            </p:cNvPr>
            <p:cNvGrpSpPr/>
            <p:nvPr/>
          </p:nvGrpSpPr>
          <p:grpSpPr>
            <a:xfrm>
              <a:off x="6737265" y="4837101"/>
              <a:ext cx="3081885" cy="1265326"/>
              <a:chOff x="6737265" y="4837101"/>
              <a:chExt cx="3081885" cy="1265326"/>
            </a:xfrm>
          </p:grpSpPr>
          <p:grpSp>
            <p:nvGrpSpPr>
              <p:cNvPr id="179" name="Group 178">
                <a:extLst>
                  <a:ext uri="{FF2B5EF4-FFF2-40B4-BE49-F238E27FC236}">
                    <a16:creationId xmlns:a16="http://schemas.microsoft.com/office/drawing/2014/main" id="{C8A361B5-0420-65D0-202B-E5E02600B6E3}"/>
                  </a:ext>
                </a:extLst>
              </p:cNvPr>
              <p:cNvGrpSpPr/>
              <p:nvPr/>
            </p:nvGrpSpPr>
            <p:grpSpPr>
              <a:xfrm>
                <a:off x="6747961" y="4848691"/>
                <a:ext cx="3071189" cy="1253736"/>
                <a:chOff x="6747961" y="4632325"/>
                <a:chExt cx="3071189" cy="1253736"/>
              </a:xfrm>
            </p:grpSpPr>
            <p:sp>
              <p:nvSpPr>
                <p:cNvPr id="177" name="Rectangle 176">
                  <a:extLst>
                    <a:ext uri="{FF2B5EF4-FFF2-40B4-BE49-F238E27FC236}">
                      <a16:creationId xmlns:a16="http://schemas.microsoft.com/office/drawing/2014/main" id="{DA21E635-A0F6-D024-E735-F2C35CF95807}"/>
                    </a:ext>
                  </a:extLst>
                </p:cNvPr>
                <p:cNvSpPr/>
                <p:nvPr/>
              </p:nvSpPr>
              <p:spPr>
                <a:xfrm>
                  <a:off x="6747961" y="4632325"/>
                  <a:ext cx="3071189" cy="1253736"/>
                </a:xfrm>
                <a:prstGeom prst="rect">
                  <a:avLst/>
                </a:prstGeom>
                <a:noFill/>
                <a:ln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b="1" i="1"/>
                </a:p>
              </p:txBody>
            </p:sp>
            <p:grpSp>
              <p:nvGrpSpPr>
                <p:cNvPr id="170" name="Group 169">
                  <a:extLst>
                    <a:ext uri="{FF2B5EF4-FFF2-40B4-BE49-F238E27FC236}">
                      <a16:creationId xmlns:a16="http://schemas.microsoft.com/office/drawing/2014/main" id="{EDA55610-E666-F414-9E24-367CC5EEF054}"/>
                    </a:ext>
                  </a:extLst>
                </p:cNvPr>
                <p:cNvGrpSpPr/>
                <p:nvPr/>
              </p:nvGrpSpPr>
              <p:grpSpPr>
                <a:xfrm>
                  <a:off x="6796469" y="4850344"/>
                  <a:ext cx="2976225" cy="990000"/>
                  <a:chOff x="6796469" y="4400188"/>
                  <a:chExt cx="2976225" cy="990000"/>
                </a:xfrm>
              </p:grpSpPr>
              <p:pic>
                <p:nvPicPr>
                  <p:cNvPr id="133" name="Picture 132" descr="A colorful dots on a black background&#10;&#10;Description automatically generated">
                    <a:extLst>
                      <a:ext uri="{FF2B5EF4-FFF2-40B4-BE49-F238E27FC236}">
                        <a16:creationId xmlns:a16="http://schemas.microsoft.com/office/drawing/2014/main" id="{7B72DEED-542E-CAAF-A571-9093BD00123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7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787635" y="4400188"/>
                    <a:ext cx="993890" cy="990000"/>
                  </a:xfrm>
                  <a:prstGeom prst="rect">
                    <a:avLst/>
                  </a:prstGeom>
                </p:spPr>
              </p:pic>
              <p:pic>
                <p:nvPicPr>
                  <p:cNvPr id="160" name="Picture 159" descr="A close-up of a computer screen&#10;&#10;Description automatically generated">
                    <a:extLst>
                      <a:ext uri="{FF2B5EF4-FFF2-40B4-BE49-F238E27FC236}">
                        <a16:creationId xmlns:a16="http://schemas.microsoft.com/office/drawing/2014/main" id="{EE0DC5DA-529C-9580-EE90-E9C2C23613F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8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796469" y="4400188"/>
                    <a:ext cx="993890" cy="990000"/>
                  </a:xfrm>
                  <a:prstGeom prst="rect">
                    <a:avLst/>
                  </a:prstGeom>
                </p:spPr>
              </p:pic>
              <p:pic>
                <p:nvPicPr>
                  <p:cNvPr id="131" name="Picture 130" descr="A green and white image of a person's body&#10;&#10;Description automatically generated">
                    <a:extLst>
                      <a:ext uri="{FF2B5EF4-FFF2-40B4-BE49-F238E27FC236}">
                        <a16:creationId xmlns:a16="http://schemas.microsoft.com/office/drawing/2014/main" id="{869B9192-6277-85A2-B98A-BB89D1861B6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9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778804" y="4400188"/>
                    <a:ext cx="993890" cy="990000"/>
                  </a:xfrm>
                  <a:prstGeom prst="rect">
                    <a:avLst/>
                  </a:prstGeom>
                </p:spPr>
              </p:pic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id="{1F27E84F-A594-59A1-2BF6-2AC5A5E8AC3B}"/>
                      </a:ext>
                    </a:extLst>
                  </p:cNvPr>
                  <p:cNvSpPr txBox="1"/>
                  <p:nvPr/>
                </p:nvSpPr>
                <p:spPr>
                  <a:xfrm>
                    <a:off x="6883028" y="4403670"/>
                    <a:ext cx="237813" cy="19581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36000" rIns="36000" bIns="36000" rtlCol="0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T</a:t>
                    </a:r>
                  </a:p>
                </p:txBody>
              </p:sp>
              <p:sp>
                <p:nvSpPr>
                  <p:cNvPr id="157" name="TextBox 156">
                    <a:extLst>
                      <a:ext uri="{FF2B5EF4-FFF2-40B4-BE49-F238E27FC236}">
                        <a16:creationId xmlns:a16="http://schemas.microsoft.com/office/drawing/2014/main" id="{BC030FBE-8601-69B8-98A0-585CF54CB8A7}"/>
                      </a:ext>
                    </a:extLst>
                  </p:cNvPr>
                  <p:cNvSpPr txBox="1"/>
                  <p:nvPr/>
                </p:nvSpPr>
                <p:spPr>
                  <a:xfrm>
                    <a:off x="7872531" y="4403670"/>
                    <a:ext cx="231401" cy="19581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36000" rIns="36000" bIns="36000" rtlCol="0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en-US" sz="8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8" name="TextBox 157">
                    <a:extLst>
                      <a:ext uri="{FF2B5EF4-FFF2-40B4-BE49-F238E27FC236}">
                        <a16:creationId xmlns:a16="http://schemas.microsoft.com/office/drawing/2014/main" id="{20EEF5BC-01B6-A7C5-F2F9-18AA2BADEB55}"/>
                      </a:ext>
                    </a:extLst>
                  </p:cNvPr>
                  <p:cNvSpPr txBox="1"/>
                  <p:nvPr/>
                </p:nvSpPr>
                <p:spPr>
                  <a:xfrm>
                    <a:off x="8866394" y="4403670"/>
                    <a:ext cx="293918" cy="195814"/>
                  </a:xfrm>
                  <a:prstGeom prst="rect">
                    <a:avLst/>
                  </a:prstGeom>
                  <a:noFill/>
                </p:spPr>
                <p:txBody>
                  <a:bodyPr wrap="none" lIns="36000" tIns="36000" rIns="36000" bIns="36000" rtlCol="0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T</a:t>
                    </a:r>
                    <a:endParaRPr lang="en-US" sz="8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F7C3DA25-9C55-EEB9-5501-63056587852D}"/>
                  </a:ext>
                </a:extLst>
              </p:cNvPr>
              <p:cNvSpPr txBox="1"/>
              <p:nvPr/>
            </p:nvSpPr>
            <p:spPr>
              <a:xfrm>
                <a:off x="6737265" y="4837101"/>
                <a:ext cx="3071188" cy="226591"/>
              </a:xfrm>
              <a:prstGeom prst="rect">
                <a:avLst/>
              </a:prstGeom>
              <a:noFill/>
            </p:spPr>
            <p:txBody>
              <a:bodyPr wrap="square" lIns="36000" tIns="36000" rIns="36000" bIns="36000" rtlCol="0">
                <a:spAutoFit/>
              </a:bodyPr>
              <a:lstStyle/>
              <a:p>
                <a:pPr algn="ctr"/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OH7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77228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531</TotalTime>
  <Words>3643</Words>
  <Application>Microsoft Office PowerPoint</Application>
  <PresentationFormat>A4 Paper (210x297 mm)</PresentationFormat>
  <Paragraphs>858</Paragraphs>
  <Slides>1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Grubich Atac</dc:creator>
  <cp:lastModifiedBy>Kevin Maggi</cp:lastModifiedBy>
  <cp:revision>75</cp:revision>
  <dcterms:created xsi:type="dcterms:W3CDTF">2023-09-12T12:57:44Z</dcterms:created>
  <dcterms:modified xsi:type="dcterms:W3CDTF">2024-06-04T07:44:00Z</dcterms:modified>
</cp:coreProperties>
</file>